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82" r:id="rId2"/>
    <p:sldId id="283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5F8FEFF-B0C0-FA41-AD12-AB2FA826A491}" v="4" dt="2020-09-25T15:46:38.2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679"/>
    <p:restoredTop sz="73473"/>
  </p:normalViewPr>
  <p:slideViewPr>
    <p:cSldViewPr snapToGrid="0" snapToObjects="1">
      <p:cViewPr varScale="1">
        <p:scale>
          <a:sx n="63" d="100"/>
          <a:sy n="63" d="100"/>
        </p:scale>
        <p:origin x="27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TANO MASAKI" userId="6e12ec381f1ebf76" providerId="Windows Live" clId="Web-{3590EFB8-AA1B-4F9E-8546-1D4FA2606E64}"/>
    <pc:docChg chg="modSld">
      <pc:chgData name="HATANO MASAKI" userId="6e12ec381f1ebf76" providerId="Windows Live" clId="Web-{3590EFB8-AA1B-4F9E-8546-1D4FA2606E64}" dt="2020-08-07T04:29:03.471" v="16" actId="14100"/>
      <pc:docMkLst>
        <pc:docMk/>
      </pc:docMkLst>
      <pc:sldChg chg="addSp modSp">
        <pc:chgData name="HATANO MASAKI" userId="6e12ec381f1ebf76" providerId="Windows Live" clId="Web-{3590EFB8-AA1B-4F9E-8546-1D4FA2606E64}" dt="2020-08-07T04:29:03.471" v="16" actId="14100"/>
        <pc:sldMkLst>
          <pc:docMk/>
          <pc:sldMk cId="175394170" sldId="280"/>
        </pc:sldMkLst>
        <pc:picChg chg="add mod modCrop">
          <ac:chgData name="HATANO MASAKI" userId="6e12ec381f1ebf76" providerId="Windows Live" clId="Web-{3590EFB8-AA1B-4F9E-8546-1D4FA2606E64}" dt="2020-08-07T04:28:56.284" v="14" actId="14100"/>
          <ac:picMkLst>
            <pc:docMk/>
            <pc:sldMk cId="175394170" sldId="280"/>
            <ac:picMk id="3" creationId="{39ABC70A-E69C-40E8-8CE2-64FCF324FD90}"/>
          </ac:picMkLst>
        </pc:picChg>
        <pc:picChg chg="add mod modCrop">
          <ac:chgData name="HATANO MASAKI" userId="6e12ec381f1ebf76" providerId="Windows Live" clId="Web-{3590EFB8-AA1B-4F9E-8546-1D4FA2606E64}" dt="2020-08-07T04:29:03.471" v="16" actId="14100"/>
          <ac:picMkLst>
            <pc:docMk/>
            <pc:sldMk cId="175394170" sldId="280"/>
            <ac:picMk id="4" creationId="{43A9605E-2583-4C72-8B82-041A8EC828B0}"/>
          </ac:picMkLst>
        </pc:picChg>
      </pc:sldChg>
    </pc:docChg>
  </pc:docChgLst>
  <pc:docChgLst>
    <pc:chgData name="HATANO MASAKI" userId="6e12ec381f1ebf76" providerId="LiveId" clId="{E2720761-4A40-F34F-A0F2-6B9458A4B8A2}"/>
    <pc:docChg chg="modSld">
      <pc:chgData name="HATANO MASAKI" userId="6e12ec381f1ebf76" providerId="LiveId" clId="{E2720761-4A40-F34F-A0F2-6B9458A4B8A2}" dt="2020-08-07T13:08:28.166" v="184" actId="14100"/>
      <pc:docMkLst>
        <pc:docMk/>
      </pc:docMkLst>
      <pc:sldChg chg="modSp mod">
        <pc:chgData name="HATANO MASAKI" userId="6e12ec381f1ebf76" providerId="LiveId" clId="{E2720761-4A40-F34F-A0F2-6B9458A4B8A2}" dt="2020-08-07T12:57:55.532" v="16" actId="14100"/>
        <pc:sldMkLst>
          <pc:docMk/>
          <pc:sldMk cId="2311538212" sldId="264"/>
        </pc:sldMkLst>
        <pc:picChg chg="mod modCrop">
          <ac:chgData name="HATANO MASAKI" userId="6e12ec381f1ebf76" providerId="LiveId" clId="{E2720761-4A40-F34F-A0F2-6B9458A4B8A2}" dt="2020-08-07T12:57:55.532" v="16" actId="14100"/>
          <ac:picMkLst>
            <pc:docMk/>
            <pc:sldMk cId="2311538212" sldId="264"/>
            <ac:picMk id="6" creationId="{AC6B819C-CA7A-4F45-99AB-BA3DAE9D03B0}"/>
          </ac:picMkLst>
        </pc:picChg>
        <pc:picChg chg="mod modCrop">
          <ac:chgData name="HATANO MASAKI" userId="6e12ec381f1ebf76" providerId="LiveId" clId="{E2720761-4A40-F34F-A0F2-6B9458A4B8A2}" dt="2020-08-07T12:57:43.945" v="14" actId="14100"/>
          <ac:picMkLst>
            <pc:docMk/>
            <pc:sldMk cId="2311538212" sldId="264"/>
            <ac:picMk id="7" creationId="{0C2F1226-88D2-410A-831D-F37637A8885F}"/>
          </ac:picMkLst>
        </pc:picChg>
      </pc:sldChg>
      <pc:sldChg chg="modSp mod">
        <pc:chgData name="HATANO MASAKI" userId="6e12ec381f1ebf76" providerId="LiveId" clId="{E2720761-4A40-F34F-A0F2-6B9458A4B8A2}" dt="2020-08-07T12:59:00.447" v="24" actId="732"/>
        <pc:sldMkLst>
          <pc:docMk/>
          <pc:sldMk cId="3619332507" sldId="265"/>
        </pc:sldMkLst>
        <pc:picChg chg="mod modCrop">
          <ac:chgData name="HATANO MASAKI" userId="6e12ec381f1ebf76" providerId="LiveId" clId="{E2720761-4A40-F34F-A0F2-6B9458A4B8A2}" dt="2020-08-07T12:59:00.447" v="24" actId="732"/>
          <ac:picMkLst>
            <pc:docMk/>
            <pc:sldMk cId="3619332507" sldId="265"/>
            <ac:picMk id="3" creationId="{E70B1210-0810-4025-B7A1-61FBBD0082B0}"/>
          </ac:picMkLst>
        </pc:picChg>
        <pc:picChg chg="mod modCrop">
          <ac:chgData name="HATANO MASAKI" userId="6e12ec381f1ebf76" providerId="LiveId" clId="{E2720761-4A40-F34F-A0F2-6B9458A4B8A2}" dt="2020-08-07T12:58:43.841" v="21" actId="1076"/>
          <ac:picMkLst>
            <pc:docMk/>
            <pc:sldMk cId="3619332507" sldId="265"/>
            <ac:picMk id="4" creationId="{2755BCCE-80DD-4F0C-AFE2-E61E1C4BBBFA}"/>
          </ac:picMkLst>
        </pc:picChg>
      </pc:sldChg>
      <pc:sldChg chg="modSp mod">
        <pc:chgData name="HATANO MASAKI" userId="6e12ec381f1ebf76" providerId="LiveId" clId="{E2720761-4A40-F34F-A0F2-6B9458A4B8A2}" dt="2020-08-07T13:02:37.961" v="76" actId="1038"/>
        <pc:sldMkLst>
          <pc:docMk/>
          <pc:sldMk cId="4117825274" sldId="266"/>
        </pc:sldMkLst>
        <pc:picChg chg="mod modCrop">
          <ac:chgData name="HATANO MASAKI" userId="6e12ec381f1ebf76" providerId="LiveId" clId="{E2720761-4A40-F34F-A0F2-6B9458A4B8A2}" dt="2020-08-07T13:02:37.961" v="76" actId="1038"/>
          <ac:picMkLst>
            <pc:docMk/>
            <pc:sldMk cId="4117825274" sldId="266"/>
            <ac:picMk id="6" creationId="{3AF41496-CE4D-482C-9949-A2B41015B3CC}"/>
          </ac:picMkLst>
        </pc:picChg>
        <pc:picChg chg="mod modCrop">
          <ac:chgData name="HATANO MASAKI" userId="6e12ec381f1ebf76" providerId="LiveId" clId="{E2720761-4A40-F34F-A0F2-6B9458A4B8A2}" dt="2020-08-07T13:02:36.556" v="75" actId="1036"/>
          <ac:picMkLst>
            <pc:docMk/>
            <pc:sldMk cId="4117825274" sldId="266"/>
            <ac:picMk id="7" creationId="{955DC52C-7E44-4C3B-B3BC-B3D4C6C8DD7B}"/>
          </ac:picMkLst>
        </pc:picChg>
      </pc:sldChg>
      <pc:sldChg chg="modSp mod">
        <pc:chgData name="HATANO MASAKI" userId="6e12ec381f1ebf76" providerId="LiveId" clId="{E2720761-4A40-F34F-A0F2-6B9458A4B8A2}" dt="2020-08-07T13:04:43.295" v="111" actId="20577"/>
        <pc:sldMkLst>
          <pc:docMk/>
          <pc:sldMk cId="2265648155" sldId="279"/>
        </pc:sldMkLst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3" creationId="{1C2F6EB0-E90D-2F4C-A62C-C2EF5FA2D5CC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5" creationId="{845652A0-F8F1-D54D-B5A1-7A2244D543EB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6" creationId="{2E227BA7-563C-4448-B329-484E36D4183E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7" creationId="{2605F7A7-A1B5-AC4B-A604-C49849AF2379}"/>
          </ac:spMkLst>
        </pc:spChg>
        <pc:spChg chg="mod">
          <ac:chgData name="HATANO MASAKI" userId="6e12ec381f1ebf76" providerId="LiveId" clId="{E2720761-4A40-F34F-A0F2-6B9458A4B8A2}" dt="2020-08-07T13:04:33.149" v="105" actId="20577"/>
          <ac:spMkLst>
            <pc:docMk/>
            <pc:sldMk cId="2265648155" sldId="279"/>
            <ac:spMk id="10" creationId="{A3C13260-E995-A946-B85B-74DACD1CFA5B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28" creationId="{BB63BBF5-7826-A44B-ABF4-3AE79335558F}"/>
          </ac:spMkLst>
        </pc:spChg>
        <pc:spChg chg="mod">
          <ac:chgData name="HATANO MASAKI" userId="6e12ec381f1ebf76" providerId="LiveId" clId="{E2720761-4A40-F34F-A0F2-6B9458A4B8A2}" dt="2020-08-07T13:04:36.590" v="107" actId="20577"/>
          <ac:spMkLst>
            <pc:docMk/>
            <pc:sldMk cId="2265648155" sldId="279"/>
            <ac:spMk id="29" creationId="{ACEA2B39-7975-BA48-83EB-2464197B4C95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31" creationId="{D0E75FC6-8629-B347-86D3-A8FAF1BBA83E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34" creationId="{918B3030-A16F-7F47-AED1-2A27D020A570}"/>
          </ac:spMkLst>
        </pc:spChg>
        <pc:spChg chg="mod">
          <ac:chgData name="HATANO MASAKI" userId="6e12ec381f1ebf76" providerId="LiveId" clId="{E2720761-4A40-F34F-A0F2-6B9458A4B8A2}" dt="2020-08-07T13:04:15.483" v="103" actId="1038"/>
          <ac:spMkLst>
            <pc:docMk/>
            <pc:sldMk cId="2265648155" sldId="279"/>
            <ac:spMk id="35" creationId="{18ED0BE7-B2F4-374D-8777-9DAA87D87851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36" creationId="{73146EB4-8ED5-9542-AA8B-EC9C1A08FFB4}"/>
          </ac:spMkLst>
        </pc:spChg>
        <pc:spChg chg="mod">
          <ac:chgData name="HATANO MASAKI" userId="6e12ec381f1ebf76" providerId="LiveId" clId="{E2720761-4A40-F34F-A0F2-6B9458A4B8A2}" dt="2020-08-07T13:04:43.295" v="111" actId="20577"/>
          <ac:spMkLst>
            <pc:docMk/>
            <pc:sldMk cId="2265648155" sldId="279"/>
            <ac:spMk id="37" creationId="{1D80161F-879A-A746-A77D-D7286B20A418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38" creationId="{A4F37389-0E9A-4248-A563-D9F7983C3E93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39" creationId="{053F5F1C-2657-EB45-94EE-1A007F356690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40" creationId="{C9E64501-9A24-0E4A-AF76-6C392D8E2E7F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42" creationId="{FA87CF36-55B6-5840-BB33-6338F45FA924}"/>
          </ac:spMkLst>
        </pc:spChg>
        <pc:spChg chg="mod">
          <ac:chgData name="HATANO MASAKI" userId="6e12ec381f1ebf76" providerId="LiveId" clId="{E2720761-4A40-F34F-A0F2-6B9458A4B8A2}" dt="2020-08-07T13:04:40.112" v="109" actId="20577"/>
          <ac:spMkLst>
            <pc:docMk/>
            <pc:sldMk cId="2265648155" sldId="279"/>
            <ac:spMk id="45" creationId="{66B79B2F-F7DF-C746-AE08-5A6B47FE0CFC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49" creationId="{D5682F43-2C00-7749-BB83-2E468896F7BD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50" creationId="{FC6861E3-0BBE-E947-87FC-0FE4D37BF667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51" creationId="{B7349551-E639-5041-92FE-0F48DE608C4C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53" creationId="{D32731DB-9334-9940-A1DA-FDBAF0BC0656}"/>
          </ac:spMkLst>
        </pc:spChg>
        <pc:spChg chg="mod">
          <ac:chgData name="HATANO MASAKI" userId="6e12ec381f1ebf76" providerId="LiveId" clId="{E2720761-4A40-F34F-A0F2-6B9458A4B8A2}" dt="2020-08-07T13:03:32.171" v="78" actId="2711"/>
          <ac:spMkLst>
            <pc:docMk/>
            <pc:sldMk cId="2265648155" sldId="279"/>
            <ac:spMk id="54" creationId="{4C65C503-52B3-E646-852A-A079A34344BD}"/>
          </ac:spMkLst>
        </pc:spChg>
      </pc:sldChg>
      <pc:sldChg chg="modSp mod">
        <pc:chgData name="HATANO MASAKI" userId="6e12ec381f1ebf76" providerId="LiveId" clId="{E2720761-4A40-F34F-A0F2-6B9458A4B8A2}" dt="2020-08-07T13:02:14.656" v="69" actId="1037"/>
        <pc:sldMkLst>
          <pc:docMk/>
          <pc:sldMk cId="175394170" sldId="280"/>
        </pc:sldMkLst>
        <pc:picChg chg="mod modCrop">
          <ac:chgData name="HATANO MASAKI" userId="6e12ec381f1ebf76" providerId="LiveId" clId="{E2720761-4A40-F34F-A0F2-6B9458A4B8A2}" dt="2020-08-07T13:02:13.554" v="68" actId="1037"/>
          <ac:picMkLst>
            <pc:docMk/>
            <pc:sldMk cId="175394170" sldId="280"/>
            <ac:picMk id="3" creationId="{39ABC70A-E69C-40E8-8CE2-64FCF324FD90}"/>
          </ac:picMkLst>
        </pc:picChg>
        <pc:picChg chg="mod modCrop">
          <ac:chgData name="HATANO MASAKI" userId="6e12ec381f1ebf76" providerId="LiveId" clId="{E2720761-4A40-F34F-A0F2-6B9458A4B8A2}" dt="2020-08-07T13:02:14.656" v="69" actId="1037"/>
          <ac:picMkLst>
            <pc:docMk/>
            <pc:sldMk cId="175394170" sldId="280"/>
            <ac:picMk id="4" creationId="{43A9605E-2583-4C72-8B82-041A8EC828B0}"/>
          </ac:picMkLst>
        </pc:picChg>
      </pc:sldChg>
      <pc:sldChg chg="modSp mod">
        <pc:chgData name="HATANO MASAKI" userId="6e12ec381f1ebf76" providerId="LiveId" clId="{E2720761-4A40-F34F-A0F2-6B9458A4B8A2}" dt="2020-08-07T13:06:52.300" v="169" actId="1035"/>
        <pc:sldMkLst>
          <pc:docMk/>
          <pc:sldMk cId="3244315699" sldId="281"/>
        </pc:sldMkLst>
        <pc:spChg chg="mod">
          <ac:chgData name="HATANO MASAKI" userId="6e12ec381f1ebf76" providerId="LiveId" clId="{E2720761-4A40-F34F-A0F2-6B9458A4B8A2}" dt="2020-08-07T13:05:34.712" v="135" actId="1037"/>
          <ac:spMkLst>
            <pc:docMk/>
            <pc:sldMk cId="3244315699" sldId="281"/>
            <ac:spMk id="2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3:46.816" v="79" actId="2711"/>
          <ac:spMkLst>
            <pc:docMk/>
            <pc:sldMk cId="3244315699" sldId="281"/>
            <ac:spMk id="9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6:12.736" v="139" actId="1037"/>
          <ac:spMkLst>
            <pc:docMk/>
            <pc:sldMk cId="3244315699" sldId="281"/>
            <ac:spMk id="11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6:22.184" v="141" actId="1035"/>
          <ac:spMkLst>
            <pc:docMk/>
            <pc:sldMk cId="3244315699" sldId="281"/>
            <ac:spMk id="24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6:52.300" v="169" actId="1035"/>
          <ac:spMkLst>
            <pc:docMk/>
            <pc:sldMk cId="3244315699" sldId="281"/>
            <ac:spMk id="25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6:16.173" v="140" actId="1037"/>
          <ac:spMkLst>
            <pc:docMk/>
            <pc:sldMk cId="3244315699" sldId="281"/>
            <ac:spMk id="26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3:46.816" v="79" actId="2711"/>
          <ac:spMkLst>
            <pc:docMk/>
            <pc:sldMk cId="3244315699" sldId="281"/>
            <ac:spMk id="27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4:54.254" v="112" actId="14100"/>
          <ac:spMkLst>
            <pc:docMk/>
            <pc:sldMk cId="3244315699" sldId="281"/>
            <ac:spMk id="28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6:09.066" v="138" actId="1035"/>
          <ac:spMkLst>
            <pc:docMk/>
            <pc:sldMk cId="3244315699" sldId="281"/>
            <ac:spMk id="30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5:08.356" v="130" actId="1037"/>
          <ac:spMkLst>
            <pc:docMk/>
            <pc:sldMk cId="3244315699" sldId="281"/>
            <ac:spMk id="32" creationId="{D305F542-1C9E-824D-8DCC-E4BB7F5A3A73}"/>
          </ac:spMkLst>
        </pc:spChg>
        <pc:spChg chg="mod">
          <ac:chgData name="HATANO MASAKI" userId="6e12ec381f1ebf76" providerId="LiveId" clId="{E2720761-4A40-F34F-A0F2-6B9458A4B8A2}" dt="2020-08-07T13:03:46.816" v="79" actId="2711"/>
          <ac:spMkLst>
            <pc:docMk/>
            <pc:sldMk cId="3244315699" sldId="281"/>
            <ac:spMk id="38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3:46.816" v="79" actId="2711"/>
          <ac:spMkLst>
            <pc:docMk/>
            <pc:sldMk cId="3244315699" sldId="281"/>
            <ac:spMk id="39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5:17.477" v="133" actId="14100"/>
          <ac:spMkLst>
            <pc:docMk/>
            <pc:sldMk cId="3244315699" sldId="281"/>
            <ac:spMk id="40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3:46.816" v="79" actId="2711"/>
          <ac:spMkLst>
            <pc:docMk/>
            <pc:sldMk cId="3244315699" sldId="281"/>
            <ac:spMk id="41" creationId="{1DE3609F-1A89-5B49-85D7-78B4AA8502CE}"/>
          </ac:spMkLst>
        </pc:spChg>
        <pc:spChg chg="mod">
          <ac:chgData name="HATANO MASAKI" userId="6e12ec381f1ebf76" providerId="LiveId" clId="{E2720761-4A40-F34F-A0F2-6B9458A4B8A2}" dt="2020-08-07T13:03:46.816" v="79" actId="2711"/>
          <ac:spMkLst>
            <pc:docMk/>
            <pc:sldMk cId="3244315699" sldId="281"/>
            <ac:spMk id="43" creationId="{040379FE-DF5B-CD4E-BE1C-5A444BC1AE63}"/>
          </ac:spMkLst>
        </pc:spChg>
        <pc:spChg chg="mod">
          <ac:chgData name="HATANO MASAKI" userId="6e12ec381f1ebf76" providerId="LiveId" clId="{E2720761-4A40-F34F-A0F2-6B9458A4B8A2}" dt="2020-08-07T13:03:46.816" v="79" actId="2711"/>
          <ac:spMkLst>
            <pc:docMk/>
            <pc:sldMk cId="3244315699" sldId="281"/>
            <ac:spMk id="44" creationId="{FA30B3BF-A9EA-CF45-B4B1-1E3213F0AD5E}"/>
          </ac:spMkLst>
        </pc:spChg>
        <pc:spChg chg="mod">
          <ac:chgData name="HATANO MASAKI" userId="6e12ec381f1ebf76" providerId="LiveId" clId="{E2720761-4A40-F34F-A0F2-6B9458A4B8A2}" dt="2020-08-07T13:03:46.816" v="79" actId="2711"/>
          <ac:spMkLst>
            <pc:docMk/>
            <pc:sldMk cId="3244315699" sldId="281"/>
            <ac:spMk id="45" creationId="{56A51CDA-CBF4-9B42-85E9-5241D88BAA6A}"/>
          </ac:spMkLst>
        </pc:spChg>
        <pc:spChg chg="mod">
          <ac:chgData name="HATANO MASAKI" userId="6e12ec381f1ebf76" providerId="LiveId" clId="{E2720761-4A40-F34F-A0F2-6B9458A4B8A2}" dt="2020-08-07T13:03:46.816" v="79" actId="2711"/>
          <ac:spMkLst>
            <pc:docMk/>
            <pc:sldMk cId="3244315699" sldId="281"/>
            <ac:spMk id="51" creationId="{CE1F308D-B67F-0949-886E-3E007B28FD5E}"/>
          </ac:spMkLst>
        </pc:spChg>
        <pc:spChg chg="mod">
          <ac:chgData name="HATANO MASAKI" userId="6e12ec381f1ebf76" providerId="LiveId" clId="{E2720761-4A40-F34F-A0F2-6B9458A4B8A2}" dt="2020-08-07T13:03:46.816" v="79" actId="2711"/>
          <ac:spMkLst>
            <pc:docMk/>
            <pc:sldMk cId="3244315699" sldId="281"/>
            <ac:spMk id="52" creationId="{8715DAD6-C1E6-DC4E-BF8F-D73AEFF2C46A}"/>
          </ac:spMkLst>
        </pc:spChg>
        <pc:spChg chg="mod">
          <ac:chgData name="HATANO MASAKI" userId="6e12ec381f1ebf76" providerId="LiveId" clId="{E2720761-4A40-F34F-A0F2-6B9458A4B8A2}" dt="2020-08-07T13:03:46.816" v="79" actId="2711"/>
          <ac:spMkLst>
            <pc:docMk/>
            <pc:sldMk cId="3244315699" sldId="281"/>
            <ac:spMk id="53" creationId="{24AF6DBA-90DD-1A40-9B84-E1AE8606167F}"/>
          </ac:spMkLst>
        </pc:spChg>
      </pc:sldChg>
      <pc:sldChg chg="modSp mod">
        <pc:chgData name="HATANO MASAKI" userId="6e12ec381f1ebf76" providerId="LiveId" clId="{E2720761-4A40-F34F-A0F2-6B9458A4B8A2}" dt="2020-08-07T13:07:31.813" v="177" actId="1036"/>
        <pc:sldMkLst>
          <pc:docMk/>
          <pc:sldMk cId="3588872444" sldId="282"/>
        </pc:sldMkLst>
        <pc:spChg chg="mod">
          <ac:chgData name="HATANO MASAKI" userId="6e12ec381f1ebf76" providerId="LiveId" clId="{E2720761-4A40-F34F-A0F2-6B9458A4B8A2}" dt="2020-08-07T13:07:28.643" v="175" actId="1036"/>
          <ac:spMkLst>
            <pc:docMk/>
            <pc:sldMk cId="3588872444" sldId="282"/>
            <ac:spMk id="2" creationId="{C2B4D606-31ED-2D4B-A02E-1B716EA8E47A}"/>
          </ac:spMkLst>
        </pc:spChg>
        <pc:spChg chg="mod">
          <ac:chgData name="HATANO MASAKI" userId="6e12ec381f1ebf76" providerId="LiveId" clId="{E2720761-4A40-F34F-A0F2-6B9458A4B8A2}" dt="2020-08-07T13:07:10.690" v="170" actId="2711"/>
          <ac:spMkLst>
            <pc:docMk/>
            <pc:sldMk cId="3588872444" sldId="282"/>
            <ac:spMk id="7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7:16.202" v="171" actId="14100"/>
          <ac:spMkLst>
            <pc:docMk/>
            <pc:sldMk cId="3588872444" sldId="282"/>
            <ac:spMk id="15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7:10.690" v="170" actId="2711"/>
          <ac:spMkLst>
            <pc:docMk/>
            <pc:sldMk cId="3588872444" sldId="282"/>
            <ac:spMk id="44" creationId="{A9A39706-5730-C44E-BC02-5F55C414DCE7}"/>
          </ac:spMkLst>
        </pc:spChg>
        <pc:spChg chg="mod">
          <ac:chgData name="HATANO MASAKI" userId="6e12ec381f1ebf76" providerId="LiveId" clId="{E2720761-4A40-F34F-A0F2-6B9458A4B8A2}" dt="2020-08-07T13:07:10.690" v="170" actId="2711"/>
          <ac:spMkLst>
            <pc:docMk/>
            <pc:sldMk cId="3588872444" sldId="282"/>
            <ac:spMk id="46" creationId="{16004E84-495D-A044-A285-000129A4AA7E}"/>
          </ac:spMkLst>
        </pc:spChg>
        <pc:spChg chg="mod">
          <ac:chgData name="HATANO MASAKI" userId="6e12ec381f1ebf76" providerId="LiveId" clId="{E2720761-4A40-F34F-A0F2-6B9458A4B8A2}" dt="2020-08-07T13:07:10.690" v="170" actId="2711"/>
          <ac:spMkLst>
            <pc:docMk/>
            <pc:sldMk cId="3588872444" sldId="282"/>
            <ac:spMk id="49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7:10.690" v="170" actId="2711"/>
          <ac:spMkLst>
            <pc:docMk/>
            <pc:sldMk cId="3588872444" sldId="282"/>
            <ac:spMk id="50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7:31.813" v="177" actId="1036"/>
          <ac:spMkLst>
            <pc:docMk/>
            <pc:sldMk cId="3588872444" sldId="282"/>
            <ac:spMk id="59" creationId="{31FF7768-E4A4-2E49-A032-DA602315B67B}"/>
          </ac:spMkLst>
        </pc:spChg>
        <pc:spChg chg="mod">
          <ac:chgData name="HATANO MASAKI" userId="6e12ec381f1ebf76" providerId="LiveId" clId="{E2720761-4A40-F34F-A0F2-6B9458A4B8A2}" dt="2020-08-07T13:07:10.690" v="170" actId="2711"/>
          <ac:spMkLst>
            <pc:docMk/>
            <pc:sldMk cId="3588872444" sldId="282"/>
            <ac:spMk id="60" creationId="{E65C809A-3EFC-434F-9AFA-D96877FF512F}"/>
          </ac:spMkLst>
        </pc:spChg>
        <pc:spChg chg="mod">
          <ac:chgData name="HATANO MASAKI" userId="6e12ec381f1ebf76" providerId="LiveId" clId="{E2720761-4A40-F34F-A0F2-6B9458A4B8A2}" dt="2020-08-07T13:07:10.690" v="170" actId="2711"/>
          <ac:spMkLst>
            <pc:docMk/>
            <pc:sldMk cId="3588872444" sldId="282"/>
            <ac:spMk id="61" creationId="{EF966A40-7DDB-1247-A3FD-E774CA0C10EE}"/>
          </ac:spMkLst>
        </pc:spChg>
        <pc:spChg chg="mod">
          <ac:chgData name="HATANO MASAKI" userId="6e12ec381f1ebf76" providerId="LiveId" clId="{E2720761-4A40-F34F-A0F2-6B9458A4B8A2}" dt="2020-08-07T13:07:10.690" v="170" actId="2711"/>
          <ac:spMkLst>
            <pc:docMk/>
            <pc:sldMk cId="3588872444" sldId="282"/>
            <ac:spMk id="71" creationId="{6E90A854-9B37-1D45-B4DB-DBD9B43D5D95}"/>
          </ac:spMkLst>
        </pc:spChg>
      </pc:sldChg>
      <pc:sldChg chg="modSp mod">
        <pc:chgData name="HATANO MASAKI" userId="6e12ec381f1ebf76" providerId="LiveId" clId="{E2720761-4A40-F34F-A0F2-6B9458A4B8A2}" dt="2020-08-07T13:08:28.166" v="184" actId="14100"/>
        <pc:sldMkLst>
          <pc:docMk/>
          <pc:sldMk cId="731009805" sldId="283"/>
        </pc:sldMkLst>
        <pc:spChg chg="mod">
          <ac:chgData name="HATANO MASAKI" userId="6e12ec381f1ebf76" providerId="LiveId" clId="{E2720761-4A40-F34F-A0F2-6B9458A4B8A2}" dt="2020-08-07T13:07:58.944" v="178" actId="2711"/>
          <ac:spMkLst>
            <pc:docMk/>
            <pc:sldMk cId="731009805" sldId="283"/>
            <ac:spMk id="8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7:58.944" v="178" actId="2711"/>
          <ac:spMkLst>
            <pc:docMk/>
            <pc:sldMk cId="731009805" sldId="283"/>
            <ac:spMk id="10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8:14.284" v="182" actId="14100"/>
          <ac:spMkLst>
            <pc:docMk/>
            <pc:sldMk cId="731009805" sldId="283"/>
            <ac:spMk id="13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7:58.944" v="178" actId="2711"/>
          <ac:spMkLst>
            <pc:docMk/>
            <pc:sldMk cId="731009805" sldId="283"/>
            <ac:spMk id="14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7:58.944" v="178" actId="2711"/>
          <ac:spMkLst>
            <pc:docMk/>
            <pc:sldMk cId="731009805" sldId="283"/>
            <ac:spMk id="15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7:58.944" v="178" actId="2711"/>
          <ac:spMkLst>
            <pc:docMk/>
            <pc:sldMk cId="731009805" sldId="283"/>
            <ac:spMk id="16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7:58.944" v="178" actId="2711"/>
          <ac:spMkLst>
            <pc:docMk/>
            <pc:sldMk cId="731009805" sldId="283"/>
            <ac:spMk id="18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7:58.944" v="178" actId="2711"/>
          <ac:spMkLst>
            <pc:docMk/>
            <pc:sldMk cId="731009805" sldId="283"/>
            <ac:spMk id="19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7:58.944" v="178" actId="2711"/>
          <ac:spMkLst>
            <pc:docMk/>
            <pc:sldMk cId="731009805" sldId="283"/>
            <ac:spMk id="23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7:58.944" v="178" actId="2711"/>
          <ac:spMkLst>
            <pc:docMk/>
            <pc:sldMk cId="731009805" sldId="283"/>
            <ac:spMk id="29" creationId="{00000000-0000-0000-0000-000000000000}"/>
          </ac:spMkLst>
        </pc:spChg>
        <pc:spChg chg="mod">
          <ac:chgData name="HATANO MASAKI" userId="6e12ec381f1ebf76" providerId="LiveId" clId="{E2720761-4A40-F34F-A0F2-6B9458A4B8A2}" dt="2020-08-07T13:07:58.944" v="178" actId="2711"/>
          <ac:spMkLst>
            <pc:docMk/>
            <pc:sldMk cId="731009805" sldId="283"/>
            <ac:spMk id="32" creationId="{AE23FAC2-20FD-E94E-83AE-A5B2DE74BF65}"/>
          </ac:spMkLst>
        </pc:spChg>
        <pc:spChg chg="mod">
          <ac:chgData name="HATANO MASAKI" userId="6e12ec381f1ebf76" providerId="LiveId" clId="{E2720761-4A40-F34F-A0F2-6B9458A4B8A2}" dt="2020-08-07T13:07:58.944" v="178" actId="2711"/>
          <ac:spMkLst>
            <pc:docMk/>
            <pc:sldMk cId="731009805" sldId="283"/>
            <ac:spMk id="34" creationId="{73875B6D-45CE-2C44-91E5-56D55E53B7B0}"/>
          </ac:spMkLst>
        </pc:spChg>
        <pc:spChg chg="mod">
          <ac:chgData name="HATANO MASAKI" userId="6e12ec381f1ebf76" providerId="LiveId" clId="{E2720761-4A40-F34F-A0F2-6B9458A4B8A2}" dt="2020-08-07T13:07:58.944" v="178" actId="2711"/>
          <ac:spMkLst>
            <pc:docMk/>
            <pc:sldMk cId="731009805" sldId="283"/>
            <ac:spMk id="35" creationId="{C23BFF0D-9BAF-8649-A93F-D8DF18C173EF}"/>
          </ac:spMkLst>
        </pc:spChg>
        <pc:spChg chg="mod">
          <ac:chgData name="HATANO MASAKI" userId="6e12ec381f1ebf76" providerId="LiveId" clId="{E2720761-4A40-F34F-A0F2-6B9458A4B8A2}" dt="2020-08-07T13:08:23.376" v="183" actId="14100"/>
          <ac:spMkLst>
            <pc:docMk/>
            <pc:sldMk cId="731009805" sldId="283"/>
            <ac:spMk id="38" creationId="{156EAB48-CA36-1644-844C-FE6B8F80AF46}"/>
          </ac:spMkLst>
        </pc:spChg>
        <pc:spChg chg="mod">
          <ac:chgData name="HATANO MASAKI" userId="6e12ec381f1ebf76" providerId="LiveId" clId="{E2720761-4A40-F34F-A0F2-6B9458A4B8A2}" dt="2020-08-07T13:08:28.166" v="184" actId="14100"/>
          <ac:spMkLst>
            <pc:docMk/>
            <pc:sldMk cId="731009805" sldId="283"/>
            <ac:spMk id="39" creationId="{B3173DC5-B476-3642-8BD0-0B5E519D1A5C}"/>
          </ac:spMkLst>
        </pc:spChg>
      </pc:sldChg>
    </pc:docChg>
  </pc:docChgLst>
  <pc:docChgLst>
    <pc:chgData name="HATANO MASAKI" userId="6e12ec381f1ebf76" providerId="LiveId" clId="{5CA12708-F39A-A448-8280-F66F43AA0882}"/>
    <pc:docChg chg="modSld">
      <pc:chgData name="HATANO MASAKI" userId="6e12ec381f1ebf76" providerId="LiveId" clId="{5CA12708-F39A-A448-8280-F66F43AA0882}" dt="2020-09-25T05:43:38.052" v="65" actId="2711"/>
      <pc:docMkLst>
        <pc:docMk/>
      </pc:docMkLst>
      <pc:sldChg chg="modSp mod">
        <pc:chgData name="HATANO MASAKI" userId="6e12ec381f1ebf76" providerId="LiveId" clId="{5CA12708-F39A-A448-8280-F66F43AA0882}" dt="2020-09-25T05:41:03.811" v="0" actId="2711"/>
        <pc:sldMkLst>
          <pc:docMk/>
          <pc:sldMk cId="3083337674" sldId="261"/>
        </pc:sldMkLst>
        <pc:spChg chg="mod">
          <ac:chgData name="HATANO MASAKI" userId="6e12ec381f1ebf76" providerId="LiveId" clId="{5CA12708-F39A-A448-8280-F66F43AA0882}" dt="2020-09-25T05:41:03.811" v="0" actId="2711"/>
          <ac:spMkLst>
            <pc:docMk/>
            <pc:sldMk cId="3083337674" sldId="261"/>
            <ac:spMk id="15" creationId="{0AAB943E-7858-44BE-B42D-0A248D4A203D}"/>
          </ac:spMkLst>
        </pc:spChg>
        <pc:spChg chg="mod">
          <ac:chgData name="HATANO MASAKI" userId="6e12ec381f1ebf76" providerId="LiveId" clId="{5CA12708-F39A-A448-8280-F66F43AA0882}" dt="2020-09-25T05:41:03.811" v="0" actId="2711"/>
          <ac:spMkLst>
            <pc:docMk/>
            <pc:sldMk cId="3083337674" sldId="261"/>
            <ac:spMk id="16" creationId="{876AF92A-0A07-4307-8234-CD7AC500FC57}"/>
          </ac:spMkLst>
        </pc:spChg>
        <pc:spChg chg="mod">
          <ac:chgData name="HATANO MASAKI" userId="6e12ec381f1ebf76" providerId="LiveId" clId="{5CA12708-F39A-A448-8280-F66F43AA0882}" dt="2020-09-25T05:41:03.811" v="0" actId="2711"/>
          <ac:spMkLst>
            <pc:docMk/>
            <pc:sldMk cId="3083337674" sldId="261"/>
            <ac:spMk id="17" creationId="{E1998112-4DF4-4E8E-9B4C-ABD05625FBFE}"/>
          </ac:spMkLst>
        </pc:spChg>
      </pc:sldChg>
      <pc:sldChg chg="modSp mod">
        <pc:chgData name="HATANO MASAKI" userId="6e12ec381f1ebf76" providerId="LiveId" clId="{5CA12708-F39A-A448-8280-F66F43AA0882}" dt="2020-09-25T05:41:10.185" v="1" actId="2711"/>
        <pc:sldMkLst>
          <pc:docMk/>
          <pc:sldMk cId="962339529" sldId="262"/>
        </pc:sldMkLst>
        <pc:spChg chg="mod">
          <ac:chgData name="HATANO MASAKI" userId="6e12ec381f1ebf76" providerId="LiveId" clId="{5CA12708-F39A-A448-8280-F66F43AA0882}" dt="2020-09-25T05:41:10.185" v="1" actId="2711"/>
          <ac:spMkLst>
            <pc:docMk/>
            <pc:sldMk cId="962339529" sldId="262"/>
            <ac:spMk id="2" creationId="{47E745B1-4A80-43D0-97CF-C6504DDE7C51}"/>
          </ac:spMkLst>
        </pc:spChg>
        <pc:spChg chg="mod">
          <ac:chgData name="HATANO MASAKI" userId="6e12ec381f1ebf76" providerId="LiveId" clId="{5CA12708-F39A-A448-8280-F66F43AA0882}" dt="2020-09-25T05:41:10.185" v="1" actId="2711"/>
          <ac:spMkLst>
            <pc:docMk/>
            <pc:sldMk cId="962339529" sldId="262"/>
            <ac:spMk id="5" creationId="{3018848F-3A8A-496F-817A-7A6C5D0214E1}"/>
          </ac:spMkLst>
        </pc:spChg>
        <pc:spChg chg="mod">
          <ac:chgData name="HATANO MASAKI" userId="6e12ec381f1ebf76" providerId="LiveId" clId="{5CA12708-F39A-A448-8280-F66F43AA0882}" dt="2020-09-25T05:41:10.185" v="1" actId="2711"/>
          <ac:spMkLst>
            <pc:docMk/>
            <pc:sldMk cId="962339529" sldId="262"/>
            <ac:spMk id="9" creationId="{F7840237-8C7E-44A9-8100-D04FE984B9B1}"/>
          </ac:spMkLst>
        </pc:spChg>
      </pc:sldChg>
      <pc:sldChg chg="modSp mod">
        <pc:chgData name="HATANO MASAKI" userId="6e12ec381f1ebf76" providerId="LiveId" clId="{5CA12708-F39A-A448-8280-F66F43AA0882}" dt="2020-09-25T05:41:16.698" v="2" actId="2711"/>
        <pc:sldMkLst>
          <pc:docMk/>
          <pc:sldMk cId="1280214885" sldId="263"/>
        </pc:sldMkLst>
        <pc:spChg chg="mod">
          <ac:chgData name="HATANO MASAKI" userId="6e12ec381f1ebf76" providerId="LiveId" clId="{5CA12708-F39A-A448-8280-F66F43AA0882}" dt="2020-09-25T05:41:16.698" v="2" actId="2711"/>
          <ac:spMkLst>
            <pc:docMk/>
            <pc:sldMk cId="1280214885" sldId="263"/>
            <ac:spMk id="2" creationId="{47E745B1-4A80-43D0-97CF-C6504DDE7C51}"/>
          </ac:spMkLst>
        </pc:spChg>
        <pc:spChg chg="mod">
          <ac:chgData name="HATANO MASAKI" userId="6e12ec381f1ebf76" providerId="LiveId" clId="{5CA12708-F39A-A448-8280-F66F43AA0882}" dt="2020-09-25T05:41:16.698" v="2" actId="2711"/>
          <ac:spMkLst>
            <pc:docMk/>
            <pc:sldMk cId="1280214885" sldId="263"/>
            <ac:spMk id="5" creationId="{3018848F-3A8A-496F-817A-7A6C5D0214E1}"/>
          </ac:spMkLst>
        </pc:spChg>
        <pc:spChg chg="mod">
          <ac:chgData name="HATANO MASAKI" userId="6e12ec381f1ebf76" providerId="LiveId" clId="{5CA12708-F39A-A448-8280-F66F43AA0882}" dt="2020-09-25T05:41:16.698" v="2" actId="2711"/>
          <ac:spMkLst>
            <pc:docMk/>
            <pc:sldMk cId="1280214885" sldId="263"/>
            <ac:spMk id="9" creationId="{F7840237-8C7E-44A9-8100-D04FE984B9B1}"/>
          </ac:spMkLst>
        </pc:spChg>
      </pc:sldChg>
      <pc:sldChg chg="modSp mod">
        <pc:chgData name="HATANO MASAKI" userId="6e12ec381f1ebf76" providerId="LiveId" clId="{5CA12708-F39A-A448-8280-F66F43AA0882}" dt="2020-09-25T05:41:24.036" v="3" actId="2711"/>
        <pc:sldMkLst>
          <pc:docMk/>
          <pc:sldMk cId="2311538212" sldId="264"/>
        </pc:sldMkLst>
        <pc:spChg chg="mod">
          <ac:chgData name="HATANO MASAKI" userId="6e12ec381f1ebf76" providerId="LiveId" clId="{5CA12708-F39A-A448-8280-F66F43AA0882}" dt="2020-09-25T05:41:24.036" v="3" actId="2711"/>
          <ac:spMkLst>
            <pc:docMk/>
            <pc:sldMk cId="2311538212" sldId="264"/>
            <ac:spMk id="2" creationId="{47E745B1-4A80-43D0-97CF-C6504DDE7C51}"/>
          </ac:spMkLst>
        </pc:spChg>
        <pc:spChg chg="mod">
          <ac:chgData name="HATANO MASAKI" userId="6e12ec381f1ebf76" providerId="LiveId" clId="{5CA12708-F39A-A448-8280-F66F43AA0882}" dt="2020-09-25T05:41:24.036" v="3" actId="2711"/>
          <ac:spMkLst>
            <pc:docMk/>
            <pc:sldMk cId="2311538212" sldId="264"/>
            <ac:spMk id="5" creationId="{3018848F-3A8A-496F-817A-7A6C5D0214E1}"/>
          </ac:spMkLst>
        </pc:spChg>
        <pc:spChg chg="mod">
          <ac:chgData name="HATANO MASAKI" userId="6e12ec381f1ebf76" providerId="LiveId" clId="{5CA12708-F39A-A448-8280-F66F43AA0882}" dt="2020-09-25T05:41:24.036" v="3" actId="2711"/>
          <ac:spMkLst>
            <pc:docMk/>
            <pc:sldMk cId="2311538212" sldId="264"/>
            <ac:spMk id="9" creationId="{F7840237-8C7E-44A9-8100-D04FE984B9B1}"/>
          </ac:spMkLst>
        </pc:spChg>
      </pc:sldChg>
      <pc:sldChg chg="modSp mod">
        <pc:chgData name="HATANO MASAKI" userId="6e12ec381f1ebf76" providerId="LiveId" clId="{5CA12708-F39A-A448-8280-F66F43AA0882}" dt="2020-09-25T05:41:30.453" v="4" actId="2711"/>
        <pc:sldMkLst>
          <pc:docMk/>
          <pc:sldMk cId="3619332507" sldId="265"/>
        </pc:sldMkLst>
        <pc:spChg chg="mod">
          <ac:chgData name="HATANO MASAKI" userId="6e12ec381f1ebf76" providerId="LiveId" clId="{5CA12708-F39A-A448-8280-F66F43AA0882}" dt="2020-09-25T05:41:30.453" v="4" actId="2711"/>
          <ac:spMkLst>
            <pc:docMk/>
            <pc:sldMk cId="3619332507" sldId="265"/>
            <ac:spMk id="2" creationId="{47E745B1-4A80-43D0-97CF-C6504DDE7C51}"/>
          </ac:spMkLst>
        </pc:spChg>
        <pc:spChg chg="mod">
          <ac:chgData name="HATANO MASAKI" userId="6e12ec381f1ebf76" providerId="LiveId" clId="{5CA12708-F39A-A448-8280-F66F43AA0882}" dt="2020-09-25T05:41:30.453" v="4" actId="2711"/>
          <ac:spMkLst>
            <pc:docMk/>
            <pc:sldMk cId="3619332507" sldId="265"/>
            <ac:spMk id="5" creationId="{3018848F-3A8A-496F-817A-7A6C5D0214E1}"/>
          </ac:spMkLst>
        </pc:spChg>
        <pc:spChg chg="mod">
          <ac:chgData name="HATANO MASAKI" userId="6e12ec381f1ebf76" providerId="LiveId" clId="{5CA12708-F39A-A448-8280-F66F43AA0882}" dt="2020-09-25T05:41:30.453" v="4" actId="2711"/>
          <ac:spMkLst>
            <pc:docMk/>
            <pc:sldMk cId="3619332507" sldId="265"/>
            <ac:spMk id="9" creationId="{F7840237-8C7E-44A9-8100-D04FE984B9B1}"/>
          </ac:spMkLst>
        </pc:spChg>
      </pc:sldChg>
      <pc:sldChg chg="modSp mod">
        <pc:chgData name="HATANO MASAKI" userId="6e12ec381f1ebf76" providerId="LiveId" clId="{5CA12708-F39A-A448-8280-F66F43AA0882}" dt="2020-09-25T05:41:44.357" v="6" actId="2711"/>
        <pc:sldMkLst>
          <pc:docMk/>
          <pc:sldMk cId="4117825274" sldId="266"/>
        </pc:sldMkLst>
        <pc:spChg chg="mod">
          <ac:chgData name="HATANO MASAKI" userId="6e12ec381f1ebf76" providerId="LiveId" clId="{5CA12708-F39A-A448-8280-F66F43AA0882}" dt="2020-09-25T05:41:44.357" v="6" actId="2711"/>
          <ac:spMkLst>
            <pc:docMk/>
            <pc:sldMk cId="4117825274" sldId="266"/>
            <ac:spMk id="2" creationId="{47E745B1-4A80-43D0-97CF-C6504DDE7C51}"/>
          </ac:spMkLst>
        </pc:spChg>
        <pc:spChg chg="mod">
          <ac:chgData name="HATANO MASAKI" userId="6e12ec381f1ebf76" providerId="LiveId" clId="{5CA12708-F39A-A448-8280-F66F43AA0882}" dt="2020-09-25T05:41:44.357" v="6" actId="2711"/>
          <ac:spMkLst>
            <pc:docMk/>
            <pc:sldMk cId="4117825274" sldId="266"/>
            <ac:spMk id="5" creationId="{3018848F-3A8A-496F-817A-7A6C5D0214E1}"/>
          </ac:spMkLst>
        </pc:spChg>
        <pc:spChg chg="mod">
          <ac:chgData name="HATANO MASAKI" userId="6e12ec381f1ebf76" providerId="LiveId" clId="{5CA12708-F39A-A448-8280-F66F43AA0882}" dt="2020-09-25T05:41:44.357" v="6" actId="2711"/>
          <ac:spMkLst>
            <pc:docMk/>
            <pc:sldMk cId="4117825274" sldId="266"/>
            <ac:spMk id="9" creationId="{F7840237-8C7E-44A9-8100-D04FE984B9B1}"/>
          </ac:spMkLst>
        </pc:spChg>
      </pc:sldChg>
      <pc:sldChg chg="modSp mod">
        <pc:chgData name="HATANO MASAKI" userId="6e12ec381f1ebf76" providerId="LiveId" clId="{5CA12708-F39A-A448-8280-F66F43AA0882}" dt="2020-09-25T05:42:53.945" v="58" actId="1038"/>
        <pc:sldMkLst>
          <pc:docMk/>
          <pc:sldMk cId="2265648155" sldId="279"/>
        </pc:sldMkLst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3" creationId="{1C2F6EB0-E90D-2F4C-A62C-C2EF5FA2D5CC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5" creationId="{845652A0-F8F1-D54D-B5A1-7A2244D543EB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6" creationId="{2E227BA7-563C-4448-B329-484E36D4183E}"/>
          </ac:spMkLst>
        </pc:spChg>
        <pc:spChg chg="mod">
          <ac:chgData name="HATANO MASAKI" userId="6e12ec381f1ebf76" providerId="LiveId" clId="{5CA12708-F39A-A448-8280-F66F43AA0882}" dt="2020-09-25T05:42:47.445" v="55" actId="1038"/>
          <ac:spMkLst>
            <pc:docMk/>
            <pc:sldMk cId="2265648155" sldId="279"/>
            <ac:spMk id="7" creationId="{2605F7A7-A1B5-AC4B-A604-C49849AF2379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10" creationId="{A3C13260-E995-A946-B85B-74DACD1CFA5B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28" creationId="{BB63BBF5-7826-A44B-ABF4-3AE79335558F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29" creationId="{ACEA2B39-7975-BA48-83EB-2464197B4C95}"/>
          </ac:spMkLst>
        </pc:spChg>
        <pc:spChg chg="mod">
          <ac:chgData name="HATANO MASAKI" userId="6e12ec381f1ebf76" providerId="LiveId" clId="{5CA12708-F39A-A448-8280-F66F43AA0882}" dt="2020-09-25T05:42:15.200" v="18" actId="1036"/>
          <ac:spMkLst>
            <pc:docMk/>
            <pc:sldMk cId="2265648155" sldId="279"/>
            <ac:spMk id="31" creationId="{D0E75FC6-8629-B347-86D3-A8FAF1BBA83E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34" creationId="{918B3030-A16F-7F47-AED1-2A27D020A570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35" creationId="{18ED0BE7-B2F4-374D-8777-9DAA87D87851}"/>
          </ac:spMkLst>
        </pc:spChg>
        <pc:spChg chg="mod">
          <ac:chgData name="HATANO MASAKI" userId="6e12ec381f1ebf76" providerId="LiveId" clId="{5CA12708-F39A-A448-8280-F66F43AA0882}" dt="2020-09-25T05:42:27.309" v="37" actId="1036"/>
          <ac:spMkLst>
            <pc:docMk/>
            <pc:sldMk cId="2265648155" sldId="279"/>
            <ac:spMk id="36" creationId="{73146EB4-8ED5-9542-AA8B-EC9C1A08FFB4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37" creationId="{1D80161F-879A-A746-A77D-D7286B20A418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38" creationId="{A4F37389-0E9A-4248-A563-D9F7983C3E93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39" creationId="{053F5F1C-2657-EB45-94EE-1A007F356690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40" creationId="{C9E64501-9A24-0E4A-AF76-6C392D8E2E7F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42" creationId="{FA87CF36-55B6-5840-BB33-6338F45FA924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45" creationId="{66B79B2F-F7DF-C746-AE08-5A6B47FE0CFC}"/>
          </ac:spMkLst>
        </pc:spChg>
        <pc:spChg chg="mod">
          <ac:chgData name="HATANO MASAKI" userId="6e12ec381f1ebf76" providerId="LiveId" clId="{5CA12708-F39A-A448-8280-F66F43AA0882}" dt="2020-09-25T05:42:20.656" v="27" actId="1036"/>
          <ac:spMkLst>
            <pc:docMk/>
            <pc:sldMk cId="2265648155" sldId="279"/>
            <ac:spMk id="49" creationId="{D5682F43-2C00-7749-BB83-2E468896F7BD}"/>
          </ac:spMkLst>
        </pc:spChg>
        <pc:spChg chg="mod">
          <ac:chgData name="HATANO MASAKI" userId="6e12ec381f1ebf76" providerId="LiveId" clId="{5CA12708-F39A-A448-8280-F66F43AA0882}" dt="2020-09-25T05:42:42.523" v="52" actId="1036"/>
          <ac:spMkLst>
            <pc:docMk/>
            <pc:sldMk cId="2265648155" sldId="279"/>
            <ac:spMk id="50" creationId="{FC6861E3-0BBE-E947-87FC-0FE4D37BF667}"/>
          </ac:spMkLst>
        </pc:spChg>
        <pc:spChg chg="mod">
          <ac:chgData name="HATANO MASAKI" userId="6e12ec381f1ebf76" providerId="LiveId" clId="{5CA12708-F39A-A448-8280-F66F43AA0882}" dt="2020-09-25T05:42:53.945" v="58" actId="1038"/>
          <ac:spMkLst>
            <pc:docMk/>
            <pc:sldMk cId="2265648155" sldId="279"/>
            <ac:spMk id="51" creationId="{B7349551-E639-5041-92FE-0F48DE608C4C}"/>
          </ac:spMkLst>
        </pc:spChg>
        <pc:spChg chg="mod">
          <ac:chgData name="HATANO MASAKI" userId="6e12ec381f1ebf76" providerId="LiveId" clId="{5CA12708-F39A-A448-8280-F66F43AA0882}" dt="2020-09-25T05:42:05.396" v="8" actId="2711"/>
          <ac:spMkLst>
            <pc:docMk/>
            <pc:sldMk cId="2265648155" sldId="279"/>
            <ac:spMk id="53" creationId="{D32731DB-9334-9940-A1DA-FDBAF0BC0656}"/>
          </ac:spMkLst>
        </pc:spChg>
        <pc:spChg chg="mod">
          <ac:chgData name="HATANO MASAKI" userId="6e12ec381f1ebf76" providerId="LiveId" clId="{5CA12708-F39A-A448-8280-F66F43AA0882}" dt="2020-09-25T05:42:34.549" v="42" actId="1038"/>
          <ac:spMkLst>
            <pc:docMk/>
            <pc:sldMk cId="2265648155" sldId="279"/>
            <ac:spMk id="54" creationId="{4C65C503-52B3-E646-852A-A079A34344BD}"/>
          </ac:spMkLst>
        </pc:spChg>
      </pc:sldChg>
      <pc:sldChg chg="modSp mod">
        <pc:chgData name="HATANO MASAKI" userId="6e12ec381f1ebf76" providerId="LiveId" clId="{5CA12708-F39A-A448-8280-F66F43AA0882}" dt="2020-09-25T05:41:52.304" v="7" actId="2711"/>
        <pc:sldMkLst>
          <pc:docMk/>
          <pc:sldMk cId="175394170" sldId="280"/>
        </pc:sldMkLst>
        <pc:spChg chg="mod">
          <ac:chgData name="HATANO MASAKI" userId="6e12ec381f1ebf76" providerId="LiveId" clId="{5CA12708-F39A-A448-8280-F66F43AA0882}" dt="2020-09-25T05:41:52.304" v="7" actId="2711"/>
          <ac:spMkLst>
            <pc:docMk/>
            <pc:sldMk cId="175394170" sldId="280"/>
            <ac:spMk id="2" creationId="{47E745B1-4A80-43D0-97CF-C6504DDE7C51}"/>
          </ac:spMkLst>
        </pc:spChg>
        <pc:spChg chg="mod">
          <ac:chgData name="HATANO MASAKI" userId="6e12ec381f1ebf76" providerId="LiveId" clId="{5CA12708-F39A-A448-8280-F66F43AA0882}" dt="2020-09-25T05:41:52.304" v="7" actId="2711"/>
          <ac:spMkLst>
            <pc:docMk/>
            <pc:sldMk cId="175394170" sldId="280"/>
            <ac:spMk id="5" creationId="{3018848F-3A8A-496F-817A-7A6C5D0214E1}"/>
          </ac:spMkLst>
        </pc:spChg>
        <pc:spChg chg="mod">
          <ac:chgData name="HATANO MASAKI" userId="6e12ec381f1ebf76" providerId="LiveId" clId="{5CA12708-F39A-A448-8280-F66F43AA0882}" dt="2020-09-25T05:41:52.304" v="7" actId="2711"/>
          <ac:spMkLst>
            <pc:docMk/>
            <pc:sldMk cId="175394170" sldId="280"/>
            <ac:spMk id="8" creationId="{79B06D53-AE17-4E26-BE9E-A17BFF47D9EC}"/>
          </ac:spMkLst>
        </pc:spChg>
        <pc:spChg chg="mod">
          <ac:chgData name="HATANO MASAKI" userId="6e12ec381f1ebf76" providerId="LiveId" clId="{5CA12708-F39A-A448-8280-F66F43AA0882}" dt="2020-09-25T05:41:52.304" v="7" actId="2711"/>
          <ac:spMkLst>
            <pc:docMk/>
            <pc:sldMk cId="175394170" sldId="280"/>
            <ac:spMk id="9" creationId="{F7840237-8C7E-44A9-8100-D04FE984B9B1}"/>
          </ac:spMkLst>
        </pc:spChg>
      </pc:sldChg>
      <pc:sldChg chg="modSp mod">
        <pc:chgData name="HATANO MASAKI" userId="6e12ec381f1ebf76" providerId="LiveId" clId="{5CA12708-F39A-A448-8280-F66F43AA0882}" dt="2020-09-25T05:43:03.131" v="59" actId="2711"/>
        <pc:sldMkLst>
          <pc:docMk/>
          <pc:sldMk cId="3244315699" sldId="281"/>
        </pc:sldMkLst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2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9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11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24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25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26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27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28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30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32" creationId="{D305F542-1C9E-824D-8DCC-E4BB7F5A3A73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38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39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40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41" creationId="{1DE3609F-1A89-5B49-85D7-78B4AA8502CE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43" creationId="{040379FE-DF5B-CD4E-BE1C-5A444BC1AE63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44" creationId="{FA30B3BF-A9EA-CF45-B4B1-1E3213F0AD5E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45" creationId="{56A51CDA-CBF4-9B42-85E9-5241D88BAA6A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51" creationId="{CE1F308D-B67F-0949-886E-3E007B28FD5E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52" creationId="{8715DAD6-C1E6-DC4E-BF8F-D73AEFF2C46A}"/>
          </ac:spMkLst>
        </pc:spChg>
        <pc:spChg chg="mod">
          <ac:chgData name="HATANO MASAKI" userId="6e12ec381f1ebf76" providerId="LiveId" clId="{5CA12708-F39A-A448-8280-F66F43AA0882}" dt="2020-09-25T05:43:03.131" v="59" actId="2711"/>
          <ac:spMkLst>
            <pc:docMk/>
            <pc:sldMk cId="3244315699" sldId="281"/>
            <ac:spMk id="53" creationId="{24AF6DBA-90DD-1A40-9B84-E1AE8606167F}"/>
          </ac:spMkLst>
        </pc:spChg>
      </pc:sldChg>
      <pc:sldChg chg="modSp mod">
        <pc:chgData name="HATANO MASAKI" userId="6e12ec381f1ebf76" providerId="LiveId" clId="{5CA12708-F39A-A448-8280-F66F43AA0882}" dt="2020-09-25T05:43:29.995" v="64" actId="1037"/>
        <pc:sldMkLst>
          <pc:docMk/>
          <pc:sldMk cId="3588872444" sldId="282"/>
        </pc:sldMkLst>
        <pc:spChg chg="mod">
          <ac:chgData name="HATANO MASAKI" userId="6e12ec381f1ebf76" providerId="LiveId" clId="{5CA12708-F39A-A448-8280-F66F43AA0882}" dt="2020-09-25T05:43:20.261" v="62" actId="1037"/>
          <ac:spMkLst>
            <pc:docMk/>
            <pc:sldMk cId="3588872444" sldId="282"/>
            <ac:spMk id="2" creationId="{C2B4D606-31ED-2D4B-A02E-1B716EA8E47A}"/>
          </ac:spMkLst>
        </pc:spChg>
        <pc:spChg chg="mod">
          <ac:chgData name="HATANO MASAKI" userId="6e12ec381f1ebf76" providerId="LiveId" clId="{5CA12708-F39A-A448-8280-F66F43AA0882}" dt="2020-09-25T05:43:16.476" v="60" actId="2711"/>
          <ac:spMkLst>
            <pc:docMk/>
            <pc:sldMk cId="3588872444" sldId="282"/>
            <ac:spMk id="7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16.476" v="60" actId="2711"/>
          <ac:spMkLst>
            <pc:docMk/>
            <pc:sldMk cId="3588872444" sldId="282"/>
            <ac:spMk id="15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16.476" v="60" actId="2711"/>
          <ac:spMkLst>
            <pc:docMk/>
            <pc:sldMk cId="3588872444" sldId="282"/>
            <ac:spMk id="44" creationId="{A9A39706-5730-C44E-BC02-5F55C414DCE7}"/>
          </ac:spMkLst>
        </pc:spChg>
        <pc:spChg chg="mod">
          <ac:chgData name="HATANO MASAKI" userId="6e12ec381f1ebf76" providerId="LiveId" clId="{5CA12708-F39A-A448-8280-F66F43AA0882}" dt="2020-09-25T05:43:16.476" v="60" actId="2711"/>
          <ac:spMkLst>
            <pc:docMk/>
            <pc:sldMk cId="3588872444" sldId="282"/>
            <ac:spMk id="46" creationId="{16004E84-495D-A044-A285-000129A4AA7E}"/>
          </ac:spMkLst>
        </pc:spChg>
        <pc:spChg chg="mod">
          <ac:chgData name="HATANO MASAKI" userId="6e12ec381f1ebf76" providerId="LiveId" clId="{5CA12708-F39A-A448-8280-F66F43AA0882}" dt="2020-09-25T05:43:16.476" v="60" actId="2711"/>
          <ac:spMkLst>
            <pc:docMk/>
            <pc:sldMk cId="3588872444" sldId="282"/>
            <ac:spMk id="49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16.476" v="60" actId="2711"/>
          <ac:spMkLst>
            <pc:docMk/>
            <pc:sldMk cId="3588872444" sldId="282"/>
            <ac:spMk id="50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29.995" v="64" actId="1037"/>
          <ac:spMkLst>
            <pc:docMk/>
            <pc:sldMk cId="3588872444" sldId="282"/>
            <ac:spMk id="59" creationId="{31FF7768-E4A4-2E49-A032-DA602315B67B}"/>
          </ac:spMkLst>
        </pc:spChg>
        <pc:spChg chg="mod">
          <ac:chgData name="HATANO MASAKI" userId="6e12ec381f1ebf76" providerId="LiveId" clId="{5CA12708-F39A-A448-8280-F66F43AA0882}" dt="2020-09-25T05:43:16.476" v="60" actId="2711"/>
          <ac:spMkLst>
            <pc:docMk/>
            <pc:sldMk cId="3588872444" sldId="282"/>
            <ac:spMk id="60" creationId="{E65C809A-3EFC-434F-9AFA-D96877FF512F}"/>
          </ac:spMkLst>
        </pc:spChg>
        <pc:spChg chg="mod">
          <ac:chgData name="HATANO MASAKI" userId="6e12ec381f1ebf76" providerId="LiveId" clId="{5CA12708-F39A-A448-8280-F66F43AA0882}" dt="2020-09-25T05:43:16.476" v="60" actId="2711"/>
          <ac:spMkLst>
            <pc:docMk/>
            <pc:sldMk cId="3588872444" sldId="282"/>
            <ac:spMk id="61" creationId="{EF966A40-7DDB-1247-A3FD-E774CA0C10EE}"/>
          </ac:spMkLst>
        </pc:spChg>
        <pc:spChg chg="mod">
          <ac:chgData name="HATANO MASAKI" userId="6e12ec381f1ebf76" providerId="LiveId" clId="{5CA12708-F39A-A448-8280-F66F43AA0882}" dt="2020-09-25T05:43:16.476" v="60" actId="2711"/>
          <ac:spMkLst>
            <pc:docMk/>
            <pc:sldMk cId="3588872444" sldId="282"/>
            <ac:spMk id="71" creationId="{6E90A854-9B37-1D45-B4DB-DBD9B43D5D95}"/>
          </ac:spMkLst>
        </pc:spChg>
      </pc:sldChg>
      <pc:sldChg chg="modSp mod">
        <pc:chgData name="HATANO MASAKI" userId="6e12ec381f1ebf76" providerId="LiveId" clId="{5CA12708-F39A-A448-8280-F66F43AA0882}" dt="2020-09-25T05:43:38.052" v="65" actId="2711"/>
        <pc:sldMkLst>
          <pc:docMk/>
          <pc:sldMk cId="731009805" sldId="283"/>
        </pc:sldMkLst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8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10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13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14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15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16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18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19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23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29" creationId="{00000000-0000-0000-0000-000000000000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32" creationId="{AE23FAC2-20FD-E94E-83AE-A5B2DE74BF65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34" creationId="{73875B6D-45CE-2C44-91E5-56D55E53B7B0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35" creationId="{C23BFF0D-9BAF-8649-A93F-D8DF18C173EF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38" creationId="{156EAB48-CA36-1644-844C-FE6B8F80AF46}"/>
          </ac:spMkLst>
        </pc:spChg>
        <pc:spChg chg="mod">
          <ac:chgData name="HATANO MASAKI" userId="6e12ec381f1ebf76" providerId="LiveId" clId="{5CA12708-F39A-A448-8280-F66F43AA0882}" dt="2020-09-25T05:43:38.052" v="65" actId="2711"/>
          <ac:spMkLst>
            <pc:docMk/>
            <pc:sldMk cId="731009805" sldId="283"/>
            <ac:spMk id="39" creationId="{B3173DC5-B476-3642-8BD0-0B5E519D1A5C}"/>
          </ac:spMkLst>
        </pc:spChg>
      </pc:sldChg>
    </pc:docChg>
  </pc:docChgLst>
  <pc:docChgLst>
    <pc:chgData name="HATANO MASAKI" userId="6e12ec381f1ebf76" providerId="LiveId" clId="{6EFB3291-DF96-D747-90C8-438749A88B6D}"/>
    <pc:docChg chg="custSel addSld delSld modSld">
      <pc:chgData name="HATANO MASAKI" userId="6e12ec381f1ebf76" providerId="LiveId" clId="{6EFB3291-DF96-D747-90C8-438749A88B6D}" dt="2020-08-06T05:33:17.692" v="177" actId="20577"/>
      <pc:docMkLst>
        <pc:docMk/>
      </pc:docMkLst>
      <pc:sldChg chg="del">
        <pc:chgData name="HATANO MASAKI" userId="6e12ec381f1ebf76" providerId="LiveId" clId="{6EFB3291-DF96-D747-90C8-438749A88B6D}" dt="2020-08-06T05:32:45.533" v="175" actId="2696"/>
        <pc:sldMkLst>
          <pc:docMk/>
          <pc:sldMk cId="4007352137" sldId="269"/>
        </pc:sldMkLst>
      </pc:sldChg>
      <pc:sldChg chg="del">
        <pc:chgData name="HATANO MASAKI" userId="6e12ec381f1ebf76" providerId="LiveId" clId="{6EFB3291-DF96-D747-90C8-438749A88B6D}" dt="2020-08-06T05:32:14.882" v="173" actId="2696"/>
        <pc:sldMkLst>
          <pc:docMk/>
          <pc:sldMk cId="331932687" sldId="276"/>
        </pc:sldMkLst>
      </pc:sldChg>
      <pc:sldChg chg="del">
        <pc:chgData name="HATANO MASAKI" userId="6e12ec381f1ebf76" providerId="LiveId" clId="{6EFB3291-DF96-D747-90C8-438749A88B6D}" dt="2020-08-06T05:31:25.533" v="171" actId="2696"/>
        <pc:sldMkLst>
          <pc:docMk/>
          <pc:sldMk cId="3559493455" sldId="278"/>
        </pc:sldMkLst>
      </pc:sldChg>
      <pc:sldChg chg="modSp mod">
        <pc:chgData name="HATANO MASAKI" userId="6e12ec381f1ebf76" providerId="LiveId" clId="{6EFB3291-DF96-D747-90C8-438749A88B6D}" dt="2020-08-06T05:28:19.599" v="114" actId="1038"/>
        <pc:sldMkLst>
          <pc:docMk/>
          <pc:sldMk cId="2265648155" sldId="279"/>
        </pc:sldMkLst>
        <pc:spChg chg="mod">
          <ac:chgData name="HATANO MASAKI" userId="6e12ec381f1ebf76" providerId="LiveId" clId="{6EFB3291-DF96-D747-90C8-438749A88B6D}" dt="2020-08-06T05:26:45.248" v="6" actId="2711"/>
          <ac:spMkLst>
            <pc:docMk/>
            <pc:sldMk cId="2265648155" sldId="279"/>
            <ac:spMk id="3" creationId="{1C2F6EB0-E90D-2F4C-A62C-C2EF5FA2D5CC}"/>
          </ac:spMkLst>
        </pc:spChg>
        <pc:spChg chg="mod">
          <ac:chgData name="HATANO MASAKI" userId="6e12ec381f1ebf76" providerId="LiveId" clId="{6EFB3291-DF96-D747-90C8-438749A88B6D}" dt="2020-08-06T05:26:45.248" v="6" actId="2711"/>
          <ac:spMkLst>
            <pc:docMk/>
            <pc:sldMk cId="2265648155" sldId="279"/>
            <ac:spMk id="5" creationId="{845652A0-F8F1-D54D-B5A1-7A2244D543EB}"/>
          </ac:spMkLst>
        </pc:spChg>
        <pc:spChg chg="mod">
          <ac:chgData name="HATANO MASAKI" userId="6e12ec381f1ebf76" providerId="LiveId" clId="{6EFB3291-DF96-D747-90C8-438749A88B6D}" dt="2020-08-06T05:26:45.248" v="6" actId="2711"/>
          <ac:spMkLst>
            <pc:docMk/>
            <pc:sldMk cId="2265648155" sldId="279"/>
            <ac:spMk id="6" creationId="{2E227BA7-563C-4448-B329-484E36D4183E}"/>
          </ac:spMkLst>
        </pc:spChg>
        <pc:spChg chg="mod">
          <ac:chgData name="HATANO MASAKI" userId="6e12ec381f1ebf76" providerId="LiveId" clId="{6EFB3291-DF96-D747-90C8-438749A88B6D}" dt="2020-08-06T05:26:45.248" v="6" actId="2711"/>
          <ac:spMkLst>
            <pc:docMk/>
            <pc:sldMk cId="2265648155" sldId="279"/>
            <ac:spMk id="7" creationId="{2605F7A7-A1B5-AC4B-A604-C49849AF2379}"/>
          </ac:spMkLst>
        </pc:spChg>
        <pc:spChg chg="mod">
          <ac:chgData name="HATANO MASAKI" userId="6e12ec381f1ebf76" providerId="LiveId" clId="{6EFB3291-DF96-D747-90C8-438749A88B6D}" dt="2020-08-06T05:26:54.957" v="7" actId="14100"/>
          <ac:spMkLst>
            <pc:docMk/>
            <pc:sldMk cId="2265648155" sldId="279"/>
            <ac:spMk id="10" creationId="{A3C13260-E995-A946-B85B-74DACD1CFA5B}"/>
          </ac:spMkLst>
        </pc:spChg>
        <pc:spChg chg="mod">
          <ac:chgData name="HATANO MASAKI" userId="6e12ec381f1ebf76" providerId="LiveId" clId="{6EFB3291-DF96-D747-90C8-438749A88B6D}" dt="2020-08-06T05:26:45.248" v="6" actId="2711"/>
          <ac:spMkLst>
            <pc:docMk/>
            <pc:sldMk cId="2265648155" sldId="279"/>
            <ac:spMk id="28" creationId="{BB63BBF5-7826-A44B-ABF4-3AE79335558F}"/>
          </ac:spMkLst>
        </pc:spChg>
        <pc:spChg chg="mod">
          <ac:chgData name="HATANO MASAKI" userId="6e12ec381f1ebf76" providerId="LiveId" clId="{6EFB3291-DF96-D747-90C8-438749A88B6D}" dt="2020-08-06T05:26:58.715" v="8" actId="14100"/>
          <ac:spMkLst>
            <pc:docMk/>
            <pc:sldMk cId="2265648155" sldId="279"/>
            <ac:spMk id="29" creationId="{ACEA2B39-7975-BA48-83EB-2464197B4C95}"/>
          </ac:spMkLst>
        </pc:spChg>
        <pc:spChg chg="mod">
          <ac:chgData name="HATANO MASAKI" userId="6e12ec381f1ebf76" providerId="LiveId" clId="{6EFB3291-DF96-D747-90C8-438749A88B6D}" dt="2020-08-06T05:27:56.576" v="96" actId="1036"/>
          <ac:spMkLst>
            <pc:docMk/>
            <pc:sldMk cId="2265648155" sldId="279"/>
            <ac:spMk id="31" creationId="{D0E75FC6-8629-B347-86D3-A8FAF1BBA83E}"/>
          </ac:spMkLst>
        </pc:spChg>
        <pc:spChg chg="mod">
          <ac:chgData name="HATANO MASAKI" userId="6e12ec381f1ebf76" providerId="LiveId" clId="{6EFB3291-DF96-D747-90C8-438749A88B6D}" dt="2020-08-06T05:26:45.248" v="6" actId="2711"/>
          <ac:spMkLst>
            <pc:docMk/>
            <pc:sldMk cId="2265648155" sldId="279"/>
            <ac:spMk id="34" creationId="{918B3030-A16F-7F47-AED1-2A27D020A570}"/>
          </ac:spMkLst>
        </pc:spChg>
        <pc:spChg chg="mod">
          <ac:chgData name="HATANO MASAKI" userId="6e12ec381f1ebf76" providerId="LiveId" clId="{6EFB3291-DF96-D747-90C8-438749A88B6D}" dt="2020-08-06T05:26:45.248" v="6" actId="2711"/>
          <ac:spMkLst>
            <pc:docMk/>
            <pc:sldMk cId="2265648155" sldId="279"/>
            <ac:spMk id="35" creationId="{18ED0BE7-B2F4-374D-8777-9DAA87D87851}"/>
          </ac:spMkLst>
        </pc:spChg>
        <pc:spChg chg="mod">
          <ac:chgData name="HATANO MASAKI" userId="6e12ec381f1ebf76" providerId="LiveId" clId="{6EFB3291-DF96-D747-90C8-438749A88B6D}" dt="2020-08-06T05:28:08.540" v="108" actId="1036"/>
          <ac:spMkLst>
            <pc:docMk/>
            <pc:sldMk cId="2265648155" sldId="279"/>
            <ac:spMk id="36" creationId="{73146EB4-8ED5-9542-AA8B-EC9C1A08FFB4}"/>
          </ac:spMkLst>
        </pc:spChg>
        <pc:spChg chg="mod">
          <ac:chgData name="HATANO MASAKI" userId="6e12ec381f1ebf76" providerId="LiveId" clId="{6EFB3291-DF96-D747-90C8-438749A88B6D}" dt="2020-08-06T05:27:17.282" v="55" actId="1038"/>
          <ac:spMkLst>
            <pc:docMk/>
            <pc:sldMk cId="2265648155" sldId="279"/>
            <ac:spMk id="37" creationId="{1D80161F-879A-A746-A77D-D7286B20A418}"/>
          </ac:spMkLst>
        </pc:spChg>
        <pc:spChg chg="mod">
          <ac:chgData name="HATANO MASAKI" userId="6e12ec381f1ebf76" providerId="LiveId" clId="{6EFB3291-DF96-D747-90C8-438749A88B6D}" dt="2020-08-06T05:26:45.248" v="6" actId="2711"/>
          <ac:spMkLst>
            <pc:docMk/>
            <pc:sldMk cId="2265648155" sldId="279"/>
            <ac:spMk id="38" creationId="{A4F37389-0E9A-4248-A563-D9F7983C3E93}"/>
          </ac:spMkLst>
        </pc:spChg>
        <pc:spChg chg="mod">
          <ac:chgData name="HATANO MASAKI" userId="6e12ec381f1ebf76" providerId="LiveId" clId="{6EFB3291-DF96-D747-90C8-438749A88B6D}" dt="2020-08-06T05:26:45.248" v="6" actId="2711"/>
          <ac:spMkLst>
            <pc:docMk/>
            <pc:sldMk cId="2265648155" sldId="279"/>
            <ac:spMk id="39" creationId="{053F5F1C-2657-EB45-94EE-1A007F356690}"/>
          </ac:spMkLst>
        </pc:spChg>
        <pc:spChg chg="mod">
          <ac:chgData name="HATANO MASAKI" userId="6e12ec381f1ebf76" providerId="LiveId" clId="{6EFB3291-DF96-D747-90C8-438749A88B6D}" dt="2020-08-06T05:27:22.854" v="68" actId="1037"/>
          <ac:spMkLst>
            <pc:docMk/>
            <pc:sldMk cId="2265648155" sldId="279"/>
            <ac:spMk id="40" creationId="{C9E64501-9A24-0E4A-AF76-6C392D8E2E7F}"/>
          </ac:spMkLst>
        </pc:spChg>
        <pc:spChg chg="mod">
          <ac:chgData name="HATANO MASAKI" userId="6e12ec381f1ebf76" providerId="LiveId" clId="{6EFB3291-DF96-D747-90C8-438749A88B6D}" dt="2020-08-06T05:26:45.248" v="6" actId="2711"/>
          <ac:spMkLst>
            <pc:docMk/>
            <pc:sldMk cId="2265648155" sldId="279"/>
            <ac:spMk id="42" creationId="{FA87CF36-55B6-5840-BB33-6338F45FA924}"/>
          </ac:spMkLst>
        </pc:spChg>
        <pc:spChg chg="mod">
          <ac:chgData name="HATANO MASAKI" userId="6e12ec381f1ebf76" providerId="LiveId" clId="{6EFB3291-DF96-D747-90C8-438749A88B6D}" dt="2020-08-06T05:27:10.469" v="44" actId="1037"/>
          <ac:spMkLst>
            <pc:docMk/>
            <pc:sldMk cId="2265648155" sldId="279"/>
            <ac:spMk id="45" creationId="{66B79B2F-F7DF-C746-AE08-5A6B47FE0CFC}"/>
          </ac:spMkLst>
        </pc:spChg>
        <pc:spChg chg="mod">
          <ac:chgData name="HATANO MASAKI" userId="6e12ec381f1ebf76" providerId="LiveId" clId="{6EFB3291-DF96-D747-90C8-438749A88B6D}" dt="2020-08-06T05:27:50.298" v="92" actId="1037"/>
          <ac:spMkLst>
            <pc:docMk/>
            <pc:sldMk cId="2265648155" sldId="279"/>
            <ac:spMk id="49" creationId="{D5682F43-2C00-7749-BB83-2E468896F7BD}"/>
          </ac:spMkLst>
        </pc:spChg>
        <pc:spChg chg="mod">
          <ac:chgData name="HATANO MASAKI" userId="6e12ec381f1ebf76" providerId="LiveId" clId="{6EFB3291-DF96-D747-90C8-438749A88B6D}" dt="2020-08-06T05:28:19.599" v="114" actId="1038"/>
          <ac:spMkLst>
            <pc:docMk/>
            <pc:sldMk cId="2265648155" sldId="279"/>
            <ac:spMk id="50" creationId="{FC6861E3-0BBE-E947-87FC-0FE4D37BF667}"/>
          </ac:spMkLst>
        </pc:spChg>
        <pc:spChg chg="mod">
          <ac:chgData name="HATANO MASAKI" userId="6e12ec381f1ebf76" providerId="LiveId" clId="{6EFB3291-DF96-D747-90C8-438749A88B6D}" dt="2020-08-06T05:26:45.248" v="6" actId="2711"/>
          <ac:spMkLst>
            <pc:docMk/>
            <pc:sldMk cId="2265648155" sldId="279"/>
            <ac:spMk id="51" creationId="{B7349551-E639-5041-92FE-0F48DE608C4C}"/>
          </ac:spMkLst>
        </pc:spChg>
        <pc:spChg chg="mod">
          <ac:chgData name="HATANO MASAKI" userId="6e12ec381f1ebf76" providerId="LiveId" clId="{6EFB3291-DF96-D747-90C8-438749A88B6D}" dt="2020-08-06T05:26:45.248" v="6" actId="2711"/>
          <ac:spMkLst>
            <pc:docMk/>
            <pc:sldMk cId="2265648155" sldId="279"/>
            <ac:spMk id="53" creationId="{D32731DB-9334-9940-A1DA-FDBAF0BC0656}"/>
          </ac:spMkLst>
        </pc:spChg>
        <pc:spChg chg="mod">
          <ac:chgData name="HATANO MASAKI" userId="6e12ec381f1ebf76" providerId="LiveId" clId="{6EFB3291-DF96-D747-90C8-438749A88B6D}" dt="2020-08-06T05:26:45.248" v="6" actId="2711"/>
          <ac:spMkLst>
            <pc:docMk/>
            <pc:sldMk cId="2265648155" sldId="279"/>
            <ac:spMk id="54" creationId="{4C65C503-52B3-E646-852A-A079A34344BD}"/>
          </ac:spMkLst>
        </pc:spChg>
      </pc:sldChg>
      <pc:sldChg chg="delSp modSp add mod">
        <pc:chgData name="HATANO MASAKI" userId="6e12ec381f1ebf76" providerId="LiveId" clId="{6EFB3291-DF96-D747-90C8-438749A88B6D}" dt="2020-08-06T05:25:10.891" v="4" actId="478"/>
        <pc:sldMkLst>
          <pc:docMk/>
          <pc:sldMk cId="175394170" sldId="280"/>
        </pc:sldMkLst>
        <pc:spChg chg="mod">
          <ac:chgData name="HATANO MASAKI" userId="6e12ec381f1ebf76" providerId="LiveId" clId="{6EFB3291-DF96-D747-90C8-438749A88B6D}" dt="2020-08-06T05:25:07.002" v="2" actId="20577"/>
          <ac:spMkLst>
            <pc:docMk/>
            <pc:sldMk cId="175394170" sldId="280"/>
            <ac:spMk id="5" creationId="{3018848F-3A8A-496F-817A-7A6C5D0214E1}"/>
          </ac:spMkLst>
        </pc:spChg>
        <pc:picChg chg="del">
          <ac:chgData name="HATANO MASAKI" userId="6e12ec381f1ebf76" providerId="LiveId" clId="{6EFB3291-DF96-D747-90C8-438749A88B6D}" dt="2020-08-06T05:25:09.965" v="3" actId="478"/>
          <ac:picMkLst>
            <pc:docMk/>
            <pc:sldMk cId="175394170" sldId="280"/>
            <ac:picMk id="6" creationId="{3AF41496-CE4D-482C-9949-A2B41015B3CC}"/>
          </ac:picMkLst>
        </pc:picChg>
        <pc:picChg chg="del">
          <ac:chgData name="HATANO MASAKI" userId="6e12ec381f1ebf76" providerId="LiveId" clId="{6EFB3291-DF96-D747-90C8-438749A88B6D}" dt="2020-08-06T05:25:10.891" v="4" actId="478"/>
          <ac:picMkLst>
            <pc:docMk/>
            <pc:sldMk cId="175394170" sldId="280"/>
            <ac:picMk id="7" creationId="{955DC52C-7E44-4C3B-B3BC-B3D4C6C8DD7B}"/>
          </ac:picMkLst>
        </pc:picChg>
      </pc:sldChg>
      <pc:sldChg chg="modSp add mod modNotesTx">
        <pc:chgData name="HATANO MASAKI" userId="6e12ec381f1ebf76" providerId="LiveId" clId="{6EFB3291-DF96-D747-90C8-438749A88B6D}" dt="2020-08-06T05:33:10.134" v="176" actId="20577"/>
        <pc:sldMkLst>
          <pc:docMk/>
          <pc:sldMk cId="3244315699" sldId="281"/>
        </pc:sldMkLst>
        <pc:spChg chg="mod">
          <ac:chgData name="HATANO MASAKI" userId="6e12ec381f1ebf76" providerId="LiveId" clId="{6EFB3291-DF96-D747-90C8-438749A88B6D}" dt="2020-08-06T05:30:44.979" v="147" actId="1037"/>
          <ac:spMkLst>
            <pc:docMk/>
            <pc:sldMk cId="3244315699" sldId="281"/>
            <ac:spMk id="30" creationId="{00000000-0000-0000-0000-000000000000}"/>
          </ac:spMkLst>
        </pc:spChg>
        <pc:spChg chg="mod">
          <ac:chgData name="HATANO MASAKI" userId="6e12ec381f1ebf76" providerId="LiveId" clId="{6EFB3291-DF96-D747-90C8-438749A88B6D}" dt="2020-08-06T05:30:55.807" v="170" actId="1038"/>
          <ac:spMkLst>
            <pc:docMk/>
            <pc:sldMk cId="3244315699" sldId="281"/>
            <ac:spMk id="38" creationId="{00000000-0000-0000-0000-000000000000}"/>
          </ac:spMkLst>
        </pc:spChg>
        <pc:spChg chg="mod">
          <ac:chgData name="HATANO MASAKI" userId="6e12ec381f1ebf76" providerId="LiveId" clId="{6EFB3291-DF96-D747-90C8-438749A88B6D}" dt="2020-08-06T05:30:33.485" v="130" actId="1037"/>
          <ac:spMkLst>
            <pc:docMk/>
            <pc:sldMk cId="3244315699" sldId="281"/>
            <ac:spMk id="39" creationId="{00000000-0000-0000-0000-000000000000}"/>
          </ac:spMkLst>
        </pc:spChg>
        <pc:spChg chg="mod">
          <ac:chgData name="HATANO MASAKI" userId="6e12ec381f1ebf76" providerId="LiveId" clId="{6EFB3291-DF96-D747-90C8-438749A88B6D}" dt="2020-08-06T05:30:27.519" v="116" actId="1037"/>
          <ac:spMkLst>
            <pc:docMk/>
            <pc:sldMk cId="3244315699" sldId="281"/>
            <ac:spMk id="41" creationId="{1DE3609F-1A89-5B49-85D7-78B4AA8502CE}"/>
          </ac:spMkLst>
        </pc:spChg>
        <pc:picChg chg="mod">
          <ac:chgData name="HATANO MASAKI" userId="6e12ec381f1ebf76" providerId="LiveId" clId="{6EFB3291-DF96-D747-90C8-438749A88B6D}" dt="2020-08-06T05:30:37.287" v="132" actId="1038"/>
          <ac:picMkLst>
            <pc:docMk/>
            <pc:sldMk cId="3244315699" sldId="281"/>
            <ac:picMk id="3" creationId="{00000000-0000-0000-0000-000000000000}"/>
          </ac:picMkLst>
        </pc:picChg>
      </pc:sldChg>
      <pc:sldChg chg="add">
        <pc:chgData name="HATANO MASAKI" userId="6e12ec381f1ebf76" providerId="LiveId" clId="{6EFB3291-DF96-D747-90C8-438749A88B6D}" dt="2020-08-06T05:31:39.867" v="172"/>
        <pc:sldMkLst>
          <pc:docMk/>
          <pc:sldMk cId="3588872444" sldId="282"/>
        </pc:sldMkLst>
      </pc:sldChg>
      <pc:sldChg chg="add modNotesTx">
        <pc:chgData name="HATANO MASAKI" userId="6e12ec381f1ebf76" providerId="LiveId" clId="{6EFB3291-DF96-D747-90C8-438749A88B6D}" dt="2020-08-06T05:33:17.692" v="177" actId="20577"/>
        <pc:sldMkLst>
          <pc:docMk/>
          <pc:sldMk cId="731009805" sldId="283"/>
        </pc:sldMkLst>
      </pc:sldChg>
    </pc:docChg>
  </pc:docChgLst>
  <pc:docChgLst>
    <pc:chgData name="HATANO MASAKI" userId="6e12ec381f1ebf76" providerId="LiveId" clId="{35F8FEFF-B0C0-FA41-AD12-AB2FA826A491}"/>
    <pc:docChg chg="custSel delSld modSld">
      <pc:chgData name="HATANO MASAKI" userId="6e12ec381f1ebf76" providerId="LiveId" clId="{35F8FEFF-B0C0-FA41-AD12-AB2FA826A491}" dt="2020-09-25T15:46:45.224" v="15" actId="20577"/>
      <pc:docMkLst>
        <pc:docMk/>
      </pc:docMkLst>
      <pc:sldChg chg="del">
        <pc:chgData name="HATANO MASAKI" userId="6e12ec381f1ebf76" providerId="LiveId" clId="{35F8FEFF-B0C0-FA41-AD12-AB2FA826A491}" dt="2020-09-25T15:45:06.813" v="0" actId="2696"/>
        <pc:sldMkLst>
          <pc:docMk/>
          <pc:sldMk cId="3083337674" sldId="261"/>
        </pc:sldMkLst>
      </pc:sldChg>
      <pc:sldChg chg="del">
        <pc:chgData name="HATANO MASAKI" userId="6e12ec381f1ebf76" providerId="LiveId" clId="{35F8FEFF-B0C0-FA41-AD12-AB2FA826A491}" dt="2020-09-25T15:45:07.135" v="1" actId="2696"/>
        <pc:sldMkLst>
          <pc:docMk/>
          <pc:sldMk cId="962339529" sldId="262"/>
        </pc:sldMkLst>
      </pc:sldChg>
      <pc:sldChg chg="del">
        <pc:chgData name="HATANO MASAKI" userId="6e12ec381f1ebf76" providerId="LiveId" clId="{35F8FEFF-B0C0-FA41-AD12-AB2FA826A491}" dt="2020-09-25T15:45:07.390" v="2" actId="2696"/>
        <pc:sldMkLst>
          <pc:docMk/>
          <pc:sldMk cId="1280214885" sldId="263"/>
        </pc:sldMkLst>
      </pc:sldChg>
      <pc:sldChg chg="del">
        <pc:chgData name="HATANO MASAKI" userId="6e12ec381f1ebf76" providerId="LiveId" clId="{35F8FEFF-B0C0-FA41-AD12-AB2FA826A491}" dt="2020-09-25T15:45:07.650" v="3" actId="2696"/>
        <pc:sldMkLst>
          <pc:docMk/>
          <pc:sldMk cId="2311538212" sldId="264"/>
        </pc:sldMkLst>
      </pc:sldChg>
      <pc:sldChg chg="del">
        <pc:chgData name="HATANO MASAKI" userId="6e12ec381f1ebf76" providerId="LiveId" clId="{35F8FEFF-B0C0-FA41-AD12-AB2FA826A491}" dt="2020-09-25T15:45:08.037" v="4" actId="2696"/>
        <pc:sldMkLst>
          <pc:docMk/>
          <pc:sldMk cId="3619332507" sldId="265"/>
        </pc:sldMkLst>
      </pc:sldChg>
      <pc:sldChg chg="del">
        <pc:chgData name="HATANO MASAKI" userId="6e12ec381f1ebf76" providerId="LiveId" clId="{35F8FEFF-B0C0-FA41-AD12-AB2FA826A491}" dt="2020-09-25T15:45:08.261" v="5" actId="2696"/>
        <pc:sldMkLst>
          <pc:docMk/>
          <pc:sldMk cId="4117825274" sldId="266"/>
        </pc:sldMkLst>
      </pc:sldChg>
      <pc:sldChg chg="del">
        <pc:chgData name="HATANO MASAKI" userId="6e12ec381f1ebf76" providerId="LiveId" clId="{35F8FEFF-B0C0-FA41-AD12-AB2FA826A491}" dt="2020-09-25T15:45:10.057" v="7" actId="2696"/>
        <pc:sldMkLst>
          <pc:docMk/>
          <pc:sldMk cId="2265648155" sldId="279"/>
        </pc:sldMkLst>
      </pc:sldChg>
      <pc:sldChg chg="del">
        <pc:chgData name="HATANO MASAKI" userId="6e12ec381f1ebf76" providerId="LiveId" clId="{35F8FEFF-B0C0-FA41-AD12-AB2FA826A491}" dt="2020-09-25T15:45:09.240" v="6" actId="2696"/>
        <pc:sldMkLst>
          <pc:docMk/>
          <pc:sldMk cId="175394170" sldId="280"/>
        </pc:sldMkLst>
      </pc:sldChg>
      <pc:sldChg chg="del">
        <pc:chgData name="HATANO MASAKI" userId="6e12ec381f1ebf76" providerId="LiveId" clId="{35F8FEFF-B0C0-FA41-AD12-AB2FA826A491}" dt="2020-09-25T15:45:10.982" v="8" actId="2696"/>
        <pc:sldMkLst>
          <pc:docMk/>
          <pc:sldMk cId="3244315699" sldId="281"/>
        </pc:sldMkLst>
      </pc:sldChg>
      <pc:sldChg chg="delSp mod modNotesTx">
        <pc:chgData name="HATANO MASAKI" userId="6e12ec381f1ebf76" providerId="LiveId" clId="{35F8FEFF-B0C0-FA41-AD12-AB2FA826A491}" dt="2020-09-25T15:46:45.224" v="15" actId="20577"/>
        <pc:sldMkLst>
          <pc:docMk/>
          <pc:sldMk cId="3588872444" sldId="282"/>
        </pc:sldMkLst>
        <pc:spChg chg="del">
          <ac:chgData name="HATANO MASAKI" userId="6e12ec381f1ebf76" providerId="LiveId" clId="{35F8FEFF-B0C0-FA41-AD12-AB2FA826A491}" dt="2020-09-25T15:46:30.122" v="9" actId="478"/>
          <ac:spMkLst>
            <pc:docMk/>
            <pc:sldMk cId="3588872444" sldId="282"/>
            <ac:spMk id="71" creationId="{6E90A854-9B37-1D45-B4DB-DBD9B43D5D95}"/>
          </ac:spMkLst>
        </pc:spChg>
      </pc:sldChg>
      <pc:sldChg chg="delSp mod modNotesTx">
        <pc:chgData name="HATANO MASAKI" userId="6e12ec381f1ebf76" providerId="LiveId" clId="{35F8FEFF-B0C0-FA41-AD12-AB2FA826A491}" dt="2020-09-25T15:46:40.387" v="13" actId="20577"/>
        <pc:sldMkLst>
          <pc:docMk/>
          <pc:sldMk cId="731009805" sldId="283"/>
        </pc:sldMkLst>
        <pc:spChg chg="del">
          <ac:chgData name="HATANO MASAKI" userId="6e12ec381f1ebf76" providerId="LiveId" clId="{35F8FEFF-B0C0-FA41-AD12-AB2FA826A491}" dt="2020-09-25T15:46:33.876" v="10" actId="478"/>
          <ac:spMkLst>
            <pc:docMk/>
            <pc:sldMk cId="731009805" sldId="283"/>
            <ac:spMk id="32" creationId="{AE23FAC2-20FD-E94E-83AE-A5B2DE74BF65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BAA3D1-1CB1-D749-9DB0-DF98F72C4041}" type="datetimeFigureOut">
              <a:rPr kumimoji="1" lang="ja-JP" altLang="en-US" smtClean="0"/>
              <a:t>2020/9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8F8006-F627-2947-885A-D92EA9121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01093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1</a:t>
            </a:r>
            <a:r>
              <a:rPr kumimoji="1" lang="en-US" altLang="ja-JP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liac trabecular bone section, osteoblasts with cuboidal cytoplasm (red arrows). Analysis of the 2</a:t>
            </a:r>
            <a:r>
              <a:rPr kumimoji="1" lang="en-US" altLang="ja-JP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d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liac trabecular bone section, osteoblasts with flattened cytoplasm (blue arrows).</a:t>
            </a:r>
            <a:r>
              <a:rPr lang="ja-JP" altLang="ja-JP">
                <a:effectLst/>
              </a:rPr>
              <a:t> </a:t>
            </a:r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9E4A41-C8B2-4A96-9C79-9E6A7F42465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76626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1</a:t>
            </a:r>
            <a:r>
              <a:rPr kumimoji="1" lang="en-US" altLang="ja-JP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liac trabecular bone section, multinucleated osteoclasts, that assisted in breaking down bone in the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owship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acuna. Analysis of the 2</a:t>
            </a:r>
            <a:r>
              <a:rPr kumimoji="1" lang="en-US" altLang="ja-JP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d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liac trabecular bone section with a decrease in multinucleated osteoclasts and a small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owship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acuna, compared with first biopsy.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kumimoji="1" lang="ja-JP" altLang="ja-JP" sz="1200" kern="120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9E4A41-C8B2-4A96-9C79-9E6A7F424654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12970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38608-7FEA-A54D-BDE2-98A5AB808AE1}" type="datetimeFigureOut">
              <a:rPr kumimoji="1" lang="ja-JP" altLang="en-US" smtClean="0"/>
              <a:t>2020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E18FD-87DD-2347-B59C-7A6192D5DE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7649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38608-7FEA-A54D-BDE2-98A5AB808AE1}" type="datetimeFigureOut">
              <a:rPr kumimoji="1" lang="ja-JP" altLang="en-US" smtClean="0"/>
              <a:t>2020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E18FD-87DD-2347-B59C-7A6192D5DE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8761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38608-7FEA-A54D-BDE2-98A5AB808AE1}" type="datetimeFigureOut">
              <a:rPr kumimoji="1" lang="ja-JP" altLang="en-US" smtClean="0"/>
              <a:t>2020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E18FD-87DD-2347-B59C-7A6192D5DE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2041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38608-7FEA-A54D-BDE2-98A5AB808AE1}" type="datetimeFigureOut">
              <a:rPr kumimoji="1" lang="ja-JP" altLang="en-US" smtClean="0"/>
              <a:t>2020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E18FD-87DD-2347-B59C-7A6192D5DE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4434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38608-7FEA-A54D-BDE2-98A5AB808AE1}" type="datetimeFigureOut">
              <a:rPr kumimoji="1" lang="ja-JP" altLang="en-US" smtClean="0"/>
              <a:t>2020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E18FD-87DD-2347-B59C-7A6192D5DE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599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38608-7FEA-A54D-BDE2-98A5AB808AE1}" type="datetimeFigureOut">
              <a:rPr kumimoji="1" lang="ja-JP" altLang="en-US" smtClean="0"/>
              <a:t>2020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E18FD-87DD-2347-B59C-7A6192D5DE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1019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38608-7FEA-A54D-BDE2-98A5AB808AE1}" type="datetimeFigureOut">
              <a:rPr kumimoji="1" lang="ja-JP" altLang="en-US" smtClean="0"/>
              <a:t>2020/9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E18FD-87DD-2347-B59C-7A6192D5DE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5062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38608-7FEA-A54D-BDE2-98A5AB808AE1}" type="datetimeFigureOut">
              <a:rPr kumimoji="1" lang="ja-JP" altLang="en-US" smtClean="0"/>
              <a:t>2020/9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E18FD-87DD-2347-B59C-7A6192D5DE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111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38608-7FEA-A54D-BDE2-98A5AB808AE1}" type="datetimeFigureOut">
              <a:rPr kumimoji="1" lang="ja-JP" altLang="en-US" smtClean="0"/>
              <a:t>2020/9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E18FD-87DD-2347-B59C-7A6192D5DE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119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38608-7FEA-A54D-BDE2-98A5AB808AE1}" type="datetimeFigureOut">
              <a:rPr kumimoji="1" lang="ja-JP" altLang="en-US" smtClean="0"/>
              <a:t>2020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E18FD-87DD-2347-B59C-7A6192D5DE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672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38608-7FEA-A54D-BDE2-98A5AB808AE1}" type="datetimeFigureOut">
              <a:rPr kumimoji="1" lang="ja-JP" altLang="en-US" smtClean="0"/>
              <a:t>2020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8E18FD-87DD-2347-B59C-7A6192D5DE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3675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438608-7FEA-A54D-BDE2-98A5AB808AE1}" type="datetimeFigureOut">
              <a:rPr kumimoji="1" lang="ja-JP" altLang="en-US" smtClean="0"/>
              <a:t>2020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8E18FD-87DD-2347-B59C-7A6192D5DE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3846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図 54">
            <a:extLst>
              <a:ext uri="{FF2B5EF4-FFF2-40B4-BE49-F238E27FC236}">
                <a16:creationId xmlns:a16="http://schemas.microsoft.com/office/drawing/2014/main" id="{BA7B0559-920E-4C19-98CF-B210F488F2F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74541"/>
            <a:ext cx="4255396" cy="3204063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BC8FB03C-FC1C-4B11-A442-3501D81ABD0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1438" y="3329260"/>
            <a:ext cx="4255396" cy="3204063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63" y="74541"/>
            <a:ext cx="4255396" cy="3204063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63" y="3329260"/>
            <a:ext cx="4255396" cy="3204063"/>
          </a:xfrm>
          <a:prstGeom prst="rect">
            <a:avLst/>
          </a:prstGeom>
        </p:spPr>
      </p:pic>
      <p:sp>
        <p:nvSpPr>
          <p:cNvPr id="7" name="正方形/長方形 6"/>
          <p:cNvSpPr/>
          <p:nvPr/>
        </p:nvSpPr>
        <p:spPr>
          <a:xfrm rot="21371486">
            <a:off x="2228043" y="711086"/>
            <a:ext cx="1066021" cy="803195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線矢印コネクタ 8"/>
          <p:cNvCxnSpPr>
            <a:cxnSpLocks/>
          </p:cNvCxnSpPr>
          <p:nvPr/>
        </p:nvCxnSpPr>
        <p:spPr>
          <a:xfrm>
            <a:off x="2708944" y="1544976"/>
            <a:ext cx="0" cy="1792263"/>
          </a:xfrm>
          <a:prstGeom prst="straightConnector1">
            <a:avLst/>
          </a:prstGeom>
          <a:ln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/>
          <p:cNvSpPr txBox="1"/>
          <p:nvPr/>
        </p:nvSpPr>
        <p:spPr>
          <a:xfrm>
            <a:off x="987695" y="3396495"/>
            <a:ext cx="26224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Cuboidal osteoblast</a:t>
            </a:r>
            <a:endParaRPr kumimoji="1" lang="ja-JP" altLang="en-US" sz="2000" b="1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19" name="直線矢印コネクタ 18"/>
          <p:cNvCxnSpPr>
            <a:cxnSpLocks/>
          </p:cNvCxnSpPr>
          <p:nvPr/>
        </p:nvCxnSpPr>
        <p:spPr>
          <a:xfrm flipH="1">
            <a:off x="688955" y="3772459"/>
            <a:ext cx="8592" cy="244511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/>
          <p:cNvCxnSpPr>
            <a:cxnSpLocks/>
          </p:cNvCxnSpPr>
          <p:nvPr/>
        </p:nvCxnSpPr>
        <p:spPr>
          <a:xfrm flipH="1">
            <a:off x="1043882" y="3974773"/>
            <a:ext cx="8592" cy="244511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/>
          <p:cNvCxnSpPr>
            <a:cxnSpLocks/>
          </p:cNvCxnSpPr>
          <p:nvPr/>
        </p:nvCxnSpPr>
        <p:spPr>
          <a:xfrm flipH="1">
            <a:off x="1265661" y="4087212"/>
            <a:ext cx="8592" cy="244511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/>
          <p:cNvCxnSpPr>
            <a:cxnSpLocks/>
          </p:cNvCxnSpPr>
          <p:nvPr/>
        </p:nvCxnSpPr>
        <p:spPr>
          <a:xfrm flipH="1">
            <a:off x="444726" y="3674349"/>
            <a:ext cx="8592" cy="244511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/>
          <p:cNvCxnSpPr>
            <a:cxnSpLocks/>
          </p:cNvCxnSpPr>
          <p:nvPr/>
        </p:nvCxnSpPr>
        <p:spPr>
          <a:xfrm flipH="1">
            <a:off x="1447378" y="4489438"/>
            <a:ext cx="8592" cy="244511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/>
          <p:cNvCxnSpPr>
            <a:cxnSpLocks/>
          </p:cNvCxnSpPr>
          <p:nvPr/>
        </p:nvCxnSpPr>
        <p:spPr>
          <a:xfrm flipH="1">
            <a:off x="2157853" y="4587418"/>
            <a:ext cx="45330" cy="217498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/>
          <p:cNvCxnSpPr>
            <a:cxnSpLocks/>
          </p:cNvCxnSpPr>
          <p:nvPr/>
        </p:nvCxnSpPr>
        <p:spPr>
          <a:xfrm>
            <a:off x="2806997" y="4443766"/>
            <a:ext cx="11720" cy="247191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>
            <a:cxnSpLocks/>
          </p:cNvCxnSpPr>
          <p:nvPr/>
        </p:nvCxnSpPr>
        <p:spPr>
          <a:xfrm flipH="1">
            <a:off x="2161554" y="4271774"/>
            <a:ext cx="8592" cy="244511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/>
          <p:cNvCxnSpPr>
            <a:cxnSpLocks/>
          </p:cNvCxnSpPr>
          <p:nvPr/>
        </p:nvCxnSpPr>
        <p:spPr>
          <a:xfrm flipH="1">
            <a:off x="2015505" y="4219284"/>
            <a:ext cx="8592" cy="244511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/>
          <p:cNvCxnSpPr>
            <a:cxnSpLocks/>
          </p:cNvCxnSpPr>
          <p:nvPr/>
        </p:nvCxnSpPr>
        <p:spPr>
          <a:xfrm flipH="1">
            <a:off x="2566201" y="4686654"/>
            <a:ext cx="2672" cy="260864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/>
          <p:cNvCxnSpPr>
            <a:cxnSpLocks/>
          </p:cNvCxnSpPr>
          <p:nvPr/>
        </p:nvCxnSpPr>
        <p:spPr>
          <a:xfrm flipH="1">
            <a:off x="2439647" y="4991454"/>
            <a:ext cx="10163" cy="133247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/>
          <p:cNvCxnSpPr>
            <a:cxnSpLocks/>
          </p:cNvCxnSpPr>
          <p:nvPr/>
        </p:nvCxnSpPr>
        <p:spPr>
          <a:xfrm>
            <a:off x="3007021" y="4970816"/>
            <a:ext cx="43420" cy="288211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矢印コネクタ 35"/>
          <p:cNvCxnSpPr>
            <a:cxnSpLocks/>
          </p:cNvCxnSpPr>
          <p:nvPr/>
        </p:nvCxnSpPr>
        <p:spPr>
          <a:xfrm flipH="1">
            <a:off x="2850831" y="4996216"/>
            <a:ext cx="2203" cy="288211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矢印コネクタ 36"/>
          <p:cNvCxnSpPr>
            <a:cxnSpLocks/>
          </p:cNvCxnSpPr>
          <p:nvPr/>
        </p:nvCxnSpPr>
        <p:spPr>
          <a:xfrm flipH="1">
            <a:off x="3210155" y="5442304"/>
            <a:ext cx="6418" cy="251748"/>
          </a:xfrm>
          <a:prstGeom prst="straightConnector1">
            <a:avLst/>
          </a:prstGeom>
          <a:ln w="22225"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/>
          <p:cNvCxnSpPr>
            <a:cxnSpLocks/>
          </p:cNvCxnSpPr>
          <p:nvPr/>
        </p:nvCxnSpPr>
        <p:spPr>
          <a:xfrm flipH="1">
            <a:off x="6299963" y="4543070"/>
            <a:ext cx="8592" cy="244511"/>
          </a:xfrm>
          <a:prstGeom prst="straightConnector1">
            <a:avLst/>
          </a:prstGeom>
          <a:ln w="22225">
            <a:solidFill>
              <a:srgbClr val="0070C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/>
          <p:cNvCxnSpPr>
            <a:cxnSpLocks/>
          </p:cNvCxnSpPr>
          <p:nvPr/>
        </p:nvCxnSpPr>
        <p:spPr>
          <a:xfrm flipH="1">
            <a:off x="6521742" y="4682660"/>
            <a:ext cx="8592" cy="244511"/>
          </a:xfrm>
          <a:prstGeom prst="straightConnector1">
            <a:avLst/>
          </a:prstGeom>
          <a:ln w="22225">
            <a:solidFill>
              <a:srgbClr val="0070C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矢印コネクタ 38"/>
          <p:cNvCxnSpPr>
            <a:cxnSpLocks/>
          </p:cNvCxnSpPr>
          <p:nvPr/>
        </p:nvCxnSpPr>
        <p:spPr>
          <a:xfrm flipH="1">
            <a:off x="5948180" y="4479536"/>
            <a:ext cx="8592" cy="244511"/>
          </a:xfrm>
          <a:prstGeom prst="straightConnector1">
            <a:avLst/>
          </a:prstGeom>
          <a:ln w="22225">
            <a:solidFill>
              <a:srgbClr val="0070C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矢印コネクタ 39"/>
          <p:cNvCxnSpPr>
            <a:cxnSpLocks/>
          </p:cNvCxnSpPr>
          <p:nvPr/>
        </p:nvCxnSpPr>
        <p:spPr>
          <a:xfrm flipH="1">
            <a:off x="6836928" y="4840147"/>
            <a:ext cx="8592" cy="244511"/>
          </a:xfrm>
          <a:prstGeom prst="straightConnector1">
            <a:avLst/>
          </a:prstGeom>
          <a:ln w="22225">
            <a:solidFill>
              <a:srgbClr val="0070C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矢印コネクタ 40"/>
          <p:cNvCxnSpPr>
            <a:cxnSpLocks/>
          </p:cNvCxnSpPr>
          <p:nvPr/>
        </p:nvCxnSpPr>
        <p:spPr>
          <a:xfrm flipH="1">
            <a:off x="7097635" y="5114921"/>
            <a:ext cx="8592" cy="244511"/>
          </a:xfrm>
          <a:prstGeom prst="straightConnector1">
            <a:avLst/>
          </a:prstGeom>
          <a:ln w="22225">
            <a:solidFill>
              <a:srgbClr val="0070C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矢印コネクタ 41"/>
          <p:cNvCxnSpPr>
            <a:cxnSpLocks/>
          </p:cNvCxnSpPr>
          <p:nvPr/>
        </p:nvCxnSpPr>
        <p:spPr>
          <a:xfrm flipH="1">
            <a:off x="7207194" y="5330371"/>
            <a:ext cx="8592" cy="244511"/>
          </a:xfrm>
          <a:prstGeom prst="straightConnector1">
            <a:avLst/>
          </a:prstGeom>
          <a:ln w="22225">
            <a:solidFill>
              <a:srgbClr val="0070C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矢印コネクタ 42"/>
          <p:cNvCxnSpPr>
            <a:cxnSpLocks/>
          </p:cNvCxnSpPr>
          <p:nvPr/>
        </p:nvCxnSpPr>
        <p:spPr>
          <a:xfrm flipH="1">
            <a:off x="7431559" y="5609365"/>
            <a:ext cx="8592" cy="244511"/>
          </a:xfrm>
          <a:prstGeom prst="straightConnector1">
            <a:avLst/>
          </a:prstGeom>
          <a:ln w="22225">
            <a:solidFill>
              <a:srgbClr val="0070C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矢印コネクタ 44"/>
          <p:cNvCxnSpPr>
            <a:cxnSpLocks/>
          </p:cNvCxnSpPr>
          <p:nvPr/>
        </p:nvCxnSpPr>
        <p:spPr>
          <a:xfrm flipH="1">
            <a:off x="5717809" y="4426446"/>
            <a:ext cx="8592" cy="244511"/>
          </a:xfrm>
          <a:prstGeom prst="straightConnector1">
            <a:avLst/>
          </a:prstGeom>
          <a:ln w="22225">
            <a:solidFill>
              <a:srgbClr val="0070C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矢印コネクタ 46"/>
          <p:cNvCxnSpPr>
            <a:cxnSpLocks/>
          </p:cNvCxnSpPr>
          <p:nvPr/>
        </p:nvCxnSpPr>
        <p:spPr>
          <a:xfrm flipH="1">
            <a:off x="5323184" y="4357123"/>
            <a:ext cx="90184" cy="140028"/>
          </a:xfrm>
          <a:prstGeom prst="straightConnector1">
            <a:avLst/>
          </a:prstGeom>
          <a:ln w="22225">
            <a:solidFill>
              <a:srgbClr val="0070C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矢印コネクタ 47"/>
          <p:cNvCxnSpPr>
            <a:cxnSpLocks/>
          </p:cNvCxnSpPr>
          <p:nvPr/>
        </p:nvCxnSpPr>
        <p:spPr>
          <a:xfrm flipH="1">
            <a:off x="5121479" y="4185943"/>
            <a:ext cx="69310" cy="163290"/>
          </a:xfrm>
          <a:prstGeom prst="straightConnector1">
            <a:avLst/>
          </a:prstGeom>
          <a:ln w="22225">
            <a:solidFill>
              <a:srgbClr val="0070C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48"/>
          <p:cNvSpPr txBox="1"/>
          <p:nvPr/>
        </p:nvSpPr>
        <p:spPr>
          <a:xfrm>
            <a:off x="4797695" y="3760433"/>
            <a:ext cx="28231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Flattened osteoblast</a:t>
            </a:r>
            <a:endParaRPr kumimoji="1" lang="ja-JP" altLang="en-US" sz="2000" b="1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0" name="正方形/長方形 49"/>
          <p:cNvSpPr/>
          <p:nvPr/>
        </p:nvSpPr>
        <p:spPr>
          <a:xfrm>
            <a:off x="5578245" y="1835049"/>
            <a:ext cx="1066021" cy="803195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直線矢印コネクタ 50"/>
          <p:cNvCxnSpPr>
            <a:cxnSpLocks/>
          </p:cNvCxnSpPr>
          <p:nvPr/>
        </p:nvCxnSpPr>
        <p:spPr>
          <a:xfrm>
            <a:off x="6394690" y="2674326"/>
            <a:ext cx="0" cy="698636"/>
          </a:xfrm>
          <a:prstGeom prst="straightConnector1">
            <a:avLst/>
          </a:prstGeom>
          <a:ln>
            <a:solidFill>
              <a:srgbClr val="FF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A9A39706-5730-C44E-BC02-5F55C414DCE7}"/>
              </a:ext>
            </a:extLst>
          </p:cNvPr>
          <p:cNvSpPr txBox="1"/>
          <p:nvPr/>
        </p:nvSpPr>
        <p:spPr>
          <a:xfrm>
            <a:off x="94574" y="3003828"/>
            <a:ext cx="182287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Natural microscopy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16004E84-495D-A044-A285-000129A4AA7E}"/>
              </a:ext>
            </a:extLst>
          </p:cNvPr>
          <p:cNvSpPr txBox="1"/>
          <p:nvPr/>
        </p:nvSpPr>
        <p:spPr>
          <a:xfrm>
            <a:off x="4571348" y="3007368"/>
            <a:ext cx="167923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Natural microscopy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2B4D606-31ED-2D4B-A02E-1B716EA8E47A}"/>
              </a:ext>
            </a:extLst>
          </p:cNvPr>
          <p:cNvSpPr txBox="1"/>
          <p:nvPr/>
        </p:nvSpPr>
        <p:spPr>
          <a:xfrm>
            <a:off x="92299" y="6277870"/>
            <a:ext cx="244490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image of the upper section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31FF7768-E4A4-2E49-A032-DA602315B67B}"/>
              </a:ext>
            </a:extLst>
          </p:cNvPr>
          <p:cNvSpPr txBox="1"/>
          <p:nvPr/>
        </p:nvSpPr>
        <p:spPr>
          <a:xfrm>
            <a:off x="4563387" y="6270616"/>
            <a:ext cx="244490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tended image of the upper section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E65C809A-3EFC-434F-9AFA-D96877FF512F}"/>
              </a:ext>
            </a:extLst>
          </p:cNvPr>
          <p:cNvSpPr txBox="1"/>
          <p:nvPr/>
        </p:nvSpPr>
        <p:spPr>
          <a:xfrm>
            <a:off x="1501361" y="38007"/>
            <a:ext cx="148551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First biopsy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EF966A40-7DDB-1247-A3FD-E774CA0C10EE}"/>
              </a:ext>
            </a:extLst>
          </p:cNvPr>
          <p:cNvSpPr txBox="1"/>
          <p:nvPr/>
        </p:nvSpPr>
        <p:spPr>
          <a:xfrm>
            <a:off x="5932210" y="51925"/>
            <a:ext cx="169634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Second</a:t>
            </a:r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 biopsy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88724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図 30">
            <a:extLst>
              <a:ext uri="{FF2B5EF4-FFF2-40B4-BE49-F238E27FC236}">
                <a16:creationId xmlns:a16="http://schemas.microsoft.com/office/drawing/2014/main" id="{23338B15-5450-48C2-9FA5-50F8C5FCAF9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75112"/>
            <a:ext cx="4177803" cy="3145640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251AD81C-E8AE-445E-82B0-77E0A0A8B38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3327734"/>
            <a:ext cx="4177803" cy="314564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325" y="3327734"/>
            <a:ext cx="4177803" cy="3145640"/>
          </a:xfrm>
          <a:prstGeom prst="rect">
            <a:avLst/>
          </a:prstGeom>
        </p:spPr>
      </p:pic>
      <p:sp>
        <p:nvSpPr>
          <p:cNvPr id="14" name="フリーフォーム 13"/>
          <p:cNvSpPr/>
          <p:nvPr/>
        </p:nvSpPr>
        <p:spPr>
          <a:xfrm>
            <a:off x="2393488" y="4100599"/>
            <a:ext cx="1005876" cy="610309"/>
          </a:xfrm>
          <a:custGeom>
            <a:avLst/>
            <a:gdLst>
              <a:gd name="connsiteX0" fmla="*/ 521250 w 1073720"/>
              <a:gd name="connsiteY0" fmla="*/ 908 h 649570"/>
              <a:gd name="connsiteX1" fmla="*/ 368850 w 1073720"/>
              <a:gd name="connsiteY1" fmla="*/ 43770 h 649570"/>
              <a:gd name="connsiteX2" fmla="*/ 316463 w 1073720"/>
              <a:gd name="connsiteY2" fmla="*/ 115208 h 649570"/>
              <a:gd name="connsiteX3" fmla="*/ 202163 w 1073720"/>
              <a:gd name="connsiteY3" fmla="*/ 196170 h 649570"/>
              <a:gd name="connsiteX4" fmla="*/ 102150 w 1073720"/>
              <a:gd name="connsiteY4" fmla="*/ 267608 h 649570"/>
              <a:gd name="connsiteX5" fmla="*/ 40238 w 1073720"/>
              <a:gd name="connsiteY5" fmla="*/ 386670 h 649570"/>
              <a:gd name="connsiteX6" fmla="*/ 21188 w 1073720"/>
              <a:gd name="connsiteY6" fmla="*/ 477158 h 649570"/>
              <a:gd name="connsiteX7" fmla="*/ 349800 w 1073720"/>
              <a:gd name="connsiteY7" fmla="*/ 643845 h 649570"/>
              <a:gd name="connsiteX8" fmla="*/ 649838 w 1073720"/>
              <a:gd name="connsiteY8" fmla="*/ 610508 h 649570"/>
              <a:gd name="connsiteX9" fmla="*/ 926063 w 1073720"/>
              <a:gd name="connsiteY9" fmla="*/ 605745 h 649570"/>
              <a:gd name="connsiteX10" fmla="*/ 1073700 w 1073720"/>
              <a:gd name="connsiteY10" fmla="*/ 448583 h 649570"/>
              <a:gd name="connsiteX11" fmla="*/ 935588 w 1073720"/>
              <a:gd name="connsiteY11" fmla="*/ 200933 h 649570"/>
              <a:gd name="connsiteX12" fmla="*/ 768900 w 1073720"/>
              <a:gd name="connsiteY12" fmla="*/ 110445 h 649570"/>
              <a:gd name="connsiteX13" fmla="*/ 702225 w 1073720"/>
              <a:gd name="connsiteY13" fmla="*/ 67583 h 649570"/>
              <a:gd name="connsiteX14" fmla="*/ 635550 w 1073720"/>
              <a:gd name="connsiteY14" fmla="*/ 19958 h 649570"/>
              <a:gd name="connsiteX15" fmla="*/ 521250 w 1073720"/>
              <a:gd name="connsiteY15" fmla="*/ 908 h 6495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</a:cxnLst>
            <a:rect l="l" t="t" r="r" b="b"/>
            <a:pathLst>
              <a:path w="1073720" h="649570">
                <a:moveTo>
                  <a:pt x="521250" y="908"/>
                </a:moveTo>
                <a:cubicBezTo>
                  <a:pt x="476800" y="4877"/>
                  <a:pt x="402981" y="24720"/>
                  <a:pt x="368850" y="43770"/>
                </a:cubicBezTo>
                <a:cubicBezTo>
                  <a:pt x="334719" y="62820"/>
                  <a:pt x="344244" y="89808"/>
                  <a:pt x="316463" y="115208"/>
                </a:cubicBezTo>
                <a:cubicBezTo>
                  <a:pt x="288682" y="140608"/>
                  <a:pt x="202163" y="196170"/>
                  <a:pt x="202163" y="196170"/>
                </a:cubicBezTo>
                <a:cubicBezTo>
                  <a:pt x="166444" y="221570"/>
                  <a:pt x="129137" y="235858"/>
                  <a:pt x="102150" y="267608"/>
                </a:cubicBezTo>
                <a:cubicBezTo>
                  <a:pt x="75163" y="299358"/>
                  <a:pt x="53732" y="351745"/>
                  <a:pt x="40238" y="386670"/>
                </a:cubicBezTo>
                <a:cubicBezTo>
                  <a:pt x="26744" y="421595"/>
                  <a:pt x="-30406" y="434295"/>
                  <a:pt x="21188" y="477158"/>
                </a:cubicBezTo>
                <a:cubicBezTo>
                  <a:pt x="72782" y="520021"/>
                  <a:pt x="245025" y="621620"/>
                  <a:pt x="349800" y="643845"/>
                </a:cubicBezTo>
                <a:cubicBezTo>
                  <a:pt x="454575" y="666070"/>
                  <a:pt x="553794" y="616858"/>
                  <a:pt x="649838" y="610508"/>
                </a:cubicBezTo>
                <a:cubicBezTo>
                  <a:pt x="745882" y="604158"/>
                  <a:pt x="855419" y="632732"/>
                  <a:pt x="926063" y="605745"/>
                </a:cubicBezTo>
                <a:cubicBezTo>
                  <a:pt x="996707" y="578758"/>
                  <a:pt x="1072113" y="516052"/>
                  <a:pt x="1073700" y="448583"/>
                </a:cubicBezTo>
                <a:cubicBezTo>
                  <a:pt x="1075288" y="381114"/>
                  <a:pt x="986388" y="257289"/>
                  <a:pt x="935588" y="200933"/>
                </a:cubicBezTo>
                <a:cubicBezTo>
                  <a:pt x="884788" y="144577"/>
                  <a:pt x="807794" y="132670"/>
                  <a:pt x="768900" y="110445"/>
                </a:cubicBezTo>
                <a:cubicBezTo>
                  <a:pt x="730006" y="88220"/>
                  <a:pt x="724450" y="82664"/>
                  <a:pt x="702225" y="67583"/>
                </a:cubicBezTo>
                <a:cubicBezTo>
                  <a:pt x="680000" y="52502"/>
                  <a:pt x="662538" y="33452"/>
                  <a:pt x="635550" y="19958"/>
                </a:cubicBezTo>
                <a:cubicBezTo>
                  <a:pt x="608563" y="6464"/>
                  <a:pt x="565700" y="-3061"/>
                  <a:pt x="521250" y="908"/>
                </a:cubicBezTo>
                <a:close/>
              </a:path>
            </a:pathLst>
          </a:custGeom>
          <a:solidFill>
            <a:srgbClr val="FF00FF">
              <a:alpha val="30000"/>
            </a:srgbClr>
          </a:solidFill>
          <a:ln w="19050"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フリーフォーム 14"/>
          <p:cNvSpPr/>
          <p:nvPr/>
        </p:nvSpPr>
        <p:spPr>
          <a:xfrm>
            <a:off x="922722" y="4120626"/>
            <a:ext cx="663558" cy="1212849"/>
          </a:xfrm>
          <a:custGeom>
            <a:avLst/>
            <a:gdLst>
              <a:gd name="connsiteX0" fmla="*/ 209254 w 708314"/>
              <a:gd name="connsiteY0" fmla="*/ 18981 h 1290872"/>
              <a:gd name="connsiteX1" fmla="*/ 85429 w 708314"/>
              <a:gd name="connsiteY1" fmla="*/ 142806 h 1290872"/>
              <a:gd name="connsiteX2" fmla="*/ 9229 w 708314"/>
              <a:gd name="connsiteY2" fmla="*/ 338068 h 1290872"/>
              <a:gd name="connsiteX3" fmla="*/ 9229 w 708314"/>
              <a:gd name="connsiteY3" fmla="*/ 519043 h 1290872"/>
              <a:gd name="connsiteX4" fmla="*/ 80666 w 708314"/>
              <a:gd name="connsiteY4" fmla="*/ 661918 h 1290872"/>
              <a:gd name="connsiteX5" fmla="*/ 56854 w 708314"/>
              <a:gd name="connsiteY5" fmla="*/ 790506 h 1290872"/>
              <a:gd name="connsiteX6" fmla="*/ 180679 w 708314"/>
              <a:gd name="connsiteY6" fmla="*/ 957193 h 1290872"/>
              <a:gd name="connsiteX7" fmla="*/ 190204 w 708314"/>
              <a:gd name="connsiteY7" fmla="*/ 1061968 h 1290872"/>
              <a:gd name="connsiteX8" fmla="*/ 194966 w 708314"/>
              <a:gd name="connsiteY8" fmla="*/ 1290568 h 1290872"/>
              <a:gd name="connsiteX9" fmla="*/ 652166 w 708314"/>
              <a:gd name="connsiteY9" fmla="*/ 1009581 h 1290872"/>
              <a:gd name="connsiteX10" fmla="*/ 680741 w 708314"/>
              <a:gd name="connsiteY10" fmla="*/ 738118 h 1290872"/>
              <a:gd name="connsiteX11" fmla="*/ 695029 w 708314"/>
              <a:gd name="connsiteY11" fmla="*/ 628581 h 1290872"/>
              <a:gd name="connsiteX12" fmla="*/ 704554 w 708314"/>
              <a:gd name="connsiteY12" fmla="*/ 557143 h 1290872"/>
              <a:gd name="connsiteX13" fmla="*/ 628354 w 708314"/>
              <a:gd name="connsiteY13" fmla="*/ 390456 h 1290872"/>
              <a:gd name="connsiteX14" fmla="*/ 647404 w 708314"/>
              <a:gd name="connsiteY14" fmla="*/ 290443 h 1290872"/>
              <a:gd name="connsiteX15" fmla="*/ 561679 w 708314"/>
              <a:gd name="connsiteY15" fmla="*/ 180906 h 1290872"/>
              <a:gd name="connsiteX16" fmla="*/ 394991 w 708314"/>
              <a:gd name="connsiteY16" fmla="*/ 52318 h 1290872"/>
              <a:gd name="connsiteX17" fmla="*/ 304504 w 708314"/>
              <a:gd name="connsiteY17" fmla="*/ 4693 h 1290872"/>
              <a:gd name="connsiteX18" fmla="*/ 209254 w 708314"/>
              <a:gd name="connsiteY18" fmla="*/ 18981 h 12908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708314" h="1290872">
                <a:moveTo>
                  <a:pt x="209254" y="18981"/>
                </a:moveTo>
                <a:cubicBezTo>
                  <a:pt x="172742" y="42000"/>
                  <a:pt x="118766" y="89625"/>
                  <a:pt x="85429" y="142806"/>
                </a:cubicBezTo>
                <a:cubicBezTo>
                  <a:pt x="52092" y="195987"/>
                  <a:pt x="21929" y="275362"/>
                  <a:pt x="9229" y="338068"/>
                </a:cubicBezTo>
                <a:cubicBezTo>
                  <a:pt x="-3471" y="400774"/>
                  <a:pt x="-2677" y="465068"/>
                  <a:pt x="9229" y="519043"/>
                </a:cubicBezTo>
                <a:cubicBezTo>
                  <a:pt x="21135" y="573018"/>
                  <a:pt x="72729" y="616674"/>
                  <a:pt x="80666" y="661918"/>
                </a:cubicBezTo>
                <a:cubicBezTo>
                  <a:pt x="88603" y="707162"/>
                  <a:pt x="40185" y="741294"/>
                  <a:pt x="56854" y="790506"/>
                </a:cubicBezTo>
                <a:cubicBezTo>
                  <a:pt x="73523" y="839719"/>
                  <a:pt x="158454" y="911949"/>
                  <a:pt x="180679" y="957193"/>
                </a:cubicBezTo>
                <a:cubicBezTo>
                  <a:pt x="202904" y="1002437"/>
                  <a:pt x="187823" y="1006406"/>
                  <a:pt x="190204" y="1061968"/>
                </a:cubicBezTo>
                <a:cubicBezTo>
                  <a:pt x="192585" y="1117530"/>
                  <a:pt x="117972" y="1299299"/>
                  <a:pt x="194966" y="1290568"/>
                </a:cubicBezTo>
                <a:cubicBezTo>
                  <a:pt x="271960" y="1281837"/>
                  <a:pt x="571204" y="1101656"/>
                  <a:pt x="652166" y="1009581"/>
                </a:cubicBezTo>
                <a:cubicBezTo>
                  <a:pt x="733128" y="917506"/>
                  <a:pt x="673597" y="801618"/>
                  <a:pt x="680741" y="738118"/>
                </a:cubicBezTo>
                <a:cubicBezTo>
                  <a:pt x="687885" y="674618"/>
                  <a:pt x="691060" y="658743"/>
                  <a:pt x="695029" y="628581"/>
                </a:cubicBezTo>
                <a:cubicBezTo>
                  <a:pt x="698998" y="598419"/>
                  <a:pt x="715667" y="596831"/>
                  <a:pt x="704554" y="557143"/>
                </a:cubicBezTo>
                <a:cubicBezTo>
                  <a:pt x="693442" y="517456"/>
                  <a:pt x="637879" y="434906"/>
                  <a:pt x="628354" y="390456"/>
                </a:cubicBezTo>
                <a:cubicBezTo>
                  <a:pt x="618829" y="346006"/>
                  <a:pt x="658517" y="325368"/>
                  <a:pt x="647404" y="290443"/>
                </a:cubicBezTo>
                <a:cubicBezTo>
                  <a:pt x="636292" y="255518"/>
                  <a:pt x="603748" y="220593"/>
                  <a:pt x="561679" y="180906"/>
                </a:cubicBezTo>
                <a:cubicBezTo>
                  <a:pt x="519610" y="141219"/>
                  <a:pt x="437853" y="81687"/>
                  <a:pt x="394991" y="52318"/>
                </a:cubicBezTo>
                <a:cubicBezTo>
                  <a:pt x="352129" y="22949"/>
                  <a:pt x="335460" y="11837"/>
                  <a:pt x="304504" y="4693"/>
                </a:cubicBezTo>
                <a:cubicBezTo>
                  <a:pt x="273548" y="-2451"/>
                  <a:pt x="245766" y="-4038"/>
                  <a:pt x="209254" y="18981"/>
                </a:cubicBezTo>
                <a:close/>
              </a:path>
            </a:pathLst>
          </a:custGeom>
          <a:solidFill>
            <a:srgbClr val="FF00FF">
              <a:alpha val="30000"/>
            </a:srgbClr>
          </a:solidFill>
          <a:ln w="19050"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フリーフォーム 15"/>
          <p:cNvSpPr/>
          <p:nvPr/>
        </p:nvSpPr>
        <p:spPr>
          <a:xfrm>
            <a:off x="3436243" y="4474008"/>
            <a:ext cx="295201" cy="889791"/>
          </a:xfrm>
          <a:custGeom>
            <a:avLst/>
            <a:gdLst>
              <a:gd name="connsiteX0" fmla="*/ 84920 w 315112"/>
              <a:gd name="connsiteY0" fmla="*/ 70411 h 947031"/>
              <a:gd name="connsiteX1" fmla="*/ 32533 w 315112"/>
              <a:gd name="connsiteY1" fmla="*/ 403786 h 947031"/>
              <a:gd name="connsiteX2" fmla="*/ 8720 w 315112"/>
              <a:gd name="connsiteY2" fmla="*/ 603811 h 947031"/>
              <a:gd name="connsiteX3" fmla="*/ 8720 w 315112"/>
              <a:gd name="connsiteY3" fmla="*/ 741924 h 947031"/>
              <a:gd name="connsiteX4" fmla="*/ 113495 w 315112"/>
              <a:gd name="connsiteY4" fmla="*/ 937186 h 947031"/>
              <a:gd name="connsiteX5" fmla="*/ 299233 w 315112"/>
              <a:gd name="connsiteY5" fmla="*/ 880036 h 947031"/>
              <a:gd name="connsiteX6" fmla="*/ 303995 w 315112"/>
              <a:gd name="connsiteY6" fmla="*/ 556186 h 947031"/>
              <a:gd name="connsiteX7" fmla="*/ 289708 w 315112"/>
              <a:gd name="connsiteY7" fmla="*/ 427599 h 947031"/>
              <a:gd name="connsiteX8" fmla="*/ 261133 w 315112"/>
              <a:gd name="connsiteY8" fmla="*/ 337111 h 947031"/>
              <a:gd name="connsiteX9" fmla="*/ 242083 w 315112"/>
              <a:gd name="connsiteY9" fmla="*/ 222811 h 947031"/>
              <a:gd name="connsiteX10" fmla="*/ 103970 w 315112"/>
              <a:gd name="connsiteY10" fmla="*/ 13261 h 947031"/>
              <a:gd name="connsiteX11" fmla="*/ 84920 w 315112"/>
              <a:gd name="connsiteY11" fmla="*/ 70411 h 94703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15112" h="947031">
                <a:moveTo>
                  <a:pt x="84920" y="70411"/>
                </a:moveTo>
                <a:cubicBezTo>
                  <a:pt x="73014" y="135498"/>
                  <a:pt x="45233" y="314886"/>
                  <a:pt x="32533" y="403786"/>
                </a:cubicBezTo>
                <a:cubicBezTo>
                  <a:pt x="19833" y="492686"/>
                  <a:pt x="12689" y="547455"/>
                  <a:pt x="8720" y="603811"/>
                </a:cubicBezTo>
                <a:cubicBezTo>
                  <a:pt x="4751" y="660167"/>
                  <a:pt x="-8743" y="686361"/>
                  <a:pt x="8720" y="741924"/>
                </a:cubicBezTo>
                <a:cubicBezTo>
                  <a:pt x="26183" y="797487"/>
                  <a:pt x="65076" y="914167"/>
                  <a:pt x="113495" y="937186"/>
                </a:cubicBezTo>
                <a:cubicBezTo>
                  <a:pt x="161914" y="960205"/>
                  <a:pt x="267483" y="943536"/>
                  <a:pt x="299233" y="880036"/>
                </a:cubicBezTo>
                <a:cubicBezTo>
                  <a:pt x="330983" y="816536"/>
                  <a:pt x="305582" y="631592"/>
                  <a:pt x="303995" y="556186"/>
                </a:cubicBezTo>
                <a:cubicBezTo>
                  <a:pt x="302408" y="480780"/>
                  <a:pt x="296852" y="464112"/>
                  <a:pt x="289708" y="427599"/>
                </a:cubicBezTo>
                <a:cubicBezTo>
                  <a:pt x="282564" y="391087"/>
                  <a:pt x="269071" y="371242"/>
                  <a:pt x="261133" y="337111"/>
                </a:cubicBezTo>
                <a:cubicBezTo>
                  <a:pt x="253195" y="302980"/>
                  <a:pt x="268277" y="276786"/>
                  <a:pt x="242083" y="222811"/>
                </a:cubicBezTo>
                <a:cubicBezTo>
                  <a:pt x="215889" y="168836"/>
                  <a:pt x="130164" y="43424"/>
                  <a:pt x="103970" y="13261"/>
                </a:cubicBezTo>
                <a:cubicBezTo>
                  <a:pt x="77776" y="-16902"/>
                  <a:pt x="96826" y="5324"/>
                  <a:pt x="84920" y="70411"/>
                </a:cubicBezTo>
                <a:close/>
              </a:path>
            </a:pathLst>
          </a:custGeom>
          <a:solidFill>
            <a:srgbClr val="FF00FF">
              <a:alpha val="30000"/>
            </a:srgbClr>
          </a:solidFill>
          <a:ln w="19050"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325" y="75112"/>
            <a:ext cx="4177803" cy="3145640"/>
          </a:xfrm>
          <a:prstGeom prst="rect">
            <a:avLst/>
          </a:prstGeom>
        </p:spPr>
      </p:pic>
      <p:cxnSp>
        <p:nvCxnSpPr>
          <p:cNvPr id="6" name="直線矢印コネクタ 5"/>
          <p:cNvCxnSpPr>
            <a:cxnSpLocks/>
          </p:cNvCxnSpPr>
          <p:nvPr/>
        </p:nvCxnSpPr>
        <p:spPr>
          <a:xfrm>
            <a:off x="1228327" y="1256068"/>
            <a:ext cx="0" cy="2079498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フリーフォーム 7"/>
          <p:cNvSpPr/>
          <p:nvPr/>
        </p:nvSpPr>
        <p:spPr>
          <a:xfrm>
            <a:off x="1233891" y="76205"/>
            <a:ext cx="1043775" cy="3161080"/>
          </a:xfrm>
          <a:custGeom>
            <a:avLst/>
            <a:gdLst>
              <a:gd name="connsiteX0" fmla="*/ 1595 w 1109744"/>
              <a:gd name="connsiteY0" fmla="*/ 56041 h 3392270"/>
              <a:gd name="connsiteX1" fmla="*/ 96845 w 1109744"/>
              <a:gd name="connsiteY1" fmla="*/ 465616 h 3392270"/>
              <a:gd name="connsiteX2" fmla="*/ 144470 w 1109744"/>
              <a:gd name="connsiteY2" fmla="*/ 656116 h 3392270"/>
              <a:gd name="connsiteX3" fmla="*/ 125420 w 1109744"/>
              <a:gd name="connsiteY3" fmla="*/ 846616 h 3392270"/>
              <a:gd name="connsiteX4" fmla="*/ 192095 w 1109744"/>
              <a:gd name="connsiteY4" fmla="*/ 1027591 h 3392270"/>
              <a:gd name="connsiteX5" fmla="*/ 11120 w 1109744"/>
              <a:gd name="connsiteY5" fmla="*/ 1446691 h 3392270"/>
              <a:gd name="connsiteX6" fmla="*/ 68270 w 1109744"/>
              <a:gd name="connsiteY6" fmla="*/ 1732441 h 3392270"/>
              <a:gd name="connsiteX7" fmla="*/ 58745 w 1109744"/>
              <a:gd name="connsiteY7" fmla="*/ 2256316 h 3392270"/>
              <a:gd name="connsiteX8" fmla="*/ 106370 w 1109744"/>
              <a:gd name="connsiteY8" fmla="*/ 2513491 h 3392270"/>
              <a:gd name="connsiteX9" fmla="*/ 49220 w 1109744"/>
              <a:gd name="connsiteY9" fmla="*/ 2846866 h 3392270"/>
              <a:gd name="connsiteX10" fmla="*/ 68270 w 1109744"/>
              <a:gd name="connsiteY10" fmla="*/ 3180241 h 3392270"/>
              <a:gd name="connsiteX11" fmla="*/ 134945 w 1109744"/>
              <a:gd name="connsiteY11" fmla="*/ 3380266 h 3392270"/>
              <a:gd name="connsiteX12" fmla="*/ 49220 w 1109744"/>
              <a:gd name="connsiteY12" fmla="*/ 3370741 h 3392270"/>
              <a:gd name="connsiteX13" fmla="*/ 668345 w 1109744"/>
              <a:gd name="connsiteY13" fmla="*/ 3380266 h 3392270"/>
              <a:gd name="connsiteX14" fmla="*/ 630245 w 1109744"/>
              <a:gd name="connsiteY14" fmla="*/ 3370741 h 3392270"/>
              <a:gd name="connsiteX15" fmla="*/ 668345 w 1109744"/>
              <a:gd name="connsiteY15" fmla="*/ 3361216 h 3392270"/>
              <a:gd name="connsiteX16" fmla="*/ 668345 w 1109744"/>
              <a:gd name="connsiteY16" fmla="*/ 3275491 h 3392270"/>
              <a:gd name="connsiteX17" fmla="*/ 620720 w 1109744"/>
              <a:gd name="connsiteY17" fmla="*/ 3208816 h 3392270"/>
              <a:gd name="connsiteX18" fmla="*/ 611195 w 1109744"/>
              <a:gd name="connsiteY18" fmla="*/ 2999266 h 3392270"/>
              <a:gd name="connsiteX19" fmla="*/ 534995 w 1109744"/>
              <a:gd name="connsiteY19" fmla="*/ 2675416 h 3392270"/>
              <a:gd name="connsiteX20" fmla="*/ 439745 w 1109744"/>
              <a:gd name="connsiteY20" fmla="*/ 2561116 h 3392270"/>
              <a:gd name="connsiteX21" fmla="*/ 430220 w 1109744"/>
              <a:gd name="connsiteY21" fmla="*/ 2456341 h 3392270"/>
              <a:gd name="connsiteX22" fmla="*/ 487370 w 1109744"/>
              <a:gd name="connsiteY22" fmla="*/ 2342041 h 3392270"/>
              <a:gd name="connsiteX23" fmla="*/ 630245 w 1109744"/>
              <a:gd name="connsiteY23" fmla="*/ 2599216 h 3392270"/>
              <a:gd name="connsiteX24" fmla="*/ 725495 w 1109744"/>
              <a:gd name="connsiteY24" fmla="*/ 2589691 h 3392270"/>
              <a:gd name="connsiteX25" fmla="*/ 896945 w 1109744"/>
              <a:gd name="connsiteY25" fmla="*/ 2303941 h 3392270"/>
              <a:gd name="connsiteX26" fmla="*/ 839795 w 1109744"/>
              <a:gd name="connsiteY26" fmla="*/ 2084866 h 3392270"/>
              <a:gd name="connsiteX27" fmla="*/ 896945 w 1109744"/>
              <a:gd name="connsiteY27" fmla="*/ 1846741 h 3392270"/>
              <a:gd name="connsiteX28" fmla="*/ 925520 w 1109744"/>
              <a:gd name="connsiteY28" fmla="*/ 1656241 h 3392270"/>
              <a:gd name="connsiteX29" fmla="*/ 1049345 w 1109744"/>
              <a:gd name="connsiteY29" fmla="*/ 1494316 h 3392270"/>
              <a:gd name="connsiteX30" fmla="*/ 1106495 w 1109744"/>
              <a:gd name="connsiteY30" fmla="*/ 1265716 h 3392270"/>
              <a:gd name="connsiteX31" fmla="*/ 1096970 w 1109744"/>
              <a:gd name="connsiteY31" fmla="*/ 1065691 h 3392270"/>
              <a:gd name="connsiteX32" fmla="*/ 1049345 w 1109744"/>
              <a:gd name="connsiteY32" fmla="*/ 989491 h 3392270"/>
              <a:gd name="connsiteX33" fmla="*/ 887420 w 1109744"/>
              <a:gd name="connsiteY33" fmla="*/ 1046641 h 3392270"/>
              <a:gd name="connsiteX34" fmla="*/ 868370 w 1109744"/>
              <a:gd name="connsiteY34" fmla="*/ 903766 h 3392270"/>
              <a:gd name="connsiteX35" fmla="*/ 830270 w 1109744"/>
              <a:gd name="connsiteY35" fmla="*/ 713266 h 3392270"/>
              <a:gd name="connsiteX36" fmla="*/ 677870 w 1109744"/>
              <a:gd name="connsiteY36" fmla="*/ 646591 h 3392270"/>
              <a:gd name="connsiteX37" fmla="*/ 601670 w 1109744"/>
              <a:gd name="connsiteY37" fmla="*/ 608491 h 3392270"/>
              <a:gd name="connsiteX38" fmla="*/ 315920 w 1109744"/>
              <a:gd name="connsiteY38" fmla="*/ 475141 h 3392270"/>
              <a:gd name="connsiteX39" fmla="*/ 144470 w 1109744"/>
              <a:gd name="connsiteY39" fmla="*/ 27466 h 3392270"/>
              <a:gd name="connsiteX40" fmla="*/ 182570 w 1109744"/>
              <a:gd name="connsiteY40" fmla="*/ 46516 h 3392270"/>
              <a:gd name="connsiteX41" fmla="*/ 1595 w 1109744"/>
              <a:gd name="connsiteY41" fmla="*/ 56041 h 3392270"/>
              <a:gd name="connsiteX0" fmla="*/ 5957 w 1114106"/>
              <a:gd name="connsiteY0" fmla="*/ 56041 h 3392270"/>
              <a:gd name="connsiteX1" fmla="*/ 48820 w 1114106"/>
              <a:gd name="connsiteY1" fmla="*/ 156054 h 3392270"/>
              <a:gd name="connsiteX2" fmla="*/ 101207 w 1114106"/>
              <a:gd name="connsiteY2" fmla="*/ 465616 h 3392270"/>
              <a:gd name="connsiteX3" fmla="*/ 148832 w 1114106"/>
              <a:gd name="connsiteY3" fmla="*/ 656116 h 3392270"/>
              <a:gd name="connsiteX4" fmla="*/ 129782 w 1114106"/>
              <a:gd name="connsiteY4" fmla="*/ 846616 h 3392270"/>
              <a:gd name="connsiteX5" fmla="*/ 196457 w 1114106"/>
              <a:gd name="connsiteY5" fmla="*/ 1027591 h 3392270"/>
              <a:gd name="connsiteX6" fmla="*/ 15482 w 1114106"/>
              <a:gd name="connsiteY6" fmla="*/ 1446691 h 3392270"/>
              <a:gd name="connsiteX7" fmla="*/ 72632 w 1114106"/>
              <a:gd name="connsiteY7" fmla="*/ 1732441 h 3392270"/>
              <a:gd name="connsiteX8" fmla="*/ 63107 w 1114106"/>
              <a:gd name="connsiteY8" fmla="*/ 2256316 h 3392270"/>
              <a:gd name="connsiteX9" fmla="*/ 110732 w 1114106"/>
              <a:gd name="connsiteY9" fmla="*/ 2513491 h 3392270"/>
              <a:gd name="connsiteX10" fmla="*/ 53582 w 1114106"/>
              <a:gd name="connsiteY10" fmla="*/ 2846866 h 3392270"/>
              <a:gd name="connsiteX11" fmla="*/ 72632 w 1114106"/>
              <a:gd name="connsiteY11" fmla="*/ 3180241 h 3392270"/>
              <a:gd name="connsiteX12" fmla="*/ 139307 w 1114106"/>
              <a:gd name="connsiteY12" fmla="*/ 3380266 h 3392270"/>
              <a:gd name="connsiteX13" fmla="*/ 53582 w 1114106"/>
              <a:gd name="connsiteY13" fmla="*/ 3370741 h 3392270"/>
              <a:gd name="connsiteX14" fmla="*/ 672707 w 1114106"/>
              <a:gd name="connsiteY14" fmla="*/ 3380266 h 3392270"/>
              <a:gd name="connsiteX15" fmla="*/ 634607 w 1114106"/>
              <a:gd name="connsiteY15" fmla="*/ 3370741 h 3392270"/>
              <a:gd name="connsiteX16" fmla="*/ 672707 w 1114106"/>
              <a:gd name="connsiteY16" fmla="*/ 3361216 h 3392270"/>
              <a:gd name="connsiteX17" fmla="*/ 672707 w 1114106"/>
              <a:gd name="connsiteY17" fmla="*/ 3275491 h 3392270"/>
              <a:gd name="connsiteX18" fmla="*/ 625082 w 1114106"/>
              <a:gd name="connsiteY18" fmla="*/ 3208816 h 3392270"/>
              <a:gd name="connsiteX19" fmla="*/ 615557 w 1114106"/>
              <a:gd name="connsiteY19" fmla="*/ 2999266 h 3392270"/>
              <a:gd name="connsiteX20" fmla="*/ 539357 w 1114106"/>
              <a:gd name="connsiteY20" fmla="*/ 2675416 h 3392270"/>
              <a:gd name="connsiteX21" fmla="*/ 444107 w 1114106"/>
              <a:gd name="connsiteY21" fmla="*/ 2561116 h 3392270"/>
              <a:gd name="connsiteX22" fmla="*/ 434582 w 1114106"/>
              <a:gd name="connsiteY22" fmla="*/ 2456341 h 3392270"/>
              <a:gd name="connsiteX23" fmla="*/ 491732 w 1114106"/>
              <a:gd name="connsiteY23" fmla="*/ 2342041 h 3392270"/>
              <a:gd name="connsiteX24" fmla="*/ 634607 w 1114106"/>
              <a:gd name="connsiteY24" fmla="*/ 2599216 h 3392270"/>
              <a:gd name="connsiteX25" fmla="*/ 729857 w 1114106"/>
              <a:gd name="connsiteY25" fmla="*/ 2589691 h 3392270"/>
              <a:gd name="connsiteX26" fmla="*/ 901307 w 1114106"/>
              <a:gd name="connsiteY26" fmla="*/ 2303941 h 3392270"/>
              <a:gd name="connsiteX27" fmla="*/ 844157 w 1114106"/>
              <a:gd name="connsiteY27" fmla="*/ 2084866 h 3392270"/>
              <a:gd name="connsiteX28" fmla="*/ 901307 w 1114106"/>
              <a:gd name="connsiteY28" fmla="*/ 1846741 h 3392270"/>
              <a:gd name="connsiteX29" fmla="*/ 929882 w 1114106"/>
              <a:gd name="connsiteY29" fmla="*/ 1656241 h 3392270"/>
              <a:gd name="connsiteX30" fmla="*/ 1053707 w 1114106"/>
              <a:gd name="connsiteY30" fmla="*/ 1494316 h 3392270"/>
              <a:gd name="connsiteX31" fmla="*/ 1110857 w 1114106"/>
              <a:gd name="connsiteY31" fmla="*/ 1265716 h 3392270"/>
              <a:gd name="connsiteX32" fmla="*/ 1101332 w 1114106"/>
              <a:gd name="connsiteY32" fmla="*/ 1065691 h 3392270"/>
              <a:gd name="connsiteX33" fmla="*/ 1053707 w 1114106"/>
              <a:gd name="connsiteY33" fmla="*/ 989491 h 3392270"/>
              <a:gd name="connsiteX34" fmla="*/ 891782 w 1114106"/>
              <a:gd name="connsiteY34" fmla="*/ 1046641 h 3392270"/>
              <a:gd name="connsiteX35" fmla="*/ 872732 w 1114106"/>
              <a:gd name="connsiteY35" fmla="*/ 903766 h 3392270"/>
              <a:gd name="connsiteX36" fmla="*/ 834632 w 1114106"/>
              <a:gd name="connsiteY36" fmla="*/ 713266 h 3392270"/>
              <a:gd name="connsiteX37" fmla="*/ 682232 w 1114106"/>
              <a:gd name="connsiteY37" fmla="*/ 646591 h 3392270"/>
              <a:gd name="connsiteX38" fmla="*/ 606032 w 1114106"/>
              <a:gd name="connsiteY38" fmla="*/ 608491 h 3392270"/>
              <a:gd name="connsiteX39" fmla="*/ 320282 w 1114106"/>
              <a:gd name="connsiteY39" fmla="*/ 475141 h 3392270"/>
              <a:gd name="connsiteX40" fmla="*/ 148832 w 1114106"/>
              <a:gd name="connsiteY40" fmla="*/ 27466 h 3392270"/>
              <a:gd name="connsiteX41" fmla="*/ 186932 w 1114106"/>
              <a:gd name="connsiteY41" fmla="*/ 46516 h 3392270"/>
              <a:gd name="connsiteX42" fmla="*/ 5957 w 1114106"/>
              <a:gd name="connsiteY42" fmla="*/ 56041 h 3392270"/>
              <a:gd name="connsiteX0" fmla="*/ 5957 w 1114106"/>
              <a:gd name="connsiteY0" fmla="*/ 56041 h 3392270"/>
              <a:gd name="connsiteX1" fmla="*/ 48820 w 1114106"/>
              <a:gd name="connsiteY1" fmla="*/ 156054 h 3392270"/>
              <a:gd name="connsiteX2" fmla="*/ 110732 w 1114106"/>
              <a:gd name="connsiteY2" fmla="*/ 408466 h 3392270"/>
              <a:gd name="connsiteX3" fmla="*/ 101207 w 1114106"/>
              <a:gd name="connsiteY3" fmla="*/ 465616 h 3392270"/>
              <a:gd name="connsiteX4" fmla="*/ 148832 w 1114106"/>
              <a:gd name="connsiteY4" fmla="*/ 656116 h 3392270"/>
              <a:gd name="connsiteX5" fmla="*/ 129782 w 1114106"/>
              <a:gd name="connsiteY5" fmla="*/ 846616 h 3392270"/>
              <a:gd name="connsiteX6" fmla="*/ 196457 w 1114106"/>
              <a:gd name="connsiteY6" fmla="*/ 1027591 h 3392270"/>
              <a:gd name="connsiteX7" fmla="*/ 15482 w 1114106"/>
              <a:gd name="connsiteY7" fmla="*/ 1446691 h 3392270"/>
              <a:gd name="connsiteX8" fmla="*/ 72632 w 1114106"/>
              <a:gd name="connsiteY8" fmla="*/ 1732441 h 3392270"/>
              <a:gd name="connsiteX9" fmla="*/ 63107 w 1114106"/>
              <a:gd name="connsiteY9" fmla="*/ 2256316 h 3392270"/>
              <a:gd name="connsiteX10" fmla="*/ 110732 w 1114106"/>
              <a:gd name="connsiteY10" fmla="*/ 2513491 h 3392270"/>
              <a:gd name="connsiteX11" fmla="*/ 53582 w 1114106"/>
              <a:gd name="connsiteY11" fmla="*/ 2846866 h 3392270"/>
              <a:gd name="connsiteX12" fmla="*/ 72632 w 1114106"/>
              <a:gd name="connsiteY12" fmla="*/ 3180241 h 3392270"/>
              <a:gd name="connsiteX13" fmla="*/ 139307 w 1114106"/>
              <a:gd name="connsiteY13" fmla="*/ 3380266 h 3392270"/>
              <a:gd name="connsiteX14" fmla="*/ 53582 w 1114106"/>
              <a:gd name="connsiteY14" fmla="*/ 3370741 h 3392270"/>
              <a:gd name="connsiteX15" fmla="*/ 672707 w 1114106"/>
              <a:gd name="connsiteY15" fmla="*/ 3380266 h 3392270"/>
              <a:gd name="connsiteX16" fmla="*/ 634607 w 1114106"/>
              <a:gd name="connsiteY16" fmla="*/ 3370741 h 3392270"/>
              <a:gd name="connsiteX17" fmla="*/ 672707 w 1114106"/>
              <a:gd name="connsiteY17" fmla="*/ 3361216 h 3392270"/>
              <a:gd name="connsiteX18" fmla="*/ 672707 w 1114106"/>
              <a:gd name="connsiteY18" fmla="*/ 3275491 h 3392270"/>
              <a:gd name="connsiteX19" fmla="*/ 625082 w 1114106"/>
              <a:gd name="connsiteY19" fmla="*/ 3208816 h 3392270"/>
              <a:gd name="connsiteX20" fmla="*/ 615557 w 1114106"/>
              <a:gd name="connsiteY20" fmla="*/ 2999266 h 3392270"/>
              <a:gd name="connsiteX21" fmla="*/ 539357 w 1114106"/>
              <a:gd name="connsiteY21" fmla="*/ 2675416 h 3392270"/>
              <a:gd name="connsiteX22" fmla="*/ 444107 w 1114106"/>
              <a:gd name="connsiteY22" fmla="*/ 2561116 h 3392270"/>
              <a:gd name="connsiteX23" fmla="*/ 434582 w 1114106"/>
              <a:gd name="connsiteY23" fmla="*/ 2456341 h 3392270"/>
              <a:gd name="connsiteX24" fmla="*/ 491732 w 1114106"/>
              <a:gd name="connsiteY24" fmla="*/ 2342041 h 3392270"/>
              <a:gd name="connsiteX25" fmla="*/ 634607 w 1114106"/>
              <a:gd name="connsiteY25" fmla="*/ 2599216 h 3392270"/>
              <a:gd name="connsiteX26" fmla="*/ 729857 w 1114106"/>
              <a:gd name="connsiteY26" fmla="*/ 2589691 h 3392270"/>
              <a:gd name="connsiteX27" fmla="*/ 901307 w 1114106"/>
              <a:gd name="connsiteY27" fmla="*/ 2303941 h 3392270"/>
              <a:gd name="connsiteX28" fmla="*/ 844157 w 1114106"/>
              <a:gd name="connsiteY28" fmla="*/ 2084866 h 3392270"/>
              <a:gd name="connsiteX29" fmla="*/ 901307 w 1114106"/>
              <a:gd name="connsiteY29" fmla="*/ 1846741 h 3392270"/>
              <a:gd name="connsiteX30" fmla="*/ 929882 w 1114106"/>
              <a:gd name="connsiteY30" fmla="*/ 1656241 h 3392270"/>
              <a:gd name="connsiteX31" fmla="*/ 1053707 w 1114106"/>
              <a:gd name="connsiteY31" fmla="*/ 1494316 h 3392270"/>
              <a:gd name="connsiteX32" fmla="*/ 1110857 w 1114106"/>
              <a:gd name="connsiteY32" fmla="*/ 1265716 h 3392270"/>
              <a:gd name="connsiteX33" fmla="*/ 1101332 w 1114106"/>
              <a:gd name="connsiteY33" fmla="*/ 1065691 h 3392270"/>
              <a:gd name="connsiteX34" fmla="*/ 1053707 w 1114106"/>
              <a:gd name="connsiteY34" fmla="*/ 989491 h 3392270"/>
              <a:gd name="connsiteX35" fmla="*/ 891782 w 1114106"/>
              <a:gd name="connsiteY35" fmla="*/ 1046641 h 3392270"/>
              <a:gd name="connsiteX36" fmla="*/ 872732 w 1114106"/>
              <a:gd name="connsiteY36" fmla="*/ 903766 h 3392270"/>
              <a:gd name="connsiteX37" fmla="*/ 834632 w 1114106"/>
              <a:gd name="connsiteY37" fmla="*/ 713266 h 3392270"/>
              <a:gd name="connsiteX38" fmla="*/ 682232 w 1114106"/>
              <a:gd name="connsiteY38" fmla="*/ 646591 h 3392270"/>
              <a:gd name="connsiteX39" fmla="*/ 606032 w 1114106"/>
              <a:gd name="connsiteY39" fmla="*/ 608491 h 3392270"/>
              <a:gd name="connsiteX40" fmla="*/ 320282 w 1114106"/>
              <a:gd name="connsiteY40" fmla="*/ 475141 h 3392270"/>
              <a:gd name="connsiteX41" fmla="*/ 148832 w 1114106"/>
              <a:gd name="connsiteY41" fmla="*/ 27466 h 3392270"/>
              <a:gd name="connsiteX42" fmla="*/ 186932 w 1114106"/>
              <a:gd name="connsiteY42" fmla="*/ 46516 h 3392270"/>
              <a:gd name="connsiteX43" fmla="*/ 5957 w 1114106"/>
              <a:gd name="connsiteY43" fmla="*/ 56041 h 3392270"/>
              <a:gd name="connsiteX0" fmla="*/ 5568 w 1118479"/>
              <a:gd name="connsiteY0" fmla="*/ 37267 h 3392546"/>
              <a:gd name="connsiteX1" fmla="*/ 53193 w 1118479"/>
              <a:gd name="connsiteY1" fmla="*/ 156330 h 3392546"/>
              <a:gd name="connsiteX2" fmla="*/ 115105 w 1118479"/>
              <a:gd name="connsiteY2" fmla="*/ 408742 h 3392546"/>
              <a:gd name="connsiteX3" fmla="*/ 105580 w 1118479"/>
              <a:gd name="connsiteY3" fmla="*/ 465892 h 3392546"/>
              <a:gd name="connsiteX4" fmla="*/ 153205 w 1118479"/>
              <a:gd name="connsiteY4" fmla="*/ 656392 h 3392546"/>
              <a:gd name="connsiteX5" fmla="*/ 134155 w 1118479"/>
              <a:gd name="connsiteY5" fmla="*/ 846892 h 3392546"/>
              <a:gd name="connsiteX6" fmla="*/ 200830 w 1118479"/>
              <a:gd name="connsiteY6" fmla="*/ 1027867 h 3392546"/>
              <a:gd name="connsiteX7" fmla="*/ 19855 w 1118479"/>
              <a:gd name="connsiteY7" fmla="*/ 1446967 h 3392546"/>
              <a:gd name="connsiteX8" fmla="*/ 77005 w 1118479"/>
              <a:gd name="connsiteY8" fmla="*/ 1732717 h 3392546"/>
              <a:gd name="connsiteX9" fmla="*/ 67480 w 1118479"/>
              <a:gd name="connsiteY9" fmla="*/ 2256592 h 3392546"/>
              <a:gd name="connsiteX10" fmla="*/ 115105 w 1118479"/>
              <a:gd name="connsiteY10" fmla="*/ 2513767 h 3392546"/>
              <a:gd name="connsiteX11" fmla="*/ 57955 w 1118479"/>
              <a:gd name="connsiteY11" fmla="*/ 2847142 h 3392546"/>
              <a:gd name="connsiteX12" fmla="*/ 77005 w 1118479"/>
              <a:gd name="connsiteY12" fmla="*/ 3180517 h 3392546"/>
              <a:gd name="connsiteX13" fmla="*/ 143680 w 1118479"/>
              <a:gd name="connsiteY13" fmla="*/ 3380542 h 3392546"/>
              <a:gd name="connsiteX14" fmla="*/ 57955 w 1118479"/>
              <a:gd name="connsiteY14" fmla="*/ 3371017 h 3392546"/>
              <a:gd name="connsiteX15" fmla="*/ 677080 w 1118479"/>
              <a:gd name="connsiteY15" fmla="*/ 3380542 h 3392546"/>
              <a:gd name="connsiteX16" fmla="*/ 638980 w 1118479"/>
              <a:gd name="connsiteY16" fmla="*/ 3371017 h 3392546"/>
              <a:gd name="connsiteX17" fmla="*/ 677080 w 1118479"/>
              <a:gd name="connsiteY17" fmla="*/ 3361492 h 3392546"/>
              <a:gd name="connsiteX18" fmla="*/ 677080 w 1118479"/>
              <a:gd name="connsiteY18" fmla="*/ 3275767 h 3392546"/>
              <a:gd name="connsiteX19" fmla="*/ 629455 w 1118479"/>
              <a:gd name="connsiteY19" fmla="*/ 3209092 h 3392546"/>
              <a:gd name="connsiteX20" fmla="*/ 619930 w 1118479"/>
              <a:gd name="connsiteY20" fmla="*/ 2999542 h 3392546"/>
              <a:gd name="connsiteX21" fmla="*/ 543730 w 1118479"/>
              <a:gd name="connsiteY21" fmla="*/ 2675692 h 3392546"/>
              <a:gd name="connsiteX22" fmla="*/ 448480 w 1118479"/>
              <a:gd name="connsiteY22" fmla="*/ 2561392 h 3392546"/>
              <a:gd name="connsiteX23" fmla="*/ 438955 w 1118479"/>
              <a:gd name="connsiteY23" fmla="*/ 2456617 h 3392546"/>
              <a:gd name="connsiteX24" fmla="*/ 496105 w 1118479"/>
              <a:gd name="connsiteY24" fmla="*/ 2342317 h 3392546"/>
              <a:gd name="connsiteX25" fmla="*/ 638980 w 1118479"/>
              <a:gd name="connsiteY25" fmla="*/ 2599492 h 3392546"/>
              <a:gd name="connsiteX26" fmla="*/ 734230 w 1118479"/>
              <a:gd name="connsiteY26" fmla="*/ 2589967 h 3392546"/>
              <a:gd name="connsiteX27" fmla="*/ 905680 w 1118479"/>
              <a:gd name="connsiteY27" fmla="*/ 2304217 h 3392546"/>
              <a:gd name="connsiteX28" fmla="*/ 848530 w 1118479"/>
              <a:gd name="connsiteY28" fmla="*/ 2085142 h 3392546"/>
              <a:gd name="connsiteX29" fmla="*/ 905680 w 1118479"/>
              <a:gd name="connsiteY29" fmla="*/ 1847017 h 3392546"/>
              <a:gd name="connsiteX30" fmla="*/ 934255 w 1118479"/>
              <a:gd name="connsiteY30" fmla="*/ 1656517 h 3392546"/>
              <a:gd name="connsiteX31" fmla="*/ 1058080 w 1118479"/>
              <a:gd name="connsiteY31" fmla="*/ 1494592 h 3392546"/>
              <a:gd name="connsiteX32" fmla="*/ 1115230 w 1118479"/>
              <a:gd name="connsiteY32" fmla="*/ 1265992 h 3392546"/>
              <a:gd name="connsiteX33" fmla="*/ 1105705 w 1118479"/>
              <a:gd name="connsiteY33" fmla="*/ 1065967 h 3392546"/>
              <a:gd name="connsiteX34" fmla="*/ 1058080 w 1118479"/>
              <a:gd name="connsiteY34" fmla="*/ 989767 h 3392546"/>
              <a:gd name="connsiteX35" fmla="*/ 896155 w 1118479"/>
              <a:gd name="connsiteY35" fmla="*/ 1046917 h 3392546"/>
              <a:gd name="connsiteX36" fmla="*/ 877105 w 1118479"/>
              <a:gd name="connsiteY36" fmla="*/ 904042 h 3392546"/>
              <a:gd name="connsiteX37" fmla="*/ 839005 w 1118479"/>
              <a:gd name="connsiteY37" fmla="*/ 713542 h 3392546"/>
              <a:gd name="connsiteX38" fmla="*/ 686605 w 1118479"/>
              <a:gd name="connsiteY38" fmla="*/ 646867 h 3392546"/>
              <a:gd name="connsiteX39" fmla="*/ 610405 w 1118479"/>
              <a:gd name="connsiteY39" fmla="*/ 608767 h 3392546"/>
              <a:gd name="connsiteX40" fmla="*/ 324655 w 1118479"/>
              <a:gd name="connsiteY40" fmla="*/ 475417 h 3392546"/>
              <a:gd name="connsiteX41" fmla="*/ 153205 w 1118479"/>
              <a:gd name="connsiteY41" fmla="*/ 27742 h 3392546"/>
              <a:gd name="connsiteX42" fmla="*/ 191305 w 1118479"/>
              <a:gd name="connsiteY42" fmla="*/ 46792 h 3392546"/>
              <a:gd name="connsiteX43" fmla="*/ 5568 w 1118479"/>
              <a:gd name="connsiteY43" fmla="*/ 37267 h 3392546"/>
              <a:gd name="connsiteX0" fmla="*/ 5568 w 1118479"/>
              <a:gd name="connsiteY0" fmla="*/ 37267 h 3392546"/>
              <a:gd name="connsiteX1" fmla="*/ 53193 w 1118479"/>
              <a:gd name="connsiteY1" fmla="*/ 156330 h 3392546"/>
              <a:gd name="connsiteX2" fmla="*/ 115105 w 1118479"/>
              <a:gd name="connsiteY2" fmla="*/ 408742 h 3392546"/>
              <a:gd name="connsiteX3" fmla="*/ 110342 w 1118479"/>
              <a:gd name="connsiteY3" fmla="*/ 503992 h 3392546"/>
              <a:gd name="connsiteX4" fmla="*/ 153205 w 1118479"/>
              <a:gd name="connsiteY4" fmla="*/ 656392 h 3392546"/>
              <a:gd name="connsiteX5" fmla="*/ 134155 w 1118479"/>
              <a:gd name="connsiteY5" fmla="*/ 846892 h 3392546"/>
              <a:gd name="connsiteX6" fmla="*/ 200830 w 1118479"/>
              <a:gd name="connsiteY6" fmla="*/ 1027867 h 3392546"/>
              <a:gd name="connsiteX7" fmla="*/ 19855 w 1118479"/>
              <a:gd name="connsiteY7" fmla="*/ 1446967 h 3392546"/>
              <a:gd name="connsiteX8" fmla="*/ 77005 w 1118479"/>
              <a:gd name="connsiteY8" fmla="*/ 1732717 h 3392546"/>
              <a:gd name="connsiteX9" fmla="*/ 67480 w 1118479"/>
              <a:gd name="connsiteY9" fmla="*/ 2256592 h 3392546"/>
              <a:gd name="connsiteX10" fmla="*/ 115105 w 1118479"/>
              <a:gd name="connsiteY10" fmla="*/ 2513767 h 3392546"/>
              <a:gd name="connsiteX11" fmla="*/ 57955 w 1118479"/>
              <a:gd name="connsiteY11" fmla="*/ 2847142 h 3392546"/>
              <a:gd name="connsiteX12" fmla="*/ 77005 w 1118479"/>
              <a:gd name="connsiteY12" fmla="*/ 3180517 h 3392546"/>
              <a:gd name="connsiteX13" fmla="*/ 143680 w 1118479"/>
              <a:gd name="connsiteY13" fmla="*/ 3380542 h 3392546"/>
              <a:gd name="connsiteX14" fmla="*/ 57955 w 1118479"/>
              <a:gd name="connsiteY14" fmla="*/ 3371017 h 3392546"/>
              <a:gd name="connsiteX15" fmla="*/ 677080 w 1118479"/>
              <a:gd name="connsiteY15" fmla="*/ 3380542 h 3392546"/>
              <a:gd name="connsiteX16" fmla="*/ 638980 w 1118479"/>
              <a:gd name="connsiteY16" fmla="*/ 3371017 h 3392546"/>
              <a:gd name="connsiteX17" fmla="*/ 677080 w 1118479"/>
              <a:gd name="connsiteY17" fmla="*/ 3361492 h 3392546"/>
              <a:gd name="connsiteX18" fmla="*/ 677080 w 1118479"/>
              <a:gd name="connsiteY18" fmla="*/ 3275767 h 3392546"/>
              <a:gd name="connsiteX19" fmla="*/ 629455 w 1118479"/>
              <a:gd name="connsiteY19" fmla="*/ 3209092 h 3392546"/>
              <a:gd name="connsiteX20" fmla="*/ 619930 w 1118479"/>
              <a:gd name="connsiteY20" fmla="*/ 2999542 h 3392546"/>
              <a:gd name="connsiteX21" fmla="*/ 543730 w 1118479"/>
              <a:gd name="connsiteY21" fmla="*/ 2675692 h 3392546"/>
              <a:gd name="connsiteX22" fmla="*/ 448480 w 1118479"/>
              <a:gd name="connsiteY22" fmla="*/ 2561392 h 3392546"/>
              <a:gd name="connsiteX23" fmla="*/ 438955 w 1118479"/>
              <a:gd name="connsiteY23" fmla="*/ 2456617 h 3392546"/>
              <a:gd name="connsiteX24" fmla="*/ 496105 w 1118479"/>
              <a:gd name="connsiteY24" fmla="*/ 2342317 h 3392546"/>
              <a:gd name="connsiteX25" fmla="*/ 638980 w 1118479"/>
              <a:gd name="connsiteY25" fmla="*/ 2599492 h 3392546"/>
              <a:gd name="connsiteX26" fmla="*/ 734230 w 1118479"/>
              <a:gd name="connsiteY26" fmla="*/ 2589967 h 3392546"/>
              <a:gd name="connsiteX27" fmla="*/ 905680 w 1118479"/>
              <a:gd name="connsiteY27" fmla="*/ 2304217 h 3392546"/>
              <a:gd name="connsiteX28" fmla="*/ 848530 w 1118479"/>
              <a:gd name="connsiteY28" fmla="*/ 2085142 h 3392546"/>
              <a:gd name="connsiteX29" fmla="*/ 905680 w 1118479"/>
              <a:gd name="connsiteY29" fmla="*/ 1847017 h 3392546"/>
              <a:gd name="connsiteX30" fmla="*/ 934255 w 1118479"/>
              <a:gd name="connsiteY30" fmla="*/ 1656517 h 3392546"/>
              <a:gd name="connsiteX31" fmla="*/ 1058080 w 1118479"/>
              <a:gd name="connsiteY31" fmla="*/ 1494592 h 3392546"/>
              <a:gd name="connsiteX32" fmla="*/ 1115230 w 1118479"/>
              <a:gd name="connsiteY32" fmla="*/ 1265992 h 3392546"/>
              <a:gd name="connsiteX33" fmla="*/ 1105705 w 1118479"/>
              <a:gd name="connsiteY33" fmla="*/ 1065967 h 3392546"/>
              <a:gd name="connsiteX34" fmla="*/ 1058080 w 1118479"/>
              <a:gd name="connsiteY34" fmla="*/ 989767 h 3392546"/>
              <a:gd name="connsiteX35" fmla="*/ 896155 w 1118479"/>
              <a:gd name="connsiteY35" fmla="*/ 1046917 h 3392546"/>
              <a:gd name="connsiteX36" fmla="*/ 877105 w 1118479"/>
              <a:gd name="connsiteY36" fmla="*/ 904042 h 3392546"/>
              <a:gd name="connsiteX37" fmla="*/ 839005 w 1118479"/>
              <a:gd name="connsiteY37" fmla="*/ 713542 h 3392546"/>
              <a:gd name="connsiteX38" fmla="*/ 686605 w 1118479"/>
              <a:gd name="connsiteY38" fmla="*/ 646867 h 3392546"/>
              <a:gd name="connsiteX39" fmla="*/ 610405 w 1118479"/>
              <a:gd name="connsiteY39" fmla="*/ 608767 h 3392546"/>
              <a:gd name="connsiteX40" fmla="*/ 324655 w 1118479"/>
              <a:gd name="connsiteY40" fmla="*/ 475417 h 3392546"/>
              <a:gd name="connsiteX41" fmla="*/ 153205 w 1118479"/>
              <a:gd name="connsiteY41" fmla="*/ 27742 h 3392546"/>
              <a:gd name="connsiteX42" fmla="*/ 191305 w 1118479"/>
              <a:gd name="connsiteY42" fmla="*/ 46792 h 3392546"/>
              <a:gd name="connsiteX43" fmla="*/ 5568 w 1118479"/>
              <a:gd name="connsiteY43" fmla="*/ 37267 h 3392546"/>
              <a:gd name="connsiteX0" fmla="*/ 5568 w 1118479"/>
              <a:gd name="connsiteY0" fmla="*/ 37267 h 3392546"/>
              <a:gd name="connsiteX1" fmla="*/ 53193 w 1118479"/>
              <a:gd name="connsiteY1" fmla="*/ 156330 h 3392546"/>
              <a:gd name="connsiteX2" fmla="*/ 57956 w 1118479"/>
              <a:gd name="connsiteY2" fmla="*/ 242055 h 3392546"/>
              <a:gd name="connsiteX3" fmla="*/ 115105 w 1118479"/>
              <a:gd name="connsiteY3" fmla="*/ 408742 h 3392546"/>
              <a:gd name="connsiteX4" fmla="*/ 110342 w 1118479"/>
              <a:gd name="connsiteY4" fmla="*/ 503992 h 3392546"/>
              <a:gd name="connsiteX5" fmla="*/ 153205 w 1118479"/>
              <a:gd name="connsiteY5" fmla="*/ 656392 h 3392546"/>
              <a:gd name="connsiteX6" fmla="*/ 134155 w 1118479"/>
              <a:gd name="connsiteY6" fmla="*/ 846892 h 3392546"/>
              <a:gd name="connsiteX7" fmla="*/ 200830 w 1118479"/>
              <a:gd name="connsiteY7" fmla="*/ 1027867 h 3392546"/>
              <a:gd name="connsiteX8" fmla="*/ 19855 w 1118479"/>
              <a:gd name="connsiteY8" fmla="*/ 1446967 h 3392546"/>
              <a:gd name="connsiteX9" fmla="*/ 77005 w 1118479"/>
              <a:gd name="connsiteY9" fmla="*/ 1732717 h 3392546"/>
              <a:gd name="connsiteX10" fmla="*/ 67480 w 1118479"/>
              <a:gd name="connsiteY10" fmla="*/ 2256592 h 3392546"/>
              <a:gd name="connsiteX11" fmla="*/ 115105 w 1118479"/>
              <a:gd name="connsiteY11" fmla="*/ 2513767 h 3392546"/>
              <a:gd name="connsiteX12" fmla="*/ 57955 w 1118479"/>
              <a:gd name="connsiteY12" fmla="*/ 2847142 h 3392546"/>
              <a:gd name="connsiteX13" fmla="*/ 77005 w 1118479"/>
              <a:gd name="connsiteY13" fmla="*/ 3180517 h 3392546"/>
              <a:gd name="connsiteX14" fmla="*/ 143680 w 1118479"/>
              <a:gd name="connsiteY14" fmla="*/ 3380542 h 3392546"/>
              <a:gd name="connsiteX15" fmla="*/ 57955 w 1118479"/>
              <a:gd name="connsiteY15" fmla="*/ 3371017 h 3392546"/>
              <a:gd name="connsiteX16" fmla="*/ 677080 w 1118479"/>
              <a:gd name="connsiteY16" fmla="*/ 3380542 h 3392546"/>
              <a:gd name="connsiteX17" fmla="*/ 638980 w 1118479"/>
              <a:gd name="connsiteY17" fmla="*/ 3371017 h 3392546"/>
              <a:gd name="connsiteX18" fmla="*/ 677080 w 1118479"/>
              <a:gd name="connsiteY18" fmla="*/ 3361492 h 3392546"/>
              <a:gd name="connsiteX19" fmla="*/ 677080 w 1118479"/>
              <a:gd name="connsiteY19" fmla="*/ 3275767 h 3392546"/>
              <a:gd name="connsiteX20" fmla="*/ 629455 w 1118479"/>
              <a:gd name="connsiteY20" fmla="*/ 3209092 h 3392546"/>
              <a:gd name="connsiteX21" fmla="*/ 619930 w 1118479"/>
              <a:gd name="connsiteY21" fmla="*/ 2999542 h 3392546"/>
              <a:gd name="connsiteX22" fmla="*/ 543730 w 1118479"/>
              <a:gd name="connsiteY22" fmla="*/ 2675692 h 3392546"/>
              <a:gd name="connsiteX23" fmla="*/ 448480 w 1118479"/>
              <a:gd name="connsiteY23" fmla="*/ 2561392 h 3392546"/>
              <a:gd name="connsiteX24" fmla="*/ 438955 w 1118479"/>
              <a:gd name="connsiteY24" fmla="*/ 2456617 h 3392546"/>
              <a:gd name="connsiteX25" fmla="*/ 496105 w 1118479"/>
              <a:gd name="connsiteY25" fmla="*/ 2342317 h 3392546"/>
              <a:gd name="connsiteX26" fmla="*/ 638980 w 1118479"/>
              <a:gd name="connsiteY26" fmla="*/ 2599492 h 3392546"/>
              <a:gd name="connsiteX27" fmla="*/ 734230 w 1118479"/>
              <a:gd name="connsiteY27" fmla="*/ 2589967 h 3392546"/>
              <a:gd name="connsiteX28" fmla="*/ 905680 w 1118479"/>
              <a:gd name="connsiteY28" fmla="*/ 2304217 h 3392546"/>
              <a:gd name="connsiteX29" fmla="*/ 848530 w 1118479"/>
              <a:gd name="connsiteY29" fmla="*/ 2085142 h 3392546"/>
              <a:gd name="connsiteX30" fmla="*/ 905680 w 1118479"/>
              <a:gd name="connsiteY30" fmla="*/ 1847017 h 3392546"/>
              <a:gd name="connsiteX31" fmla="*/ 934255 w 1118479"/>
              <a:gd name="connsiteY31" fmla="*/ 1656517 h 3392546"/>
              <a:gd name="connsiteX32" fmla="*/ 1058080 w 1118479"/>
              <a:gd name="connsiteY32" fmla="*/ 1494592 h 3392546"/>
              <a:gd name="connsiteX33" fmla="*/ 1115230 w 1118479"/>
              <a:gd name="connsiteY33" fmla="*/ 1265992 h 3392546"/>
              <a:gd name="connsiteX34" fmla="*/ 1105705 w 1118479"/>
              <a:gd name="connsiteY34" fmla="*/ 1065967 h 3392546"/>
              <a:gd name="connsiteX35" fmla="*/ 1058080 w 1118479"/>
              <a:gd name="connsiteY35" fmla="*/ 989767 h 3392546"/>
              <a:gd name="connsiteX36" fmla="*/ 896155 w 1118479"/>
              <a:gd name="connsiteY36" fmla="*/ 1046917 h 3392546"/>
              <a:gd name="connsiteX37" fmla="*/ 877105 w 1118479"/>
              <a:gd name="connsiteY37" fmla="*/ 904042 h 3392546"/>
              <a:gd name="connsiteX38" fmla="*/ 839005 w 1118479"/>
              <a:gd name="connsiteY38" fmla="*/ 713542 h 3392546"/>
              <a:gd name="connsiteX39" fmla="*/ 686605 w 1118479"/>
              <a:gd name="connsiteY39" fmla="*/ 646867 h 3392546"/>
              <a:gd name="connsiteX40" fmla="*/ 610405 w 1118479"/>
              <a:gd name="connsiteY40" fmla="*/ 608767 h 3392546"/>
              <a:gd name="connsiteX41" fmla="*/ 324655 w 1118479"/>
              <a:gd name="connsiteY41" fmla="*/ 475417 h 3392546"/>
              <a:gd name="connsiteX42" fmla="*/ 153205 w 1118479"/>
              <a:gd name="connsiteY42" fmla="*/ 27742 h 3392546"/>
              <a:gd name="connsiteX43" fmla="*/ 191305 w 1118479"/>
              <a:gd name="connsiteY43" fmla="*/ 46792 h 3392546"/>
              <a:gd name="connsiteX44" fmla="*/ 5568 w 1118479"/>
              <a:gd name="connsiteY44" fmla="*/ 37267 h 3392546"/>
              <a:gd name="connsiteX0" fmla="*/ 5568 w 1118479"/>
              <a:gd name="connsiteY0" fmla="*/ 7069 h 3362348"/>
              <a:gd name="connsiteX1" fmla="*/ 53193 w 1118479"/>
              <a:gd name="connsiteY1" fmla="*/ 126132 h 3362348"/>
              <a:gd name="connsiteX2" fmla="*/ 57956 w 1118479"/>
              <a:gd name="connsiteY2" fmla="*/ 211857 h 3362348"/>
              <a:gd name="connsiteX3" fmla="*/ 115105 w 1118479"/>
              <a:gd name="connsiteY3" fmla="*/ 378544 h 3362348"/>
              <a:gd name="connsiteX4" fmla="*/ 110342 w 1118479"/>
              <a:gd name="connsiteY4" fmla="*/ 473794 h 3362348"/>
              <a:gd name="connsiteX5" fmla="*/ 153205 w 1118479"/>
              <a:gd name="connsiteY5" fmla="*/ 626194 h 3362348"/>
              <a:gd name="connsiteX6" fmla="*/ 134155 w 1118479"/>
              <a:gd name="connsiteY6" fmla="*/ 816694 h 3362348"/>
              <a:gd name="connsiteX7" fmla="*/ 200830 w 1118479"/>
              <a:gd name="connsiteY7" fmla="*/ 997669 h 3362348"/>
              <a:gd name="connsiteX8" fmla="*/ 19855 w 1118479"/>
              <a:gd name="connsiteY8" fmla="*/ 1416769 h 3362348"/>
              <a:gd name="connsiteX9" fmla="*/ 77005 w 1118479"/>
              <a:gd name="connsiteY9" fmla="*/ 1702519 h 3362348"/>
              <a:gd name="connsiteX10" fmla="*/ 67480 w 1118479"/>
              <a:gd name="connsiteY10" fmla="*/ 2226394 h 3362348"/>
              <a:gd name="connsiteX11" fmla="*/ 115105 w 1118479"/>
              <a:gd name="connsiteY11" fmla="*/ 2483569 h 3362348"/>
              <a:gd name="connsiteX12" fmla="*/ 57955 w 1118479"/>
              <a:gd name="connsiteY12" fmla="*/ 2816944 h 3362348"/>
              <a:gd name="connsiteX13" fmla="*/ 77005 w 1118479"/>
              <a:gd name="connsiteY13" fmla="*/ 3150319 h 3362348"/>
              <a:gd name="connsiteX14" fmla="*/ 143680 w 1118479"/>
              <a:gd name="connsiteY14" fmla="*/ 3350344 h 3362348"/>
              <a:gd name="connsiteX15" fmla="*/ 57955 w 1118479"/>
              <a:gd name="connsiteY15" fmla="*/ 3340819 h 3362348"/>
              <a:gd name="connsiteX16" fmla="*/ 677080 w 1118479"/>
              <a:gd name="connsiteY16" fmla="*/ 3350344 h 3362348"/>
              <a:gd name="connsiteX17" fmla="*/ 638980 w 1118479"/>
              <a:gd name="connsiteY17" fmla="*/ 3340819 h 3362348"/>
              <a:gd name="connsiteX18" fmla="*/ 677080 w 1118479"/>
              <a:gd name="connsiteY18" fmla="*/ 3331294 h 3362348"/>
              <a:gd name="connsiteX19" fmla="*/ 677080 w 1118479"/>
              <a:gd name="connsiteY19" fmla="*/ 3245569 h 3362348"/>
              <a:gd name="connsiteX20" fmla="*/ 629455 w 1118479"/>
              <a:gd name="connsiteY20" fmla="*/ 3178894 h 3362348"/>
              <a:gd name="connsiteX21" fmla="*/ 619930 w 1118479"/>
              <a:gd name="connsiteY21" fmla="*/ 2969344 h 3362348"/>
              <a:gd name="connsiteX22" fmla="*/ 543730 w 1118479"/>
              <a:gd name="connsiteY22" fmla="*/ 2645494 h 3362348"/>
              <a:gd name="connsiteX23" fmla="*/ 448480 w 1118479"/>
              <a:gd name="connsiteY23" fmla="*/ 2531194 h 3362348"/>
              <a:gd name="connsiteX24" fmla="*/ 438955 w 1118479"/>
              <a:gd name="connsiteY24" fmla="*/ 2426419 h 3362348"/>
              <a:gd name="connsiteX25" fmla="*/ 496105 w 1118479"/>
              <a:gd name="connsiteY25" fmla="*/ 2312119 h 3362348"/>
              <a:gd name="connsiteX26" fmla="*/ 638980 w 1118479"/>
              <a:gd name="connsiteY26" fmla="*/ 2569294 h 3362348"/>
              <a:gd name="connsiteX27" fmla="*/ 734230 w 1118479"/>
              <a:gd name="connsiteY27" fmla="*/ 2559769 h 3362348"/>
              <a:gd name="connsiteX28" fmla="*/ 905680 w 1118479"/>
              <a:gd name="connsiteY28" fmla="*/ 2274019 h 3362348"/>
              <a:gd name="connsiteX29" fmla="*/ 848530 w 1118479"/>
              <a:gd name="connsiteY29" fmla="*/ 2054944 h 3362348"/>
              <a:gd name="connsiteX30" fmla="*/ 905680 w 1118479"/>
              <a:gd name="connsiteY30" fmla="*/ 1816819 h 3362348"/>
              <a:gd name="connsiteX31" fmla="*/ 934255 w 1118479"/>
              <a:gd name="connsiteY31" fmla="*/ 1626319 h 3362348"/>
              <a:gd name="connsiteX32" fmla="*/ 1058080 w 1118479"/>
              <a:gd name="connsiteY32" fmla="*/ 1464394 h 3362348"/>
              <a:gd name="connsiteX33" fmla="*/ 1115230 w 1118479"/>
              <a:gd name="connsiteY33" fmla="*/ 1235794 h 3362348"/>
              <a:gd name="connsiteX34" fmla="*/ 1105705 w 1118479"/>
              <a:gd name="connsiteY34" fmla="*/ 1035769 h 3362348"/>
              <a:gd name="connsiteX35" fmla="*/ 1058080 w 1118479"/>
              <a:gd name="connsiteY35" fmla="*/ 959569 h 3362348"/>
              <a:gd name="connsiteX36" fmla="*/ 896155 w 1118479"/>
              <a:gd name="connsiteY36" fmla="*/ 1016719 h 3362348"/>
              <a:gd name="connsiteX37" fmla="*/ 877105 w 1118479"/>
              <a:gd name="connsiteY37" fmla="*/ 873844 h 3362348"/>
              <a:gd name="connsiteX38" fmla="*/ 839005 w 1118479"/>
              <a:gd name="connsiteY38" fmla="*/ 683344 h 3362348"/>
              <a:gd name="connsiteX39" fmla="*/ 686605 w 1118479"/>
              <a:gd name="connsiteY39" fmla="*/ 616669 h 3362348"/>
              <a:gd name="connsiteX40" fmla="*/ 610405 w 1118479"/>
              <a:gd name="connsiteY40" fmla="*/ 578569 h 3362348"/>
              <a:gd name="connsiteX41" fmla="*/ 324655 w 1118479"/>
              <a:gd name="connsiteY41" fmla="*/ 445219 h 3362348"/>
              <a:gd name="connsiteX42" fmla="*/ 162730 w 1118479"/>
              <a:gd name="connsiteY42" fmla="*/ 40407 h 3362348"/>
              <a:gd name="connsiteX43" fmla="*/ 191305 w 1118479"/>
              <a:gd name="connsiteY43" fmla="*/ 16594 h 3362348"/>
              <a:gd name="connsiteX44" fmla="*/ 5568 w 1118479"/>
              <a:gd name="connsiteY44" fmla="*/ 7069 h 3362348"/>
              <a:gd name="connsiteX0" fmla="*/ 4215 w 1117126"/>
              <a:gd name="connsiteY0" fmla="*/ 10188 h 3365467"/>
              <a:gd name="connsiteX1" fmla="*/ 51840 w 1117126"/>
              <a:gd name="connsiteY1" fmla="*/ 129251 h 3365467"/>
              <a:gd name="connsiteX2" fmla="*/ 56603 w 1117126"/>
              <a:gd name="connsiteY2" fmla="*/ 214976 h 3365467"/>
              <a:gd name="connsiteX3" fmla="*/ 113752 w 1117126"/>
              <a:gd name="connsiteY3" fmla="*/ 381663 h 3365467"/>
              <a:gd name="connsiteX4" fmla="*/ 108989 w 1117126"/>
              <a:gd name="connsiteY4" fmla="*/ 476913 h 3365467"/>
              <a:gd name="connsiteX5" fmla="*/ 151852 w 1117126"/>
              <a:gd name="connsiteY5" fmla="*/ 629313 h 3365467"/>
              <a:gd name="connsiteX6" fmla="*/ 132802 w 1117126"/>
              <a:gd name="connsiteY6" fmla="*/ 819813 h 3365467"/>
              <a:gd name="connsiteX7" fmla="*/ 199477 w 1117126"/>
              <a:gd name="connsiteY7" fmla="*/ 1000788 h 3365467"/>
              <a:gd name="connsiteX8" fmla="*/ 18502 w 1117126"/>
              <a:gd name="connsiteY8" fmla="*/ 1419888 h 3365467"/>
              <a:gd name="connsiteX9" fmla="*/ 75652 w 1117126"/>
              <a:gd name="connsiteY9" fmla="*/ 1705638 h 3365467"/>
              <a:gd name="connsiteX10" fmla="*/ 66127 w 1117126"/>
              <a:gd name="connsiteY10" fmla="*/ 2229513 h 3365467"/>
              <a:gd name="connsiteX11" fmla="*/ 113752 w 1117126"/>
              <a:gd name="connsiteY11" fmla="*/ 2486688 h 3365467"/>
              <a:gd name="connsiteX12" fmla="*/ 56602 w 1117126"/>
              <a:gd name="connsiteY12" fmla="*/ 2820063 h 3365467"/>
              <a:gd name="connsiteX13" fmla="*/ 75652 w 1117126"/>
              <a:gd name="connsiteY13" fmla="*/ 3153438 h 3365467"/>
              <a:gd name="connsiteX14" fmla="*/ 142327 w 1117126"/>
              <a:gd name="connsiteY14" fmla="*/ 3353463 h 3365467"/>
              <a:gd name="connsiteX15" fmla="*/ 56602 w 1117126"/>
              <a:gd name="connsiteY15" fmla="*/ 3343938 h 3365467"/>
              <a:gd name="connsiteX16" fmla="*/ 675727 w 1117126"/>
              <a:gd name="connsiteY16" fmla="*/ 3353463 h 3365467"/>
              <a:gd name="connsiteX17" fmla="*/ 637627 w 1117126"/>
              <a:gd name="connsiteY17" fmla="*/ 3343938 h 3365467"/>
              <a:gd name="connsiteX18" fmla="*/ 675727 w 1117126"/>
              <a:gd name="connsiteY18" fmla="*/ 3334413 h 3365467"/>
              <a:gd name="connsiteX19" fmla="*/ 675727 w 1117126"/>
              <a:gd name="connsiteY19" fmla="*/ 3248688 h 3365467"/>
              <a:gd name="connsiteX20" fmla="*/ 628102 w 1117126"/>
              <a:gd name="connsiteY20" fmla="*/ 3182013 h 3365467"/>
              <a:gd name="connsiteX21" fmla="*/ 618577 w 1117126"/>
              <a:gd name="connsiteY21" fmla="*/ 2972463 h 3365467"/>
              <a:gd name="connsiteX22" fmla="*/ 542377 w 1117126"/>
              <a:gd name="connsiteY22" fmla="*/ 2648613 h 3365467"/>
              <a:gd name="connsiteX23" fmla="*/ 447127 w 1117126"/>
              <a:gd name="connsiteY23" fmla="*/ 2534313 h 3365467"/>
              <a:gd name="connsiteX24" fmla="*/ 437602 w 1117126"/>
              <a:gd name="connsiteY24" fmla="*/ 2429538 h 3365467"/>
              <a:gd name="connsiteX25" fmla="*/ 494752 w 1117126"/>
              <a:gd name="connsiteY25" fmla="*/ 2315238 h 3365467"/>
              <a:gd name="connsiteX26" fmla="*/ 637627 w 1117126"/>
              <a:gd name="connsiteY26" fmla="*/ 2572413 h 3365467"/>
              <a:gd name="connsiteX27" fmla="*/ 732877 w 1117126"/>
              <a:gd name="connsiteY27" fmla="*/ 2562888 h 3365467"/>
              <a:gd name="connsiteX28" fmla="*/ 904327 w 1117126"/>
              <a:gd name="connsiteY28" fmla="*/ 2277138 h 3365467"/>
              <a:gd name="connsiteX29" fmla="*/ 847177 w 1117126"/>
              <a:gd name="connsiteY29" fmla="*/ 2058063 h 3365467"/>
              <a:gd name="connsiteX30" fmla="*/ 904327 w 1117126"/>
              <a:gd name="connsiteY30" fmla="*/ 1819938 h 3365467"/>
              <a:gd name="connsiteX31" fmla="*/ 932902 w 1117126"/>
              <a:gd name="connsiteY31" fmla="*/ 1629438 h 3365467"/>
              <a:gd name="connsiteX32" fmla="*/ 1056727 w 1117126"/>
              <a:gd name="connsiteY32" fmla="*/ 1467513 h 3365467"/>
              <a:gd name="connsiteX33" fmla="*/ 1113877 w 1117126"/>
              <a:gd name="connsiteY33" fmla="*/ 1238913 h 3365467"/>
              <a:gd name="connsiteX34" fmla="*/ 1104352 w 1117126"/>
              <a:gd name="connsiteY34" fmla="*/ 1038888 h 3365467"/>
              <a:gd name="connsiteX35" fmla="*/ 1056727 w 1117126"/>
              <a:gd name="connsiteY35" fmla="*/ 962688 h 3365467"/>
              <a:gd name="connsiteX36" fmla="*/ 894802 w 1117126"/>
              <a:gd name="connsiteY36" fmla="*/ 1019838 h 3365467"/>
              <a:gd name="connsiteX37" fmla="*/ 875752 w 1117126"/>
              <a:gd name="connsiteY37" fmla="*/ 876963 h 3365467"/>
              <a:gd name="connsiteX38" fmla="*/ 837652 w 1117126"/>
              <a:gd name="connsiteY38" fmla="*/ 686463 h 3365467"/>
              <a:gd name="connsiteX39" fmla="*/ 685252 w 1117126"/>
              <a:gd name="connsiteY39" fmla="*/ 619788 h 3365467"/>
              <a:gd name="connsiteX40" fmla="*/ 609052 w 1117126"/>
              <a:gd name="connsiteY40" fmla="*/ 581688 h 3365467"/>
              <a:gd name="connsiteX41" fmla="*/ 323302 w 1117126"/>
              <a:gd name="connsiteY41" fmla="*/ 448338 h 3365467"/>
              <a:gd name="connsiteX42" fmla="*/ 161377 w 1117126"/>
              <a:gd name="connsiteY42" fmla="*/ 43526 h 3365467"/>
              <a:gd name="connsiteX43" fmla="*/ 166139 w 1117126"/>
              <a:gd name="connsiteY43" fmla="*/ 10188 h 3365467"/>
              <a:gd name="connsiteX44" fmla="*/ 4215 w 1117126"/>
              <a:gd name="connsiteY44" fmla="*/ 10188 h 3365467"/>
              <a:gd name="connsiteX0" fmla="*/ 4215 w 1117126"/>
              <a:gd name="connsiteY0" fmla="*/ 10188 h 3365467"/>
              <a:gd name="connsiteX1" fmla="*/ 51840 w 1117126"/>
              <a:gd name="connsiteY1" fmla="*/ 129251 h 3365467"/>
              <a:gd name="connsiteX2" fmla="*/ 56603 w 1117126"/>
              <a:gd name="connsiteY2" fmla="*/ 214976 h 3365467"/>
              <a:gd name="connsiteX3" fmla="*/ 113752 w 1117126"/>
              <a:gd name="connsiteY3" fmla="*/ 381663 h 3365467"/>
              <a:gd name="connsiteX4" fmla="*/ 108989 w 1117126"/>
              <a:gd name="connsiteY4" fmla="*/ 476913 h 3365467"/>
              <a:gd name="connsiteX5" fmla="*/ 151852 w 1117126"/>
              <a:gd name="connsiteY5" fmla="*/ 629313 h 3365467"/>
              <a:gd name="connsiteX6" fmla="*/ 132802 w 1117126"/>
              <a:gd name="connsiteY6" fmla="*/ 819813 h 3365467"/>
              <a:gd name="connsiteX7" fmla="*/ 199477 w 1117126"/>
              <a:gd name="connsiteY7" fmla="*/ 1000788 h 3365467"/>
              <a:gd name="connsiteX8" fmla="*/ 18502 w 1117126"/>
              <a:gd name="connsiteY8" fmla="*/ 1419888 h 3365467"/>
              <a:gd name="connsiteX9" fmla="*/ 75652 w 1117126"/>
              <a:gd name="connsiteY9" fmla="*/ 1705638 h 3365467"/>
              <a:gd name="connsiteX10" fmla="*/ 66127 w 1117126"/>
              <a:gd name="connsiteY10" fmla="*/ 2229513 h 3365467"/>
              <a:gd name="connsiteX11" fmla="*/ 113752 w 1117126"/>
              <a:gd name="connsiteY11" fmla="*/ 2486688 h 3365467"/>
              <a:gd name="connsiteX12" fmla="*/ 56602 w 1117126"/>
              <a:gd name="connsiteY12" fmla="*/ 2820063 h 3365467"/>
              <a:gd name="connsiteX13" fmla="*/ 75652 w 1117126"/>
              <a:gd name="connsiteY13" fmla="*/ 3153438 h 3365467"/>
              <a:gd name="connsiteX14" fmla="*/ 142327 w 1117126"/>
              <a:gd name="connsiteY14" fmla="*/ 3353463 h 3365467"/>
              <a:gd name="connsiteX15" fmla="*/ 56602 w 1117126"/>
              <a:gd name="connsiteY15" fmla="*/ 3343938 h 3365467"/>
              <a:gd name="connsiteX16" fmla="*/ 675727 w 1117126"/>
              <a:gd name="connsiteY16" fmla="*/ 3353463 h 3365467"/>
              <a:gd name="connsiteX17" fmla="*/ 637627 w 1117126"/>
              <a:gd name="connsiteY17" fmla="*/ 3343938 h 3365467"/>
              <a:gd name="connsiteX18" fmla="*/ 675727 w 1117126"/>
              <a:gd name="connsiteY18" fmla="*/ 3334413 h 3365467"/>
              <a:gd name="connsiteX19" fmla="*/ 675727 w 1117126"/>
              <a:gd name="connsiteY19" fmla="*/ 3248688 h 3365467"/>
              <a:gd name="connsiteX20" fmla="*/ 628102 w 1117126"/>
              <a:gd name="connsiteY20" fmla="*/ 3182013 h 3365467"/>
              <a:gd name="connsiteX21" fmla="*/ 618577 w 1117126"/>
              <a:gd name="connsiteY21" fmla="*/ 2972463 h 3365467"/>
              <a:gd name="connsiteX22" fmla="*/ 542377 w 1117126"/>
              <a:gd name="connsiteY22" fmla="*/ 2648613 h 3365467"/>
              <a:gd name="connsiteX23" fmla="*/ 447127 w 1117126"/>
              <a:gd name="connsiteY23" fmla="*/ 2534313 h 3365467"/>
              <a:gd name="connsiteX24" fmla="*/ 437602 w 1117126"/>
              <a:gd name="connsiteY24" fmla="*/ 2429538 h 3365467"/>
              <a:gd name="connsiteX25" fmla="*/ 494752 w 1117126"/>
              <a:gd name="connsiteY25" fmla="*/ 2315238 h 3365467"/>
              <a:gd name="connsiteX26" fmla="*/ 637627 w 1117126"/>
              <a:gd name="connsiteY26" fmla="*/ 2572413 h 3365467"/>
              <a:gd name="connsiteX27" fmla="*/ 732877 w 1117126"/>
              <a:gd name="connsiteY27" fmla="*/ 2562888 h 3365467"/>
              <a:gd name="connsiteX28" fmla="*/ 904327 w 1117126"/>
              <a:gd name="connsiteY28" fmla="*/ 2277138 h 3365467"/>
              <a:gd name="connsiteX29" fmla="*/ 847177 w 1117126"/>
              <a:gd name="connsiteY29" fmla="*/ 2058063 h 3365467"/>
              <a:gd name="connsiteX30" fmla="*/ 904327 w 1117126"/>
              <a:gd name="connsiteY30" fmla="*/ 1819938 h 3365467"/>
              <a:gd name="connsiteX31" fmla="*/ 932902 w 1117126"/>
              <a:gd name="connsiteY31" fmla="*/ 1629438 h 3365467"/>
              <a:gd name="connsiteX32" fmla="*/ 1056727 w 1117126"/>
              <a:gd name="connsiteY32" fmla="*/ 1467513 h 3365467"/>
              <a:gd name="connsiteX33" fmla="*/ 1113877 w 1117126"/>
              <a:gd name="connsiteY33" fmla="*/ 1238913 h 3365467"/>
              <a:gd name="connsiteX34" fmla="*/ 1104352 w 1117126"/>
              <a:gd name="connsiteY34" fmla="*/ 1038888 h 3365467"/>
              <a:gd name="connsiteX35" fmla="*/ 1056727 w 1117126"/>
              <a:gd name="connsiteY35" fmla="*/ 962688 h 3365467"/>
              <a:gd name="connsiteX36" fmla="*/ 894802 w 1117126"/>
              <a:gd name="connsiteY36" fmla="*/ 1019838 h 3365467"/>
              <a:gd name="connsiteX37" fmla="*/ 875752 w 1117126"/>
              <a:gd name="connsiteY37" fmla="*/ 876963 h 3365467"/>
              <a:gd name="connsiteX38" fmla="*/ 837652 w 1117126"/>
              <a:gd name="connsiteY38" fmla="*/ 686463 h 3365467"/>
              <a:gd name="connsiteX39" fmla="*/ 666202 w 1117126"/>
              <a:gd name="connsiteY39" fmla="*/ 653126 h 3365467"/>
              <a:gd name="connsiteX40" fmla="*/ 609052 w 1117126"/>
              <a:gd name="connsiteY40" fmla="*/ 581688 h 3365467"/>
              <a:gd name="connsiteX41" fmla="*/ 323302 w 1117126"/>
              <a:gd name="connsiteY41" fmla="*/ 448338 h 3365467"/>
              <a:gd name="connsiteX42" fmla="*/ 161377 w 1117126"/>
              <a:gd name="connsiteY42" fmla="*/ 43526 h 3365467"/>
              <a:gd name="connsiteX43" fmla="*/ 166139 w 1117126"/>
              <a:gd name="connsiteY43" fmla="*/ 10188 h 3365467"/>
              <a:gd name="connsiteX44" fmla="*/ 4215 w 1117126"/>
              <a:gd name="connsiteY44" fmla="*/ 10188 h 3365467"/>
              <a:gd name="connsiteX0" fmla="*/ 4215 w 1117126"/>
              <a:gd name="connsiteY0" fmla="*/ 10188 h 3365467"/>
              <a:gd name="connsiteX1" fmla="*/ 51840 w 1117126"/>
              <a:gd name="connsiteY1" fmla="*/ 129251 h 3365467"/>
              <a:gd name="connsiteX2" fmla="*/ 56603 w 1117126"/>
              <a:gd name="connsiteY2" fmla="*/ 214976 h 3365467"/>
              <a:gd name="connsiteX3" fmla="*/ 113752 w 1117126"/>
              <a:gd name="connsiteY3" fmla="*/ 381663 h 3365467"/>
              <a:gd name="connsiteX4" fmla="*/ 108989 w 1117126"/>
              <a:gd name="connsiteY4" fmla="*/ 476913 h 3365467"/>
              <a:gd name="connsiteX5" fmla="*/ 151852 w 1117126"/>
              <a:gd name="connsiteY5" fmla="*/ 629313 h 3365467"/>
              <a:gd name="connsiteX6" fmla="*/ 132802 w 1117126"/>
              <a:gd name="connsiteY6" fmla="*/ 819813 h 3365467"/>
              <a:gd name="connsiteX7" fmla="*/ 199477 w 1117126"/>
              <a:gd name="connsiteY7" fmla="*/ 1000788 h 3365467"/>
              <a:gd name="connsiteX8" fmla="*/ 18502 w 1117126"/>
              <a:gd name="connsiteY8" fmla="*/ 1419888 h 3365467"/>
              <a:gd name="connsiteX9" fmla="*/ 75652 w 1117126"/>
              <a:gd name="connsiteY9" fmla="*/ 1705638 h 3365467"/>
              <a:gd name="connsiteX10" fmla="*/ 66127 w 1117126"/>
              <a:gd name="connsiteY10" fmla="*/ 2229513 h 3365467"/>
              <a:gd name="connsiteX11" fmla="*/ 113752 w 1117126"/>
              <a:gd name="connsiteY11" fmla="*/ 2486688 h 3365467"/>
              <a:gd name="connsiteX12" fmla="*/ 56602 w 1117126"/>
              <a:gd name="connsiteY12" fmla="*/ 2820063 h 3365467"/>
              <a:gd name="connsiteX13" fmla="*/ 75652 w 1117126"/>
              <a:gd name="connsiteY13" fmla="*/ 3153438 h 3365467"/>
              <a:gd name="connsiteX14" fmla="*/ 142327 w 1117126"/>
              <a:gd name="connsiteY14" fmla="*/ 3353463 h 3365467"/>
              <a:gd name="connsiteX15" fmla="*/ 56602 w 1117126"/>
              <a:gd name="connsiteY15" fmla="*/ 3343938 h 3365467"/>
              <a:gd name="connsiteX16" fmla="*/ 675727 w 1117126"/>
              <a:gd name="connsiteY16" fmla="*/ 3353463 h 3365467"/>
              <a:gd name="connsiteX17" fmla="*/ 637627 w 1117126"/>
              <a:gd name="connsiteY17" fmla="*/ 3343938 h 3365467"/>
              <a:gd name="connsiteX18" fmla="*/ 675727 w 1117126"/>
              <a:gd name="connsiteY18" fmla="*/ 3334413 h 3365467"/>
              <a:gd name="connsiteX19" fmla="*/ 675727 w 1117126"/>
              <a:gd name="connsiteY19" fmla="*/ 3248688 h 3365467"/>
              <a:gd name="connsiteX20" fmla="*/ 628102 w 1117126"/>
              <a:gd name="connsiteY20" fmla="*/ 3182013 h 3365467"/>
              <a:gd name="connsiteX21" fmla="*/ 618577 w 1117126"/>
              <a:gd name="connsiteY21" fmla="*/ 2972463 h 3365467"/>
              <a:gd name="connsiteX22" fmla="*/ 542377 w 1117126"/>
              <a:gd name="connsiteY22" fmla="*/ 2648613 h 3365467"/>
              <a:gd name="connsiteX23" fmla="*/ 447127 w 1117126"/>
              <a:gd name="connsiteY23" fmla="*/ 2534313 h 3365467"/>
              <a:gd name="connsiteX24" fmla="*/ 437602 w 1117126"/>
              <a:gd name="connsiteY24" fmla="*/ 2429538 h 3365467"/>
              <a:gd name="connsiteX25" fmla="*/ 494752 w 1117126"/>
              <a:gd name="connsiteY25" fmla="*/ 2315238 h 3365467"/>
              <a:gd name="connsiteX26" fmla="*/ 637627 w 1117126"/>
              <a:gd name="connsiteY26" fmla="*/ 2572413 h 3365467"/>
              <a:gd name="connsiteX27" fmla="*/ 732877 w 1117126"/>
              <a:gd name="connsiteY27" fmla="*/ 2562888 h 3365467"/>
              <a:gd name="connsiteX28" fmla="*/ 904327 w 1117126"/>
              <a:gd name="connsiteY28" fmla="*/ 2277138 h 3365467"/>
              <a:gd name="connsiteX29" fmla="*/ 847177 w 1117126"/>
              <a:gd name="connsiteY29" fmla="*/ 2058063 h 3365467"/>
              <a:gd name="connsiteX30" fmla="*/ 904327 w 1117126"/>
              <a:gd name="connsiteY30" fmla="*/ 1819938 h 3365467"/>
              <a:gd name="connsiteX31" fmla="*/ 932902 w 1117126"/>
              <a:gd name="connsiteY31" fmla="*/ 1629438 h 3365467"/>
              <a:gd name="connsiteX32" fmla="*/ 1056727 w 1117126"/>
              <a:gd name="connsiteY32" fmla="*/ 1467513 h 3365467"/>
              <a:gd name="connsiteX33" fmla="*/ 1113877 w 1117126"/>
              <a:gd name="connsiteY33" fmla="*/ 1238913 h 3365467"/>
              <a:gd name="connsiteX34" fmla="*/ 1104352 w 1117126"/>
              <a:gd name="connsiteY34" fmla="*/ 1038888 h 3365467"/>
              <a:gd name="connsiteX35" fmla="*/ 1056727 w 1117126"/>
              <a:gd name="connsiteY35" fmla="*/ 962688 h 3365467"/>
              <a:gd name="connsiteX36" fmla="*/ 894802 w 1117126"/>
              <a:gd name="connsiteY36" fmla="*/ 1019838 h 3365467"/>
              <a:gd name="connsiteX37" fmla="*/ 875752 w 1117126"/>
              <a:gd name="connsiteY37" fmla="*/ 876963 h 3365467"/>
              <a:gd name="connsiteX38" fmla="*/ 837652 w 1117126"/>
              <a:gd name="connsiteY38" fmla="*/ 686463 h 3365467"/>
              <a:gd name="connsiteX39" fmla="*/ 666202 w 1117126"/>
              <a:gd name="connsiteY39" fmla="*/ 653126 h 3365467"/>
              <a:gd name="connsiteX40" fmla="*/ 609052 w 1117126"/>
              <a:gd name="connsiteY40" fmla="*/ 581688 h 3365467"/>
              <a:gd name="connsiteX41" fmla="*/ 323302 w 1117126"/>
              <a:gd name="connsiteY41" fmla="*/ 448338 h 3365467"/>
              <a:gd name="connsiteX42" fmla="*/ 161377 w 1117126"/>
              <a:gd name="connsiteY42" fmla="*/ 43526 h 3365467"/>
              <a:gd name="connsiteX43" fmla="*/ 166139 w 1117126"/>
              <a:gd name="connsiteY43" fmla="*/ 10188 h 3365467"/>
              <a:gd name="connsiteX44" fmla="*/ 4215 w 1117126"/>
              <a:gd name="connsiteY44" fmla="*/ 10188 h 3365467"/>
              <a:gd name="connsiteX0" fmla="*/ 4215 w 1117126"/>
              <a:gd name="connsiteY0" fmla="*/ 10188 h 3365467"/>
              <a:gd name="connsiteX1" fmla="*/ 51840 w 1117126"/>
              <a:gd name="connsiteY1" fmla="*/ 129251 h 3365467"/>
              <a:gd name="connsiteX2" fmla="*/ 56603 w 1117126"/>
              <a:gd name="connsiteY2" fmla="*/ 214976 h 3365467"/>
              <a:gd name="connsiteX3" fmla="*/ 113752 w 1117126"/>
              <a:gd name="connsiteY3" fmla="*/ 381663 h 3365467"/>
              <a:gd name="connsiteX4" fmla="*/ 108989 w 1117126"/>
              <a:gd name="connsiteY4" fmla="*/ 476913 h 3365467"/>
              <a:gd name="connsiteX5" fmla="*/ 151852 w 1117126"/>
              <a:gd name="connsiteY5" fmla="*/ 629313 h 3365467"/>
              <a:gd name="connsiteX6" fmla="*/ 132802 w 1117126"/>
              <a:gd name="connsiteY6" fmla="*/ 819813 h 3365467"/>
              <a:gd name="connsiteX7" fmla="*/ 199477 w 1117126"/>
              <a:gd name="connsiteY7" fmla="*/ 1000788 h 3365467"/>
              <a:gd name="connsiteX8" fmla="*/ 18502 w 1117126"/>
              <a:gd name="connsiteY8" fmla="*/ 1419888 h 3365467"/>
              <a:gd name="connsiteX9" fmla="*/ 75652 w 1117126"/>
              <a:gd name="connsiteY9" fmla="*/ 1705638 h 3365467"/>
              <a:gd name="connsiteX10" fmla="*/ 66127 w 1117126"/>
              <a:gd name="connsiteY10" fmla="*/ 2229513 h 3365467"/>
              <a:gd name="connsiteX11" fmla="*/ 113752 w 1117126"/>
              <a:gd name="connsiteY11" fmla="*/ 2486688 h 3365467"/>
              <a:gd name="connsiteX12" fmla="*/ 56602 w 1117126"/>
              <a:gd name="connsiteY12" fmla="*/ 2820063 h 3365467"/>
              <a:gd name="connsiteX13" fmla="*/ 75652 w 1117126"/>
              <a:gd name="connsiteY13" fmla="*/ 3153438 h 3365467"/>
              <a:gd name="connsiteX14" fmla="*/ 142327 w 1117126"/>
              <a:gd name="connsiteY14" fmla="*/ 3353463 h 3365467"/>
              <a:gd name="connsiteX15" fmla="*/ 56602 w 1117126"/>
              <a:gd name="connsiteY15" fmla="*/ 3343938 h 3365467"/>
              <a:gd name="connsiteX16" fmla="*/ 675727 w 1117126"/>
              <a:gd name="connsiteY16" fmla="*/ 3353463 h 3365467"/>
              <a:gd name="connsiteX17" fmla="*/ 637627 w 1117126"/>
              <a:gd name="connsiteY17" fmla="*/ 3343938 h 3365467"/>
              <a:gd name="connsiteX18" fmla="*/ 675727 w 1117126"/>
              <a:gd name="connsiteY18" fmla="*/ 3334413 h 3365467"/>
              <a:gd name="connsiteX19" fmla="*/ 675727 w 1117126"/>
              <a:gd name="connsiteY19" fmla="*/ 3248688 h 3365467"/>
              <a:gd name="connsiteX20" fmla="*/ 628102 w 1117126"/>
              <a:gd name="connsiteY20" fmla="*/ 3182013 h 3365467"/>
              <a:gd name="connsiteX21" fmla="*/ 618577 w 1117126"/>
              <a:gd name="connsiteY21" fmla="*/ 2972463 h 3365467"/>
              <a:gd name="connsiteX22" fmla="*/ 542377 w 1117126"/>
              <a:gd name="connsiteY22" fmla="*/ 2648613 h 3365467"/>
              <a:gd name="connsiteX23" fmla="*/ 447127 w 1117126"/>
              <a:gd name="connsiteY23" fmla="*/ 2534313 h 3365467"/>
              <a:gd name="connsiteX24" fmla="*/ 437602 w 1117126"/>
              <a:gd name="connsiteY24" fmla="*/ 2429538 h 3365467"/>
              <a:gd name="connsiteX25" fmla="*/ 494752 w 1117126"/>
              <a:gd name="connsiteY25" fmla="*/ 2315238 h 3365467"/>
              <a:gd name="connsiteX26" fmla="*/ 637627 w 1117126"/>
              <a:gd name="connsiteY26" fmla="*/ 2572413 h 3365467"/>
              <a:gd name="connsiteX27" fmla="*/ 732877 w 1117126"/>
              <a:gd name="connsiteY27" fmla="*/ 2562888 h 3365467"/>
              <a:gd name="connsiteX28" fmla="*/ 904327 w 1117126"/>
              <a:gd name="connsiteY28" fmla="*/ 2277138 h 3365467"/>
              <a:gd name="connsiteX29" fmla="*/ 847177 w 1117126"/>
              <a:gd name="connsiteY29" fmla="*/ 2058063 h 3365467"/>
              <a:gd name="connsiteX30" fmla="*/ 904327 w 1117126"/>
              <a:gd name="connsiteY30" fmla="*/ 1819938 h 3365467"/>
              <a:gd name="connsiteX31" fmla="*/ 932902 w 1117126"/>
              <a:gd name="connsiteY31" fmla="*/ 1629438 h 3365467"/>
              <a:gd name="connsiteX32" fmla="*/ 1056727 w 1117126"/>
              <a:gd name="connsiteY32" fmla="*/ 1467513 h 3365467"/>
              <a:gd name="connsiteX33" fmla="*/ 1113877 w 1117126"/>
              <a:gd name="connsiteY33" fmla="*/ 1238913 h 3365467"/>
              <a:gd name="connsiteX34" fmla="*/ 1104352 w 1117126"/>
              <a:gd name="connsiteY34" fmla="*/ 1038888 h 3365467"/>
              <a:gd name="connsiteX35" fmla="*/ 1056727 w 1117126"/>
              <a:gd name="connsiteY35" fmla="*/ 962688 h 3365467"/>
              <a:gd name="connsiteX36" fmla="*/ 894802 w 1117126"/>
              <a:gd name="connsiteY36" fmla="*/ 1019838 h 3365467"/>
              <a:gd name="connsiteX37" fmla="*/ 875752 w 1117126"/>
              <a:gd name="connsiteY37" fmla="*/ 876963 h 3365467"/>
              <a:gd name="connsiteX38" fmla="*/ 837652 w 1117126"/>
              <a:gd name="connsiteY38" fmla="*/ 686463 h 3365467"/>
              <a:gd name="connsiteX39" fmla="*/ 642390 w 1117126"/>
              <a:gd name="connsiteY39" fmla="*/ 648364 h 3365467"/>
              <a:gd name="connsiteX40" fmla="*/ 609052 w 1117126"/>
              <a:gd name="connsiteY40" fmla="*/ 581688 h 3365467"/>
              <a:gd name="connsiteX41" fmla="*/ 323302 w 1117126"/>
              <a:gd name="connsiteY41" fmla="*/ 448338 h 3365467"/>
              <a:gd name="connsiteX42" fmla="*/ 161377 w 1117126"/>
              <a:gd name="connsiteY42" fmla="*/ 43526 h 3365467"/>
              <a:gd name="connsiteX43" fmla="*/ 166139 w 1117126"/>
              <a:gd name="connsiteY43" fmla="*/ 10188 h 3365467"/>
              <a:gd name="connsiteX44" fmla="*/ 4215 w 1117126"/>
              <a:gd name="connsiteY44" fmla="*/ 10188 h 3365467"/>
              <a:gd name="connsiteX0" fmla="*/ 4215 w 1117126"/>
              <a:gd name="connsiteY0" fmla="*/ 10188 h 3365467"/>
              <a:gd name="connsiteX1" fmla="*/ 51840 w 1117126"/>
              <a:gd name="connsiteY1" fmla="*/ 129251 h 3365467"/>
              <a:gd name="connsiteX2" fmla="*/ 56603 w 1117126"/>
              <a:gd name="connsiteY2" fmla="*/ 214976 h 3365467"/>
              <a:gd name="connsiteX3" fmla="*/ 113752 w 1117126"/>
              <a:gd name="connsiteY3" fmla="*/ 381663 h 3365467"/>
              <a:gd name="connsiteX4" fmla="*/ 108989 w 1117126"/>
              <a:gd name="connsiteY4" fmla="*/ 476913 h 3365467"/>
              <a:gd name="connsiteX5" fmla="*/ 151852 w 1117126"/>
              <a:gd name="connsiteY5" fmla="*/ 629313 h 3365467"/>
              <a:gd name="connsiteX6" fmla="*/ 132802 w 1117126"/>
              <a:gd name="connsiteY6" fmla="*/ 819813 h 3365467"/>
              <a:gd name="connsiteX7" fmla="*/ 199477 w 1117126"/>
              <a:gd name="connsiteY7" fmla="*/ 1000788 h 3365467"/>
              <a:gd name="connsiteX8" fmla="*/ 18502 w 1117126"/>
              <a:gd name="connsiteY8" fmla="*/ 1419888 h 3365467"/>
              <a:gd name="connsiteX9" fmla="*/ 75652 w 1117126"/>
              <a:gd name="connsiteY9" fmla="*/ 1705638 h 3365467"/>
              <a:gd name="connsiteX10" fmla="*/ 66127 w 1117126"/>
              <a:gd name="connsiteY10" fmla="*/ 2229513 h 3365467"/>
              <a:gd name="connsiteX11" fmla="*/ 113752 w 1117126"/>
              <a:gd name="connsiteY11" fmla="*/ 2486688 h 3365467"/>
              <a:gd name="connsiteX12" fmla="*/ 56602 w 1117126"/>
              <a:gd name="connsiteY12" fmla="*/ 2820063 h 3365467"/>
              <a:gd name="connsiteX13" fmla="*/ 75652 w 1117126"/>
              <a:gd name="connsiteY13" fmla="*/ 3153438 h 3365467"/>
              <a:gd name="connsiteX14" fmla="*/ 142327 w 1117126"/>
              <a:gd name="connsiteY14" fmla="*/ 3353463 h 3365467"/>
              <a:gd name="connsiteX15" fmla="*/ 56602 w 1117126"/>
              <a:gd name="connsiteY15" fmla="*/ 3343938 h 3365467"/>
              <a:gd name="connsiteX16" fmla="*/ 675727 w 1117126"/>
              <a:gd name="connsiteY16" fmla="*/ 3353463 h 3365467"/>
              <a:gd name="connsiteX17" fmla="*/ 637627 w 1117126"/>
              <a:gd name="connsiteY17" fmla="*/ 3343938 h 3365467"/>
              <a:gd name="connsiteX18" fmla="*/ 675727 w 1117126"/>
              <a:gd name="connsiteY18" fmla="*/ 3334413 h 3365467"/>
              <a:gd name="connsiteX19" fmla="*/ 675727 w 1117126"/>
              <a:gd name="connsiteY19" fmla="*/ 3248688 h 3365467"/>
              <a:gd name="connsiteX20" fmla="*/ 628102 w 1117126"/>
              <a:gd name="connsiteY20" fmla="*/ 3182013 h 3365467"/>
              <a:gd name="connsiteX21" fmla="*/ 618577 w 1117126"/>
              <a:gd name="connsiteY21" fmla="*/ 2972463 h 3365467"/>
              <a:gd name="connsiteX22" fmla="*/ 542377 w 1117126"/>
              <a:gd name="connsiteY22" fmla="*/ 2648613 h 3365467"/>
              <a:gd name="connsiteX23" fmla="*/ 447127 w 1117126"/>
              <a:gd name="connsiteY23" fmla="*/ 2534313 h 3365467"/>
              <a:gd name="connsiteX24" fmla="*/ 437602 w 1117126"/>
              <a:gd name="connsiteY24" fmla="*/ 2429538 h 3365467"/>
              <a:gd name="connsiteX25" fmla="*/ 494752 w 1117126"/>
              <a:gd name="connsiteY25" fmla="*/ 2315238 h 3365467"/>
              <a:gd name="connsiteX26" fmla="*/ 637627 w 1117126"/>
              <a:gd name="connsiteY26" fmla="*/ 2572413 h 3365467"/>
              <a:gd name="connsiteX27" fmla="*/ 732877 w 1117126"/>
              <a:gd name="connsiteY27" fmla="*/ 2562888 h 3365467"/>
              <a:gd name="connsiteX28" fmla="*/ 904327 w 1117126"/>
              <a:gd name="connsiteY28" fmla="*/ 2277138 h 3365467"/>
              <a:gd name="connsiteX29" fmla="*/ 847177 w 1117126"/>
              <a:gd name="connsiteY29" fmla="*/ 2058063 h 3365467"/>
              <a:gd name="connsiteX30" fmla="*/ 904327 w 1117126"/>
              <a:gd name="connsiteY30" fmla="*/ 1819938 h 3365467"/>
              <a:gd name="connsiteX31" fmla="*/ 932902 w 1117126"/>
              <a:gd name="connsiteY31" fmla="*/ 1629438 h 3365467"/>
              <a:gd name="connsiteX32" fmla="*/ 1056727 w 1117126"/>
              <a:gd name="connsiteY32" fmla="*/ 1467513 h 3365467"/>
              <a:gd name="connsiteX33" fmla="*/ 1113877 w 1117126"/>
              <a:gd name="connsiteY33" fmla="*/ 1238913 h 3365467"/>
              <a:gd name="connsiteX34" fmla="*/ 1104352 w 1117126"/>
              <a:gd name="connsiteY34" fmla="*/ 1038888 h 3365467"/>
              <a:gd name="connsiteX35" fmla="*/ 1056727 w 1117126"/>
              <a:gd name="connsiteY35" fmla="*/ 962688 h 3365467"/>
              <a:gd name="connsiteX36" fmla="*/ 894802 w 1117126"/>
              <a:gd name="connsiteY36" fmla="*/ 1019838 h 3365467"/>
              <a:gd name="connsiteX37" fmla="*/ 875752 w 1117126"/>
              <a:gd name="connsiteY37" fmla="*/ 876963 h 3365467"/>
              <a:gd name="connsiteX38" fmla="*/ 837652 w 1117126"/>
              <a:gd name="connsiteY38" fmla="*/ 686463 h 3365467"/>
              <a:gd name="connsiteX39" fmla="*/ 642390 w 1117126"/>
              <a:gd name="connsiteY39" fmla="*/ 648364 h 3365467"/>
              <a:gd name="connsiteX40" fmla="*/ 609052 w 1117126"/>
              <a:gd name="connsiteY40" fmla="*/ 581688 h 3365467"/>
              <a:gd name="connsiteX41" fmla="*/ 442365 w 1117126"/>
              <a:gd name="connsiteY41" fmla="*/ 543589 h 3365467"/>
              <a:gd name="connsiteX42" fmla="*/ 323302 w 1117126"/>
              <a:gd name="connsiteY42" fmla="*/ 448338 h 3365467"/>
              <a:gd name="connsiteX43" fmla="*/ 161377 w 1117126"/>
              <a:gd name="connsiteY43" fmla="*/ 43526 h 3365467"/>
              <a:gd name="connsiteX44" fmla="*/ 166139 w 1117126"/>
              <a:gd name="connsiteY44" fmla="*/ 10188 h 3365467"/>
              <a:gd name="connsiteX45" fmla="*/ 4215 w 1117126"/>
              <a:gd name="connsiteY45" fmla="*/ 10188 h 3365467"/>
              <a:gd name="connsiteX0" fmla="*/ 4215 w 1117126"/>
              <a:gd name="connsiteY0" fmla="*/ 10188 h 3365467"/>
              <a:gd name="connsiteX1" fmla="*/ 51840 w 1117126"/>
              <a:gd name="connsiteY1" fmla="*/ 129251 h 3365467"/>
              <a:gd name="connsiteX2" fmla="*/ 56603 w 1117126"/>
              <a:gd name="connsiteY2" fmla="*/ 214976 h 3365467"/>
              <a:gd name="connsiteX3" fmla="*/ 113752 w 1117126"/>
              <a:gd name="connsiteY3" fmla="*/ 381663 h 3365467"/>
              <a:gd name="connsiteX4" fmla="*/ 108989 w 1117126"/>
              <a:gd name="connsiteY4" fmla="*/ 476913 h 3365467"/>
              <a:gd name="connsiteX5" fmla="*/ 151852 w 1117126"/>
              <a:gd name="connsiteY5" fmla="*/ 629313 h 3365467"/>
              <a:gd name="connsiteX6" fmla="*/ 132802 w 1117126"/>
              <a:gd name="connsiteY6" fmla="*/ 819813 h 3365467"/>
              <a:gd name="connsiteX7" fmla="*/ 199477 w 1117126"/>
              <a:gd name="connsiteY7" fmla="*/ 1000788 h 3365467"/>
              <a:gd name="connsiteX8" fmla="*/ 18502 w 1117126"/>
              <a:gd name="connsiteY8" fmla="*/ 1419888 h 3365467"/>
              <a:gd name="connsiteX9" fmla="*/ 75652 w 1117126"/>
              <a:gd name="connsiteY9" fmla="*/ 1705638 h 3365467"/>
              <a:gd name="connsiteX10" fmla="*/ 66127 w 1117126"/>
              <a:gd name="connsiteY10" fmla="*/ 2229513 h 3365467"/>
              <a:gd name="connsiteX11" fmla="*/ 113752 w 1117126"/>
              <a:gd name="connsiteY11" fmla="*/ 2486688 h 3365467"/>
              <a:gd name="connsiteX12" fmla="*/ 56602 w 1117126"/>
              <a:gd name="connsiteY12" fmla="*/ 2820063 h 3365467"/>
              <a:gd name="connsiteX13" fmla="*/ 75652 w 1117126"/>
              <a:gd name="connsiteY13" fmla="*/ 3153438 h 3365467"/>
              <a:gd name="connsiteX14" fmla="*/ 142327 w 1117126"/>
              <a:gd name="connsiteY14" fmla="*/ 3353463 h 3365467"/>
              <a:gd name="connsiteX15" fmla="*/ 56602 w 1117126"/>
              <a:gd name="connsiteY15" fmla="*/ 3343938 h 3365467"/>
              <a:gd name="connsiteX16" fmla="*/ 675727 w 1117126"/>
              <a:gd name="connsiteY16" fmla="*/ 3353463 h 3365467"/>
              <a:gd name="connsiteX17" fmla="*/ 637627 w 1117126"/>
              <a:gd name="connsiteY17" fmla="*/ 3343938 h 3365467"/>
              <a:gd name="connsiteX18" fmla="*/ 675727 w 1117126"/>
              <a:gd name="connsiteY18" fmla="*/ 3334413 h 3365467"/>
              <a:gd name="connsiteX19" fmla="*/ 675727 w 1117126"/>
              <a:gd name="connsiteY19" fmla="*/ 3248688 h 3365467"/>
              <a:gd name="connsiteX20" fmla="*/ 628102 w 1117126"/>
              <a:gd name="connsiteY20" fmla="*/ 3182013 h 3365467"/>
              <a:gd name="connsiteX21" fmla="*/ 618577 w 1117126"/>
              <a:gd name="connsiteY21" fmla="*/ 2972463 h 3365467"/>
              <a:gd name="connsiteX22" fmla="*/ 542377 w 1117126"/>
              <a:gd name="connsiteY22" fmla="*/ 2648613 h 3365467"/>
              <a:gd name="connsiteX23" fmla="*/ 447127 w 1117126"/>
              <a:gd name="connsiteY23" fmla="*/ 2534313 h 3365467"/>
              <a:gd name="connsiteX24" fmla="*/ 437602 w 1117126"/>
              <a:gd name="connsiteY24" fmla="*/ 2429538 h 3365467"/>
              <a:gd name="connsiteX25" fmla="*/ 494752 w 1117126"/>
              <a:gd name="connsiteY25" fmla="*/ 2315238 h 3365467"/>
              <a:gd name="connsiteX26" fmla="*/ 637627 w 1117126"/>
              <a:gd name="connsiteY26" fmla="*/ 2572413 h 3365467"/>
              <a:gd name="connsiteX27" fmla="*/ 732877 w 1117126"/>
              <a:gd name="connsiteY27" fmla="*/ 2562888 h 3365467"/>
              <a:gd name="connsiteX28" fmla="*/ 904327 w 1117126"/>
              <a:gd name="connsiteY28" fmla="*/ 2277138 h 3365467"/>
              <a:gd name="connsiteX29" fmla="*/ 847177 w 1117126"/>
              <a:gd name="connsiteY29" fmla="*/ 2058063 h 3365467"/>
              <a:gd name="connsiteX30" fmla="*/ 904327 w 1117126"/>
              <a:gd name="connsiteY30" fmla="*/ 1819938 h 3365467"/>
              <a:gd name="connsiteX31" fmla="*/ 932902 w 1117126"/>
              <a:gd name="connsiteY31" fmla="*/ 1629438 h 3365467"/>
              <a:gd name="connsiteX32" fmla="*/ 1056727 w 1117126"/>
              <a:gd name="connsiteY32" fmla="*/ 1467513 h 3365467"/>
              <a:gd name="connsiteX33" fmla="*/ 1113877 w 1117126"/>
              <a:gd name="connsiteY33" fmla="*/ 1238913 h 3365467"/>
              <a:gd name="connsiteX34" fmla="*/ 1104352 w 1117126"/>
              <a:gd name="connsiteY34" fmla="*/ 1038888 h 3365467"/>
              <a:gd name="connsiteX35" fmla="*/ 1056727 w 1117126"/>
              <a:gd name="connsiteY35" fmla="*/ 962688 h 3365467"/>
              <a:gd name="connsiteX36" fmla="*/ 894802 w 1117126"/>
              <a:gd name="connsiteY36" fmla="*/ 1019838 h 3365467"/>
              <a:gd name="connsiteX37" fmla="*/ 890039 w 1117126"/>
              <a:gd name="connsiteY37" fmla="*/ 848388 h 3365467"/>
              <a:gd name="connsiteX38" fmla="*/ 837652 w 1117126"/>
              <a:gd name="connsiteY38" fmla="*/ 686463 h 3365467"/>
              <a:gd name="connsiteX39" fmla="*/ 642390 w 1117126"/>
              <a:gd name="connsiteY39" fmla="*/ 648364 h 3365467"/>
              <a:gd name="connsiteX40" fmla="*/ 609052 w 1117126"/>
              <a:gd name="connsiteY40" fmla="*/ 581688 h 3365467"/>
              <a:gd name="connsiteX41" fmla="*/ 442365 w 1117126"/>
              <a:gd name="connsiteY41" fmla="*/ 543589 h 3365467"/>
              <a:gd name="connsiteX42" fmla="*/ 323302 w 1117126"/>
              <a:gd name="connsiteY42" fmla="*/ 448338 h 3365467"/>
              <a:gd name="connsiteX43" fmla="*/ 161377 w 1117126"/>
              <a:gd name="connsiteY43" fmla="*/ 43526 h 3365467"/>
              <a:gd name="connsiteX44" fmla="*/ 166139 w 1117126"/>
              <a:gd name="connsiteY44" fmla="*/ 10188 h 3365467"/>
              <a:gd name="connsiteX45" fmla="*/ 4215 w 1117126"/>
              <a:gd name="connsiteY45" fmla="*/ 10188 h 3365467"/>
              <a:gd name="connsiteX0" fmla="*/ 4215 w 1117126"/>
              <a:gd name="connsiteY0" fmla="*/ 10188 h 3365467"/>
              <a:gd name="connsiteX1" fmla="*/ 51840 w 1117126"/>
              <a:gd name="connsiteY1" fmla="*/ 129251 h 3365467"/>
              <a:gd name="connsiteX2" fmla="*/ 56603 w 1117126"/>
              <a:gd name="connsiteY2" fmla="*/ 214976 h 3365467"/>
              <a:gd name="connsiteX3" fmla="*/ 113752 w 1117126"/>
              <a:gd name="connsiteY3" fmla="*/ 381663 h 3365467"/>
              <a:gd name="connsiteX4" fmla="*/ 108989 w 1117126"/>
              <a:gd name="connsiteY4" fmla="*/ 476913 h 3365467"/>
              <a:gd name="connsiteX5" fmla="*/ 151852 w 1117126"/>
              <a:gd name="connsiteY5" fmla="*/ 629313 h 3365467"/>
              <a:gd name="connsiteX6" fmla="*/ 132802 w 1117126"/>
              <a:gd name="connsiteY6" fmla="*/ 819813 h 3365467"/>
              <a:gd name="connsiteX7" fmla="*/ 199477 w 1117126"/>
              <a:gd name="connsiteY7" fmla="*/ 1000788 h 3365467"/>
              <a:gd name="connsiteX8" fmla="*/ 18502 w 1117126"/>
              <a:gd name="connsiteY8" fmla="*/ 1419888 h 3365467"/>
              <a:gd name="connsiteX9" fmla="*/ 75652 w 1117126"/>
              <a:gd name="connsiteY9" fmla="*/ 1705638 h 3365467"/>
              <a:gd name="connsiteX10" fmla="*/ 66127 w 1117126"/>
              <a:gd name="connsiteY10" fmla="*/ 2229513 h 3365467"/>
              <a:gd name="connsiteX11" fmla="*/ 113752 w 1117126"/>
              <a:gd name="connsiteY11" fmla="*/ 2486688 h 3365467"/>
              <a:gd name="connsiteX12" fmla="*/ 56602 w 1117126"/>
              <a:gd name="connsiteY12" fmla="*/ 2820063 h 3365467"/>
              <a:gd name="connsiteX13" fmla="*/ 75652 w 1117126"/>
              <a:gd name="connsiteY13" fmla="*/ 3153438 h 3365467"/>
              <a:gd name="connsiteX14" fmla="*/ 142327 w 1117126"/>
              <a:gd name="connsiteY14" fmla="*/ 3353463 h 3365467"/>
              <a:gd name="connsiteX15" fmla="*/ 56602 w 1117126"/>
              <a:gd name="connsiteY15" fmla="*/ 3343938 h 3365467"/>
              <a:gd name="connsiteX16" fmla="*/ 675727 w 1117126"/>
              <a:gd name="connsiteY16" fmla="*/ 3353463 h 3365467"/>
              <a:gd name="connsiteX17" fmla="*/ 637627 w 1117126"/>
              <a:gd name="connsiteY17" fmla="*/ 3343938 h 3365467"/>
              <a:gd name="connsiteX18" fmla="*/ 675727 w 1117126"/>
              <a:gd name="connsiteY18" fmla="*/ 3334413 h 3365467"/>
              <a:gd name="connsiteX19" fmla="*/ 675727 w 1117126"/>
              <a:gd name="connsiteY19" fmla="*/ 3248688 h 3365467"/>
              <a:gd name="connsiteX20" fmla="*/ 628102 w 1117126"/>
              <a:gd name="connsiteY20" fmla="*/ 3182013 h 3365467"/>
              <a:gd name="connsiteX21" fmla="*/ 618577 w 1117126"/>
              <a:gd name="connsiteY21" fmla="*/ 2972463 h 3365467"/>
              <a:gd name="connsiteX22" fmla="*/ 542377 w 1117126"/>
              <a:gd name="connsiteY22" fmla="*/ 2648613 h 3365467"/>
              <a:gd name="connsiteX23" fmla="*/ 447127 w 1117126"/>
              <a:gd name="connsiteY23" fmla="*/ 2534313 h 3365467"/>
              <a:gd name="connsiteX24" fmla="*/ 437602 w 1117126"/>
              <a:gd name="connsiteY24" fmla="*/ 2429538 h 3365467"/>
              <a:gd name="connsiteX25" fmla="*/ 494752 w 1117126"/>
              <a:gd name="connsiteY25" fmla="*/ 2315238 h 3365467"/>
              <a:gd name="connsiteX26" fmla="*/ 637627 w 1117126"/>
              <a:gd name="connsiteY26" fmla="*/ 2572413 h 3365467"/>
              <a:gd name="connsiteX27" fmla="*/ 732877 w 1117126"/>
              <a:gd name="connsiteY27" fmla="*/ 2562888 h 3365467"/>
              <a:gd name="connsiteX28" fmla="*/ 904327 w 1117126"/>
              <a:gd name="connsiteY28" fmla="*/ 2277138 h 3365467"/>
              <a:gd name="connsiteX29" fmla="*/ 847177 w 1117126"/>
              <a:gd name="connsiteY29" fmla="*/ 2058063 h 3365467"/>
              <a:gd name="connsiteX30" fmla="*/ 904327 w 1117126"/>
              <a:gd name="connsiteY30" fmla="*/ 1819938 h 3365467"/>
              <a:gd name="connsiteX31" fmla="*/ 932902 w 1117126"/>
              <a:gd name="connsiteY31" fmla="*/ 1629438 h 3365467"/>
              <a:gd name="connsiteX32" fmla="*/ 1056727 w 1117126"/>
              <a:gd name="connsiteY32" fmla="*/ 1467513 h 3365467"/>
              <a:gd name="connsiteX33" fmla="*/ 1113877 w 1117126"/>
              <a:gd name="connsiteY33" fmla="*/ 1238913 h 3365467"/>
              <a:gd name="connsiteX34" fmla="*/ 1104352 w 1117126"/>
              <a:gd name="connsiteY34" fmla="*/ 1038888 h 3365467"/>
              <a:gd name="connsiteX35" fmla="*/ 1056727 w 1117126"/>
              <a:gd name="connsiteY35" fmla="*/ 962688 h 3365467"/>
              <a:gd name="connsiteX36" fmla="*/ 894802 w 1117126"/>
              <a:gd name="connsiteY36" fmla="*/ 1019838 h 3365467"/>
              <a:gd name="connsiteX37" fmla="*/ 890039 w 1117126"/>
              <a:gd name="connsiteY37" fmla="*/ 848388 h 3365467"/>
              <a:gd name="connsiteX38" fmla="*/ 799552 w 1117126"/>
              <a:gd name="connsiteY38" fmla="*/ 667413 h 3365467"/>
              <a:gd name="connsiteX39" fmla="*/ 642390 w 1117126"/>
              <a:gd name="connsiteY39" fmla="*/ 648364 h 3365467"/>
              <a:gd name="connsiteX40" fmla="*/ 609052 w 1117126"/>
              <a:gd name="connsiteY40" fmla="*/ 581688 h 3365467"/>
              <a:gd name="connsiteX41" fmla="*/ 442365 w 1117126"/>
              <a:gd name="connsiteY41" fmla="*/ 543589 h 3365467"/>
              <a:gd name="connsiteX42" fmla="*/ 323302 w 1117126"/>
              <a:gd name="connsiteY42" fmla="*/ 448338 h 3365467"/>
              <a:gd name="connsiteX43" fmla="*/ 161377 w 1117126"/>
              <a:gd name="connsiteY43" fmla="*/ 43526 h 3365467"/>
              <a:gd name="connsiteX44" fmla="*/ 166139 w 1117126"/>
              <a:gd name="connsiteY44" fmla="*/ 10188 h 3365467"/>
              <a:gd name="connsiteX45" fmla="*/ 4215 w 1117126"/>
              <a:gd name="connsiteY45" fmla="*/ 10188 h 3365467"/>
              <a:gd name="connsiteX0" fmla="*/ 4215 w 1113990"/>
              <a:gd name="connsiteY0" fmla="*/ 10188 h 3365467"/>
              <a:gd name="connsiteX1" fmla="*/ 51840 w 1113990"/>
              <a:gd name="connsiteY1" fmla="*/ 129251 h 3365467"/>
              <a:gd name="connsiteX2" fmla="*/ 56603 w 1113990"/>
              <a:gd name="connsiteY2" fmla="*/ 214976 h 3365467"/>
              <a:gd name="connsiteX3" fmla="*/ 113752 w 1113990"/>
              <a:gd name="connsiteY3" fmla="*/ 381663 h 3365467"/>
              <a:gd name="connsiteX4" fmla="*/ 108989 w 1113990"/>
              <a:gd name="connsiteY4" fmla="*/ 476913 h 3365467"/>
              <a:gd name="connsiteX5" fmla="*/ 151852 w 1113990"/>
              <a:gd name="connsiteY5" fmla="*/ 629313 h 3365467"/>
              <a:gd name="connsiteX6" fmla="*/ 132802 w 1113990"/>
              <a:gd name="connsiteY6" fmla="*/ 819813 h 3365467"/>
              <a:gd name="connsiteX7" fmla="*/ 199477 w 1113990"/>
              <a:gd name="connsiteY7" fmla="*/ 1000788 h 3365467"/>
              <a:gd name="connsiteX8" fmla="*/ 18502 w 1113990"/>
              <a:gd name="connsiteY8" fmla="*/ 1419888 h 3365467"/>
              <a:gd name="connsiteX9" fmla="*/ 75652 w 1113990"/>
              <a:gd name="connsiteY9" fmla="*/ 1705638 h 3365467"/>
              <a:gd name="connsiteX10" fmla="*/ 66127 w 1113990"/>
              <a:gd name="connsiteY10" fmla="*/ 2229513 h 3365467"/>
              <a:gd name="connsiteX11" fmla="*/ 113752 w 1113990"/>
              <a:gd name="connsiteY11" fmla="*/ 2486688 h 3365467"/>
              <a:gd name="connsiteX12" fmla="*/ 56602 w 1113990"/>
              <a:gd name="connsiteY12" fmla="*/ 2820063 h 3365467"/>
              <a:gd name="connsiteX13" fmla="*/ 75652 w 1113990"/>
              <a:gd name="connsiteY13" fmla="*/ 3153438 h 3365467"/>
              <a:gd name="connsiteX14" fmla="*/ 142327 w 1113990"/>
              <a:gd name="connsiteY14" fmla="*/ 3353463 h 3365467"/>
              <a:gd name="connsiteX15" fmla="*/ 56602 w 1113990"/>
              <a:gd name="connsiteY15" fmla="*/ 3343938 h 3365467"/>
              <a:gd name="connsiteX16" fmla="*/ 675727 w 1113990"/>
              <a:gd name="connsiteY16" fmla="*/ 3353463 h 3365467"/>
              <a:gd name="connsiteX17" fmla="*/ 637627 w 1113990"/>
              <a:gd name="connsiteY17" fmla="*/ 3343938 h 3365467"/>
              <a:gd name="connsiteX18" fmla="*/ 675727 w 1113990"/>
              <a:gd name="connsiteY18" fmla="*/ 3334413 h 3365467"/>
              <a:gd name="connsiteX19" fmla="*/ 675727 w 1113990"/>
              <a:gd name="connsiteY19" fmla="*/ 3248688 h 3365467"/>
              <a:gd name="connsiteX20" fmla="*/ 628102 w 1113990"/>
              <a:gd name="connsiteY20" fmla="*/ 3182013 h 3365467"/>
              <a:gd name="connsiteX21" fmla="*/ 618577 w 1113990"/>
              <a:gd name="connsiteY21" fmla="*/ 2972463 h 3365467"/>
              <a:gd name="connsiteX22" fmla="*/ 542377 w 1113990"/>
              <a:gd name="connsiteY22" fmla="*/ 2648613 h 3365467"/>
              <a:gd name="connsiteX23" fmla="*/ 447127 w 1113990"/>
              <a:gd name="connsiteY23" fmla="*/ 2534313 h 3365467"/>
              <a:gd name="connsiteX24" fmla="*/ 437602 w 1113990"/>
              <a:gd name="connsiteY24" fmla="*/ 2429538 h 3365467"/>
              <a:gd name="connsiteX25" fmla="*/ 494752 w 1113990"/>
              <a:gd name="connsiteY25" fmla="*/ 2315238 h 3365467"/>
              <a:gd name="connsiteX26" fmla="*/ 637627 w 1113990"/>
              <a:gd name="connsiteY26" fmla="*/ 2572413 h 3365467"/>
              <a:gd name="connsiteX27" fmla="*/ 732877 w 1113990"/>
              <a:gd name="connsiteY27" fmla="*/ 2562888 h 3365467"/>
              <a:gd name="connsiteX28" fmla="*/ 904327 w 1113990"/>
              <a:gd name="connsiteY28" fmla="*/ 2277138 h 3365467"/>
              <a:gd name="connsiteX29" fmla="*/ 847177 w 1113990"/>
              <a:gd name="connsiteY29" fmla="*/ 2058063 h 3365467"/>
              <a:gd name="connsiteX30" fmla="*/ 904327 w 1113990"/>
              <a:gd name="connsiteY30" fmla="*/ 1819938 h 3365467"/>
              <a:gd name="connsiteX31" fmla="*/ 932902 w 1113990"/>
              <a:gd name="connsiteY31" fmla="*/ 1629438 h 3365467"/>
              <a:gd name="connsiteX32" fmla="*/ 1056727 w 1113990"/>
              <a:gd name="connsiteY32" fmla="*/ 1467513 h 3365467"/>
              <a:gd name="connsiteX33" fmla="*/ 1113877 w 1113990"/>
              <a:gd name="connsiteY33" fmla="*/ 1238913 h 3365467"/>
              <a:gd name="connsiteX34" fmla="*/ 1071015 w 1113990"/>
              <a:gd name="connsiteY34" fmla="*/ 1067463 h 3365467"/>
              <a:gd name="connsiteX35" fmla="*/ 1056727 w 1113990"/>
              <a:gd name="connsiteY35" fmla="*/ 962688 h 3365467"/>
              <a:gd name="connsiteX36" fmla="*/ 894802 w 1113990"/>
              <a:gd name="connsiteY36" fmla="*/ 1019838 h 3365467"/>
              <a:gd name="connsiteX37" fmla="*/ 890039 w 1113990"/>
              <a:gd name="connsiteY37" fmla="*/ 848388 h 3365467"/>
              <a:gd name="connsiteX38" fmla="*/ 799552 w 1113990"/>
              <a:gd name="connsiteY38" fmla="*/ 667413 h 3365467"/>
              <a:gd name="connsiteX39" fmla="*/ 642390 w 1113990"/>
              <a:gd name="connsiteY39" fmla="*/ 648364 h 3365467"/>
              <a:gd name="connsiteX40" fmla="*/ 609052 w 1113990"/>
              <a:gd name="connsiteY40" fmla="*/ 581688 h 3365467"/>
              <a:gd name="connsiteX41" fmla="*/ 442365 w 1113990"/>
              <a:gd name="connsiteY41" fmla="*/ 543589 h 3365467"/>
              <a:gd name="connsiteX42" fmla="*/ 323302 w 1113990"/>
              <a:gd name="connsiteY42" fmla="*/ 448338 h 3365467"/>
              <a:gd name="connsiteX43" fmla="*/ 161377 w 1113990"/>
              <a:gd name="connsiteY43" fmla="*/ 43526 h 3365467"/>
              <a:gd name="connsiteX44" fmla="*/ 166139 w 1113990"/>
              <a:gd name="connsiteY44" fmla="*/ 10188 h 3365467"/>
              <a:gd name="connsiteX45" fmla="*/ 4215 w 1113990"/>
              <a:gd name="connsiteY45" fmla="*/ 10188 h 3365467"/>
              <a:gd name="connsiteX0" fmla="*/ 4215 w 1114288"/>
              <a:gd name="connsiteY0" fmla="*/ 10188 h 3365467"/>
              <a:gd name="connsiteX1" fmla="*/ 51840 w 1114288"/>
              <a:gd name="connsiteY1" fmla="*/ 129251 h 3365467"/>
              <a:gd name="connsiteX2" fmla="*/ 56603 w 1114288"/>
              <a:gd name="connsiteY2" fmla="*/ 214976 h 3365467"/>
              <a:gd name="connsiteX3" fmla="*/ 113752 w 1114288"/>
              <a:gd name="connsiteY3" fmla="*/ 381663 h 3365467"/>
              <a:gd name="connsiteX4" fmla="*/ 108989 w 1114288"/>
              <a:gd name="connsiteY4" fmla="*/ 476913 h 3365467"/>
              <a:gd name="connsiteX5" fmla="*/ 151852 w 1114288"/>
              <a:gd name="connsiteY5" fmla="*/ 629313 h 3365467"/>
              <a:gd name="connsiteX6" fmla="*/ 132802 w 1114288"/>
              <a:gd name="connsiteY6" fmla="*/ 819813 h 3365467"/>
              <a:gd name="connsiteX7" fmla="*/ 199477 w 1114288"/>
              <a:gd name="connsiteY7" fmla="*/ 1000788 h 3365467"/>
              <a:gd name="connsiteX8" fmla="*/ 18502 w 1114288"/>
              <a:gd name="connsiteY8" fmla="*/ 1419888 h 3365467"/>
              <a:gd name="connsiteX9" fmla="*/ 75652 w 1114288"/>
              <a:gd name="connsiteY9" fmla="*/ 1705638 h 3365467"/>
              <a:gd name="connsiteX10" fmla="*/ 66127 w 1114288"/>
              <a:gd name="connsiteY10" fmla="*/ 2229513 h 3365467"/>
              <a:gd name="connsiteX11" fmla="*/ 113752 w 1114288"/>
              <a:gd name="connsiteY11" fmla="*/ 2486688 h 3365467"/>
              <a:gd name="connsiteX12" fmla="*/ 56602 w 1114288"/>
              <a:gd name="connsiteY12" fmla="*/ 2820063 h 3365467"/>
              <a:gd name="connsiteX13" fmla="*/ 75652 w 1114288"/>
              <a:gd name="connsiteY13" fmla="*/ 3153438 h 3365467"/>
              <a:gd name="connsiteX14" fmla="*/ 142327 w 1114288"/>
              <a:gd name="connsiteY14" fmla="*/ 3353463 h 3365467"/>
              <a:gd name="connsiteX15" fmla="*/ 56602 w 1114288"/>
              <a:gd name="connsiteY15" fmla="*/ 3343938 h 3365467"/>
              <a:gd name="connsiteX16" fmla="*/ 675727 w 1114288"/>
              <a:gd name="connsiteY16" fmla="*/ 3353463 h 3365467"/>
              <a:gd name="connsiteX17" fmla="*/ 637627 w 1114288"/>
              <a:gd name="connsiteY17" fmla="*/ 3343938 h 3365467"/>
              <a:gd name="connsiteX18" fmla="*/ 675727 w 1114288"/>
              <a:gd name="connsiteY18" fmla="*/ 3334413 h 3365467"/>
              <a:gd name="connsiteX19" fmla="*/ 675727 w 1114288"/>
              <a:gd name="connsiteY19" fmla="*/ 3248688 h 3365467"/>
              <a:gd name="connsiteX20" fmla="*/ 628102 w 1114288"/>
              <a:gd name="connsiteY20" fmla="*/ 3182013 h 3365467"/>
              <a:gd name="connsiteX21" fmla="*/ 618577 w 1114288"/>
              <a:gd name="connsiteY21" fmla="*/ 2972463 h 3365467"/>
              <a:gd name="connsiteX22" fmla="*/ 542377 w 1114288"/>
              <a:gd name="connsiteY22" fmla="*/ 2648613 h 3365467"/>
              <a:gd name="connsiteX23" fmla="*/ 447127 w 1114288"/>
              <a:gd name="connsiteY23" fmla="*/ 2534313 h 3365467"/>
              <a:gd name="connsiteX24" fmla="*/ 437602 w 1114288"/>
              <a:gd name="connsiteY24" fmla="*/ 2429538 h 3365467"/>
              <a:gd name="connsiteX25" fmla="*/ 494752 w 1114288"/>
              <a:gd name="connsiteY25" fmla="*/ 2315238 h 3365467"/>
              <a:gd name="connsiteX26" fmla="*/ 637627 w 1114288"/>
              <a:gd name="connsiteY26" fmla="*/ 2572413 h 3365467"/>
              <a:gd name="connsiteX27" fmla="*/ 732877 w 1114288"/>
              <a:gd name="connsiteY27" fmla="*/ 2562888 h 3365467"/>
              <a:gd name="connsiteX28" fmla="*/ 904327 w 1114288"/>
              <a:gd name="connsiteY28" fmla="*/ 2277138 h 3365467"/>
              <a:gd name="connsiteX29" fmla="*/ 847177 w 1114288"/>
              <a:gd name="connsiteY29" fmla="*/ 2058063 h 3365467"/>
              <a:gd name="connsiteX30" fmla="*/ 904327 w 1114288"/>
              <a:gd name="connsiteY30" fmla="*/ 1819938 h 3365467"/>
              <a:gd name="connsiteX31" fmla="*/ 932902 w 1114288"/>
              <a:gd name="connsiteY31" fmla="*/ 1629438 h 3365467"/>
              <a:gd name="connsiteX32" fmla="*/ 1056727 w 1114288"/>
              <a:gd name="connsiteY32" fmla="*/ 1467513 h 3365467"/>
              <a:gd name="connsiteX33" fmla="*/ 1113877 w 1114288"/>
              <a:gd name="connsiteY33" fmla="*/ 1238913 h 3365467"/>
              <a:gd name="connsiteX34" fmla="*/ 1071015 w 1114288"/>
              <a:gd name="connsiteY34" fmla="*/ 1067463 h 3365467"/>
              <a:gd name="connsiteX35" fmla="*/ 1056727 w 1114288"/>
              <a:gd name="connsiteY35" fmla="*/ 962688 h 3365467"/>
              <a:gd name="connsiteX36" fmla="*/ 894802 w 1114288"/>
              <a:gd name="connsiteY36" fmla="*/ 1019838 h 3365467"/>
              <a:gd name="connsiteX37" fmla="*/ 890039 w 1114288"/>
              <a:gd name="connsiteY37" fmla="*/ 848388 h 3365467"/>
              <a:gd name="connsiteX38" fmla="*/ 799552 w 1114288"/>
              <a:gd name="connsiteY38" fmla="*/ 667413 h 3365467"/>
              <a:gd name="connsiteX39" fmla="*/ 642390 w 1114288"/>
              <a:gd name="connsiteY39" fmla="*/ 648364 h 3365467"/>
              <a:gd name="connsiteX40" fmla="*/ 609052 w 1114288"/>
              <a:gd name="connsiteY40" fmla="*/ 581688 h 3365467"/>
              <a:gd name="connsiteX41" fmla="*/ 442365 w 1114288"/>
              <a:gd name="connsiteY41" fmla="*/ 543589 h 3365467"/>
              <a:gd name="connsiteX42" fmla="*/ 323302 w 1114288"/>
              <a:gd name="connsiteY42" fmla="*/ 448338 h 3365467"/>
              <a:gd name="connsiteX43" fmla="*/ 161377 w 1114288"/>
              <a:gd name="connsiteY43" fmla="*/ 43526 h 3365467"/>
              <a:gd name="connsiteX44" fmla="*/ 166139 w 1114288"/>
              <a:gd name="connsiteY44" fmla="*/ 10188 h 3365467"/>
              <a:gd name="connsiteX45" fmla="*/ 4215 w 1114288"/>
              <a:gd name="connsiteY45" fmla="*/ 10188 h 3365467"/>
              <a:gd name="connsiteX0" fmla="*/ 4215 w 1115836"/>
              <a:gd name="connsiteY0" fmla="*/ 10188 h 3365467"/>
              <a:gd name="connsiteX1" fmla="*/ 51840 w 1115836"/>
              <a:gd name="connsiteY1" fmla="*/ 129251 h 3365467"/>
              <a:gd name="connsiteX2" fmla="*/ 56603 w 1115836"/>
              <a:gd name="connsiteY2" fmla="*/ 214976 h 3365467"/>
              <a:gd name="connsiteX3" fmla="*/ 113752 w 1115836"/>
              <a:gd name="connsiteY3" fmla="*/ 381663 h 3365467"/>
              <a:gd name="connsiteX4" fmla="*/ 108989 w 1115836"/>
              <a:gd name="connsiteY4" fmla="*/ 476913 h 3365467"/>
              <a:gd name="connsiteX5" fmla="*/ 151852 w 1115836"/>
              <a:gd name="connsiteY5" fmla="*/ 629313 h 3365467"/>
              <a:gd name="connsiteX6" fmla="*/ 132802 w 1115836"/>
              <a:gd name="connsiteY6" fmla="*/ 819813 h 3365467"/>
              <a:gd name="connsiteX7" fmla="*/ 199477 w 1115836"/>
              <a:gd name="connsiteY7" fmla="*/ 1000788 h 3365467"/>
              <a:gd name="connsiteX8" fmla="*/ 18502 w 1115836"/>
              <a:gd name="connsiteY8" fmla="*/ 1419888 h 3365467"/>
              <a:gd name="connsiteX9" fmla="*/ 75652 w 1115836"/>
              <a:gd name="connsiteY9" fmla="*/ 1705638 h 3365467"/>
              <a:gd name="connsiteX10" fmla="*/ 66127 w 1115836"/>
              <a:gd name="connsiteY10" fmla="*/ 2229513 h 3365467"/>
              <a:gd name="connsiteX11" fmla="*/ 113752 w 1115836"/>
              <a:gd name="connsiteY11" fmla="*/ 2486688 h 3365467"/>
              <a:gd name="connsiteX12" fmla="*/ 56602 w 1115836"/>
              <a:gd name="connsiteY12" fmla="*/ 2820063 h 3365467"/>
              <a:gd name="connsiteX13" fmla="*/ 75652 w 1115836"/>
              <a:gd name="connsiteY13" fmla="*/ 3153438 h 3365467"/>
              <a:gd name="connsiteX14" fmla="*/ 142327 w 1115836"/>
              <a:gd name="connsiteY14" fmla="*/ 3353463 h 3365467"/>
              <a:gd name="connsiteX15" fmla="*/ 56602 w 1115836"/>
              <a:gd name="connsiteY15" fmla="*/ 3343938 h 3365467"/>
              <a:gd name="connsiteX16" fmla="*/ 675727 w 1115836"/>
              <a:gd name="connsiteY16" fmla="*/ 3353463 h 3365467"/>
              <a:gd name="connsiteX17" fmla="*/ 637627 w 1115836"/>
              <a:gd name="connsiteY17" fmla="*/ 3343938 h 3365467"/>
              <a:gd name="connsiteX18" fmla="*/ 675727 w 1115836"/>
              <a:gd name="connsiteY18" fmla="*/ 3334413 h 3365467"/>
              <a:gd name="connsiteX19" fmla="*/ 675727 w 1115836"/>
              <a:gd name="connsiteY19" fmla="*/ 3248688 h 3365467"/>
              <a:gd name="connsiteX20" fmla="*/ 628102 w 1115836"/>
              <a:gd name="connsiteY20" fmla="*/ 3182013 h 3365467"/>
              <a:gd name="connsiteX21" fmla="*/ 618577 w 1115836"/>
              <a:gd name="connsiteY21" fmla="*/ 2972463 h 3365467"/>
              <a:gd name="connsiteX22" fmla="*/ 542377 w 1115836"/>
              <a:gd name="connsiteY22" fmla="*/ 2648613 h 3365467"/>
              <a:gd name="connsiteX23" fmla="*/ 447127 w 1115836"/>
              <a:gd name="connsiteY23" fmla="*/ 2534313 h 3365467"/>
              <a:gd name="connsiteX24" fmla="*/ 437602 w 1115836"/>
              <a:gd name="connsiteY24" fmla="*/ 2429538 h 3365467"/>
              <a:gd name="connsiteX25" fmla="*/ 494752 w 1115836"/>
              <a:gd name="connsiteY25" fmla="*/ 2315238 h 3365467"/>
              <a:gd name="connsiteX26" fmla="*/ 637627 w 1115836"/>
              <a:gd name="connsiteY26" fmla="*/ 2572413 h 3365467"/>
              <a:gd name="connsiteX27" fmla="*/ 732877 w 1115836"/>
              <a:gd name="connsiteY27" fmla="*/ 2562888 h 3365467"/>
              <a:gd name="connsiteX28" fmla="*/ 904327 w 1115836"/>
              <a:gd name="connsiteY28" fmla="*/ 2277138 h 3365467"/>
              <a:gd name="connsiteX29" fmla="*/ 847177 w 1115836"/>
              <a:gd name="connsiteY29" fmla="*/ 2058063 h 3365467"/>
              <a:gd name="connsiteX30" fmla="*/ 904327 w 1115836"/>
              <a:gd name="connsiteY30" fmla="*/ 1819938 h 3365467"/>
              <a:gd name="connsiteX31" fmla="*/ 932902 w 1115836"/>
              <a:gd name="connsiteY31" fmla="*/ 1629438 h 3365467"/>
              <a:gd name="connsiteX32" fmla="*/ 1090064 w 1115836"/>
              <a:gd name="connsiteY32" fmla="*/ 1467513 h 3365467"/>
              <a:gd name="connsiteX33" fmla="*/ 1113877 w 1115836"/>
              <a:gd name="connsiteY33" fmla="*/ 1238913 h 3365467"/>
              <a:gd name="connsiteX34" fmla="*/ 1071015 w 1115836"/>
              <a:gd name="connsiteY34" fmla="*/ 1067463 h 3365467"/>
              <a:gd name="connsiteX35" fmla="*/ 1056727 w 1115836"/>
              <a:gd name="connsiteY35" fmla="*/ 962688 h 3365467"/>
              <a:gd name="connsiteX36" fmla="*/ 894802 w 1115836"/>
              <a:gd name="connsiteY36" fmla="*/ 1019838 h 3365467"/>
              <a:gd name="connsiteX37" fmla="*/ 890039 w 1115836"/>
              <a:gd name="connsiteY37" fmla="*/ 848388 h 3365467"/>
              <a:gd name="connsiteX38" fmla="*/ 799552 w 1115836"/>
              <a:gd name="connsiteY38" fmla="*/ 667413 h 3365467"/>
              <a:gd name="connsiteX39" fmla="*/ 642390 w 1115836"/>
              <a:gd name="connsiteY39" fmla="*/ 648364 h 3365467"/>
              <a:gd name="connsiteX40" fmla="*/ 609052 w 1115836"/>
              <a:gd name="connsiteY40" fmla="*/ 581688 h 3365467"/>
              <a:gd name="connsiteX41" fmla="*/ 442365 w 1115836"/>
              <a:gd name="connsiteY41" fmla="*/ 543589 h 3365467"/>
              <a:gd name="connsiteX42" fmla="*/ 323302 w 1115836"/>
              <a:gd name="connsiteY42" fmla="*/ 448338 h 3365467"/>
              <a:gd name="connsiteX43" fmla="*/ 161377 w 1115836"/>
              <a:gd name="connsiteY43" fmla="*/ 43526 h 3365467"/>
              <a:gd name="connsiteX44" fmla="*/ 166139 w 1115836"/>
              <a:gd name="connsiteY44" fmla="*/ 10188 h 3365467"/>
              <a:gd name="connsiteX45" fmla="*/ 4215 w 1115836"/>
              <a:gd name="connsiteY45" fmla="*/ 10188 h 3365467"/>
              <a:gd name="connsiteX0" fmla="*/ 4215 w 1115998"/>
              <a:gd name="connsiteY0" fmla="*/ 10188 h 3365467"/>
              <a:gd name="connsiteX1" fmla="*/ 51840 w 1115998"/>
              <a:gd name="connsiteY1" fmla="*/ 129251 h 3365467"/>
              <a:gd name="connsiteX2" fmla="*/ 56603 w 1115998"/>
              <a:gd name="connsiteY2" fmla="*/ 214976 h 3365467"/>
              <a:gd name="connsiteX3" fmla="*/ 113752 w 1115998"/>
              <a:gd name="connsiteY3" fmla="*/ 381663 h 3365467"/>
              <a:gd name="connsiteX4" fmla="*/ 108989 w 1115998"/>
              <a:gd name="connsiteY4" fmla="*/ 476913 h 3365467"/>
              <a:gd name="connsiteX5" fmla="*/ 151852 w 1115998"/>
              <a:gd name="connsiteY5" fmla="*/ 629313 h 3365467"/>
              <a:gd name="connsiteX6" fmla="*/ 132802 w 1115998"/>
              <a:gd name="connsiteY6" fmla="*/ 819813 h 3365467"/>
              <a:gd name="connsiteX7" fmla="*/ 199477 w 1115998"/>
              <a:gd name="connsiteY7" fmla="*/ 1000788 h 3365467"/>
              <a:gd name="connsiteX8" fmla="*/ 18502 w 1115998"/>
              <a:gd name="connsiteY8" fmla="*/ 1419888 h 3365467"/>
              <a:gd name="connsiteX9" fmla="*/ 75652 w 1115998"/>
              <a:gd name="connsiteY9" fmla="*/ 1705638 h 3365467"/>
              <a:gd name="connsiteX10" fmla="*/ 66127 w 1115998"/>
              <a:gd name="connsiteY10" fmla="*/ 2229513 h 3365467"/>
              <a:gd name="connsiteX11" fmla="*/ 113752 w 1115998"/>
              <a:gd name="connsiteY11" fmla="*/ 2486688 h 3365467"/>
              <a:gd name="connsiteX12" fmla="*/ 56602 w 1115998"/>
              <a:gd name="connsiteY12" fmla="*/ 2820063 h 3365467"/>
              <a:gd name="connsiteX13" fmla="*/ 75652 w 1115998"/>
              <a:gd name="connsiteY13" fmla="*/ 3153438 h 3365467"/>
              <a:gd name="connsiteX14" fmla="*/ 142327 w 1115998"/>
              <a:gd name="connsiteY14" fmla="*/ 3353463 h 3365467"/>
              <a:gd name="connsiteX15" fmla="*/ 56602 w 1115998"/>
              <a:gd name="connsiteY15" fmla="*/ 3343938 h 3365467"/>
              <a:gd name="connsiteX16" fmla="*/ 675727 w 1115998"/>
              <a:gd name="connsiteY16" fmla="*/ 3353463 h 3365467"/>
              <a:gd name="connsiteX17" fmla="*/ 637627 w 1115998"/>
              <a:gd name="connsiteY17" fmla="*/ 3343938 h 3365467"/>
              <a:gd name="connsiteX18" fmla="*/ 675727 w 1115998"/>
              <a:gd name="connsiteY18" fmla="*/ 3334413 h 3365467"/>
              <a:gd name="connsiteX19" fmla="*/ 675727 w 1115998"/>
              <a:gd name="connsiteY19" fmla="*/ 3248688 h 3365467"/>
              <a:gd name="connsiteX20" fmla="*/ 628102 w 1115998"/>
              <a:gd name="connsiteY20" fmla="*/ 3182013 h 3365467"/>
              <a:gd name="connsiteX21" fmla="*/ 618577 w 1115998"/>
              <a:gd name="connsiteY21" fmla="*/ 2972463 h 3365467"/>
              <a:gd name="connsiteX22" fmla="*/ 542377 w 1115998"/>
              <a:gd name="connsiteY22" fmla="*/ 2648613 h 3365467"/>
              <a:gd name="connsiteX23" fmla="*/ 447127 w 1115998"/>
              <a:gd name="connsiteY23" fmla="*/ 2534313 h 3365467"/>
              <a:gd name="connsiteX24" fmla="*/ 437602 w 1115998"/>
              <a:gd name="connsiteY24" fmla="*/ 2429538 h 3365467"/>
              <a:gd name="connsiteX25" fmla="*/ 494752 w 1115998"/>
              <a:gd name="connsiteY25" fmla="*/ 2315238 h 3365467"/>
              <a:gd name="connsiteX26" fmla="*/ 637627 w 1115998"/>
              <a:gd name="connsiteY26" fmla="*/ 2572413 h 3365467"/>
              <a:gd name="connsiteX27" fmla="*/ 732877 w 1115998"/>
              <a:gd name="connsiteY27" fmla="*/ 2562888 h 3365467"/>
              <a:gd name="connsiteX28" fmla="*/ 904327 w 1115998"/>
              <a:gd name="connsiteY28" fmla="*/ 2277138 h 3365467"/>
              <a:gd name="connsiteX29" fmla="*/ 847177 w 1115998"/>
              <a:gd name="connsiteY29" fmla="*/ 2058063 h 3365467"/>
              <a:gd name="connsiteX30" fmla="*/ 904327 w 1115998"/>
              <a:gd name="connsiteY30" fmla="*/ 1819938 h 3365467"/>
              <a:gd name="connsiteX31" fmla="*/ 928139 w 1115998"/>
              <a:gd name="connsiteY31" fmla="*/ 1715163 h 3365467"/>
              <a:gd name="connsiteX32" fmla="*/ 1090064 w 1115998"/>
              <a:gd name="connsiteY32" fmla="*/ 1467513 h 3365467"/>
              <a:gd name="connsiteX33" fmla="*/ 1113877 w 1115998"/>
              <a:gd name="connsiteY33" fmla="*/ 1238913 h 3365467"/>
              <a:gd name="connsiteX34" fmla="*/ 1071015 w 1115998"/>
              <a:gd name="connsiteY34" fmla="*/ 1067463 h 3365467"/>
              <a:gd name="connsiteX35" fmla="*/ 1056727 w 1115998"/>
              <a:gd name="connsiteY35" fmla="*/ 962688 h 3365467"/>
              <a:gd name="connsiteX36" fmla="*/ 894802 w 1115998"/>
              <a:gd name="connsiteY36" fmla="*/ 1019838 h 3365467"/>
              <a:gd name="connsiteX37" fmla="*/ 890039 w 1115998"/>
              <a:gd name="connsiteY37" fmla="*/ 848388 h 3365467"/>
              <a:gd name="connsiteX38" fmla="*/ 799552 w 1115998"/>
              <a:gd name="connsiteY38" fmla="*/ 667413 h 3365467"/>
              <a:gd name="connsiteX39" fmla="*/ 642390 w 1115998"/>
              <a:gd name="connsiteY39" fmla="*/ 648364 h 3365467"/>
              <a:gd name="connsiteX40" fmla="*/ 609052 w 1115998"/>
              <a:gd name="connsiteY40" fmla="*/ 581688 h 3365467"/>
              <a:gd name="connsiteX41" fmla="*/ 442365 w 1115998"/>
              <a:gd name="connsiteY41" fmla="*/ 543589 h 3365467"/>
              <a:gd name="connsiteX42" fmla="*/ 323302 w 1115998"/>
              <a:gd name="connsiteY42" fmla="*/ 448338 h 3365467"/>
              <a:gd name="connsiteX43" fmla="*/ 161377 w 1115998"/>
              <a:gd name="connsiteY43" fmla="*/ 43526 h 3365467"/>
              <a:gd name="connsiteX44" fmla="*/ 166139 w 1115998"/>
              <a:gd name="connsiteY44" fmla="*/ 10188 h 3365467"/>
              <a:gd name="connsiteX45" fmla="*/ 4215 w 1115998"/>
              <a:gd name="connsiteY45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32802 w 1114176"/>
              <a:gd name="connsiteY6" fmla="*/ 819813 h 3365467"/>
              <a:gd name="connsiteX7" fmla="*/ 199477 w 1114176"/>
              <a:gd name="connsiteY7" fmla="*/ 1000788 h 3365467"/>
              <a:gd name="connsiteX8" fmla="*/ 18502 w 1114176"/>
              <a:gd name="connsiteY8" fmla="*/ 1419888 h 3365467"/>
              <a:gd name="connsiteX9" fmla="*/ 75652 w 1114176"/>
              <a:gd name="connsiteY9" fmla="*/ 1705638 h 3365467"/>
              <a:gd name="connsiteX10" fmla="*/ 66127 w 1114176"/>
              <a:gd name="connsiteY10" fmla="*/ 2229513 h 3365467"/>
              <a:gd name="connsiteX11" fmla="*/ 113752 w 1114176"/>
              <a:gd name="connsiteY11" fmla="*/ 2486688 h 3365467"/>
              <a:gd name="connsiteX12" fmla="*/ 56602 w 1114176"/>
              <a:gd name="connsiteY12" fmla="*/ 2820063 h 3365467"/>
              <a:gd name="connsiteX13" fmla="*/ 75652 w 1114176"/>
              <a:gd name="connsiteY13" fmla="*/ 3153438 h 3365467"/>
              <a:gd name="connsiteX14" fmla="*/ 142327 w 1114176"/>
              <a:gd name="connsiteY14" fmla="*/ 3353463 h 3365467"/>
              <a:gd name="connsiteX15" fmla="*/ 56602 w 1114176"/>
              <a:gd name="connsiteY15" fmla="*/ 3343938 h 3365467"/>
              <a:gd name="connsiteX16" fmla="*/ 675727 w 1114176"/>
              <a:gd name="connsiteY16" fmla="*/ 3353463 h 3365467"/>
              <a:gd name="connsiteX17" fmla="*/ 637627 w 1114176"/>
              <a:gd name="connsiteY17" fmla="*/ 3343938 h 3365467"/>
              <a:gd name="connsiteX18" fmla="*/ 675727 w 1114176"/>
              <a:gd name="connsiteY18" fmla="*/ 3334413 h 3365467"/>
              <a:gd name="connsiteX19" fmla="*/ 675727 w 1114176"/>
              <a:gd name="connsiteY19" fmla="*/ 3248688 h 3365467"/>
              <a:gd name="connsiteX20" fmla="*/ 628102 w 1114176"/>
              <a:gd name="connsiteY20" fmla="*/ 3182013 h 3365467"/>
              <a:gd name="connsiteX21" fmla="*/ 618577 w 1114176"/>
              <a:gd name="connsiteY21" fmla="*/ 2972463 h 3365467"/>
              <a:gd name="connsiteX22" fmla="*/ 542377 w 1114176"/>
              <a:gd name="connsiteY22" fmla="*/ 2648613 h 3365467"/>
              <a:gd name="connsiteX23" fmla="*/ 447127 w 1114176"/>
              <a:gd name="connsiteY23" fmla="*/ 2534313 h 3365467"/>
              <a:gd name="connsiteX24" fmla="*/ 437602 w 1114176"/>
              <a:gd name="connsiteY24" fmla="*/ 2429538 h 3365467"/>
              <a:gd name="connsiteX25" fmla="*/ 494752 w 1114176"/>
              <a:gd name="connsiteY25" fmla="*/ 2315238 h 3365467"/>
              <a:gd name="connsiteX26" fmla="*/ 637627 w 1114176"/>
              <a:gd name="connsiteY26" fmla="*/ 2572413 h 3365467"/>
              <a:gd name="connsiteX27" fmla="*/ 732877 w 1114176"/>
              <a:gd name="connsiteY27" fmla="*/ 2562888 h 3365467"/>
              <a:gd name="connsiteX28" fmla="*/ 904327 w 1114176"/>
              <a:gd name="connsiteY28" fmla="*/ 2277138 h 3365467"/>
              <a:gd name="connsiteX29" fmla="*/ 847177 w 1114176"/>
              <a:gd name="connsiteY29" fmla="*/ 2058063 h 3365467"/>
              <a:gd name="connsiteX30" fmla="*/ 904327 w 1114176"/>
              <a:gd name="connsiteY30" fmla="*/ 1819938 h 3365467"/>
              <a:gd name="connsiteX31" fmla="*/ 928139 w 1114176"/>
              <a:gd name="connsiteY31" fmla="*/ 1715163 h 3365467"/>
              <a:gd name="connsiteX32" fmla="*/ 1090064 w 1114176"/>
              <a:gd name="connsiteY32" fmla="*/ 1467513 h 3365467"/>
              <a:gd name="connsiteX33" fmla="*/ 1090065 w 1114176"/>
              <a:gd name="connsiteY33" fmla="*/ 1381789 h 3365467"/>
              <a:gd name="connsiteX34" fmla="*/ 1113877 w 1114176"/>
              <a:gd name="connsiteY34" fmla="*/ 1238913 h 3365467"/>
              <a:gd name="connsiteX35" fmla="*/ 1071015 w 1114176"/>
              <a:gd name="connsiteY35" fmla="*/ 1067463 h 3365467"/>
              <a:gd name="connsiteX36" fmla="*/ 1056727 w 1114176"/>
              <a:gd name="connsiteY36" fmla="*/ 962688 h 3365467"/>
              <a:gd name="connsiteX37" fmla="*/ 894802 w 1114176"/>
              <a:gd name="connsiteY37" fmla="*/ 1019838 h 3365467"/>
              <a:gd name="connsiteX38" fmla="*/ 890039 w 1114176"/>
              <a:gd name="connsiteY38" fmla="*/ 848388 h 3365467"/>
              <a:gd name="connsiteX39" fmla="*/ 799552 w 1114176"/>
              <a:gd name="connsiteY39" fmla="*/ 667413 h 3365467"/>
              <a:gd name="connsiteX40" fmla="*/ 642390 w 1114176"/>
              <a:gd name="connsiteY40" fmla="*/ 648364 h 3365467"/>
              <a:gd name="connsiteX41" fmla="*/ 609052 w 1114176"/>
              <a:gd name="connsiteY41" fmla="*/ 581688 h 3365467"/>
              <a:gd name="connsiteX42" fmla="*/ 442365 w 1114176"/>
              <a:gd name="connsiteY42" fmla="*/ 543589 h 3365467"/>
              <a:gd name="connsiteX43" fmla="*/ 323302 w 1114176"/>
              <a:gd name="connsiteY43" fmla="*/ 448338 h 3365467"/>
              <a:gd name="connsiteX44" fmla="*/ 161377 w 1114176"/>
              <a:gd name="connsiteY44" fmla="*/ 43526 h 3365467"/>
              <a:gd name="connsiteX45" fmla="*/ 166139 w 1114176"/>
              <a:gd name="connsiteY45" fmla="*/ 10188 h 3365467"/>
              <a:gd name="connsiteX46" fmla="*/ 4215 w 1114176"/>
              <a:gd name="connsiteY46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56615 w 1114176"/>
              <a:gd name="connsiteY6" fmla="*/ 824575 h 3365467"/>
              <a:gd name="connsiteX7" fmla="*/ 199477 w 1114176"/>
              <a:gd name="connsiteY7" fmla="*/ 1000788 h 3365467"/>
              <a:gd name="connsiteX8" fmla="*/ 18502 w 1114176"/>
              <a:gd name="connsiteY8" fmla="*/ 1419888 h 3365467"/>
              <a:gd name="connsiteX9" fmla="*/ 75652 w 1114176"/>
              <a:gd name="connsiteY9" fmla="*/ 1705638 h 3365467"/>
              <a:gd name="connsiteX10" fmla="*/ 66127 w 1114176"/>
              <a:gd name="connsiteY10" fmla="*/ 2229513 h 3365467"/>
              <a:gd name="connsiteX11" fmla="*/ 113752 w 1114176"/>
              <a:gd name="connsiteY11" fmla="*/ 2486688 h 3365467"/>
              <a:gd name="connsiteX12" fmla="*/ 56602 w 1114176"/>
              <a:gd name="connsiteY12" fmla="*/ 2820063 h 3365467"/>
              <a:gd name="connsiteX13" fmla="*/ 75652 w 1114176"/>
              <a:gd name="connsiteY13" fmla="*/ 3153438 h 3365467"/>
              <a:gd name="connsiteX14" fmla="*/ 142327 w 1114176"/>
              <a:gd name="connsiteY14" fmla="*/ 3353463 h 3365467"/>
              <a:gd name="connsiteX15" fmla="*/ 56602 w 1114176"/>
              <a:gd name="connsiteY15" fmla="*/ 3343938 h 3365467"/>
              <a:gd name="connsiteX16" fmla="*/ 675727 w 1114176"/>
              <a:gd name="connsiteY16" fmla="*/ 3353463 h 3365467"/>
              <a:gd name="connsiteX17" fmla="*/ 637627 w 1114176"/>
              <a:gd name="connsiteY17" fmla="*/ 3343938 h 3365467"/>
              <a:gd name="connsiteX18" fmla="*/ 675727 w 1114176"/>
              <a:gd name="connsiteY18" fmla="*/ 3334413 h 3365467"/>
              <a:gd name="connsiteX19" fmla="*/ 675727 w 1114176"/>
              <a:gd name="connsiteY19" fmla="*/ 3248688 h 3365467"/>
              <a:gd name="connsiteX20" fmla="*/ 628102 w 1114176"/>
              <a:gd name="connsiteY20" fmla="*/ 3182013 h 3365467"/>
              <a:gd name="connsiteX21" fmla="*/ 618577 w 1114176"/>
              <a:gd name="connsiteY21" fmla="*/ 2972463 h 3365467"/>
              <a:gd name="connsiteX22" fmla="*/ 542377 w 1114176"/>
              <a:gd name="connsiteY22" fmla="*/ 2648613 h 3365467"/>
              <a:gd name="connsiteX23" fmla="*/ 447127 w 1114176"/>
              <a:gd name="connsiteY23" fmla="*/ 2534313 h 3365467"/>
              <a:gd name="connsiteX24" fmla="*/ 437602 w 1114176"/>
              <a:gd name="connsiteY24" fmla="*/ 2429538 h 3365467"/>
              <a:gd name="connsiteX25" fmla="*/ 494752 w 1114176"/>
              <a:gd name="connsiteY25" fmla="*/ 2315238 h 3365467"/>
              <a:gd name="connsiteX26" fmla="*/ 637627 w 1114176"/>
              <a:gd name="connsiteY26" fmla="*/ 2572413 h 3365467"/>
              <a:gd name="connsiteX27" fmla="*/ 732877 w 1114176"/>
              <a:gd name="connsiteY27" fmla="*/ 2562888 h 3365467"/>
              <a:gd name="connsiteX28" fmla="*/ 904327 w 1114176"/>
              <a:gd name="connsiteY28" fmla="*/ 2277138 h 3365467"/>
              <a:gd name="connsiteX29" fmla="*/ 847177 w 1114176"/>
              <a:gd name="connsiteY29" fmla="*/ 2058063 h 3365467"/>
              <a:gd name="connsiteX30" fmla="*/ 904327 w 1114176"/>
              <a:gd name="connsiteY30" fmla="*/ 1819938 h 3365467"/>
              <a:gd name="connsiteX31" fmla="*/ 928139 w 1114176"/>
              <a:gd name="connsiteY31" fmla="*/ 1715163 h 3365467"/>
              <a:gd name="connsiteX32" fmla="*/ 1090064 w 1114176"/>
              <a:gd name="connsiteY32" fmla="*/ 1467513 h 3365467"/>
              <a:gd name="connsiteX33" fmla="*/ 1090065 w 1114176"/>
              <a:gd name="connsiteY33" fmla="*/ 1381789 h 3365467"/>
              <a:gd name="connsiteX34" fmla="*/ 1113877 w 1114176"/>
              <a:gd name="connsiteY34" fmla="*/ 1238913 h 3365467"/>
              <a:gd name="connsiteX35" fmla="*/ 1071015 w 1114176"/>
              <a:gd name="connsiteY35" fmla="*/ 1067463 h 3365467"/>
              <a:gd name="connsiteX36" fmla="*/ 1056727 w 1114176"/>
              <a:gd name="connsiteY36" fmla="*/ 962688 h 3365467"/>
              <a:gd name="connsiteX37" fmla="*/ 894802 w 1114176"/>
              <a:gd name="connsiteY37" fmla="*/ 1019838 h 3365467"/>
              <a:gd name="connsiteX38" fmla="*/ 890039 w 1114176"/>
              <a:gd name="connsiteY38" fmla="*/ 848388 h 3365467"/>
              <a:gd name="connsiteX39" fmla="*/ 799552 w 1114176"/>
              <a:gd name="connsiteY39" fmla="*/ 667413 h 3365467"/>
              <a:gd name="connsiteX40" fmla="*/ 642390 w 1114176"/>
              <a:gd name="connsiteY40" fmla="*/ 648364 h 3365467"/>
              <a:gd name="connsiteX41" fmla="*/ 609052 w 1114176"/>
              <a:gd name="connsiteY41" fmla="*/ 581688 h 3365467"/>
              <a:gd name="connsiteX42" fmla="*/ 442365 w 1114176"/>
              <a:gd name="connsiteY42" fmla="*/ 543589 h 3365467"/>
              <a:gd name="connsiteX43" fmla="*/ 323302 w 1114176"/>
              <a:gd name="connsiteY43" fmla="*/ 448338 h 3365467"/>
              <a:gd name="connsiteX44" fmla="*/ 161377 w 1114176"/>
              <a:gd name="connsiteY44" fmla="*/ 43526 h 3365467"/>
              <a:gd name="connsiteX45" fmla="*/ 166139 w 1114176"/>
              <a:gd name="connsiteY45" fmla="*/ 10188 h 3365467"/>
              <a:gd name="connsiteX46" fmla="*/ 4215 w 1114176"/>
              <a:gd name="connsiteY46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56615 w 1114176"/>
              <a:gd name="connsiteY6" fmla="*/ 824575 h 3365467"/>
              <a:gd name="connsiteX7" fmla="*/ 170902 w 1114176"/>
              <a:gd name="connsiteY7" fmla="*/ 957927 h 3365467"/>
              <a:gd name="connsiteX8" fmla="*/ 199477 w 1114176"/>
              <a:gd name="connsiteY8" fmla="*/ 1000788 h 3365467"/>
              <a:gd name="connsiteX9" fmla="*/ 18502 w 1114176"/>
              <a:gd name="connsiteY9" fmla="*/ 1419888 h 3365467"/>
              <a:gd name="connsiteX10" fmla="*/ 75652 w 1114176"/>
              <a:gd name="connsiteY10" fmla="*/ 1705638 h 3365467"/>
              <a:gd name="connsiteX11" fmla="*/ 66127 w 1114176"/>
              <a:gd name="connsiteY11" fmla="*/ 2229513 h 3365467"/>
              <a:gd name="connsiteX12" fmla="*/ 113752 w 1114176"/>
              <a:gd name="connsiteY12" fmla="*/ 2486688 h 3365467"/>
              <a:gd name="connsiteX13" fmla="*/ 56602 w 1114176"/>
              <a:gd name="connsiteY13" fmla="*/ 2820063 h 3365467"/>
              <a:gd name="connsiteX14" fmla="*/ 75652 w 1114176"/>
              <a:gd name="connsiteY14" fmla="*/ 3153438 h 3365467"/>
              <a:gd name="connsiteX15" fmla="*/ 142327 w 1114176"/>
              <a:gd name="connsiteY15" fmla="*/ 3353463 h 3365467"/>
              <a:gd name="connsiteX16" fmla="*/ 56602 w 1114176"/>
              <a:gd name="connsiteY16" fmla="*/ 3343938 h 3365467"/>
              <a:gd name="connsiteX17" fmla="*/ 675727 w 1114176"/>
              <a:gd name="connsiteY17" fmla="*/ 3353463 h 3365467"/>
              <a:gd name="connsiteX18" fmla="*/ 637627 w 1114176"/>
              <a:gd name="connsiteY18" fmla="*/ 3343938 h 3365467"/>
              <a:gd name="connsiteX19" fmla="*/ 675727 w 1114176"/>
              <a:gd name="connsiteY19" fmla="*/ 3334413 h 3365467"/>
              <a:gd name="connsiteX20" fmla="*/ 675727 w 1114176"/>
              <a:gd name="connsiteY20" fmla="*/ 3248688 h 3365467"/>
              <a:gd name="connsiteX21" fmla="*/ 628102 w 1114176"/>
              <a:gd name="connsiteY21" fmla="*/ 3182013 h 3365467"/>
              <a:gd name="connsiteX22" fmla="*/ 618577 w 1114176"/>
              <a:gd name="connsiteY22" fmla="*/ 2972463 h 3365467"/>
              <a:gd name="connsiteX23" fmla="*/ 542377 w 1114176"/>
              <a:gd name="connsiteY23" fmla="*/ 2648613 h 3365467"/>
              <a:gd name="connsiteX24" fmla="*/ 447127 w 1114176"/>
              <a:gd name="connsiteY24" fmla="*/ 2534313 h 3365467"/>
              <a:gd name="connsiteX25" fmla="*/ 437602 w 1114176"/>
              <a:gd name="connsiteY25" fmla="*/ 2429538 h 3365467"/>
              <a:gd name="connsiteX26" fmla="*/ 494752 w 1114176"/>
              <a:gd name="connsiteY26" fmla="*/ 2315238 h 3365467"/>
              <a:gd name="connsiteX27" fmla="*/ 637627 w 1114176"/>
              <a:gd name="connsiteY27" fmla="*/ 2572413 h 3365467"/>
              <a:gd name="connsiteX28" fmla="*/ 732877 w 1114176"/>
              <a:gd name="connsiteY28" fmla="*/ 2562888 h 3365467"/>
              <a:gd name="connsiteX29" fmla="*/ 904327 w 1114176"/>
              <a:gd name="connsiteY29" fmla="*/ 2277138 h 3365467"/>
              <a:gd name="connsiteX30" fmla="*/ 847177 w 1114176"/>
              <a:gd name="connsiteY30" fmla="*/ 2058063 h 3365467"/>
              <a:gd name="connsiteX31" fmla="*/ 904327 w 1114176"/>
              <a:gd name="connsiteY31" fmla="*/ 1819938 h 3365467"/>
              <a:gd name="connsiteX32" fmla="*/ 928139 w 1114176"/>
              <a:gd name="connsiteY32" fmla="*/ 1715163 h 3365467"/>
              <a:gd name="connsiteX33" fmla="*/ 1090064 w 1114176"/>
              <a:gd name="connsiteY33" fmla="*/ 1467513 h 3365467"/>
              <a:gd name="connsiteX34" fmla="*/ 1090065 w 1114176"/>
              <a:gd name="connsiteY34" fmla="*/ 1381789 h 3365467"/>
              <a:gd name="connsiteX35" fmla="*/ 1113877 w 1114176"/>
              <a:gd name="connsiteY35" fmla="*/ 1238913 h 3365467"/>
              <a:gd name="connsiteX36" fmla="*/ 1071015 w 1114176"/>
              <a:gd name="connsiteY36" fmla="*/ 1067463 h 3365467"/>
              <a:gd name="connsiteX37" fmla="*/ 1056727 w 1114176"/>
              <a:gd name="connsiteY37" fmla="*/ 962688 h 3365467"/>
              <a:gd name="connsiteX38" fmla="*/ 894802 w 1114176"/>
              <a:gd name="connsiteY38" fmla="*/ 1019838 h 3365467"/>
              <a:gd name="connsiteX39" fmla="*/ 890039 w 1114176"/>
              <a:gd name="connsiteY39" fmla="*/ 848388 h 3365467"/>
              <a:gd name="connsiteX40" fmla="*/ 799552 w 1114176"/>
              <a:gd name="connsiteY40" fmla="*/ 667413 h 3365467"/>
              <a:gd name="connsiteX41" fmla="*/ 642390 w 1114176"/>
              <a:gd name="connsiteY41" fmla="*/ 648364 h 3365467"/>
              <a:gd name="connsiteX42" fmla="*/ 609052 w 1114176"/>
              <a:gd name="connsiteY42" fmla="*/ 581688 h 3365467"/>
              <a:gd name="connsiteX43" fmla="*/ 442365 w 1114176"/>
              <a:gd name="connsiteY43" fmla="*/ 543589 h 3365467"/>
              <a:gd name="connsiteX44" fmla="*/ 323302 w 1114176"/>
              <a:gd name="connsiteY44" fmla="*/ 448338 h 3365467"/>
              <a:gd name="connsiteX45" fmla="*/ 161377 w 1114176"/>
              <a:gd name="connsiteY45" fmla="*/ 43526 h 3365467"/>
              <a:gd name="connsiteX46" fmla="*/ 166139 w 1114176"/>
              <a:gd name="connsiteY46" fmla="*/ 10188 h 3365467"/>
              <a:gd name="connsiteX47" fmla="*/ 4215 w 1114176"/>
              <a:gd name="connsiteY47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56615 w 1114176"/>
              <a:gd name="connsiteY6" fmla="*/ 824575 h 3365467"/>
              <a:gd name="connsiteX7" fmla="*/ 170902 w 1114176"/>
              <a:gd name="connsiteY7" fmla="*/ 957927 h 3365467"/>
              <a:gd name="connsiteX8" fmla="*/ 199477 w 1114176"/>
              <a:gd name="connsiteY8" fmla="*/ 1019838 h 3365467"/>
              <a:gd name="connsiteX9" fmla="*/ 18502 w 1114176"/>
              <a:gd name="connsiteY9" fmla="*/ 1419888 h 3365467"/>
              <a:gd name="connsiteX10" fmla="*/ 75652 w 1114176"/>
              <a:gd name="connsiteY10" fmla="*/ 1705638 h 3365467"/>
              <a:gd name="connsiteX11" fmla="*/ 66127 w 1114176"/>
              <a:gd name="connsiteY11" fmla="*/ 2229513 h 3365467"/>
              <a:gd name="connsiteX12" fmla="*/ 113752 w 1114176"/>
              <a:gd name="connsiteY12" fmla="*/ 2486688 h 3365467"/>
              <a:gd name="connsiteX13" fmla="*/ 56602 w 1114176"/>
              <a:gd name="connsiteY13" fmla="*/ 2820063 h 3365467"/>
              <a:gd name="connsiteX14" fmla="*/ 75652 w 1114176"/>
              <a:gd name="connsiteY14" fmla="*/ 3153438 h 3365467"/>
              <a:gd name="connsiteX15" fmla="*/ 142327 w 1114176"/>
              <a:gd name="connsiteY15" fmla="*/ 3353463 h 3365467"/>
              <a:gd name="connsiteX16" fmla="*/ 56602 w 1114176"/>
              <a:gd name="connsiteY16" fmla="*/ 3343938 h 3365467"/>
              <a:gd name="connsiteX17" fmla="*/ 675727 w 1114176"/>
              <a:gd name="connsiteY17" fmla="*/ 3353463 h 3365467"/>
              <a:gd name="connsiteX18" fmla="*/ 637627 w 1114176"/>
              <a:gd name="connsiteY18" fmla="*/ 3343938 h 3365467"/>
              <a:gd name="connsiteX19" fmla="*/ 675727 w 1114176"/>
              <a:gd name="connsiteY19" fmla="*/ 3334413 h 3365467"/>
              <a:gd name="connsiteX20" fmla="*/ 675727 w 1114176"/>
              <a:gd name="connsiteY20" fmla="*/ 3248688 h 3365467"/>
              <a:gd name="connsiteX21" fmla="*/ 628102 w 1114176"/>
              <a:gd name="connsiteY21" fmla="*/ 3182013 h 3365467"/>
              <a:gd name="connsiteX22" fmla="*/ 618577 w 1114176"/>
              <a:gd name="connsiteY22" fmla="*/ 2972463 h 3365467"/>
              <a:gd name="connsiteX23" fmla="*/ 542377 w 1114176"/>
              <a:gd name="connsiteY23" fmla="*/ 2648613 h 3365467"/>
              <a:gd name="connsiteX24" fmla="*/ 447127 w 1114176"/>
              <a:gd name="connsiteY24" fmla="*/ 2534313 h 3365467"/>
              <a:gd name="connsiteX25" fmla="*/ 437602 w 1114176"/>
              <a:gd name="connsiteY25" fmla="*/ 2429538 h 3365467"/>
              <a:gd name="connsiteX26" fmla="*/ 494752 w 1114176"/>
              <a:gd name="connsiteY26" fmla="*/ 2315238 h 3365467"/>
              <a:gd name="connsiteX27" fmla="*/ 637627 w 1114176"/>
              <a:gd name="connsiteY27" fmla="*/ 2572413 h 3365467"/>
              <a:gd name="connsiteX28" fmla="*/ 732877 w 1114176"/>
              <a:gd name="connsiteY28" fmla="*/ 2562888 h 3365467"/>
              <a:gd name="connsiteX29" fmla="*/ 904327 w 1114176"/>
              <a:gd name="connsiteY29" fmla="*/ 2277138 h 3365467"/>
              <a:gd name="connsiteX30" fmla="*/ 847177 w 1114176"/>
              <a:gd name="connsiteY30" fmla="*/ 2058063 h 3365467"/>
              <a:gd name="connsiteX31" fmla="*/ 904327 w 1114176"/>
              <a:gd name="connsiteY31" fmla="*/ 1819938 h 3365467"/>
              <a:gd name="connsiteX32" fmla="*/ 928139 w 1114176"/>
              <a:gd name="connsiteY32" fmla="*/ 1715163 h 3365467"/>
              <a:gd name="connsiteX33" fmla="*/ 1090064 w 1114176"/>
              <a:gd name="connsiteY33" fmla="*/ 1467513 h 3365467"/>
              <a:gd name="connsiteX34" fmla="*/ 1090065 w 1114176"/>
              <a:gd name="connsiteY34" fmla="*/ 1381789 h 3365467"/>
              <a:gd name="connsiteX35" fmla="*/ 1113877 w 1114176"/>
              <a:gd name="connsiteY35" fmla="*/ 1238913 h 3365467"/>
              <a:gd name="connsiteX36" fmla="*/ 1071015 w 1114176"/>
              <a:gd name="connsiteY36" fmla="*/ 1067463 h 3365467"/>
              <a:gd name="connsiteX37" fmla="*/ 1056727 w 1114176"/>
              <a:gd name="connsiteY37" fmla="*/ 962688 h 3365467"/>
              <a:gd name="connsiteX38" fmla="*/ 894802 w 1114176"/>
              <a:gd name="connsiteY38" fmla="*/ 1019838 h 3365467"/>
              <a:gd name="connsiteX39" fmla="*/ 890039 w 1114176"/>
              <a:gd name="connsiteY39" fmla="*/ 848388 h 3365467"/>
              <a:gd name="connsiteX40" fmla="*/ 799552 w 1114176"/>
              <a:gd name="connsiteY40" fmla="*/ 667413 h 3365467"/>
              <a:gd name="connsiteX41" fmla="*/ 642390 w 1114176"/>
              <a:gd name="connsiteY41" fmla="*/ 648364 h 3365467"/>
              <a:gd name="connsiteX42" fmla="*/ 609052 w 1114176"/>
              <a:gd name="connsiteY42" fmla="*/ 581688 h 3365467"/>
              <a:gd name="connsiteX43" fmla="*/ 442365 w 1114176"/>
              <a:gd name="connsiteY43" fmla="*/ 543589 h 3365467"/>
              <a:gd name="connsiteX44" fmla="*/ 323302 w 1114176"/>
              <a:gd name="connsiteY44" fmla="*/ 448338 h 3365467"/>
              <a:gd name="connsiteX45" fmla="*/ 161377 w 1114176"/>
              <a:gd name="connsiteY45" fmla="*/ 43526 h 3365467"/>
              <a:gd name="connsiteX46" fmla="*/ 166139 w 1114176"/>
              <a:gd name="connsiteY46" fmla="*/ 10188 h 3365467"/>
              <a:gd name="connsiteX47" fmla="*/ 4215 w 1114176"/>
              <a:gd name="connsiteY47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56615 w 1114176"/>
              <a:gd name="connsiteY6" fmla="*/ 824575 h 3365467"/>
              <a:gd name="connsiteX7" fmla="*/ 170902 w 1114176"/>
              <a:gd name="connsiteY7" fmla="*/ 957927 h 3365467"/>
              <a:gd name="connsiteX8" fmla="*/ 199477 w 1114176"/>
              <a:gd name="connsiteY8" fmla="*/ 1019838 h 3365467"/>
              <a:gd name="connsiteX9" fmla="*/ 32789 w 1114176"/>
              <a:gd name="connsiteY9" fmla="*/ 1524663 h 3365467"/>
              <a:gd name="connsiteX10" fmla="*/ 75652 w 1114176"/>
              <a:gd name="connsiteY10" fmla="*/ 1705638 h 3365467"/>
              <a:gd name="connsiteX11" fmla="*/ 66127 w 1114176"/>
              <a:gd name="connsiteY11" fmla="*/ 2229513 h 3365467"/>
              <a:gd name="connsiteX12" fmla="*/ 113752 w 1114176"/>
              <a:gd name="connsiteY12" fmla="*/ 2486688 h 3365467"/>
              <a:gd name="connsiteX13" fmla="*/ 56602 w 1114176"/>
              <a:gd name="connsiteY13" fmla="*/ 2820063 h 3365467"/>
              <a:gd name="connsiteX14" fmla="*/ 75652 w 1114176"/>
              <a:gd name="connsiteY14" fmla="*/ 3153438 h 3365467"/>
              <a:gd name="connsiteX15" fmla="*/ 142327 w 1114176"/>
              <a:gd name="connsiteY15" fmla="*/ 3353463 h 3365467"/>
              <a:gd name="connsiteX16" fmla="*/ 56602 w 1114176"/>
              <a:gd name="connsiteY16" fmla="*/ 3343938 h 3365467"/>
              <a:gd name="connsiteX17" fmla="*/ 675727 w 1114176"/>
              <a:gd name="connsiteY17" fmla="*/ 3353463 h 3365467"/>
              <a:gd name="connsiteX18" fmla="*/ 637627 w 1114176"/>
              <a:gd name="connsiteY18" fmla="*/ 3343938 h 3365467"/>
              <a:gd name="connsiteX19" fmla="*/ 675727 w 1114176"/>
              <a:gd name="connsiteY19" fmla="*/ 3334413 h 3365467"/>
              <a:gd name="connsiteX20" fmla="*/ 675727 w 1114176"/>
              <a:gd name="connsiteY20" fmla="*/ 3248688 h 3365467"/>
              <a:gd name="connsiteX21" fmla="*/ 628102 w 1114176"/>
              <a:gd name="connsiteY21" fmla="*/ 3182013 h 3365467"/>
              <a:gd name="connsiteX22" fmla="*/ 618577 w 1114176"/>
              <a:gd name="connsiteY22" fmla="*/ 2972463 h 3365467"/>
              <a:gd name="connsiteX23" fmla="*/ 542377 w 1114176"/>
              <a:gd name="connsiteY23" fmla="*/ 2648613 h 3365467"/>
              <a:gd name="connsiteX24" fmla="*/ 447127 w 1114176"/>
              <a:gd name="connsiteY24" fmla="*/ 2534313 h 3365467"/>
              <a:gd name="connsiteX25" fmla="*/ 437602 w 1114176"/>
              <a:gd name="connsiteY25" fmla="*/ 2429538 h 3365467"/>
              <a:gd name="connsiteX26" fmla="*/ 494752 w 1114176"/>
              <a:gd name="connsiteY26" fmla="*/ 2315238 h 3365467"/>
              <a:gd name="connsiteX27" fmla="*/ 637627 w 1114176"/>
              <a:gd name="connsiteY27" fmla="*/ 2572413 h 3365467"/>
              <a:gd name="connsiteX28" fmla="*/ 732877 w 1114176"/>
              <a:gd name="connsiteY28" fmla="*/ 2562888 h 3365467"/>
              <a:gd name="connsiteX29" fmla="*/ 904327 w 1114176"/>
              <a:gd name="connsiteY29" fmla="*/ 2277138 h 3365467"/>
              <a:gd name="connsiteX30" fmla="*/ 847177 w 1114176"/>
              <a:gd name="connsiteY30" fmla="*/ 2058063 h 3365467"/>
              <a:gd name="connsiteX31" fmla="*/ 904327 w 1114176"/>
              <a:gd name="connsiteY31" fmla="*/ 1819938 h 3365467"/>
              <a:gd name="connsiteX32" fmla="*/ 928139 w 1114176"/>
              <a:gd name="connsiteY32" fmla="*/ 1715163 h 3365467"/>
              <a:gd name="connsiteX33" fmla="*/ 1090064 w 1114176"/>
              <a:gd name="connsiteY33" fmla="*/ 1467513 h 3365467"/>
              <a:gd name="connsiteX34" fmla="*/ 1090065 w 1114176"/>
              <a:gd name="connsiteY34" fmla="*/ 1381789 h 3365467"/>
              <a:gd name="connsiteX35" fmla="*/ 1113877 w 1114176"/>
              <a:gd name="connsiteY35" fmla="*/ 1238913 h 3365467"/>
              <a:gd name="connsiteX36" fmla="*/ 1071015 w 1114176"/>
              <a:gd name="connsiteY36" fmla="*/ 1067463 h 3365467"/>
              <a:gd name="connsiteX37" fmla="*/ 1056727 w 1114176"/>
              <a:gd name="connsiteY37" fmla="*/ 962688 h 3365467"/>
              <a:gd name="connsiteX38" fmla="*/ 894802 w 1114176"/>
              <a:gd name="connsiteY38" fmla="*/ 1019838 h 3365467"/>
              <a:gd name="connsiteX39" fmla="*/ 890039 w 1114176"/>
              <a:gd name="connsiteY39" fmla="*/ 848388 h 3365467"/>
              <a:gd name="connsiteX40" fmla="*/ 799552 w 1114176"/>
              <a:gd name="connsiteY40" fmla="*/ 667413 h 3365467"/>
              <a:gd name="connsiteX41" fmla="*/ 642390 w 1114176"/>
              <a:gd name="connsiteY41" fmla="*/ 648364 h 3365467"/>
              <a:gd name="connsiteX42" fmla="*/ 609052 w 1114176"/>
              <a:gd name="connsiteY42" fmla="*/ 581688 h 3365467"/>
              <a:gd name="connsiteX43" fmla="*/ 442365 w 1114176"/>
              <a:gd name="connsiteY43" fmla="*/ 543589 h 3365467"/>
              <a:gd name="connsiteX44" fmla="*/ 323302 w 1114176"/>
              <a:gd name="connsiteY44" fmla="*/ 448338 h 3365467"/>
              <a:gd name="connsiteX45" fmla="*/ 161377 w 1114176"/>
              <a:gd name="connsiteY45" fmla="*/ 43526 h 3365467"/>
              <a:gd name="connsiteX46" fmla="*/ 166139 w 1114176"/>
              <a:gd name="connsiteY46" fmla="*/ 10188 h 3365467"/>
              <a:gd name="connsiteX47" fmla="*/ 4215 w 1114176"/>
              <a:gd name="connsiteY47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56615 w 1114176"/>
              <a:gd name="connsiteY6" fmla="*/ 824575 h 3365467"/>
              <a:gd name="connsiteX7" fmla="*/ 170902 w 1114176"/>
              <a:gd name="connsiteY7" fmla="*/ 957927 h 3365467"/>
              <a:gd name="connsiteX8" fmla="*/ 199477 w 1114176"/>
              <a:gd name="connsiteY8" fmla="*/ 1019838 h 3365467"/>
              <a:gd name="connsiteX9" fmla="*/ 175665 w 1114176"/>
              <a:gd name="connsiteY9" fmla="*/ 1129377 h 3365467"/>
              <a:gd name="connsiteX10" fmla="*/ 32789 w 1114176"/>
              <a:gd name="connsiteY10" fmla="*/ 1524663 h 3365467"/>
              <a:gd name="connsiteX11" fmla="*/ 75652 w 1114176"/>
              <a:gd name="connsiteY11" fmla="*/ 1705638 h 3365467"/>
              <a:gd name="connsiteX12" fmla="*/ 66127 w 1114176"/>
              <a:gd name="connsiteY12" fmla="*/ 2229513 h 3365467"/>
              <a:gd name="connsiteX13" fmla="*/ 113752 w 1114176"/>
              <a:gd name="connsiteY13" fmla="*/ 2486688 h 3365467"/>
              <a:gd name="connsiteX14" fmla="*/ 56602 w 1114176"/>
              <a:gd name="connsiteY14" fmla="*/ 2820063 h 3365467"/>
              <a:gd name="connsiteX15" fmla="*/ 75652 w 1114176"/>
              <a:gd name="connsiteY15" fmla="*/ 3153438 h 3365467"/>
              <a:gd name="connsiteX16" fmla="*/ 142327 w 1114176"/>
              <a:gd name="connsiteY16" fmla="*/ 3353463 h 3365467"/>
              <a:gd name="connsiteX17" fmla="*/ 56602 w 1114176"/>
              <a:gd name="connsiteY17" fmla="*/ 3343938 h 3365467"/>
              <a:gd name="connsiteX18" fmla="*/ 675727 w 1114176"/>
              <a:gd name="connsiteY18" fmla="*/ 3353463 h 3365467"/>
              <a:gd name="connsiteX19" fmla="*/ 637627 w 1114176"/>
              <a:gd name="connsiteY19" fmla="*/ 3343938 h 3365467"/>
              <a:gd name="connsiteX20" fmla="*/ 675727 w 1114176"/>
              <a:gd name="connsiteY20" fmla="*/ 3334413 h 3365467"/>
              <a:gd name="connsiteX21" fmla="*/ 675727 w 1114176"/>
              <a:gd name="connsiteY21" fmla="*/ 3248688 h 3365467"/>
              <a:gd name="connsiteX22" fmla="*/ 628102 w 1114176"/>
              <a:gd name="connsiteY22" fmla="*/ 3182013 h 3365467"/>
              <a:gd name="connsiteX23" fmla="*/ 618577 w 1114176"/>
              <a:gd name="connsiteY23" fmla="*/ 2972463 h 3365467"/>
              <a:gd name="connsiteX24" fmla="*/ 542377 w 1114176"/>
              <a:gd name="connsiteY24" fmla="*/ 2648613 h 3365467"/>
              <a:gd name="connsiteX25" fmla="*/ 447127 w 1114176"/>
              <a:gd name="connsiteY25" fmla="*/ 2534313 h 3365467"/>
              <a:gd name="connsiteX26" fmla="*/ 437602 w 1114176"/>
              <a:gd name="connsiteY26" fmla="*/ 2429538 h 3365467"/>
              <a:gd name="connsiteX27" fmla="*/ 494752 w 1114176"/>
              <a:gd name="connsiteY27" fmla="*/ 2315238 h 3365467"/>
              <a:gd name="connsiteX28" fmla="*/ 637627 w 1114176"/>
              <a:gd name="connsiteY28" fmla="*/ 2572413 h 3365467"/>
              <a:gd name="connsiteX29" fmla="*/ 732877 w 1114176"/>
              <a:gd name="connsiteY29" fmla="*/ 2562888 h 3365467"/>
              <a:gd name="connsiteX30" fmla="*/ 904327 w 1114176"/>
              <a:gd name="connsiteY30" fmla="*/ 2277138 h 3365467"/>
              <a:gd name="connsiteX31" fmla="*/ 847177 w 1114176"/>
              <a:gd name="connsiteY31" fmla="*/ 2058063 h 3365467"/>
              <a:gd name="connsiteX32" fmla="*/ 904327 w 1114176"/>
              <a:gd name="connsiteY32" fmla="*/ 1819938 h 3365467"/>
              <a:gd name="connsiteX33" fmla="*/ 928139 w 1114176"/>
              <a:gd name="connsiteY33" fmla="*/ 1715163 h 3365467"/>
              <a:gd name="connsiteX34" fmla="*/ 1090064 w 1114176"/>
              <a:gd name="connsiteY34" fmla="*/ 1467513 h 3365467"/>
              <a:gd name="connsiteX35" fmla="*/ 1090065 w 1114176"/>
              <a:gd name="connsiteY35" fmla="*/ 1381789 h 3365467"/>
              <a:gd name="connsiteX36" fmla="*/ 1113877 w 1114176"/>
              <a:gd name="connsiteY36" fmla="*/ 1238913 h 3365467"/>
              <a:gd name="connsiteX37" fmla="*/ 1071015 w 1114176"/>
              <a:gd name="connsiteY37" fmla="*/ 1067463 h 3365467"/>
              <a:gd name="connsiteX38" fmla="*/ 1056727 w 1114176"/>
              <a:gd name="connsiteY38" fmla="*/ 962688 h 3365467"/>
              <a:gd name="connsiteX39" fmla="*/ 894802 w 1114176"/>
              <a:gd name="connsiteY39" fmla="*/ 1019838 h 3365467"/>
              <a:gd name="connsiteX40" fmla="*/ 890039 w 1114176"/>
              <a:gd name="connsiteY40" fmla="*/ 848388 h 3365467"/>
              <a:gd name="connsiteX41" fmla="*/ 799552 w 1114176"/>
              <a:gd name="connsiteY41" fmla="*/ 667413 h 3365467"/>
              <a:gd name="connsiteX42" fmla="*/ 642390 w 1114176"/>
              <a:gd name="connsiteY42" fmla="*/ 648364 h 3365467"/>
              <a:gd name="connsiteX43" fmla="*/ 609052 w 1114176"/>
              <a:gd name="connsiteY43" fmla="*/ 581688 h 3365467"/>
              <a:gd name="connsiteX44" fmla="*/ 442365 w 1114176"/>
              <a:gd name="connsiteY44" fmla="*/ 543589 h 3365467"/>
              <a:gd name="connsiteX45" fmla="*/ 323302 w 1114176"/>
              <a:gd name="connsiteY45" fmla="*/ 448338 h 3365467"/>
              <a:gd name="connsiteX46" fmla="*/ 161377 w 1114176"/>
              <a:gd name="connsiteY46" fmla="*/ 43526 h 3365467"/>
              <a:gd name="connsiteX47" fmla="*/ 166139 w 1114176"/>
              <a:gd name="connsiteY47" fmla="*/ 10188 h 3365467"/>
              <a:gd name="connsiteX48" fmla="*/ 4215 w 1114176"/>
              <a:gd name="connsiteY48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56615 w 1114176"/>
              <a:gd name="connsiteY6" fmla="*/ 824575 h 3365467"/>
              <a:gd name="connsiteX7" fmla="*/ 170902 w 1114176"/>
              <a:gd name="connsiteY7" fmla="*/ 957927 h 3365467"/>
              <a:gd name="connsiteX8" fmla="*/ 199477 w 1114176"/>
              <a:gd name="connsiteY8" fmla="*/ 1019838 h 3365467"/>
              <a:gd name="connsiteX9" fmla="*/ 175665 w 1114176"/>
              <a:gd name="connsiteY9" fmla="*/ 1129377 h 3365467"/>
              <a:gd name="connsiteX10" fmla="*/ 32789 w 1114176"/>
              <a:gd name="connsiteY10" fmla="*/ 1524663 h 3365467"/>
              <a:gd name="connsiteX11" fmla="*/ 75652 w 1114176"/>
              <a:gd name="connsiteY11" fmla="*/ 1705638 h 3365467"/>
              <a:gd name="connsiteX12" fmla="*/ 66127 w 1114176"/>
              <a:gd name="connsiteY12" fmla="*/ 2229513 h 3365467"/>
              <a:gd name="connsiteX13" fmla="*/ 113752 w 1114176"/>
              <a:gd name="connsiteY13" fmla="*/ 2486688 h 3365467"/>
              <a:gd name="connsiteX14" fmla="*/ 56602 w 1114176"/>
              <a:gd name="connsiteY14" fmla="*/ 2820063 h 3365467"/>
              <a:gd name="connsiteX15" fmla="*/ 75652 w 1114176"/>
              <a:gd name="connsiteY15" fmla="*/ 3153438 h 3365467"/>
              <a:gd name="connsiteX16" fmla="*/ 142327 w 1114176"/>
              <a:gd name="connsiteY16" fmla="*/ 3353463 h 3365467"/>
              <a:gd name="connsiteX17" fmla="*/ 56602 w 1114176"/>
              <a:gd name="connsiteY17" fmla="*/ 3343938 h 3365467"/>
              <a:gd name="connsiteX18" fmla="*/ 675727 w 1114176"/>
              <a:gd name="connsiteY18" fmla="*/ 3353463 h 3365467"/>
              <a:gd name="connsiteX19" fmla="*/ 637627 w 1114176"/>
              <a:gd name="connsiteY19" fmla="*/ 3343938 h 3365467"/>
              <a:gd name="connsiteX20" fmla="*/ 675727 w 1114176"/>
              <a:gd name="connsiteY20" fmla="*/ 3334413 h 3365467"/>
              <a:gd name="connsiteX21" fmla="*/ 675727 w 1114176"/>
              <a:gd name="connsiteY21" fmla="*/ 3248688 h 3365467"/>
              <a:gd name="connsiteX22" fmla="*/ 628102 w 1114176"/>
              <a:gd name="connsiteY22" fmla="*/ 3182013 h 3365467"/>
              <a:gd name="connsiteX23" fmla="*/ 618577 w 1114176"/>
              <a:gd name="connsiteY23" fmla="*/ 2972463 h 3365467"/>
              <a:gd name="connsiteX24" fmla="*/ 542377 w 1114176"/>
              <a:gd name="connsiteY24" fmla="*/ 2648613 h 3365467"/>
              <a:gd name="connsiteX25" fmla="*/ 447127 w 1114176"/>
              <a:gd name="connsiteY25" fmla="*/ 2534313 h 3365467"/>
              <a:gd name="connsiteX26" fmla="*/ 437602 w 1114176"/>
              <a:gd name="connsiteY26" fmla="*/ 2429538 h 3365467"/>
              <a:gd name="connsiteX27" fmla="*/ 494752 w 1114176"/>
              <a:gd name="connsiteY27" fmla="*/ 2315238 h 3365467"/>
              <a:gd name="connsiteX28" fmla="*/ 637627 w 1114176"/>
              <a:gd name="connsiteY28" fmla="*/ 2572413 h 3365467"/>
              <a:gd name="connsiteX29" fmla="*/ 732877 w 1114176"/>
              <a:gd name="connsiteY29" fmla="*/ 2562888 h 3365467"/>
              <a:gd name="connsiteX30" fmla="*/ 599527 w 1114176"/>
              <a:gd name="connsiteY30" fmla="*/ 2239038 h 3365467"/>
              <a:gd name="connsiteX31" fmla="*/ 847177 w 1114176"/>
              <a:gd name="connsiteY31" fmla="*/ 2058063 h 3365467"/>
              <a:gd name="connsiteX32" fmla="*/ 904327 w 1114176"/>
              <a:gd name="connsiteY32" fmla="*/ 1819938 h 3365467"/>
              <a:gd name="connsiteX33" fmla="*/ 928139 w 1114176"/>
              <a:gd name="connsiteY33" fmla="*/ 1715163 h 3365467"/>
              <a:gd name="connsiteX34" fmla="*/ 1090064 w 1114176"/>
              <a:gd name="connsiteY34" fmla="*/ 1467513 h 3365467"/>
              <a:gd name="connsiteX35" fmla="*/ 1090065 w 1114176"/>
              <a:gd name="connsiteY35" fmla="*/ 1381789 h 3365467"/>
              <a:gd name="connsiteX36" fmla="*/ 1113877 w 1114176"/>
              <a:gd name="connsiteY36" fmla="*/ 1238913 h 3365467"/>
              <a:gd name="connsiteX37" fmla="*/ 1071015 w 1114176"/>
              <a:gd name="connsiteY37" fmla="*/ 1067463 h 3365467"/>
              <a:gd name="connsiteX38" fmla="*/ 1056727 w 1114176"/>
              <a:gd name="connsiteY38" fmla="*/ 962688 h 3365467"/>
              <a:gd name="connsiteX39" fmla="*/ 894802 w 1114176"/>
              <a:gd name="connsiteY39" fmla="*/ 1019838 h 3365467"/>
              <a:gd name="connsiteX40" fmla="*/ 890039 w 1114176"/>
              <a:gd name="connsiteY40" fmla="*/ 848388 h 3365467"/>
              <a:gd name="connsiteX41" fmla="*/ 799552 w 1114176"/>
              <a:gd name="connsiteY41" fmla="*/ 667413 h 3365467"/>
              <a:gd name="connsiteX42" fmla="*/ 642390 w 1114176"/>
              <a:gd name="connsiteY42" fmla="*/ 648364 h 3365467"/>
              <a:gd name="connsiteX43" fmla="*/ 609052 w 1114176"/>
              <a:gd name="connsiteY43" fmla="*/ 581688 h 3365467"/>
              <a:gd name="connsiteX44" fmla="*/ 442365 w 1114176"/>
              <a:gd name="connsiteY44" fmla="*/ 543589 h 3365467"/>
              <a:gd name="connsiteX45" fmla="*/ 323302 w 1114176"/>
              <a:gd name="connsiteY45" fmla="*/ 448338 h 3365467"/>
              <a:gd name="connsiteX46" fmla="*/ 161377 w 1114176"/>
              <a:gd name="connsiteY46" fmla="*/ 43526 h 3365467"/>
              <a:gd name="connsiteX47" fmla="*/ 166139 w 1114176"/>
              <a:gd name="connsiteY47" fmla="*/ 10188 h 3365467"/>
              <a:gd name="connsiteX48" fmla="*/ 4215 w 1114176"/>
              <a:gd name="connsiteY48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56615 w 1114176"/>
              <a:gd name="connsiteY6" fmla="*/ 824575 h 3365467"/>
              <a:gd name="connsiteX7" fmla="*/ 170902 w 1114176"/>
              <a:gd name="connsiteY7" fmla="*/ 957927 h 3365467"/>
              <a:gd name="connsiteX8" fmla="*/ 199477 w 1114176"/>
              <a:gd name="connsiteY8" fmla="*/ 1019838 h 3365467"/>
              <a:gd name="connsiteX9" fmla="*/ 175665 w 1114176"/>
              <a:gd name="connsiteY9" fmla="*/ 1129377 h 3365467"/>
              <a:gd name="connsiteX10" fmla="*/ 32789 w 1114176"/>
              <a:gd name="connsiteY10" fmla="*/ 1524663 h 3365467"/>
              <a:gd name="connsiteX11" fmla="*/ 75652 w 1114176"/>
              <a:gd name="connsiteY11" fmla="*/ 1705638 h 3365467"/>
              <a:gd name="connsiteX12" fmla="*/ 66127 w 1114176"/>
              <a:gd name="connsiteY12" fmla="*/ 2229513 h 3365467"/>
              <a:gd name="connsiteX13" fmla="*/ 113752 w 1114176"/>
              <a:gd name="connsiteY13" fmla="*/ 2486688 h 3365467"/>
              <a:gd name="connsiteX14" fmla="*/ 56602 w 1114176"/>
              <a:gd name="connsiteY14" fmla="*/ 2820063 h 3365467"/>
              <a:gd name="connsiteX15" fmla="*/ 75652 w 1114176"/>
              <a:gd name="connsiteY15" fmla="*/ 3153438 h 3365467"/>
              <a:gd name="connsiteX16" fmla="*/ 142327 w 1114176"/>
              <a:gd name="connsiteY16" fmla="*/ 3353463 h 3365467"/>
              <a:gd name="connsiteX17" fmla="*/ 56602 w 1114176"/>
              <a:gd name="connsiteY17" fmla="*/ 3343938 h 3365467"/>
              <a:gd name="connsiteX18" fmla="*/ 675727 w 1114176"/>
              <a:gd name="connsiteY18" fmla="*/ 3353463 h 3365467"/>
              <a:gd name="connsiteX19" fmla="*/ 637627 w 1114176"/>
              <a:gd name="connsiteY19" fmla="*/ 3343938 h 3365467"/>
              <a:gd name="connsiteX20" fmla="*/ 675727 w 1114176"/>
              <a:gd name="connsiteY20" fmla="*/ 3334413 h 3365467"/>
              <a:gd name="connsiteX21" fmla="*/ 675727 w 1114176"/>
              <a:gd name="connsiteY21" fmla="*/ 3248688 h 3365467"/>
              <a:gd name="connsiteX22" fmla="*/ 628102 w 1114176"/>
              <a:gd name="connsiteY22" fmla="*/ 3182013 h 3365467"/>
              <a:gd name="connsiteX23" fmla="*/ 618577 w 1114176"/>
              <a:gd name="connsiteY23" fmla="*/ 2972463 h 3365467"/>
              <a:gd name="connsiteX24" fmla="*/ 542377 w 1114176"/>
              <a:gd name="connsiteY24" fmla="*/ 2648613 h 3365467"/>
              <a:gd name="connsiteX25" fmla="*/ 447127 w 1114176"/>
              <a:gd name="connsiteY25" fmla="*/ 2534313 h 3365467"/>
              <a:gd name="connsiteX26" fmla="*/ 437602 w 1114176"/>
              <a:gd name="connsiteY26" fmla="*/ 2429538 h 3365467"/>
              <a:gd name="connsiteX27" fmla="*/ 494752 w 1114176"/>
              <a:gd name="connsiteY27" fmla="*/ 2315238 h 3365467"/>
              <a:gd name="connsiteX28" fmla="*/ 637627 w 1114176"/>
              <a:gd name="connsiteY28" fmla="*/ 2572413 h 3365467"/>
              <a:gd name="connsiteX29" fmla="*/ 599527 w 1114176"/>
              <a:gd name="connsiteY29" fmla="*/ 2239038 h 3365467"/>
              <a:gd name="connsiteX30" fmla="*/ 847177 w 1114176"/>
              <a:gd name="connsiteY30" fmla="*/ 2058063 h 3365467"/>
              <a:gd name="connsiteX31" fmla="*/ 904327 w 1114176"/>
              <a:gd name="connsiteY31" fmla="*/ 1819938 h 3365467"/>
              <a:gd name="connsiteX32" fmla="*/ 928139 w 1114176"/>
              <a:gd name="connsiteY32" fmla="*/ 1715163 h 3365467"/>
              <a:gd name="connsiteX33" fmla="*/ 1090064 w 1114176"/>
              <a:gd name="connsiteY33" fmla="*/ 1467513 h 3365467"/>
              <a:gd name="connsiteX34" fmla="*/ 1090065 w 1114176"/>
              <a:gd name="connsiteY34" fmla="*/ 1381789 h 3365467"/>
              <a:gd name="connsiteX35" fmla="*/ 1113877 w 1114176"/>
              <a:gd name="connsiteY35" fmla="*/ 1238913 h 3365467"/>
              <a:gd name="connsiteX36" fmla="*/ 1071015 w 1114176"/>
              <a:gd name="connsiteY36" fmla="*/ 1067463 h 3365467"/>
              <a:gd name="connsiteX37" fmla="*/ 1056727 w 1114176"/>
              <a:gd name="connsiteY37" fmla="*/ 962688 h 3365467"/>
              <a:gd name="connsiteX38" fmla="*/ 894802 w 1114176"/>
              <a:gd name="connsiteY38" fmla="*/ 1019838 h 3365467"/>
              <a:gd name="connsiteX39" fmla="*/ 890039 w 1114176"/>
              <a:gd name="connsiteY39" fmla="*/ 848388 h 3365467"/>
              <a:gd name="connsiteX40" fmla="*/ 799552 w 1114176"/>
              <a:gd name="connsiteY40" fmla="*/ 667413 h 3365467"/>
              <a:gd name="connsiteX41" fmla="*/ 642390 w 1114176"/>
              <a:gd name="connsiteY41" fmla="*/ 648364 h 3365467"/>
              <a:gd name="connsiteX42" fmla="*/ 609052 w 1114176"/>
              <a:gd name="connsiteY42" fmla="*/ 581688 h 3365467"/>
              <a:gd name="connsiteX43" fmla="*/ 442365 w 1114176"/>
              <a:gd name="connsiteY43" fmla="*/ 543589 h 3365467"/>
              <a:gd name="connsiteX44" fmla="*/ 323302 w 1114176"/>
              <a:gd name="connsiteY44" fmla="*/ 448338 h 3365467"/>
              <a:gd name="connsiteX45" fmla="*/ 161377 w 1114176"/>
              <a:gd name="connsiteY45" fmla="*/ 43526 h 3365467"/>
              <a:gd name="connsiteX46" fmla="*/ 166139 w 1114176"/>
              <a:gd name="connsiteY46" fmla="*/ 10188 h 3365467"/>
              <a:gd name="connsiteX47" fmla="*/ 4215 w 1114176"/>
              <a:gd name="connsiteY47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56615 w 1114176"/>
              <a:gd name="connsiteY6" fmla="*/ 824575 h 3365467"/>
              <a:gd name="connsiteX7" fmla="*/ 170902 w 1114176"/>
              <a:gd name="connsiteY7" fmla="*/ 957927 h 3365467"/>
              <a:gd name="connsiteX8" fmla="*/ 199477 w 1114176"/>
              <a:gd name="connsiteY8" fmla="*/ 1019838 h 3365467"/>
              <a:gd name="connsiteX9" fmla="*/ 175665 w 1114176"/>
              <a:gd name="connsiteY9" fmla="*/ 1129377 h 3365467"/>
              <a:gd name="connsiteX10" fmla="*/ 32789 w 1114176"/>
              <a:gd name="connsiteY10" fmla="*/ 1524663 h 3365467"/>
              <a:gd name="connsiteX11" fmla="*/ 75652 w 1114176"/>
              <a:gd name="connsiteY11" fmla="*/ 1705638 h 3365467"/>
              <a:gd name="connsiteX12" fmla="*/ 66127 w 1114176"/>
              <a:gd name="connsiteY12" fmla="*/ 2229513 h 3365467"/>
              <a:gd name="connsiteX13" fmla="*/ 113752 w 1114176"/>
              <a:gd name="connsiteY13" fmla="*/ 2486688 h 3365467"/>
              <a:gd name="connsiteX14" fmla="*/ 56602 w 1114176"/>
              <a:gd name="connsiteY14" fmla="*/ 2820063 h 3365467"/>
              <a:gd name="connsiteX15" fmla="*/ 75652 w 1114176"/>
              <a:gd name="connsiteY15" fmla="*/ 3153438 h 3365467"/>
              <a:gd name="connsiteX16" fmla="*/ 142327 w 1114176"/>
              <a:gd name="connsiteY16" fmla="*/ 3353463 h 3365467"/>
              <a:gd name="connsiteX17" fmla="*/ 56602 w 1114176"/>
              <a:gd name="connsiteY17" fmla="*/ 3343938 h 3365467"/>
              <a:gd name="connsiteX18" fmla="*/ 675727 w 1114176"/>
              <a:gd name="connsiteY18" fmla="*/ 3353463 h 3365467"/>
              <a:gd name="connsiteX19" fmla="*/ 637627 w 1114176"/>
              <a:gd name="connsiteY19" fmla="*/ 3343938 h 3365467"/>
              <a:gd name="connsiteX20" fmla="*/ 675727 w 1114176"/>
              <a:gd name="connsiteY20" fmla="*/ 3334413 h 3365467"/>
              <a:gd name="connsiteX21" fmla="*/ 675727 w 1114176"/>
              <a:gd name="connsiteY21" fmla="*/ 3248688 h 3365467"/>
              <a:gd name="connsiteX22" fmla="*/ 628102 w 1114176"/>
              <a:gd name="connsiteY22" fmla="*/ 3182013 h 3365467"/>
              <a:gd name="connsiteX23" fmla="*/ 618577 w 1114176"/>
              <a:gd name="connsiteY23" fmla="*/ 2972463 h 3365467"/>
              <a:gd name="connsiteX24" fmla="*/ 542377 w 1114176"/>
              <a:gd name="connsiteY24" fmla="*/ 2648613 h 3365467"/>
              <a:gd name="connsiteX25" fmla="*/ 447127 w 1114176"/>
              <a:gd name="connsiteY25" fmla="*/ 2534313 h 3365467"/>
              <a:gd name="connsiteX26" fmla="*/ 437602 w 1114176"/>
              <a:gd name="connsiteY26" fmla="*/ 2429538 h 3365467"/>
              <a:gd name="connsiteX27" fmla="*/ 494752 w 1114176"/>
              <a:gd name="connsiteY27" fmla="*/ 2315238 h 3365467"/>
              <a:gd name="connsiteX28" fmla="*/ 599527 w 1114176"/>
              <a:gd name="connsiteY28" fmla="*/ 2239038 h 3365467"/>
              <a:gd name="connsiteX29" fmla="*/ 847177 w 1114176"/>
              <a:gd name="connsiteY29" fmla="*/ 2058063 h 3365467"/>
              <a:gd name="connsiteX30" fmla="*/ 904327 w 1114176"/>
              <a:gd name="connsiteY30" fmla="*/ 1819938 h 3365467"/>
              <a:gd name="connsiteX31" fmla="*/ 928139 w 1114176"/>
              <a:gd name="connsiteY31" fmla="*/ 1715163 h 3365467"/>
              <a:gd name="connsiteX32" fmla="*/ 1090064 w 1114176"/>
              <a:gd name="connsiteY32" fmla="*/ 1467513 h 3365467"/>
              <a:gd name="connsiteX33" fmla="*/ 1090065 w 1114176"/>
              <a:gd name="connsiteY33" fmla="*/ 1381789 h 3365467"/>
              <a:gd name="connsiteX34" fmla="*/ 1113877 w 1114176"/>
              <a:gd name="connsiteY34" fmla="*/ 1238913 h 3365467"/>
              <a:gd name="connsiteX35" fmla="*/ 1071015 w 1114176"/>
              <a:gd name="connsiteY35" fmla="*/ 1067463 h 3365467"/>
              <a:gd name="connsiteX36" fmla="*/ 1056727 w 1114176"/>
              <a:gd name="connsiteY36" fmla="*/ 962688 h 3365467"/>
              <a:gd name="connsiteX37" fmla="*/ 894802 w 1114176"/>
              <a:gd name="connsiteY37" fmla="*/ 1019838 h 3365467"/>
              <a:gd name="connsiteX38" fmla="*/ 890039 w 1114176"/>
              <a:gd name="connsiteY38" fmla="*/ 848388 h 3365467"/>
              <a:gd name="connsiteX39" fmla="*/ 799552 w 1114176"/>
              <a:gd name="connsiteY39" fmla="*/ 667413 h 3365467"/>
              <a:gd name="connsiteX40" fmla="*/ 642390 w 1114176"/>
              <a:gd name="connsiteY40" fmla="*/ 648364 h 3365467"/>
              <a:gd name="connsiteX41" fmla="*/ 609052 w 1114176"/>
              <a:gd name="connsiteY41" fmla="*/ 581688 h 3365467"/>
              <a:gd name="connsiteX42" fmla="*/ 442365 w 1114176"/>
              <a:gd name="connsiteY42" fmla="*/ 543589 h 3365467"/>
              <a:gd name="connsiteX43" fmla="*/ 323302 w 1114176"/>
              <a:gd name="connsiteY43" fmla="*/ 448338 h 3365467"/>
              <a:gd name="connsiteX44" fmla="*/ 161377 w 1114176"/>
              <a:gd name="connsiteY44" fmla="*/ 43526 h 3365467"/>
              <a:gd name="connsiteX45" fmla="*/ 166139 w 1114176"/>
              <a:gd name="connsiteY45" fmla="*/ 10188 h 3365467"/>
              <a:gd name="connsiteX46" fmla="*/ 4215 w 1114176"/>
              <a:gd name="connsiteY46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56615 w 1114176"/>
              <a:gd name="connsiteY6" fmla="*/ 824575 h 3365467"/>
              <a:gd name="connsiteX7" fmla="*/ 170902 w 1114176"/>
              <a:gd name="connsiteY7" fmla="*/ 957927 h 3365467"/>
              <a:gd name="connsiteX8" fmla="*/ 199477 w 1114176"/>
              <a:gd name="connsiteY8" fmla="*/ 1019838 h 3365467"/>
              <a:gd name="connsiteX9" fmla="*/ 175665 w 1114176"/>
              <a:gd name="connsiteY9" fmla="*/ 1129377 h 3365467"/>
              <a:gd name="connsiteX10" fmla="*/ 32789 w 1114176"/>
              <a:gd name="connsiteY10" fmla="*/ 1524663 h 3365467"/>
              <a:gd name="connsiteX11" fmla="*/ 75652 w 1114176"/>
              <a:gd name="connsiteY11" fmla="*/ 1705638 h 3365467"/>
              <a:gd name="connsiteX12" fmla="*/ 66127 w 1114176"/>
              <a:gd name="connsiteY12" fmla="*/ 2229513 h 3365467"/>
              <a:gd name="connsiteX13" fmla="*/ 113752 w 1114176"/>
              <a:gd name="connsiteY13" fmla="*/ 2486688 h 3365467"/>
              <a:gd name="connsiteX14" fmla="*/ 56602 w 1114176"/>
              <a:gd name="connsiteY14" fmla="*/ 2820063 h 3365467"/>
              <a:gd name="connsiteX15" fmla="*/ 75652 w 1114176"/>
              <a:gd name="connsiteY15" fmla="*/ 3153438 h 3365467"/>
              <a:gd name="connsiteX16" fmla="*/ 142327 w 1114176"/>
              <a:gd name="connsiteY16" fmla="*/ 3353463 h 3365467"/>
              <a:gd name="connsiteX17" fmla="*/ 56602 w 1114176"/>
              <a:gd name="connsiteY17" fmla="*/ 3343938 h 3365467"/>
              <a:gd name="connsiteX18" fmla="*/ 675727 w 1114176"/>
              <a:gd name="connsiteY18" fmla="*/ 3353463 h 3365467"/>
              <a:gd name="connsiteX19" fmla="*/ 637627 w 1114176"/>
              <a:gd name="connsiteY19" fmla="*/ 3343938 h 3365467"/>
              <a:gd name="connsiteX20" fmla="*/ 675727 w 1114176"/>
              <a:gd name="connsiteY20" fmla="*/ 3334413 h 3365467"/>
              <a:gd name="connsiteX21" fmla="*/ 675727 w 1114176"/>
              <a:gd name="connsiteY21" fmla="*/ 3248688 h 3365467"/>
              <a:gd name="connsiteX22" fmla="*/ 628102 w 1114176"/>
              <a:gd name="connsiteY22" fmla="*/ 3182013 h 3365467"/>
              <a:gd name="connsiteX23" fmla="*/ 618577 w 1114176"/>
              <a:gd name="connsiteY23" fmla="*/ 2972463 h 3365467"/>
              <a:gd name="connsiteX24" fmla="*/ 542377 w 1114176"/>
              <a:gd name="connsiteY24" fmla="*/ 2648613 h 3365467"/>
              <a:gd name="connsiteX25" fmla="*/ 447127 w 1114176"/>
              <a:gd name="connsiteY25" fmla="*/ 2534313 h 3365467"/>
              <a:gd name="connsiteX26" fmla="*/ 437602 w 1114176"/>
              <a:gd name="connsiteY26" fmla="*/ 2429538 h 3365467"/>
              <a:gd name="connsiteX27" fmla="*/ 494752 w 1114176"/>
              <a:gd name="connsiteY27" fmla="*/ 2315238 h 3365467"/>
              <a:gd name="connsiteX28" fmla="*/ 599527 w 1114176"/>
              <a:gd name="connsiteY28" fmla="*/ 2239038 h 3365467"/>
              <a:gd name="connsiteX29" fmla="*/ 799552 w 1114176"/>
              <a:gd name="connsiteY29" fmla="*/ 2039013 h 3365467"/>
              <a:gd name="connsiteX30" fmla="*/ 904327 w 1114176"/>
              <a:gd name="connsiteY30" fmla="*/ 1819938 h 3365467"/>
              <a:gd name="connsiteX31" fmla="*/ 928139 w 1114176"/>
              <a:gd name="connsiteY31" fmla="*/ 1715163 h 3365467"/>
              <a:gd name="connsiteX32" fmla="*/ 1090064 w 1114176"/>
              <a:gd name="connsiteY32" fmla="*/ 1467513 h 3365467"/>
              <a:gd name="connsiteX33" fmla="*/ 1090065 w 1114176"/>
              <a:gd name="connsiteY33" fmla="*/ 1381789 h 3365467"/>
              <a:gd name="connsiteX34" fmla="*/ 1113877 w 1114176"/>
              <a:gd name="connsiteY34" fmla="*/ 1238913 h 3365467"/>
              <a:gd name="connsiteX35" fmla="*/ 1071015 w 1114176"/>
              <a:gd name="connsiteY35" fmla="*/ 1067463 h 3365467"/>
              <a:gd name="connsiteX36" fmla="*/ 1056727 w 1114176"/>
              <a:gd name="connsiteY36" fmla="*/ 962688 h 3365467"/>
              <a:gd name="connsiteX37" fmla="*/ 894802 w 1114176"/>
              <a:gd name="connsiteY37" fmla="*/ 1019838 h 3365467"/>
              <a:gd name="connsiteX38" fmla="*/ 890039 w 1114176"/>
              <a:gd name="connsiteY38" fmla="*/ 848388 h 3365467"/>
              <a:gd name="connsiteX39" fmla="*/ 799552 w 1114176"/>
              <a:gd name="connsiteY39" fmla="*/ 667413 h 3365467"/>
              <a:gd name="connsiteX40" fmla="*/ 642390 w 1114176"/>
              <a:gd name="connsiteY40" fmla="*/ 648364 h 3365467"/>
              <a:gd name="connsiteX41" fmla="*/ 609052 w 1114176"/>
              <a:gd name="connsiteY41" fmla="*/ 581688 h 3365467"/>
              <a:gd name="connsiteX42" fmla="*/ 442365 w 1114176"/>
              <a:gd name="connsiteY42" fmla="*/ 543589 h 3365467"/>
              <a:gd name="connsiteX43" fmla="*/ 323302 w 1114176"/>
              <a:gd name="connsiteY43" fmla="*/ 448338 h 3365467"/>
              <a:gd name="connsiteX44" fmla="*/ 161377 w 1114176"/>
              <a:gd name="connsiteY44" fmla="*/ 43526 h 3365467"/>
              <a:gd name="connsiteX45" fmla="*/ 166139 w 1114176"/>
              <a:gd name="connsiteY45" fmla="*/ 10188 h 3365467"/>
              <a:gd name="connsiteX46" fmla="*/ 4215 w 1114176"/>
              <a:gd name="connsiteY46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56615 w 1114176"/>
              <a:gd name="connsiteY6" fmla="*/ 824575 h 3365467"/>
              <a:gd name="connsiteX7" fmla="*/ 170902 w 1114176"/>
              <a:gd name="connsiteY7" fmla="*/ 957927 h 3365467"/>
              <a:gd name="connsiteX8" fmla="*/ 199477 w 1114176"/>
              <a:gd name="connsiteY8" fmla="*/ 1019838 h 3365467"/>
              <a:gd name="connsiteX9" fmla="*/ 175665 w 1114176"/>
              <a:gd name="connsiteY9" fmla="*/ 1129377 h 3365467"/>
              <a:gd name="connsiteX10" fmla="*/ 32789 w 1114176"/>
              <a:gd name="connsiteY10" fmla="*/ 1524663 h 3365467"/>
              <a:gd name="connsiteX11" fmla="*/ 75652 w 1114176"/>
              <a:gd name="connsiteY11" fmla="*/ 1705638 h 3365467"/>
              <a:gd name="connsiteX12" fmla="*/ 66127 w 1114176"/>
              <a:gd name="connsiteY12" fmla="*/ 2229513 h 3365467"/>
              <a:gd name="connsiteX13" fmla="*/ 113752 w 1114176"/>
              <a:gd name="connsiteY13" fmla="*/ 2486688 h 3365467"/>
              <a:gd name="connsiteX14" fmla="*/ 56602 w 1114176"/>
              <a:gd name="connsiteY14" fmla="*/ 2820063 h 3365467"/>
              <a:gd name="connsiteX15" fmla="*/ 75652 w 1114176"/>
              <a:gd name="connsiteY15" fmla="*/ 3153438 h 3365467"/>
              <a:gd name="connsiteX16" fmla="*/ 142327 w 1114176"/>
              <a:gd name="connsiteY16" fmla="*/ 3353463 h 3365467"/>
              <a:gd name="connsiteX17" fmla="*/ 56602 w 1114176"/>
              <a:gd name="connsiteY17" fmla="*/ 3343938 h 3365467"/>
              <a:gd name="connsiteX18" fmla="*/ 675727 w 1114176"/>
              <a:gd name="connsiteY18" fmla="*/ 3353463 h 3365467"/>
              <a:gd name="connsiteX19" fmla="*/ 637627 w 1114176"/>
              <a:gd name="connsiteY19" fmla="*/ 3343938 h 3365467"/>
              <a:gd name="connsiteX20" fmla="*/ 675727 w 1114176"/>
              <a:gd name="connsiteY20" fmla="*/ 3334413 h 3365467"/>
              <a:gd name="connsiteX21" fmla="*/ 675727 w 1114176"/>
              <a:gd name="connsiteY21" fmla="*/ 3248688 h 3365467"/>
              <a:gd name="connsiteX22" fmla="*/ 628102 w 1114176"/>
              <a:gd name="connsiteY22" fmla="*/ 3182013 h 3365467"/>
              <a:gd name="connsiteX23" fmla="*/ 618577 w 1114176"/>
              <a:gd name="connsiteY23" fmla="*/ 2972463 h 3365467"/>
              <a:gd name="connsiteX24" fmla="*/ 542377 w 1114176"/>
              <a:gd name="connsiteY24" fmla="*/ 2648613 h 3365467"/>
              <a:gd name="connsiteX25" fmla="*/ 447127 w 1114176"/>
              <a:gd name="connsiteY25" fmla="*/ 2534313 h 3365467"/>
              <a:gd name="connsiteX26" fmla="*/ 437602 w 1114176"/>
              <a:gd name="connsiteY26" fmla="*/ 2429538 h 3365467"/>
              <a:gd name="connsiteX27" fmla="*/ 494752 w 1114176"/>
              <a:gd name="connsiteY27" fmla="*/ 2315238 h 3365467"/>
              <a:gd name="connsiteX28" fmla="*/ 599527 w 1114176"/>
              <a:gd name="connsiteY28" fmla="*/ 2239038 h 3365467"/>
              <a:gd name="connsiteX29" fmla="*/ 799552 w 1114176"/>
              <a:gd name="connsiteY29" fmla="*/ 2039013 h 3365467"/>
              <a:gd name="connsiteX30" fmla="*/ 923377 w 1114176"/>
              <a:gd name="connsiteY30" fmla="*/ 1829463 h 3365467"/>
              <a:gd name="connsiteX31" fmla="*/ 928139 w 1114176"/>
              <a:gd name="connsiteY31" fmla="*/ 1715163 h 3365467"/>
              <a:gd name="connsiteX32" fmla="*/ 1090064 w 1114176"/>
              <a:gd name="connsiteY32" fmla="*/ 1467513 h 3365467"/>
              <a:gd name="connsiteX33" fmla="*/ 1090065 w 1114176"/>
              <a:gd name="connsiteY33" fmla="*/ 1381789 h 3365467"/>
              <a:gd name="connsiteX34" fmla="*/ 1113877 w 1114176"/>
              <a:gd name="connsiteY34" fmla="*/ 1238913 h 3365467"/>
              <a:gd name="connsiteX35" fmla="*/ 1071015 w 1114176"/>
              <a:gd name="connsiteY35" fmla="*/ 1067463 h 3365467"/>
              <a:gd name="connsiteX36" fmla="*/ 1056727 w 1114176"/>
              <a:gd name="connsiteY36" fmla="*/ 962688 h 3365467"/>
              <a:gd name="connsiteX37" fmla="*/ 894802 w 1114176"/>
              <a:gd name="connsiteY37" fmla="*/ 1019838 h 3365467"/>
              <a:gd name="connsiteX38" fmla="*/ 890039 w 1114176"/>
              <a:gd name="connsiteY38" fmla="*/ 848388 h 3365467"/>
              <a:gd name="connsiteX39" fmla="*/ 799552 w 1114176"/>
              <a:gd name="connsiteY39" fmla="*/ 667413 h 3365467"/>
              <a:gd name="connsiteX40" fmla="*/ 642390 w 1114176"/>
              <a:gd name="connsiteY40" fmla="*/ 648364 h 3365467"/>
              <a:gd name="connsiteX41" fmla="*/ 609052 w 1114176"/>
              <a:gd name="connsiteY41" fmla="*/ 581688 h 3365467"/>
              <a:gd name="connsiteX42" fmla="*/ 442365 w 1114176"/>
              <a:gd name="connsiteY42" fmla="*/ 543589 h 3365467"/>
              <a:gd name="connsiteX43" fmla="*/ 323302 w 1114176"/>
              <a:gd name="connsiteY43" fmla="*/ 448338 h 3365467"/>
              <a:gd name="connsiteX44" fmla="*/ 161377 w 1114176"/>
              <a:gd name="connsiteY44" fmla="*/ 43526 h 3365467"/>
              <a:gd name="connsiteX45" fmla="*/ 166139 w 1114176"/>
              <a:gd name="connsiteY45" fmla="*/ 10188 h 3365467"/>
              <a:gd name="connsiteX46" fmla="*/ 4215 w 1114176"/>
              <a:gd name="connsiteY46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56615 w 1114176"/>
              <a:gd name="connsiteY6" fmla="*/ 824575 h 3365467"/>
              <a:gd name="connsiteX7" fmla="*/ 170902 w 1114176"/>
              <a:gd name="connsiteY7" fmla="*/ 957927 h 3365467"/>
              <a:gd name="connsiteX8" fmla="*/ 199477 w 1114176"/>
              <a:gd name="connsiteY8" fmla="*/ 1019838 h 3365467"/>
              <a:gd name="connsiteX9" fmla="*/ 175665 w 1114176"/>
              <a:gd name="connsiteY9" fmla="*/ 1129377 h 3365467"/>
              <a:gd name="connsiteX10" fmla="*/ 32789 w 1114176"/>
              <a:gd name="connsiteY10" fmla="*/ 1524663 h 3365467"/>
              <a:gd name="connsiteX11" fmla="*/ 75652 w 1114176"/>
              <a:gd name="connsiteY11" fmla="*/ 1705638 h 3365467"/>
              <a:gd name="connsiteX12" fmla="*/ 66127 w 1114176"/>
              <a:gd name="connsiteY12" fmla="*/ 2229513 h 3365467"/>
              <a:gd name="connsiteX13" fmla="*/ 113752 w 1114176"/>
              <a:gd name="connsiteY13" fmla="*/ 2486688 h 3365467"/>
              <a:gd name="connsiteX14" fmla="*/ 56602 w 1114176"/>
              <a:gd name="connsiteY14" fmla="*/ 2820063 h 3365467"/>
              <a:gd name="connsiteX15" fmla="*/ 75652 w 1114176"/>
              <a:gd name="connsiteY15" fmla="*/ 3153438 h 3365467"/>
              <a:gd name="connsiteX16" fmla="*/ 142327 w 1114176"/>
              <a:gd name="connsiteY16" fmla="*/ 3353463 h 3365467"/>
              <a:gd name="connsiteX17" fmla="*/ 56602 w 1114176"/>
              <a:gd name="connsiteY17" fmla="*/ 3343938 h 3365467"/>
              <a:gd name="connsiteX18" fmla="*/ 675727 w 1114176"/>
              <a:gd name="connsiteY18" fmla="*/ 3353463 h 3365467"/>
              <a:gd name="connsiteX19" fmla="*/ 637627 w 1114176"/>
              <a:gd name="connsiteY19" fmla="*/ 3343938 h 3365467"/>
              <a:gd name="connsiteX20" fmla="*/ 675727 w 1114176"/>
              <a:gd name="connsiteY20" fmla="*/ 3334413 h 3365467"/>
              <a:gd name="connsiteX21" fmla="*/ 675727 w 1114176"/>
              <a:gd name="connsiteY21" fmla="*/ 3248688 h 3365467"/>
              <a:gd name="connsiteX22" fmla="*/ 628102 w 1114176"/>
              <a:gd name="connsiteY22" fmla="*/ 3182013 h 3365467"/>
              <a:gd name="connsiteX23" fmla="*/ 618577 w 1114176"/>
              <a:gd name="connsiteY23" fmla="*/ 2972463 h 3365467"/>
              <a:gd name="connsiteX24" fmla="*/ 542377 w 1114176"/>
              <a:gd name="connsiteY24" fmla="*/ 2648613 h 3365467"/>
              <a:gd name="connsiteX25" fmla="*/ 447127 w 1114176"/>
              <a:gd name="connsiteY25" fmla="*/ 2534313 h 3365467"/>
              <a:gd name="connsiteX26" fmla="*/ 437602 w 1114176"/>
              <a:gd name="connsiteY26" fmla="*/ 2429538 h 3365467"/>
              <a:gd name="connsiteX27" fmla="*/ 494752 w 1114176"/>
              <a:gd name="connsiteY27" fmla="*/ 2315238 h 3365467"/>
              <a:gd name="connsiteX28" fmla="*/ 599527 w 1114176"/>
              <a:gd name="connsiteY28" fmla="*/ 2239038 h 3365467"/>
              <a:gd name="connsiteX29" fmla="*/ 799552 w 1114176"/>
              <a:gd name="connsiteY29" fmla="*/ 2039013 h 3365467"/>
              <a:gd name="connsiteX30" fmla="*/ 923377 w 1114176"/>
              <a:gd name="connsiteY30" fmla="*/ 1829463 h 3365467"/>
              <a:gd name="connsiteX31" fmla="*/ 928139 w 1114176"/>
              <a:gd name="connsiteY31" fmla="*/ 1715163 h 3365467"/>
              <a:gd name="connsiteX32" fmla="*/ 1090064 w 1114176"/>
              <a:gd name="connsiteY32" fmla="*/ 1467513 h 3365467"/>
              <a:gd name="connsiteX33" fmla="*/ 1090065 w 1114176"/>
              <a:gd name="connsiteY33" fmla="*/ 1381789 h 3365467"/>
              <a:gd name="connsiteX34" fmla="*/ 1113877 w 1114176"/>
              <a:gd name="connsiteY34" fmla="*/ 1238913 h 3365467"/>
              <a:gd name="connsiteX35" fmla="*/ 1071015 w 1114176"/>
              <a:gd name="connsiteY35" fmla="*/ 1067463 h 3365467"/>
              <a:gd name="connsiteX36" fmla="*/ 1056727 w 1114176"/>
              <a:gd name="connsiteY36" fmla="*/ 962688 h 3365467"/>
              <a:gd name="connsiteX37" fmla="*/ 894802 w 1114176"/>
              <a:gd name="connsiteY37" fmla="*/ 1019838 h 3365467"/>
              <a:gd name="connsiteX38" fmla="*/ 890039 w 1114176"/>
              <a:gd name="connsiteY38" fmla="*/ 848388 h 3365467"/>
              <a:gd name="connsiteX39" fmla="*/ 799552 w 1114176"/>
              <a:gd name="connsiteY39" fmla="*/ 667413 h 3365467"/>
              <a:gd name="connsiteX40" fmla="*/ 642390 w 1114176"/>
              <a:gd name="connsiteY40" fmla="*/ 648364 h 3365467"/>
              <a:gd name="connsiteX41" fmla="*/ 609052 w 1114176"/>
              <a:gd name="connsiteY41" fmla="*/ 581688 h 3365467"/>
              <a:gd name="connsiteX42" fmla="*/ 442365 w 1114176"/>
              <a:gd name="connsiteY42" fmla="*/ 543589 h 3365467"/>
              <a:gd name="connsiteX43" fmla="*/ 323302 w 1114176"/>
              <a:gd name="connsiteY43" fmla="*/ 448338 h 3365467"/>
              <a:gd name="connsiteX44" fmla="*/ 161377 w 1114176"/>
              <a:gd name="connsiteY44" fmla="*/ 43526 h 3365467"/>
              <a:gd name="connsiteX45" fmla="*/ 166139 w 1114176"/>
              <a:gd name="connsiteY45" fmla="*/ 10188 h 3365467"/>
              <a:gd name="connsiteX46" fmla="*/ 4215 w 1114176"/>
              <a:gd name="connsiteY46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56615 w 1114176"/>
              <a:gd name="connsiteY6" fmla="*/ 824575 h 3365467"/>
              <a:gd name="connsiteX7" fmla="*/ 170902 w 1114176"/>
              <a:gd name="connsiteY7" fmla="*/ 957927 h 3365467"/>
              <a:gd name="connsiteX8" fmla="*/ 199477 w 1114176"/>
              <a:gd name="connsiteY8" fmla="*/ 1019838 h 3365467"/>
              <a:gd name="connsiteX9" fmla="*/ 175665 w 1114176"/>
              <a:gd name="connsiteY9" fmla="*/ 1129377 h 3365467"/>
              <a:gd name="connsiteX10" fmla="*/ 32789 w 1114176"/>
              <a:gd name="connsiteY10" fmla="*/ 1524663 h 3365467"/>
              <a:gd name="connsiteX11" fmla="*/ 75652 w 1114176"/>
              <a:gd name="connsiteY11" fmla="*/ 1705638 h 3365467"/>
              <a:gd name="connsiteX12" fmla="*/ 66127 w 1114176"/>
              <a:gd name="connsiteY12" fmla="*/ 2229513 h 3365467"/>
              <a:gd name="connsiteX13" fmla="*/ 113752 w 1114176"/>
              <a:gd name="connsiteY13" fmla="*/ 2486688 h 3365467"/>
              <a:gd name="connsiteX14" fmla="*/ 56602 w 1114176"/>
              <a:gd name="connsiteY14" fmla="*/ 2820063 h 3365467"/>
              <a:gd name="connsiteX15" fmla="*/ 75652 w 1114176"/>
              <a:gd name="connsiteY15" fmla="*/ 3153438 h 3365467"/>
              <a:gd name="connsiteX16" fmla="*/ 142327 w 1114176"/>
              <a:gd name="connsiteY16" fmla="*/ 3353463 h 3365467"/>
              <a:gd name="connsiteX17" fmla="*/ 56602 w 1114176"/>
              <a:gd name="connsiteY17" fmla="*/ 3343938 h 3365467"/>
              <a:gd name="connsiteX18" fmla="*/ 675727 w 1114176"/>
              <a:gd name="connsiteY18" fmla="*/ 3353463 h 3365467"/>
              <a:gd name="connsiteX19" fmla="*/ 637627 w 1114176"/>
              <a:gd name="connsiteY19" fmla="*/ 3343938 h 3365467"/>
              <a:gd name="connsiteX20" fmla="*/ 675727 w 1114176"/>
              <a:gd name="connsiteY20" fmla="*/ 3334413 h 3365467"/>
              <a:gd name="connsiteX21" fmla="*/ 675727 w 1114176"/>
              <a:gd name="connsiteY21" fmla="*/ 3248688 h 3365467"/>
              <a:gd name="connsiteX22" fmla="*/ 628102 w 1114176"/>
              <a:gd name="connsiteY22" fmla="*/ 3182013 h 3365467"/>
              <a:gd name="connsiteX23" fmla="*/ 618577 w 1114176"/>
              <a:gd name="connsiteY23" fmla="*/ 2972463 h 3365467"/>
              <a:gd name="connsiteX24" fmla="*/ 542377 w 1114176"/>
              <a:gd name="connsiteY24" fmla="*/ 2648613 h 3365467"/>
              <a:gd name="connsiteX25" fmla="*/ 447127 w 1114176"/>
              <a:gd name="connsiteY25" fmla="*/ 2534313 h 3365467"/>
              <a:gd name="connsiteX26" fmla="*/ 437602 w 1114176"/>
              <a:gd name="connsiteY26" fmla="*/ 2429538 h 3365467"/>
              <a:gd name="connsiteX27" fmla="*/ 494752 w 1114176"/>
              <a:gd name="connsiteY27" fmla="*/ 2315238 h 3365467"/>
              <a:gd name="connsiteX28" fmla="*/ 599527 w 1114176"/>
              <a:gd name="connsiteY28" fmla="*/ 2239038 h 3365467"/>
              <a:gd name="connsiteX29" fmla="*/ 799552 w 1114176"/>
              <a:gd name="connsiteY29" fmla="*/ 2039013 h 3365467"/>
              <a:gd name="connsiteX30" fmla="*/ 923377 w 1114176"/>
              <a:gd name="connsiteY30" fmla="*/ 1829463 h 3365467"/>
              <a:gd name="connsiteX31" fmla="*/ 928139 w 1114176"/>
              <a:gd name="connsiteY31" fmla="*/ 1715163 h 3365467"/>
              <a:gd name="connsiteX32" fmla="*/ 1090064 w 1114176"/>
              <a:gd name="connsiteY32" fmla="*/ 1467513 h 3365467"/>
              <a:gd name="connsiteX33" fmla="*/ 1090065 w 1114176"/>
              <a:gd name="connsiteY33" fmla="*/ 1381789 h 3365467"/>
              <a:gd name="connsiteX34" fmla="*/ 1113877 w 1114176"/>
              <a:gd name="connsiteY34" fmla="*/ 1238913 h 3365467"/>
              <a:gd name="connsiteX35" fmla="*/ 1071015 w 1114176"/>
              <a:gd name="connsiteY35" fmla="*/ 1067463 h 3365467"/>
              <a:gd name="connsiteX36" fmla="*/ 1056727 w 1114176"/>
              <a:gd name="connsiteY36" fmla="*/ 962688 h 3365467"/>
              <a:gd name="connsiteX37" fmla="*/ 894802 w 1114176"/>
              <a:gd name="connsiteY37" fmla="*/ 1019838 h 3365467"/>
              <a:gd name="connsiteX38" fmla="*/ 890039 w 1114176"/>
              <a:gd name="connsiteY38" fmla="*/ 848388 h 3365467"/>
              <a:gd name="connsiteX39" fmla="*/ 799552 w 1114176"/>
              <a:gd name="connsiteY39" fmla="*/ 667413 h 3365467"/>
              <a:gd name="connsiteX40" fmla="*/ 642390 w 1114176"/>
              <a:gd name="connsiteY40" fmla="*/ 648364 h 3365467"/>
              <a:gd name="connsiteX41" fmla="*/ 609052 w 1114176"/>
              <a:gd name="connsiteY41" fmla="*/ 581688 h 3365467"/>
              <a:gd name="connsiteX42" fmla="*/ 442365 w 1114176"/>
              <a:gd name="connsiteY42" fmla="*/ 543589 h 3365467"/>
              <a:gd name="connsiteX43" fmla="*/ 323302 w 1114176"/>
              <a:gd name="connsiteY43" fmla="*/ 448338 h 3365467"/>
              <a:gd name="connsiteX44" fmla="*/ 161377 w 1114176"/>
              <a:gd name="connsiteY44" fmla="*/ 43526 h 3365467"/>
              <a:gd name="connsiteX45" fmla="*/ 166139 w 1114176"/>
              <a:gd name="connsiteY45" fmla="*/ 10188 h 3365467"/>
              <a:gd name="connsiteX46" fmla="*/ 4215 w 1114176"/>
              <a:gd name="connsiteY46" fmla="*/ 10188 h 3365467"/>
              <a:gd name="connsiteX0" fmla="*/ 4215 w 1114176"/>
              <a:gd name="connsiteY0" fmla="*/ 10188 h 3365467"/>
              <a:gd name="connsiteX1" fmla="*/ 51840 w 1114176"/>
              <a:gd name="connsiteY1" fmla="*/ 129251 h 3365467"/>
              <a:gd name="connsiteX2" fmla="*/ 56603 w 1114176"/>
              <a:gd name="connsiteY2" fmla="*/ 214976 h 3365467"/>
              <a:gd name="connsiteX3" fmla="*/ 113752 w 1114176"/>
              <a:gd name="connsiteY3" fmla="*/ 381663 h 3365467"/>
              <a:gd name="connsiteX4" fmla="*/ 108989 w 1114176"/>
              <a:gd name="connsiteY4" fmla="*/ 476913 h 3365467"/>
              <a:gd name="connsiteX5" fmla="*/ 151852 w 1114176"/>
              <a:gd name="connsiteY5" fmla="*/ 629313 h 3365467"/>
              <a:gd name="connsiteX6" fmla="*/ 156615 w 1114176"/>
              <a:gd name="connsiteY6" fmla="*/ 824575 h 3365467"/>
              <a:gd name="connsiteX7" fmla="*/ 170902 w 1114176"/>
              <a:gd name="connsiteY7" fmla="*/ 957927 h 3365467"/>
              <a:gd name="connsiteX8" fmla="*/ 199477 w 1114176"/>
              <a:gd name="connsiteY8" fmla="*/ 1019838 h 3365467"/>
              <a:gd name="connsiteX9" fmla="*/ 175665 w 1114176"/>
              <a:gd name="connsiteY9" fmla="*/ 1129377 h 3365467"/>
              <a:gd name="connsiteX10" fmla="*/ 32789 w 1114176"/>
              <a:gd name="connsiteY10" fmla="*/ 1524663 h 3365467"/>
              <a:gd name="connsiteX11" fmla="*/ 75652 w 1114176"/>
              <a:gd name="connsiteY11" fmla="*/ 1705638 h 3365467"/>
              <a:gd name="connsiteX12" fmla="*/ 66127 w 1114176"/>
              <a:gd name="connsiteY12" fmla="*/ 2229513 h 3365467"/>
              <a:gd name="connsiteX13" fmla="*/ 113752 w 1114176"/>
              <a:gd name="connsiteY13" fmla="*/ 2486688 h 3365467"/>
              <a:gd name="connsiteX14" fmla="*/ 56602 w 1114176"/>
              <a:gd name="connsiteY14" fmla="*/ 2820063 h 3365467"/>
              <a:gd name="connsiteX15" fmla="*/ 75652 w 1114176"/>
              <a:gd name="connsiteY15" fmla="*/ 3153438 h 3365467"/>
              <a:gd name="connsiteX16" fmla="*/ 142327 w 1114176"/>
              <a:gd name="connsiteY16" fmla="*/ 3353463 h 3365467"/>
              <a:gd name="connsiteX17" fmla="*/ 137564 w 1114176"/>
              <a:gd name="connsiteY17" fmla="*/ 3343938 h 3365467"/>
              <a:gd name="connsiteX18" fmla="*/ 675727 w 1114176"/>
              <a:gd name="connsiteY18" fmla="*/ 3353463 h 3365467"/>
              <a:gd name="connsiteX19" fmla="*/ 637627 w 1114176"/>
              <a:gd name="connsiteY19" fmla="*/ 3343938 h 3365467"/>
              <a:gd name="connsiteX20" fmla="*/ 675727 w 1114176"/>
              <a:gd name="connsiteY20" fmla="*/ 3334413 h 3365467"/>
              <a:gd name="connsiteX21" fmla="*/ 675727 w 1114176"/>
              <a:gd name="connsiteY21" fmla="*/ 3248688 h 3365467"/>
              <a:gd name="connsiteX22" fmla="*/ 628102 w 1114176"/>
              <a:gd name="connsiteY22" fmla="*/ 3182013 h 3365467"/>
              <a:gd name="connsiteX23" fmla="*/ 618577 w 1114176"/>
              <a:gd name="connsiteY23" fmla="*/ 2972463 h 3365467"/>
              <a:gd name="connsiteX24" fmla="*/ 542377 w 1114176"/>
              <a:gd name="connsiteY24" fmla="*/ 2648613 h 3365467"/>
              <a:gd name="connsiteX25" fmla="*/ 447127 w 1114176"/>
              <a:gd name="connsiteY25" fmla="*/ 2534313 h 3365467"/>
              <a:gd name="connsiteX26" fmla="*/ 437602 w 1114176"/>
              <a:gd name="connsiteY26" fmla="*/ 2429538 h 3365467"/>
              <a:gd name="connsiteX27" fmla="*/ 494752 w 1114176"/>
              <a:gd name="connsiteY27" fmla="*/ 2315238 h 3365467"/>
              <a:gd name="connsiteX28" fmla="*/ 599527 w 1114176"/>
              <a:gd name="connsiteY28" fmla="*/ 2239038 h 3365467"/>
              <a:gd name="connsiteX29" fmla="*/ 799552 w 1114176"/>
              <a:gd name="connsiteY29" fmla="*/ 2039013 h 3365467"/>
              <a:gd name="connsiteX30" fmla="*/ 923377 w 1114176"/>
              <a:gd name="connsiteY30" fmla="*/ 1829463 h 3365467"/>
              <a:gd name="connsiteX31" fmla="*/ 928139 w 1114176"/>
              <a:gd name="connsiteY31" fmla="*/ 1715163 h 3365467"/>
              <a:gd name="connsiteX32" fmla="*/ 1090064 w 1114176"/>
              <a:gd name="connsiteY32" fmla="*/ 1467513 h 3365467"/>
              <a:gd name="connsiteX33" fmla="*/ 1090065 w 1114176"/>
              <a:gd name="connsiteY33" fmla="*/ 1381789 h 3365467"/>
              <a:gd name="connsiteX34" fmla="*/ 1113877 w 1114176"/>
              <a:gd name="connsiteY34" fmla="*/ 1238913 h 3365467"/>
              <a:gd name="connsiteX35" fmla="*/ 1071015 w 1114176"/>
              <a:gd name="connsiteY35" fmla="*/ 1067463 h 3365467"/>
              <a:gd name="connsiteX36" fmla="*/ 1056727 w 1114176"/>
              <a:gd name="connsiteY36" fmla="*/ 962688 h 3365467"/>
              <a:gd name="connsiteX37" fmla="*/ 894802 w 1114176"/>
              <a:gd name="connsiteY37" fmla="*/ 1019838 h 3365467"/>
              <a:gd name="connsiteX38" fmla="*/ 890039 w 1114176"/>
              <a:gd name="connsiteY38" fmla="*/ 848388 h 3365467"/>
              <a:gd name="connsiteX39" fmla="*/ 799552 w 1114176"/>
              <a:gd name="connsiteY39" fmla="*/ 667413 h 3365467"/>
              <a:gd name="connsiteX40" fmla="*/ 642390 w 1114176"/>
              <a:gd name="connsiteY40" fmla="*/ 648364 h 3365467"/>
              <a:gd name="connsiteX41" fmla="*/ 609052 w 1114176"/>
              <a:gd name="connsiteY41" fmla="*/ 581688 h 3365467"/>
              <a:gd name="connsiteX42" fmla="*/ 442365 w 1114176"/>
              <a:gd name="connsiteY42" fmla="*/ 543589 h 3365467"/>
              <a:gd name="connsiteX43" fmla="*/ 323302 w 1114176"/>
              <a:gd name="connsiteY43" fmla="*/ 448338 h 3365467"/>
              <a:gd name="connsiteX44" fmla="*/ 161377 w 1114176"/>
              <a:gd name="connsiteY44" fmla="*/ 43526 h 3365467"/>
              <a:gd name="connsiteX45" fmla="*/ 166139 w 1114176"/>
              <a:gd name="connsiteY45" fmla="*/ 10188 h 3365467"/>
              <a:gd name="connsiteX46" fmla="*/ 4215 w 1114176"/>
              <a:gd name="connsiteY46" fmla="*/ 10188 h 3365467"/>
              <a:gd name="connsiteX0" fmla="*/ 4215 w 1114176"/>
              <a:gd name="connsiteY0" fmla="*/ 10188 h 3364433"/>
              <a:gd name="connsiteX1" fmla="*/ 51840 w 1114176"/>
              <a:gd name="connsiteY1" fmla="*/ 129251 h 3364433"/>
              <a:gd name="connsiteX2" fmla="*/ 56603 w 1114176"/>
              <a:gd name="connsiteY2" fmla="*/ 214976 h 3364433"/>
              <a:gd name="connsiteX3" fmla="*/ 113752 w 1114176"/>
              <a:gd name="connsiteY3" fmla="*/ 381663 h 3364433"/>
              <a:gd name="connsiteX4" fmla="*/ 108989 w 1114176"/>
              <a:gd name="connsiteY4" fmla="*/ 476913 h 3364433"/>
              <a:gd name="connsiteX5" fmla="*/ 151852 w 1114176"/>
              <a:gd name="connsiteY5" fmla="*/ 629313 h 3364433"/>
              <a:gd name="connsiteX6" fmla="*/ 156615 w 1114176"/>
              <a:gd name="connsiteY6" fmla="*/ 824575 h 3364433"/>
              <a:gd name="connsiteX7" fmla="*/ 170902 w 1114176"/>
              <a:gd name="connsiteY7" fmla="*/ 957927 h 3364433"/>
              <a:gd name="connsiteX8" fmla="*/ 199477 w 1114176"/>
              <a:gd name="connsiteY8" fmla="*/ 1019838 h 3364433"/>
              <a:gd name="connsiteX9" fmla="*/ 175665 w 1114176"/>
              <a:gd name="connsiteY9" fmla="*/ 1129377 h 3364433"/>
              <a:gd name="connsiteX10" fmla="*/ 32789 w 1114176"/>
              <a:gd name="connsiteY10" fmla="*/ 1524663 h 3364433"/>
              <a:gd name="connsiteX11" fmla="*/ 75652 w 1114176"/>
              <a:gd name="connsiteY11" fmla="*/ 1705638 h 3364433"/>
              <a:gd name="connsiteX12" fmla="*/ 66127 w 1114176"/>
              <a:gd name="connsiteY12" fmla="*/ 2229513 h 3364433"/>
              <a:gd name="connsiteX13" fmla="*/ 113752 w 1114176"/>
              <a:gd name="connsiteY13" fmla="*/ 2486688 h 3364433"/>
              <a:gd name="connsiteX14" fmla="*/ 56602 w 1114176"/>
              <a:gd name="connsiteY14" fmla="*/ 2820063 h 3364433"/>
              <a:gd name="connsiteX15" fmla="*/ 89940 w 1114176"/>
              <a:gd name="connsiteY15" fmla="*/ 3167726 h 3364433"/>
              <a:gd name="connsiteX16" fmla="*/ 142327 w 1114176"/>
              <a:gd name="connsiteY16" fmla="*/ 3353463 h 3364433"/>
              <a:gd name="connsiteX17" fmla="*/ 137564 w 1114176"/>
              <a:gd name="connsiteY17" fmla="*/ 3343938 h 3364433"/>
              <a:gd name="connsiteX18" fmla="*/ 675727 w 1114176"/>
              <a:gd name="connsiteY18" fmla="*/ 3353463 h 3364433"/>
              <a:gd name="connsiteX19" fmla="*/ 637627 w 1114176"/>
              <a:gd name="connsiteY19" fmla="*/ 3343938 h 3364433"/>
              <a:gd name="connsiteX20" fmla="*/ 675727 w 1114176"/>
              <a:gd name="connsiteY20" fmla="*/ 3334413 h 3364433"/>
              <a:gd name="connsiteX21" fmla="*/ 675727 w 1114176"/>
              <a:gd name="connsiteY21" fmla="*/ 3248688 h 3364433"/>
              <a:gd name="connsiteX22" fmla="*/ 628102 w 1114176"/>
              <a:gd name="connsiteY22" fmla="*/ 3182013 h 3364433"/>
              <a:gd name="connsiteX23" fmla="*/ 618577 w 1114176"/>
              <a:gd name="connsiteY23" fmla="*/ 2972463 h 3364433"/>
              <a:gd name="connsiteX24" fmla="*/ 542377 w 1114176"/>
              <a:gd name="connsiteY24" fmla="*/ 2648613 h 3364433"/>
              <a:gd name="connsiteX25" fmla="*/ 447127 w 1114176"/>
              <a:gd name="connsiteY25" fmla="*/ 2534313 h 3364433"/>
              <a:gd name="connsiteX26" fmla="*/ 437602 w 1114176"/>
              <a:gd name="connsiteY26" fmla="*/ 2429538 h 3364433"/>
              <a:gd name="connsiteX27" fmla="*/ 494752 w 1114176"/>
              <a:gd name="connsiteY27" fmla="*/ 2315238 h 3364433"/>
              <a:gd name="connsiteX28" fmla="*/ 599527 w 1114176"/>
              <a:gd name="connsiteY28" fmla="*/ 2239038 h 3364433"/>
              <a:gd name="connsiteX29" fmla="*/ 799552 w 1114176"/>
              <a:gd name="connsiteY29" fmla="*/ 2039013 h 3364433"/>
              <a:gd name="connsiteX30" fmla="*/ 923377 w 1114176"/>
              <a:gd name="connsiteY30" fmla="*/ 1829463 h 3364433"/>
              <a:gd name="connsiteX31" fmla="*/ 928139 w 1114176"/>
              <a:gd name="connsiteY31" fmla="*/ 1715163 h 3364433"/>
              <a:gd name="connsiteX32" fmla="*/ 1090064 w 1114176"/>
              <a:gd name="connsiteY32" fmla="*/ 1467513 h 3364433"/>
              <a:gd name="connsiteX33" fmla="*/ 1090065 w 1114176"/>
              <a:gd name="connsiteY33" fmla="*/ 1381789 h 3364433"/>
              <a:gd name="connsiteX34" fmla="*/ 1113877 w 1114176"/>
              <a:gd name="connsiteY34" fmla="*/ 1238913 h 3364433"/>
              <a:gd name="connsiteX35" fmla="*/ 1071015 w 1114176"/>
              <a:gd name="connsiteY35" fmla="*/ 1067463 h 3364433"/>
              <a:gd name="connsiteX36" fmla="*/ 1056727 w 1114176"/>
              <a:gd name="connsiteY36" fmla="*/ 962688 h 3364433"/>
              <a:gd name="connsiteX37" fmla="*/ 894802 w 1114176"/>
              <a:gd name="connsiteY37" fmla="*/ 1019838 h 3364433"/>
              <a:gd name="connsiteX38" fmla="*/ 890039 w 1114176"/>
              <a:gd name="connsiteY38" fmla="*/ 848388 h 3364433"/>
              <a:gd name="connsiteX39" fmla="*/ 799552 w 1114176"/>
              <a:gd name="connsiteY39" fmla="*/ 667413 h 3364433"/>
              <a:gd name="connsiteX40" fmla="*/ 642390 w 1114176"/>
              <a:gd name="connsiteY40" fmla="*/ 648364 h 3364433"/>
              <a:gd name="connsiteX41" fmla="*/ 609052 w 1114176"/>
              <a:gd name="connsiteY41" fmla="*/ 581688 h 3364433"/>
              <a:gd name="connsiteX42" fmla="*/ 442365 w 1114176"/>
              <a:gd name="connsiteY42" fmla="*/ 543589 h 3364433"/>
              <a:gd name="connsiteX43" fmla="*/ 323302 w 1114176"/>
              <a:gd name="connsiteY43" fmla="*/ 448338 h 3364433"/>
              <a:gd name="connsiteX44" fmla="*/ 161377 w 1114176"/>
              <a:gd name="connsiteY44" fmla="*/ 43526 h 3364433"/>
              <a:gd name="connsiteX45" fmla="*/ 166139 w 1114176"/>
              <a:gd name="connsiteY45" fmla="*/ 10188 h 3364433"/>
              <a:gd name="connsiteX46" fmla="*/ 4215 w 1114176"/>
              <a:gd name="connsiteY46" fmla="*/ 10188 h 3364433"/>
              <a:gd name="connsiteX0" fmla="*/ 4215 w 1114176"/>
              <a:gd name="connsiteY0" fmla="*/ 10188 h 3364433"/>
              <a:gd name="connsiteX1" fmla="*/ 51840 w 1114176"/>
              <a:gd name="connsiteY1" fmla="*/ 129251 h 3364433"/>
              <a:gd name="connsiteX2" fmla="*/ 56603 w 1114176"/>
              <a:gd name="connsiteY2" fmla="*/ 214976 h 3364433"/>
              <a:gd name="connsiteX3" fmla="*/ 113752 w 1114176"/>
              <a:gd name="connsiteY3" fmla="*/ 381663 h 3364433"/>
              <a:gd name="connsiteX4" fmla="*/ 108989 w 1114176"/>
              <a:gd name="connsiteY4" fmla="*/ 476913 h 3364433"/>
              <a:gd name="connsiteX5" fmla="*/ 151852 w 1114176"/>
              <a:gd name="connsiteY5" fmla="*/ 629313 h 3364433"/>
              <a:gd name="connsiteX6" fmla="*/ 156615 w 1114176"/>
              <a:gd name="connsiteY6" fmla="*/ 824575 h 3364433"/>
              <a:gd name="connsiteX7" fmla="*/ 170902 w 1114176"/>
              <a:gd name="connsiteY7" fmla="*/ 957927 h 3364433"/>
              <a:gd name="connsiteX8" fmla="*/ 199477 w 1114176"/>
              <a:gd name="connsiteY8" fmla="*/ 1019838 h 3364433"/>
              <a:gd name="connsiteX9" fmla="*/ 175665 w 1114176"/>
              <a:gd name="connsiteY9" fmla="*/ 1129377 h 3364433"/>
              <a:gd name="connsiteX10" fmla="*/ 32789 w 1114176"/>
              <a:gd name="connsiteY10" fmla="*/ 1524663 h 3364433"/>
              <a:gd name="connsiteX11" fmla="*/ 75652 w 1114176"/>
              <a:gd name="connsiteY11" fmla="*/ 1705638 h 3364433"/>
              <a:gd name="connsiteX12" fmla="*/ 66127 w 1114176"/>
              <a:gd name="connsiteY12" fmla="*/ 2229513 h 3364433"/>
              <a:gd name="connsiteX13" fmla="*/ 113752 w 1114176"/>
              <a:gd name="connsiteY13" fmla="*/ 2486688 h 3364433"/>
              <a:gd name="connsiteX14" fmla="*/ 56602 w 1114176"/>
              <a:gd name="connsiteY14" fmla="*/ 2820063 h 3364433"/>
              <a:gd name="connsiteX15" fmla="*/ 89940 w 1114176"/>
              <a:gd name="connsiteY15" fmla="*/ 3167726 h 3364433"/>
              <a:gd name="connsiteX16" fmla="*/ 142327 w 1114176"/>
              <a:gd name="connsiteY16" fmla="*/ 3353463 h 3364433"/>
              <a:gd name="connsiteX17" fmla="*/ 137564 w 1114176"/>
              <a:gd name="connsiteY17" fmla="*/ 3343938 h 3364433"/>
              <a:gd name="connsiteX18" fmla="*/ 675727 w 1114176"/>
              <a:gd name="connsiteY18" fmla="*/ 3353463 h 3364433"/>
              <a:gd name="connsiteX19" fmla="*/ 637627 w 1114176"/>
              <a:gd name="connsiteY19" fmla="*/ 3343938 h 3364433"/>
              <a:gd name="connsiteX20" fmla="*/ 675727 w 1114176"/>
              <a:gd name="connsiteY20" fmla="*/ 3334413 h 3364433"/>
              <a:gd name="connsiteX21" fmla="*/ 675727 w 1114176"/>
              <a:gd name="connsiteY21" fmla="*/ 3248688 h 3364433"/>
              <a:gd name="connsiteX22" fmla="*/ 628102 w 1114176"/>
              <a:gd name="connsiteY22" fmla="*/ 3182013 h 3364433"/>
              <a:gd name="connsiteX23" fmla="*/ 590002 w 1114176"/>
              <a:gd name="connsiteY23" fmla="*/ 2986751 h 3364433"/>
              <a:gd name="connsiteX24" fmla="*/ 542377 w 1114176"/>
              <a:gd name="connsiteY24" fmla="*/ 2648613 h 3364433"/>
              <a:gd name="connsiteX25" fmla="*/ 447127 w 1114176"/>
              <a:gd name="connsiteY25" fmla="*/ 2534313 h 3364433"/>
              <a:gd name="connsiteX26" fmla="*/ 437602 w 1114176"/>
              <a:gd name="connsiteY26" fmla="*/ 2429538 h 3364433"/>
              <a:gd name="connsiteX27" fmla="*/ 494752 w 1114176"/>
              <a:gd name="connsiteY27" fmla="*/ 2315238 h 3364433"/>
              <a:gd name="connsiteX28" fmla="*/ 599527 w 1114176"/>
              <a:gd name="connsiteY28" fmla="*/ 2239038 h 3364433"/>
              <a:gd name="connsiteX29" fmla="*/ 799552 w 1114176"/>
              <a:gd name="connsiteY29" fmla="*/ 2039013 h 3364433"/>
              <a:gd name="connsiteX30" fmla="*/ 923377 w 1114176"/>
              <a:gd name="connsiteY30" fmla="*/ 1829463 h 3364433"/>
              <a:gd name="connsiteX31" fmla="*/ 928139 w 1114176"/>
              <a:gd name="connsiteY31" fmla="*/ 1715163 h 3364433"/>
              <a:gd name="connsiteX32" fmla="*/ 1090064 w 1114176"/>
              <a:gd name="connsiteY32" fmla="*/ 1467513 h 3364433"/>
              <a:gd name="connsiteX33" fmla="*/ 1090065 w 1114176"/>
              <a:gd name="connsiteY33" fmla="*/ 1381789 h 3364433"/>
              <a:gd name="connsiteX34" fmla="*/ 1113877 w 1114176"/>
              <a:gd name="connsiteY34" fmla="*/ 1238913 h 3364433"/>
              <a:gd name="connsiteX35" fmla="*/ 1071015 w 1114176"/>
              <a:gd name="connsiteY35" fmla="*/ 1067463 h 3364433"/>
              <a:gd name="connsiteX36" fmla="*/ 1056727 w 1114176"/>
              <a:gd name="connsiteY36" fmla="*/ 962688 h 3364433"/>
              <a:gd name="connsiteX37" fmla="*/ 894802 w 1114176"/>
              <a:gd name="connsiteY37" fmla="*/ 1019838 h 3364433"/>
              <a:gd name="connsiteX38" fmla="*/ 890039 w 1114176"/>
              <a:gd name="connsiteY38" fmla="*/ 848388 h 3364433"/>
              <a:gd name="connsiteX39" fmla="*/ 799552 w 1114176"/>
              <a:gd name="connsiteY39" fmla="*/ 667413 h 3364433"/>
              <a:gd name="connsiteX40" fmla="*/ 642390 w 1114176"/>
              <a:gd name="connsiteY40" fmla="*/ 648364 h 3364433"/>
              <a:gd name="connsiteX41" fmla="*/ 609052 w 1114176"/>
              <a:gd name="connsiteY41" fmla="*/ 581688 h 3364433"/>
              <a:gd name="connsiteX42" fmla="*/ 442365 w 1114176"/>
              <a:gd name="connsiteY42" fmla="*/ 543589 h 3364433"/>
              <a:gd name="connsiteX43" fmla="*/ 323302 w 1114176"/>
              <a:gd name="connsiteY43" fmla="*/ 448338 h 3364433"/>
              <a:gd name="connsiteX44" fmla="*/ 161377 w 1114176"/>
              <a:gd name="connsiteY44" fmla="*/ 43526 h 3364433"/>
              <a:gd name="connsiteX45" fmla="*/ 166139 w 1114176"/>
              <a:gd name="connsiteY45" fmla="*/ 10188 h 3364433"/>
              <a:gd name="connsiteX46" fmla="*/ 4215 w 1114176"/>
              <a:gd name="connsiteY46" fmla="*/ 10188 h 3364433"/>
              <a:gd name="connsiteX0" fmla="*/ 4215 w 1114176"/>
              <a:gd name="connsiteY0" fmla="*/ 10188 h 3364433"/>
              <a:gd name="connsiteX1" fmla="*/ 51840 w 1114176"/>
              <a:gd name="connsiteY1" fmla="*/ 129251 h 3364433"/>
              <a:gd name="connsiteX2" fmla="*/ 56603 w 1114176"/>
              <a:gd name="connsiteY2" fmla="*/ 214976 h 3364433"/>
              <a:gd name="connsiteX3" fmla="*/ 113752 w 1114176"/>
              <a:gd name="connsiteY3" fmla="*/ 381663 h 3364433"/>
              <a:gd name="connsiteX4" fmla="*/ 108989 w 1114176"/>
              <a:gd name="connsiteY4" fmla="*/ 476913 h 3364433"/>
              <a:gd name="connsiteX5" fmla="*/ 151852 w 1114176"/>
              <a:gd name="connsiteY5" fmla="*/ 629313 h 3364433"/>
              <a:gd name="connsiteX6" fmla="*/ 156615 w 1114176"/>
              <a:gd name="connsiteY6" fmla="*/ 824575 h 3364433"/>
              <a:gd name="connsiteX7" fmla="*/ 170902 w 1114176"/>
              <a:gd name="connsiteY7" fmla="*/ 957927 h 3364433"/>
              <a:gd name="connsiteX8" fmla="*/ 199477 w 1114176"/>
              <a:gd name="connsiteY8" fmla="*/ 1019838 h 3364433"/>
              <a:gd name="connsiteX9" fmla="*/ 175665 w 1114176"/>
              <a:gd name="connsiteY9" fmla="*/ 1129377 h 3364433"/>
              <a:gd name="connsiteX10" fmla="*/ 32789 w 1114176"/>
              <a:gd name="connsiteY10" fmla="*/ 1524663 h 3364433"/>
              <a:gd name="connsiteX11" fmla="*/ 75652 w 1114176"/>
              <a:gd name="connsiteY11" fmla="*/ 1705638 h 3364433"/>
              <a:gd name="connsiteX12" fmla="*/ 66127 w 1114176"/>
              <a:gd name="connsiteY12" fmla="*/ 2229513 h 3364433"/>
              <a:gd name="connsiteX13" fmla="*/ 113752 w 1114176"/>
              <a:gd name="connsiteY13" fmla="*/ 2486688 h 3364433"/>
              <a:gd name="connsiteX14" fmla="*/ 56602 w 1114176"/>
              <a:gd name="connsiteY14" fmla="*/ 2820063 h 3364433"/>
              <a:gd name="connsiteX15" fmla="*/ 89940 w 1114176"/>
              <a:gd name="connsiteY15" fmla="*/ 3167726 h 3364433"/>
              <a:gd name="connsiteX16" fmla="*/ 142327 w 1114176"/>
              <a:gd name="connsiteY16" fmla="*/ 3353463 h 3364433"/>
              <a:gd name="connsiteX17" fmla="*/ 137564 w 1114176"/>
              <a:gd name="connsiteY17" fmla="*/ 3343938 h 3364433"/>
              <a:gd name="connsiteX18" fmla="*/ 675727 w 1114176"/>
              <a:gd name="connsiteY18" fmla="*/ 3353463 h 3364433"/>
              <a:gd name="connsiteX19" fmla="*/ 637627 w 1114176"/>
              <a:gd name="connsiteY19" fmla="*/ 3343938 h 3364433"/>
              <a:gd name="connsiteX20" fmla="*/ 675727 w 1114176"/>
              <a:gd name="connsiteY20" fmla="*/ 3334413 h 3364433"/>
              <a:gd name="connsiteX21" fmla="*/ 675727 w 1114176"/>
              <a:gd name="connsiteY21" fmla="*/ 3248688 h 3364433"/>
              <a:gd name="connsiteX22" fmla="*/ 628102 w 1114176"/>
              <a:gd name="connsiteY22" fmla="*/ 3182013 h 3364433"/>
              <a:gd name="connsiteX23" fmla="*/ 590002 w 1114176"/>
              <a:gd name="connsiteY23" fmla="*/ 2986751 h 3364433"/>
              <a:gd name="connsiteX24" fmla="*/ 523327 w 1114176"/>
              <a:gd name="connsiteY24" fmla="*/ 2610513 h 3364433"/>
              <a:gd name="connsiteX25" fmla="*/ 447127 w 1114176"/>
              <a:gd name="connsiteY25" fmla="*/ 2534313 h 3364433"/>
              <a:gd name="connsiteX26" fmla="*/ 437602 w 1114176"/>
              <a:gd name="connsiteY26" fmla="*/ 2429538 h 3364433"/>
              <a:gd name="connsiteX27" fmla="*/ 494752 w 1114176"/>
              <a:gd name="connsiteY27" fmla="*/ 2315238 h 3364433"/>
              <a:gd name="connsiteX28" fmla="*/ 599527 w 1114176"/>
              <a:gd name="connsiteY28" fmla="*/ 2239038 h 3364433"/>
              <a:gd name="connsiteX29" fmla="*/ 799552 w 1114176"/>
              <a:gd name="connsiteY29" fmla="*/ 2039013 h 3364433"/>
              <a:gd name="connsiteX30" fmla="*/ 923377 w 1114176"/>
              <a:gd name="connsiteY30" fmla="*/ 1829463 h 3364433"/>
              <a:gd name="connsiteX31" fmla="*/ 928139 w 1114176"/>
              <a:gd name="connsiteY31" fmla="*/ 1715163 h 3364433"/>
              <a:gd name="connsiteX32" fmla="*/ 1090064 w 1114176"/>
              <a:gd name="connsiteY32" fmla="*/ 1467513 h 3364433"/>
              <a:gd name="connsiteX33" fmla="*/ 1090065 w 1114176"/>
              <a:gd name="connsiteY33" fmla="*/ 1381789 h 3364433"/>
              <a:gd name="connsiteX34" fmla="*/ 1113877 w 1114176"/>
              <a:gd name="connsiteY34" fmla="*/ 1238913 h 3364433"/>
              <a:gd name="connsiteX35" fmla="*/ 1071015 w 1114176"/>
              <a:gd name="connsiteY35" fmla="*/ 1067463 h 3364433"/>
              <a:gd name="connsiteX36" fmla="*/ 1056727 w 1114176"/>
              <a:gd name="connsiteY36" fmla="*/ 962688 h 3364433"/>
              <a:gd name="connsiteX37" fmla="*/ 894802 w 1114176"/>
              <a:gd name="connsiteY37" fmla="*/ 1019838 h 3364433"/>
              <a:gd name="connsiteX38" fmla="*/ 890039 w 1114176"/>
              <a:gd name="connsiteY38" fmla="*/ 848388 h 3364433"/>
              <a:gd name="connsiteX39" fmla="*/ 799552 w 1114176"/>
              <a:gd name="connsiteY39" fmla="*/ 667413 h 3364433"/>
              <a:gd name="connsiteX40" fmla="*/ 642390 w 1114176"/>
              <a:gd name="connsiteY40" fmla="*/ 648364 h 3364433"/>
              <a:gd name="connsiteX41" fmla="*/ 609052 w 1114176"/>
              <a:gd name="connsiteY41" fmla="*/ 581688 h 3364433"/>
              <a:gd name="connsiteX42" fmla="*/ 442365 w 1114176"/>
              <a:gd name="connsiteY42" fmla="*/ 543589 h 3364433"/>
              <a:gd name="connsiteX43" fmla="*/ 323302 w 1114176"/>
              <a:gd name="connsiteY43" fmla="*/ 448338 h 3364433"/>
              <a:gd name="connsiteX44" fmla="*/ 161377 w 1114176"/>
              <a:gd name="connsiteY44" fmla="*/ 43526 h 3364433"/>
              <a:gd name="connsiteX45" fmla="*/ 166139 w 1114176"/>
              <a:gd name="connsiteY45" fmla="*/ 10188 h 3364433"/>
              <a:gd name="connsiteX46" fmla="*/ 4215 w 1114176"/>
              <a:gd name="connsiteY46" fmla="*/ 10188 h 3364433"/>
              <a:gd name="connsiteX0" fmla="*/ 4215 w 1114176"/>
              <a:gd name="connsiteY0" fmla="*/ 10188 h 3364433"/>
              <a:gd name="connsiteX1" fmla="*/ 51840 w 1114176"/>
              <a:gd name="connsiteY1" fmla="*/ 129251 h 3364433"/>
              <a:gd name="connsiteX2" fmla="*/ 56603 w 1114176"/>
              <a:gd name="connsiteY2" fmla="*/ 214976 h 3364433"/>
              <a:gd name="connsiteX3" fmla="*/ 113752 w 1114176"/>
              <a:gd name="connsiteY3" fmla="*/ 381663 h 3364433"/>
              <a:gd name="connsiteX4" fmla="*/ 108989 w 1114176"/>
              <a:gd name="connsiteY4" fmla="*/ 476913 h 3364433"/>
              <a:gd name="connsiteX5" fmla="*/ 151852 w 1114176"/>
              <a:gd name="connsiteY5" fmla="*/ 629313 h 3364433"/>
              <a:gd name="connsiteX6" fmla="*/ 156615 w 1114176"/>
              <a:gd name="connsiteY6" fmla="*/ 824575 h 3364433"/>
              <a:gd name="connsiteX7" fmla="*/ 170902 w 1114176"/>
              <a:gd name="connsiteY7" fmla="*/ 957927 h 3364433"/>
              <a:gd name="connsiteX8" fmla="*/ 199477 w 1114176"/>
              <a:gd name="connsiteY8" fmla="*/ 1019838 h 3364433"/>
              <a:gd name="connsiteX9" fmla="*/ 175665 w 1114176"/>
              <a:gd name="connsiteY9" fmla="*/ 1129377 h 3364433"/>
              <a:gd name="connsiteX10" fmla="*/ 32789 w 1114176"/>
              <a:gd name="connsiteY10" fmla="*/ 1524663 h 3364433"/>
              <a:gd name="connsiteX11" fmla="*/ 75652 w 1114176"/>
              <a:gd name="connsiteY11" fmla="*/ 1705638 h 3364433"/>
              <a:gd name="connsiteX12" fmla="*/ 66127 w 1114176"/>
              <a:gd name="connsiteY12" fmla="*/ 2229513 h 3364433"/>
              <a:gd name="connsiteX13" fmla="*/ 137564 w 1114176"/>
              <a:gd name="connsiteY13" fmla="*/ 2486688 h 3364433"/>
              <a:gd name="connsiteX14" fmla="*/ 56602 w 1114176"/>
              <a:gd name="connsiteY14" fmla="*/ 2820063 h 3364433"/>
              <a:gd name="connsiteX15" fmla="*/ 89940 w 1114176"/>
              <a:gd name="connsiteY15" fmla="*/ 3167726 h 3364433"/>
              <a:gd name="connsiteX16" fmla="*/ 142327 w 1114176"/>
              <a:gd name="connsiteY16" fmla="*/ 3353463 h 3364433"/>
              <a:gd name="connsiteX17" fmla="*/ 137564 w 1114176"/>
              <a:gd name="connsiteY17" fmla="*/ 3343938 h 3364433"/>
              <a:gd name="connsiteX18" fmla="*/ 675727 w 1114176"/>
              <a:gd name="connsiteY18" fmla="*/ 3353463 h 3364433"/>
              <a:gd name="connsiteX19" fmla="*/ 637627 w 1114176"/>
              <a:gd name="connsiteY19" fmla="*/ 3343938 h 3364433"/>
              <a:gd name="connsiteX20" fmla="*/ 675727 w 1114176"/>
              <a:gd name="connsiteY20" fmla="*/ 3334413 h 3364433"/>
              <a:gd name="connsiteX21" fmla="*/ 675727 w 1114176"/>
              <a:gd name="connsiteY21" fmla="*/ 3248688 h 3364433"/>
              <a:gd name="connsiteX22" fmla="*/ 628102 w 1114176"/>
              <a:gd name="connsiteY22" fmla="*/ 3182013 h 3364433"/>
              <a:gd name="connsiteX23" fmla="*/ 590002 w 1114176"/>
              <a:gd name="connsiteY23" fmla="*/ 2986751 h 3364433"/>
              <a:gd name="connsiteX24" fmla="*/ 523327 w 1114176"/>
              <a:gd name="connsiteY24" fmla="*/ 2610513 h 3364433"/>
              <a:gd name="connsiteX25" fmla="*/ 447127 w 1114176"/>
              <a:gd name="connsiteY25" fmla="*/ 2534313 h 3364433"/>
              <a:gd name="connsiteX26" fmla="*/ 437602 w 1114176"/>
              <a:gd name="connsiteY26" fmla="*/ 2429538 h 3364433"/>
              <a:gd name="connsiteX27" fmla="*/ 494752 w 1114176"/>
              <a:gd name="connsiteY27" fmla="*/ 2315238 h 3364433"/>
              <a:gd name="connsiteX28" fmla="*/ 599527 w 1114176"/>
              <a:gd name="connsiteY28" fmla="*/ 2239038 h 3364433"/>
              <a:gd name="connsiteX29" fmla="*/ 799552 w 1114176"/>
              <a:gd name="connsiteY29" fmla="*/ 2039013 h 3364433"/>
              <a:gd name="connsiteX30" fmla="*/ 923377 w 1114176"/>
              <a:gd name="connsiteY30" fmla="*/ 1829463 h 3364433"/>
              <a:gd name="connsiteX31" fmla="*/ 928139 w 1114176"/>
              <a:gd name="connsiteY31" fmla="*/ 1715163 h 3364433"/>
              <a:gd name="connsiteX32" fmla="*/ 1090064 w 1114176"/>
              <a:gd name="connsiteY32" fmla="*/ 1467513 h 3364433"/>
              <a:gd name="connsiteX33" fmla="*/ 1090065 w 1114176"/>
              <a:gd name="connsiteY33" fmla="*/ 1381789 h 3364433"/>
              <a:gd name="connsiteX34" fmla="*/ 1113877 w 1114176"/>
              <a:gd name="connsiteY34" fmla="*/ 1238913 h 3364433"/>
              <a:gd name="connsiteX35" fmla="*/ 1071015 w 1114176"/>
              <a:gd name="connsiteY35" fmla="*/ 1067463 h 3364433"/>
              <a:gd name="connsiteX36" fmla="*/ 1056727 w 1114176"/>
              <a:gd name="connsiteY36" fmla="*/ 962688 h 3364433"/>
              <a:gd name="connsiteX37" fmla="*/ 894802 w 1114176"/>
              <a:gd name="connsiteY37" fmla="*/ 1019838 h 3364433"/>
              <a:gd name="connsiteX38" fmla="*/ 890039 w 1114176"/>
              <a:gd name="connsiteY38" fmla="*/ 848388 h 3364433"/>
              <a:gd name="connsiteX39" fmla="*/ 799552 w 1114176"/>
              <a:gd name="connsiteY39" fmla="*/ 667413 h 3364433"/>
              <a:gd name="connsiteX40" fmla="*/ 642390 w 1114176"/>
              <a:gd name="connsiteY40" fmla="*/ 648364 h 3364433"/>
              <a:gd name="connsiteX41" fmla="*/ 609052 w 1114176"/>
              <a:gd name="connsiteY41" fmla="*/ 581688 h 3364433"/>
              <a:gd name="connsiteX42" fmla="*/ 442365 w 1114176"/>
              <a:gd name="connsiteY42" fmla="*/ 543589 h 3364433"/>
              <a:gd name="connsiteX43" fmla="*/ 323302 w 1114176"/>
              <a:gd name="connsiteY43" fmla="*/ 448338 h 3364433"/>
              <a:gd name="connsiteX44" fmla="*/ 161377 w 1114176"/>
              <a:gd name="connsiteY44" fmla="*/ 43526 h 3364433"/>
              <a:gd name="connsiteX45" fmla="*/ 166139 w 1114176"/>
              <a:gd name="connsiteY45" fmla="*/ 10188 h 3364433"/>
              <a:gd name="connsiteX46" fmla="*/ 4215 w 1114176"/>
              <a:gd name="connsiteY46" fmla="*/ 10188 h 3364433"/>
              <a:gd name="connsiteX0" fmla="*/ 4215 w 1114176"/>
              <a:gd name="connsiteY0" fmla="*/ 10188 h 3364433"/>
              <a:gd name="connsiteX1" fmla="*/ 51840 w 1114176"/>
              <a:gd name="connsiteY1" fmla="*/ 129251 h 3364433"/>
              <a:gd name="connsiteX2" fmla="*/ 56603 w 1114176"/>
              <a:gd name="connsiteY2" fmla="*/ 214976 h 3364433"/>
              <a:gd name="connsiteX3" fmla="*/ 113752 w 1114176"/>
              <a:gd name="connsiteY3" fmla="*/ 381663 h 3364433"/>
              <a:gd name="connsiteX4" fmla="*/ 108989 w 1114176"/>
              <a:gd name="connsiteY4" fmla="*/ 476913 h 3364433"/>
              <a:gd name="connsiteX5" fmla="*/ 151852 w 1114176"/>
              <a:gd name="connsiteY5" fmla="*/ 629313 h 3364433"/>
              <a:gd name="connsiteX6" fmla="*/ 156615 w 1114176"/>
              <a:gd name="connsiteY6" fmla="*/ 824575 h 3364433"/>
              <a:gd name="connsiteX7" fmla="*/ 170902 w 1114176"/>
              <a:gd name="connsiteY7" fmla="*/ 957927 h 3364433"/>
              <a:gd name="connsiteX8" fmla="*/ 199477 w 1114176"/>
              <a:gd name="connsiteY8" fmla="*/ 1019838 h 3364433"/>
              <a:gd name="connsiteX9" fmla="*/ 175665 w 1114176"/>
              <a:gd name="connsiteY9" fmla="*/ 1129377 h 3364433"/>
              <a:gd name="connsiteX10" fmla="*/ 32789 w 1114176"/>
              <a:gd name="connsiteY10" fmla="*/ 1524663 h 3364433"/>
              <a:gd name="connsiteX11" fmla="*/ 75652 w 1114176"/>
              <a:gd name="connsiteY11" fmla="*/ 1705638 h 3364433"/>
              <a:gd name="connsiteX12" fmla="*/ 85177 w 1114176"/>
              <a:gd name="connsiteY12" fmla="*/ 2219988 h 3364433"/>
              <a:gd name="connsiteX13" fmla="*/ 137564 w 1114176"/>
              <a:gd name="connsiteY13" fmla="*/ 2486688 h 3364433"/>
              <a:gd name="connsiteX14" fmla="*/ 56602 w 1114176"/>
              <a:gd name="connsiteY14" fmla="*/ 2820063 h 3364433"/>
              <a:gd name="connsiteX15" fmla="*/ 89940 w 1114176"/>
              <a:gd name="connsiteY15" fmla="*/ 3167726 h 3364433"/>
              <a:gd name="connsiteX16" fmla="*/ 142327 w 1114176"/>
              <a:gd name="connsiteY16" fmla="*/ 3353463 h 3364433"/>
              <a:gd name="connsiteX17" fmla="*/ 137564 w 1114176"/>
              <a:gd name="connsiteY17" fmla="*/ 3343938 h 3364433"/>
              <a:gd name="connsiteX18" fmla="*/ 675727 w 1114176"/>
              <a:gd name="connsiteY18" fmla="*/ 3353463 h 3364433"/>
              <a:gd name="connsiteX19" fmla="*/ 637627 w 1114176"/>
              <a:gd name="connsiteY19" fmla="*/ 3343938 h 3364433"/>
              <a:gd name="connsiteX20" fmla="*/ 675727 w 1114176"/>
              <a:gd name="connsiteY20" fmla="*/ 3334413 h 3364433"/>
              <a:gd name="connsiteX21" fmla="*/ 675727 w 1114176"/>
              <a:gd name="connsiteY21" fmla="*/ 3248688 h 3364433"/>
              <a:gd name="connsiteX22" fmla="*/ 628102 w 1114176"/>
              <a:gd name="connsiteY22" fmla="*/ 3182013 h 3364433"/>
              <a:gd name="connsiteX23" fmla="*/ 590002 w 1114176"/>
              <a:gd name="connsiteY23" fmla="*/ 2986751 h 3364433"/>
              <a:gd name="connsiteX24" fmla="*/ 523327 w 1114176"/>
              <a:gd name="connsiteY24" fmla="*/ 2610513 h 3364433"/>
              <a:gd name="connsiteX25" fmla="*/ 447127 w 1114176"/>
              <a:gd name="connsiteY25" fmla="*/ 2534313 h 3364433"/>
              <a:gd name="connsiteX26" fmla="*/ 437602 w 1114176"/>
              <a:gd name="connsiteY26" fmla="*/ 2429538 h 3364433"/>
              <a:gd name="connsiteX27" fmla="*/ 494752 w 1114176"/>
              <a:gd name="connsiteY27" fmla="*/ 2315238 h 3364433"/>
              <a:gd name="connsiteX28" fmla="*/ 599527 w 1114176"/>
              <a:gd name="connsiteY28" fmla="*/ 2239038 h 3364433"/>
              <a:gd name="connsiteX29" fmla="*/ 799552 w 1114176"/>
              <a:gd name="connsiteY29" fmla="*/ 2039013 h 3364433"/>
              <a:gd name="connsiteX30" fmla="*/ 923377 w 1114176"/>
              <a:gd name="connsiteY30" fmla="*/ 1829463 h 3364433"/>
              <a:gd name="connsiteX31" fmla="*/ 928139 w 1114176"/>
              <a:gd name="connsiteY31" fmla="*/ 1715163 h 3364433"/>
              <a:gd name="connsiteX32" fmla="*/ 1090064 w 1114176"/>
              <a:gd name="connsiteY32" fmla="*/ 1467513 h 3364433"/>
              <a:gd name="connsiteX33" fmla="*/ 1090065 w 1114176"/>
              <a:gd name="connsiteY33" fmla="*/ 1381789 h 3364433"/>
              <a:gd name="connsiteX34" fmla="*/ 1113877 w 1114176"/>
              <a:gd name="connsiteY34" fmla="*/ 1238913 h 3364433"/>
              <a:gd name="connsiteX35" fmla="*/ 1071015 w 1114176"/>
              <a:gd name="connsiteY35" fmla="*/ 1067463 h 3364433"/>
              <a:gd name="connsiteX36" fmla="*/ 1056727 w 1114176"/>
              <a:gd name="connsiteY36" fmla="*/ 962688 h 3364433"/>
              <a:gd name="connsiteX37" fmla="*/ 894802 w 1114176"/>
              <a:gd name="connsiteY37" fmla="*/ 1019838 h 3364433"/>
              <a:gd name="connsiteX38" fmla="*/ 890039 w 1114176"/>
              <a:gd name="connsiteY38" fmla="*/ 848388 h 3364433"/>
              <a:gd name="connsiteX39" fmla="*/ 799552 w 1114176"/>
              <a:gd name="connsiteY39" fmla="*/ 667413 h 3364433"/>
              <a:gd name="connsiteX40" fmla="*/ 642390 w 1114176"/>
              <a:gd name="connsiteY40" fmla="*/ 648364 h 3364433"/>
              <a:gd name="connsiteX41" fmla="*/ 609052 w 1114176"/>
              <a:gd name="connsiteY41" fmla="*/ 581688 h 3364433"/>
              <a:gd name="connsiteX42" fmla="*/ 442365 w 1114176"/>
              <a:gd name="connsiteY42" fmla="*/ 543589 h 3364433"/>
              <a:gd name="connsiteX43" fmla="*/ 323302 w 1114176"/>
              <a:gd name="connsiteY43" fmla="*/ 448338 h 3364433"/>
              <a:gd name="connsiteX44" fmla="*/ 161377 w 1114176"/>
              <a:gd name="connsiteY44" fmla="*/ 43526 h 3364433"/>
              <a:gd name="connsiteX45" fmla="*/ 166139 w 1114176"/>
              <a:gd name="connsiteY45" fmla="*/ 10188 h 3364433"/>
              <a:gd name="connsiteX46" fmla="*/ 4215 w 1114176"/>
              <a:gd name="connsiteY46" fmla="*/ 10188 h 3364433"/>
              <a:gd name="connsiteX0" fmla="*/ 4215 w 1114176"/>
              <a:gd name="connsiteY0" fmla="*/ 10188 h 3364433"/>
              <a:gd name="connsiteX1" fmla="*/ 51840 w 1114176"/>
              <a:gd name="connsiteY1" fmla="*/ 129251 h 3364433"/>
              <a:gd name="connsiteX2" fmla="*/ 56603 w 1114176"/>
              <a:gd name="connsiteY2" fmla="*/ 214976 h 3364433"/>
              <a:gd name="connsiteX3" fmla="*/ 113752 w 1114176"/>
              <a:gd name="connsiteY3" fmla="*/ 381663 h 3364433"/>
              <a:gd name="connsiteX4" fmla="*/ 108989 w 1114176"/>
              <a:gd name="connsiteY4" fmla="*/ 476913 h 3364433"/>
              <a:gd name="connsiteX5" fmla="*/ 151852 w 1114176"/>
              <a:gd name="connsiteY5" fmla="*/ 629313 h 3364433"/>
              <a:gd name="connsiteX6" fmla="*/ 156615 w 1114176"/>
              <a:gd name="connsiteY6" fmla="*/ 824575 h 3364433"/>
              <a:gd name="connsiteX7" fmla="*/ 170902 w 1114176"/>
              <a:gd name="connsiteY7" fmla="*/ 957927 h 3364433"/>
              <a:gd name="connsiteX8" fmla="*/ 199477 w 1114176"/>
              <a:gd name="connsiteY8" fmla="*/ 1019838 h 3364433"/>
              <a:gd name="connsiteX9" fmla="*/ 175665 w 1114176"/>
              <a:gd name="connsiteY9" fmla="*/ 1129377 h 3364433"/>
              <a:gd name="connsiteX10" fmla="*/ 32789 w 1114176"/>
              <a:gd name="connsiteY10" fmla="*/ 1524663 h 3364433"/>
              <a:gd name="connsiteX11" fmla="*/ 75652 w 1114176"/>
              <a:gd name="connsiteY11" fmla="*/ 1705638 h 3364433"/>
              <a:gd name="connsiteX12" fmla="*/ 94702 w 1114176"/>
              <a:gd name="connsiteY12" fmla="*/ 1967577 h 3364433"/>
              <a:gd name="connsiteX13" fmla="*/ 85177 w 1114176"/>
              <a:gd name="connsiteY13" fmla="*/ 2219988 h 3364433"/>
              <a:gd name="connsiteX14" fmla="*/ 137564 w 1114176"/>
              <a:gd name="connsiteY14" fmla="*/ 2486688 h 3364433"/>
              <a:gd name="connsiteX15" fmla="*/ 56602 w 1114176"/>
              <a:gd name="connsiteY15" fmla="*/ 2820063 h 3364433"/>
              <a:gd name="connsiteX16" fmla="*/ 89940 w 1114176"/>
              <a:gd name="connsiteY16" fmla="*/ 3167726 h 3364433"/>
              <a:gd name="connsiteX17" fmla="*/ 142327 w 1114176"/>
              <a:gd name="connsiteY17" fmla="*/ 3353463 h 3364433"/>
              <a:gd name="connsiteX18" fmla="*/ 137564 w 1114176"/>
              <a:gd name="connsiteY18" fmla="*/ 3343938 h 3364433"/>
              <a:gd name="connsiteX19" fmla="*/ 675727 w 1114176"/>
              <a:gd name="connsiteY19" fmla="*/ 3353463 h 3364433"/>
              <a:gd name="connsiteX20" fmla="*/ 637627 w 1114176"/>
              <a:gd name="connsiteY20" fmla="*/ 3343938 h 3364433"/>
              <a:gd name="connsiteX21" fmla="*/ 675727 w 1114176"/>
              <a:gd name="connsiteY21" fmla="*/ 3334413 h 3364433"/>
              <a:gd name="connsiteX22" fmla="*/ 675727 w 1114176"/>
              <a:gd name="connsiteY22" fmla="*/ 3248688 h 3364433"/>
              <a:gd name="connsiteX23" fmla="*/ 628102 w 1114176"/>
              <a:gd name="connsiteY23" fmla="*/ 3182013 h 3364433"/>
              <a:gd name="connsiteX24" fmla="*/ 590002 w 1114176"/>
              <a:gd name="connsiteY24" fmla="*/ 2986751 h 3364433"/>
              <a:gd name="connsiteX25" fmla="*/ 523327 w 1114176"/>
              <a:gd name="connsiteY25" fmla="*/ 2610513 h 3364433"/>
              <a:gd name="connsiteX26" fmla="*/ 447127 w 1114176"/>
              <a:gd name="connsiteY26" fmla="*/ 2534313 h 3364433"/>
              <a:gd name="connsiteX27" fmla="*/ 437602 w 1114176"/>
              <a:gd name="connsiteY27" fmla="*/ 2429538 h 3364433"/>
              <a:gd name="connsiteX28" fmla="*/ 494752 w 1114176"/>
              <a:gd name="connsiteY28" fmla="*/ 2315238 h 3364433"/>
              <a:gd name="connsiteX29" fmla="*/ 599527 w 1114176"/>
              <a:gd name="connsiteY29" fmla="*/ 2239038 h 3364433"/>
              <a:gd name="connsiteX30" fmla="*/ 799552 w 1114176"/>
              <a:gd name="connsiteY30" fmla="*/ 2039013 h 3364433"/>
              <a:gd name="connsiteX31" fmla="*/ 923377 w 1114176"/>
              <a:gd name="connsiteY31" fmla="*/ 1829463 h 3364433"/>
              <a:gd name="connsiteX32" fmla="*/ 928139 w 1114176"/>
              <a:gd name="connsiteY32" fmla="*/ 1715163 h 3364433"/>
              <a:gd name="connsiteX33" fmla="*/ 1090064 w 1114176"/>
              <a:gd name="connsiteY33" fmla="*/ 1467513 h 3364433"/>
              <a:gd name="connsiteX34" fmla="*/ 1090065 w 1114176"/>
              <a:gd name="connsiteY34" fmla="*/ 1381789 h 3364433"/>
              <a:gd name="connsiteX35" fmla="*/ 1113877 w 1114176"/>
              <a:gd name="connsiteY35" fmla="*/ 1238913 h 3364433"/>
              <a:gd name="connsiteX36" fmla="*/ 1071015 w 1114176"/>
              <a:gd name="connsiteY36" fmla="*/ 1067463 h 3364433"/>
              <a:gd name="connsiteX37" fmla="*/ 1056727 w 1114176"/>
              <a:gd name="connsiteY37" fmla="*/ 962688 h 3364433"/>
              <a:gd name="connsiteX38" fmla="*/ 894802 w 1114176"/>
              <a:gd name="connsiteY38" fmla="*/ 1019838 h 3364433"/>
              <a:gd name="connsiteX39" fmla="*/ 890039 w 1114176"/>
              <a:gd name="connsiteY39" fmla="*/ 848388 h 3364433"/>
              <a:gd name="connsiteX40" fmla="*/ 799552 w 1114176"/>
              <a:gd name="connsiteY40" fmla="*/ 667413 h 3364433"/>
              <a:gd name="connsiteX41" fmla="*/ 642390 w 1114176"/>
              <a:gd name="connsiteY41" fmla="*/ 648364 h 3364433"/>
              <a:gd name="connsiteX42" fmla="*/ 609052 w 1114176"/>
              <a:gd name="connsiteY42" fmla="*/ 581688 h 3364433"/>
              <a:gd name="connsiteX43" fmla="*/ 442365 w 1114176"/>
              <a:gd name="connsiteY43" fmla="*/ 543589 h 3364433"/>
              <a:gd name="connsiteX44" fmla="*/ 323302 w 1114176"/>
              <a:gd name="connsiteY44" fmla="*/ 448338 h 3364433"/>
              <a:gd name="connsiteX45" fmla="*/ 161377 w 1114176"/>
              <a:gd name="connsiteY45" fmla="*/ 43526 h 3364433"/>
              <a:gd name="connsiteX46" fmla="*/ 166139 w 1114176"/>
              <a:gd name="connsiteY46" fmla="*/ 10188 h 3364433"/>
              <a:gd name="connsiteX47" fmla="*/ 4215 w 1114176"/>
              <a:gd name="connsiteY47" fmla="*/ 10188 h 3364433"/>
              <a:gd name="connsiteX0" fmla="*/ 4215 w 1114176"/>
              <a:gd name="connsiteY0" fmla="*/ 10188 h 3364433"/>
              <a:gd name="connsiteX1" fmla="*/ 51840 w 1114176"/>
              <a:gd name="connsiteY1" fmla="*/ 129251 h 3364433"/>
              <a:gd name="connsiteX2" fmla="*/ 56603 w 1114176"/>
              <a:gd name="connsiteY2" fmla="*/ 214976 h 3364433"/>
              <a:gd name="connsiteX3" fmla="*/ 113752 w 1114176"/>
              <a:gd name="connsiteY3" fmla="*/ 381663 h 3364433"/>
              <a:gd name="connsiteX4" fmla="*/ 108989 w 1114176"/>
              <a:gd name="connsiteY4" fmla="*/ 476913 h 3364433"/>
              <a:gd name="connsiteX5" fmla="*/ 151852 w 1114176"/>
              <a:gd name="connsiteY5" fmla="*/ 629313 h 3364433"/>
              <a:gd name="connsiteX6" fmla="*/ 156615 w 1114176"/>
              <a:gd name="connsiteY6" fmla="*/ 824575 h 3364433"/>
              <a:gd name="connsiteX7" fmla="*/ 170902 w 1114176"/>
              <a:gd name="connsiteY7" fmla="*/ 957927 h 3364433"/>
              <a:gd name="connsiteX8" fmla="*/ 199477 w 1114176"/>
              <a:gd name="connsiteY8" fmla="*/ 1019838 h 3364433"/>
              <a:gd name="connsiteX9" fmla="*/ 175665 w 1114176"/>
              <a:gd name="connsiteY9" fmla="*/ 1129377 h 3364433"/>
              <a:gd name="connsiteX10" fmla="*/ 32789 w 1114176"/>
              <a:gd name="connsiteY10" fmla="*/ 1524663 h 3364433"/>
              <a:gd name="connsiteX11" fmla="*/ 47077 w 1114176"/>
              <a:gd name="connsiteY11" fmla="*/ 1581814 h 3364433"/>
              <a:gd name="connsiteX12" fmla="*/ 75652 w 1114176"/>
              <a:gd name="connsiteY12" fmla="*/ 1705638 h 3364433"/>
              <a:gd name="connsiteX13" fmla="*/ 94702 w 1114176"/>
              <a:gd name="connsiteY13" fmla="*/ 1967577 h 3364433"/>
              <a:gd name="connsiteX14" fmla="*/ 85177 w 1114176"/>
              <a:gd name="connsiteY14" fmla="*/ 2219988 h 3364433"/>
              <a:gd name="connsiteX15" fmla="*/ 137564 w 1114176"/>
              <a:gd name="connsiteY15" fmla="*/ 2486688 h 3364433"/>
              <a:gd name="connsiteX16" fmla="*/ 56602 w 1114176"/>
              <a:gd name="connsiteY16" fmla="*/ 2820063 h 3364433"/>
              <a:gd name="connsiteX17" fmla="*/ 89940 w 1114176"/>
              <a:gd name="connsiteY17" fmla="*/ 3167726 h 3364433"/>
              <a:gd name="connsiteX18" fmla="*/ 142327 w 1114176"/>
              <a:gd name="connsiteY18" fmla="*/ 3353463 h 3364433"/>
              <a:gd name="connsiteX19" fmla="*/ 137564 w 1114176"/>
              <a:gd name="connsiteY19" fmla="*/ 3343938 h 3364433"/>
              <a:gd name="connsiteX20" fmla="*/ 675727 w 1114176"/>
              <a:gd name="connsiteY20" fmla="*/ 3353463 h 3364433"/>
              <a:gd name="connsiteX21" fmla="*/ 637627 w 1114176"/>
              <a:gd name="connsiteY21" fmla="*/ 3343938 h 3364433"/>
              <a:gd name="connsiteX22" fmla="*/ 675727 w 1114176"/>
              <a:gd name="connsiteY22" fmla="*/ 3334413 h 3364433"/>
              <a:gd name="connsiteX23" fmla="*/ 675727 w 1114176"/>
              <a:gd name="connsiteY23" fmla="*/ 3248688 h 3364433"/>
              <a:gd name="connsiteX24" fmla="*/ 628102 w 1114176"/>
              <a:gd name="connsiteY24" fmla="*/ 3182013 h 3364433"/>
              <a:gd name="connsiteX25" fmla="*/ 590002 w 1114176"/>
              <a:gd name="connsiteY25" fmla="*/ 2986751 h 3364433"/>
              <a:gd name="connsiteX26" fmla="*/ 523327 w 1114176"/>
              <a:gd name="connsiteY26" fmla="*/ 2610513 h 3364433"/>
              <a:gd name="connsiteX27" fmla="*/ 447127 w 1114176"/>
              <a:gd name="connsiteY27" fmla="*/ 2534313 h 3364433"/>
              <a:gd name="connsiteX28" fmla="*/ 437602 w 1114176"/>
              <a:gd name="connsiteY28" fmla="*/ 2429538 h 3364433"/>
              <a:gd name="connsiteX29" fmla="*/ 494752 w 1114176"/>
              <a:gd name="connsiteY29" fmla="*/ 2315238 h 3364433"/>
              <a:gd name="connsiteX30" fmla="*/ 599527 w 1114176"/>
              <a:gd name="connsiteY30" fmla="*/ 2239038 h 3364433"/>
              <a:gd name="connsiteX31" fmla="*/ 799552 w 1114176"/>
              <a:gd name="connsiteY31" fmla="*/ 2039013 h 3364433"/>
              <a:gd name="connsiteX32" fmla="*/ 923377 w 1114176"/>
              <a:gd name="connsiteY32" fmla="*/ 1829463 h 3364433"/>
              <a:gd name="connsiteX33" fmla="*/ 928139 w 1114176"/>
              <a:gd name="connsiteY33" fmla="*/ 1715163 h 3364433"/>
              <a:gd name="connsiteX34" fmla="*/ 1090064 w 1114176"/>
              <a:gd name="connsiteY34" fmla="*/ 1467513 h 3364433"/>
              <a:gd name="connsiteX35" fmla="*/ 1090065 w 1114176"/>
              <a:gd name="connsiteY35" fmla="*/ 1381789 h 3364433"/>
              <a:gd name="connsiteX36" fmla="*/ 1113877 w 1114176"/>
              <a:gd name="connsiteY36" fmla="*/ 1238913 h 3364433"/>
              <a:gd name="connsiteX37" fmla="*/ 1071015 w 1114176"/>
              <a:gd name="connsiteY37" fmla="*/ 1067463 h 3364433"/>
              <a:gd name="connsiteX38" fmla="*/ 1056727 w 1114176"/>
              <a:gd name="connsiteY38" fmla="*/ 962688 h 3364433"/>
              <a:gd name="connsiteX39" fmla="*/ 894802 w 1114176"/>
              <a:gd name="connsiteY39" fmla="*/ 1019838 h 3364433"/>
              <a:gd name="connsiteX40" fmla="*/ 890039 w 1114176"/>
              <a:gd name="connsiteY40" fmla="*/ 848388 h 3364433"/>
              <a:gd name="connsiteX41" fmla="*/ 799552 w 1114176"/>
              <a:gd name="connsiteY41" fmla="*/ 667413 h 3364433"/>
              <a:gd name="connsiteX42" fmla="*/ 642390 w 1114176"/>
              <a:gd name="connsiteY42" fmla="*/ 648364 h 3364433"/>
              <a:gd name="connsiteX43" fmla="*/ 609052 w 1114176"/>
              <a:gd name="connsiteY43" fmla="*/ 581688 h 3364433"/>
              <a:gd name="connsiteX44" fmla="*/ 442365 w 1114176"/>
              <a:gd name="connsiteY44" fmla="*/ 543589 h 3364433"/>
              <a:gd name="connsiteX45" fmla="*/ 323302 w 1114176"/>
              <a:gd name="connsiteY45" fmla="*/ 448338 h 3364433"/>
              <a:gd name="connsiteX46" fmla="*/ 161377 w 1114176"/>
              <a:gd name="connsiteY46" fmla="*/ 43526 h 3364433"/>
              <a:gd name="connsiteX47" fmla="*/ 166139 w 1114176"/>
              <a:gd name="connsiteY47" fmla="*/ 10188 h 3364433"/>
              <a:gd name="connsiteX48" fmla="*/ 4215 w 1114176"/>
              <a:gd name="connsiteY48" fmla="*/ 10188 h 3364433"/>
              <a:gd name="connsiteX0" fmla="*/ 4215 w 1114176"/>
              <a:gd name="connsiteY0" fmla="*/ 10188 h 3364433"/>
              <a:gd name="connsiteX1" fmla="*/ 51840 w 1114176"/>
              <a:gd name="connsiteY1" fmla="*/ 129251 h 3364433"/>
              <a:gd name="connsiteX2" fmla="*/ 56603 w 1114176"/>
              <a:gd name="connsiteY2" fmla="*/ 214976 h 3364433"/>
              <a:gd name="connsiteX3" fmla="*/ 113752 w 1114176"/>
              <a:gd name="connsiteY3" fmla="*/ 381663 h 3364433"/>
              <a:gd name="connsiteX4" fmla="*/ 108989 w 1114176"/>
              <a:gd name="connsiteY4" fmla="*/ 476913 h 3364433"/>
              <a:gd name="connsiteX5" fmla="*/ 151852 w 1114176"/>
              <a:gd name="connsiteY5" fmla="*/ 629313 h 3364433"/>
              <a:gd name="connsiteX6" fmla="*/ 156615 w 1114176"/>
              <a:gd name="connsiteY6" fmla="*/ 824575 h 3364433"/>
              <a:gd name="connsiteX7" fmla="*/ 170902 w 1114176"/>
              <a:gd name="connsiteY7" fmla="*/ 957927 h 3364433"/>
              <a:gd name="connsiteX8" fmla="*/ 199477 w 1114176"/>
              <a:gd name="connsiteY8" fmla="*/ 1019838 h 3364433"/>
              <a:gd name="connsiteX9" fmla="*/ 175665 w 1114176"/>
              <a:gd name="connsiteY9" fmla="*/ 1129377 h 3364433"/>
              <a:gd name="connsiteX10" fmla="*/ 32789 w 1114176"/>
              <a:gd name="connsiteY10" fmla="*/ 1524663 h 3364433"/>
              <a:gd name="connsiteX11" fmla="*/ 47077 w 1114176"/>
              <a:gd name="connsiteY11" fmla="*/ 1581814 h 3364433"/>
              <a:gd name="connsiteX12" fmla="*/ 75652 w 1114176"/>
              <a:gd name="connsiteY12" fmla="*/ 1705638 h 3364433"/>
              <a:gd name="connsiteX13" fmla="*/ 94702 w 1114176"/>
              <a:gd name="connsiteY13" fmla="*/ 1967577 h 3364433"/>
              <a:gd name="connsiteX14" fmla="*/ 85177 w 1114176"/>
              <a:gd name="connsiteY14" fmla="*/ 2219988 h 3364433"/>
              <a:gd name="connsiteX15" fmla="*/ 137564 w 1114176"/>
              <a:gd name="connsiteY15" fmla="*/ 2486688 h 3364433"/>
              <a:gd name="connsiteX16" fmla="*/ 56602 w 1114176"/>
              <a:gd name="connsiteY16" fmla="*/ 2820063 h 3364433"/>
              <a:gd name="connsiteX17" fmla="*/ 89940 w 1114176"/>
              <a:gd name="connsiteY17" fmla="*/ 3167726 h 3364433"/>
              <a:gd name="connsiteX18" fmla="*/ 142327 w 1114176"/>
              <a:gd name="connsiteY18" fmla="*/ 3353463 h 3364433"/>
              <a:gd name="connsiteX19" fmla="*/ 137564 w 1114176"/>
              <a:gd name="connsiteY19" fmla="*/ 3343938 h 3364433"/>
              <a:gd name="connsiteX20" fmla="*/ 675727 w 1114176"/>
              <a:gd name="connsiteY20" fmla="*/ 3353463 h 3364433"/>
              <a:gd name="connsiteX21" fmla="*/ 637627 w 1114176"/>
              <a:gd name="connsiteY21" fmla="*/ 3343938 h 3364433"/>
              <a:gd name="connsiteX22" fmla="*/ 675727 w 1114176"/>
              <a:gd name="connsiteY22" fmla="*/ 3334413 h 3364433"/>
              <a:gd name="connsiteX23" fmla="*/ 675727 w 1114176"/>
              <a:gd name="connsiteY23" fmla="*/ 3248688 h 3364433"/>
              <a:gd name="connsiteX24" fmla="*/ 628102 w 1114176"/>
              <a:gd name="connsiteY24" fmla="*/ 3182013 h 3364433"/>
              <a:gd name="connsiteX25" fmla="*/ 590002 w 1114176"/>
              <a:gd name="connsiteY25" fmla="*/ 2986751 h 3364433"/>
              <a:gd name="connsiteX26" fmla="*/ 523327 w 1114176"/>
              <a:gd name="connsiteY26" fmla="*/ 2610513 h 3364433"/>
              <a:gd name="connsiteX27" fmla="*/ 447127 w 1114176"/>
              <a:gd name="connsiteY27" fmla="*/ 2534313 h 3364433"/>
              <a:gd name="connsiteX28" fmla="*/ 437602 w 1114176"/>
              <a:gd name="connsiteY28" fmla="*/ 2429538 h 3364433"/>
              <a:gd name="connsiteX29" fmla="*/ 494752 w 1114176"/>
              <a:gd name="connsiteY29" fmla="*/ 2315238 h 3364433"/>
              <a:gd name="connsiteX30" fmla="*/ 599527 w 1114176"/>
              <a:gd name="connsiteY30" fmla="*/ 2239038 h 3364433"/>
              <a:gd name="connsiteX31" fmla="*/ 799552 w 1114176"/>
              <a:gd name="connsiteY31" fmla="*/ 2039013 h 3364433"/>
              <a:gd name="connsiteX32" fmla="*/ 885277 w 1114176"/>
              <a:gd name="connsiteY32" fmla="*/ 1829463 h 3364433"/>
              <a:gd name="connsiteX33" fmla="*/ 928139 w 1114176"/>
              <a:gd name="connsiteY33" fmla="*/ 1715163 h 3364433"/>
              <a:gd name="connsiteX34" fmla="*/ 1090064 w 1114176"/>
              <a:gd name="connsiteY34" fmla="*/ 1467513 h 3364433"/>
              <a:gd name="connsiteX35" fmla="*/ 1090065 w 1114176"/>
              <a:gd name="connsiteY35" fmla="*/ 1381789 h 3364433"/>
              <a:gd name="connsiteX36" fmla="*/ 1113877 w 1114176"/>
              <a:gd name="connsiteY36" fmla="*/ 1238913 h 3364433"/>
              <a:gd name="connsiteX37" fmla="*/ 1071015 w 1114176"/>
              <a:gd name="connsiteY37" fmla="*/ 1067463 h 3364433"/>
              <a:gd name="connsiteX38" fmla="*/ 1056727 w 1114176"/>
              <a:gd name="connsiteY38" fmla="*/ 962688 h 3364433"/>
              <a:gd name="connsiteX39" fmla="*/ 894802 w 1114176"/>
              <a:gd name="connsiteY39" fmla="*/ 1019838 h 3364433"/>
              <a:gd name="connsiteX40" fmla="*/ 890039 w 1114176"/>
              <a:gd name="connsiteY40" fmla="*/ 848388 h 3364433"/>
              <a:gd name="connsiteX41" fmla="*/ 799552 w 1114176"/>
              <a:gd name="connsiteY41" fmla="*/ 667413 h 3364433"/>
              <a:gd name="connsiteX42" fmla="*/ 642390 w 1114176"/>
              <a:gd name="connsiteY42" fmla="*/ 648364 h 3364433"/>
              <a:gd name="connsiteX43" fmla="*/ 609052 w 1114176"/>
              <a:gd name="connsiteY43" fmla="*/ 581688 h 3364433"/>
              <a:gd name="connsiteX44" fmla="*/ 442365 w 1114176"/>
              <a:gd name="connsiteY44" fmla="*/ 543589 h 3364433"/>
              <a:gd name="connsiteX45" fmla="*/ 323302 w 1114176"/>
              <a:gd name="connsiteY45" fmla="*/ 448338 h 3364433"/>
              <a:gd name="connsiteX46" fmla="*/ 161377 w 1114176"/>
              <a:gd name="connsiteY46" fmla="*/ 43526 h 3364433"/>
              <a:gd name="connsiteX47" fmla="*/ 166139 w 1114176"/>
              <a:gd name="connsiteY47" fmla="*/ 10188 h 3364433"/>
              <a:gd name="connsiteX48" fmla="*/ 4215 w 1114176"/>
              <a:gd name="connsiteY48" fmla="*/ 10188 h 3364433"/>
              <a:gd name="connsiteX0" fmla="*/ 4215 w 1114176"/>
              <a:gd name="connsiteY0" fmla="*/ 10188 h 3364433"/>
              <a:gd name="connsiteX1" fmla="*/ 51840 w 1114176"/>
              <a:gd name="connsiteY1" fmla="*/ 129251 h 3364433"/>
              <a:gd name="connsiteX2" fmla="*/ 56603 w 1114176"/>
              <a:gd name="connsiteY2" fmla="*/ 214976 h 3364433"/>
              <a:gd name="connsiteX3" fmla="*/ 113752 w 1114176"/>
              <a:gd name="connsiteY3" fmla="*/ 381663 h 3364433"/>
              <a:gd name="connsiteX4" fmla="*/ 108989 w 1114176"/>
              <a:gd name="connsiteY4" fmla="*/ 476913 h 3364433"/>
              <a:gd name="connsiteX5" fmla="*/ 151852 w 1114176"/>
              <a:gd name="connsiteY5" fmla="*/ 629313 h 3364433"/>
              <a:gd name="connsiteX6" fmla="*/ 156615 w 1114176"/>
              <a:gd name="connsiteY6" fmla="*/ 824575 h 3364433"/>
              <a:gd name="connsiteX7" fmla="*/ 170902 w 1114176"/>
              <a:gd name="connsiteY7" fmla="*/ 957927 h 3364433"/>
              <a:gd name="connsiteX8" fmla="*/ 199477 w 1114176"/>
              <a:gd name="connsiteY8" fmla="*/ 1019838 h 3364433"/>
              <a:gd name="connsiteX9" fmla="*/ 175665 w 1114176"/>
              <a:gd name="connsiteY9" fmla="*/ 1129377 h 3364433"/>
              <a:gd name="connsiteX10" fmla="*/ 32789 w 1114176"/>
              <a:gd name="connsiteY10" fmla="*/ 1524663 h 3364433"/>
              <a:gd name="connsiteX11" fmla="*/ 47077 w 1114176"/>
              <a:gd name="connsiteY11" fmla="*/ 1581814 h 3364433"/>
              <a:gd name="connsiteX12" fmla="*/ 75652 w 1114176"/>
              <a:gd name="connsiteY12" fmla="*/ 1705638 h 3364433"/>
              <a:gd name="connsiteX13" fmla="*/ 94702 w 1114176"/>
              <a:gd name="connsiteY13" fmla="*/ 1967577 h 3364433"/>
              <a:gd name="connsiteX14" fmla="*/ 85177 w 1114176"/>
              <a:gd name="connsiteY14" fmla="*/ 2219988 h 3364433"/>
              <a:gd name="connsiteX15" fmla="*/ 137564 w 1114176"/>
              <a:gd name="connsiteY15" fmla="*/ 2486688 h 3364433"/>
              <a:gd name="connsiteX16" fmla="*/ 56602 w 1114176"/>
              <a:gd name="connsiteY16" fmla="*/ 2820063 h 3364433"/>
              <a:gd name="connsiteX17" fmla="*/ 89940 w 1114176"/>
              <a:gd name="connsiteY17" fmla="*/ 3167726 h 3364433"/>
              <a:gd name="connsiteX18" fmla="*/ 142327 w 1114176"/>
              <a:gd name="connsiteY18" fmla="*/ 3353463 h 3364433"/>
              <a:gd name="connsiteX19" fmla="*/ 137564 w 1114176"/>
              <a:gd name="connsiteY19" fmla="*/ 3343938 h 3364433"/>
              <a:gd name="connsiteX20" fmla="*/ 675727 w 1114176"/>
              <a:gd name="connsiteY20" fmla="*/ 3353463 h 3364433"/>
              <a:gd name="connsiteX21" fmla="*/ 637627 w 1114176"/>
              <a:gd name="connsiteY21" fmla="*/ 3343938 h 3364433"/>
              <a:gd name="connsiteX22" fmla="*/ 675727 w 1114176"/>
              <a:gd name="connsiteY22" fmla="*/ 3334413 h 3364433"/>
              <a:gd name="connsiteX23" fmla="*/ 675727 w 1114176"/>
              <a:gd name="connsiteY23" fmla="*/ 3248688 h 3364433"/>
              <a:gd name="connsiteX24" fmla="*/ 628102 w 1114176"/>
              <a:gd name="connsiteY24" fmla="*/ 3182013 h 3364433"/>
              <a:gd name="connsiteX25" fmla="*/ 590002 w 1114176"/>
              <a:gd name="connsiteY25" fmla="*/ 2986751 h 3364433"/>
              <a:gd name="connsiteX26" fmla="*/ 523327 w 1114176"/>
              <a:gd name="connsiteY26" fmla="*/ 2610513 h 3364433"/>
              <a:gd name="connsiteX27" fmla="*/ 447127 w 1114176"/>
              <a:gd name="connsiteY27" fmla="*/ 2534313 h 3364433"/>
              <a:gd name="connsiteX28" fmla="*/ 437602 w 1114176"/>
              <a:gd name="connsiteY28" fmla="*/ 2429538 h 3364433"/>
              <a:gd name="connsiteX29" fmla="*/ 494752 w 1114176"/>
              <a:gd name="connsiteY29" fmla="*/ 2315238 h 3364433"/>
              <a:gd name="connsiteX30" fmla="*/ 599527 w 1114176"/>
              <a:gd name="connsiteY30" fmla="*/ 2239038 h 3364433"/>
              <a:gd name="connsiteX31" fmla="*/ 799552 w 1114176"/>
              <a:gd name="connsiteY31" fmla="*/ 2039013 h 3364433"/>
              <a:gd name="connsiteX32" fmla="*/ 909090 w 1114176"/>
              <a:gd name="connsiteY32" fmla="*/ 1824701 h 3364433"/>
              <a:gd name="connsiteX33" fmla="*/ 928139 w 1114176"/>
              <a:gd name="connsiteY33" fmla="*/ 1715163 h 3364433"/>
              <a:gd name="connsiteX34" fmla="*/ 1090064 w 1114176"/>
              <a:gd name="connsiteY34" fmla="*/ 1467513 h 3364433"/>
              <a:gd name="connsiteX35" fmla="*/ 1090065 w 1114176"/>
              <a:gd name="connsiteY35" fmla="*/ 1381789 h 3364433"/>
              <a:gd name="connsiteX36" fmla="*/ 1113877 w 1114176"/>
              <a:gd name="connsiteY36" fmla="*/ 1238913 h 3364433"/>
              <a:gd name="connsiteX37" fmla="*/ 1071015 w 1114176"/>
              <a:gd name="connsiteY37" fmla="*/ 1067463 h 3364433"/>
              <a:gd name="connsiteX38" fmla="*/ 1056727 w 1114176"/>
              <a:gd name="connsiteY38" fmla="*/ 962688 h 3364433"/>
              <a:gd name="connsiteX39" fmla="*/ 894802 w 1114176"/>
              <a:gd name="connsiteY39" fmla="*/ 1019838 h 3364433"/>
              <a:gd name="connsiteX40" fmla="*/ 890039 w 1114176"/>
              <a:gd name="connsiteY40" fmla="*/ 848388 h 3364433"/>
              <a:gd name="connsiteX41" fmla="*/ 799552 w 1114176"/>
              <a:gd name="connsiteY41" fmla="*/ 667413 h 3364433"/>
              <a:gd name="connsiteX42" fmla="*/ 642390 w 1114176"/>
              <a:gd name="connsiteY42" fmla="*/ 648364 h 3364433"/>
              <a:gd name="connsiteX43" fmla="*/ 609052 w 1114176"/>
              <a:gd name="connsiteY43" fmla="*/ 581688 h 3364433"/>
              <a:gd name="connsiteX44" fmla="*/ 442365 w 1114176"/>
              <a:gd name="connsiteY44" fmla="*/ 543589 h 3364433"/>
              <a:gd name="connsiteX45" fmla="*/ 323302 w 1114176"/>
              <a:gd name="connsiteY45" fmla="*/ 448338 h 3364433"/>
              <a:gd name="connsiteX46" fmla="*/ 161377 w 1114176"/>
              <a:gd name="connsiteY46" fmla="*/ 43526 h 3364433"/>
              <a:gd name="connsiteX47" fmla="*/ 166139 w 1114176"/>
              <a:gd name="connsiteY47" fmla="*/ 10188 h 3364433"/>
              <a:gd name="connsiteX48" fmla="*/ 4215 w 1114176"/>
              <a:gd name="connsiteY48" fmla="*/ 10188 h 3364433"/>
              <a:gd name="connsiteX0" fmla="*/ 4215 w 1114176"/>
              <a:gd name="connsiteY0" fmla="*/ 10188 h 3364433"/>
              <a:gd name="connsiteX1" fmla="*/ 51840 w 1114176"/>
              <a:gd name="connsiteY1" fmla="*/ 129251 h 3364433"/>
              <a:gd name="connsiteX2" fmla="*/ 56603 w 1114176"/>
              <a:gd name="connsiteY2" fmla="*/ 214976 h 3364433"/>
              <a:gd name="connsiteX3" fmla="*/ 113752 w 1114176"/>
              <a:gd name="connsiteY3" fmla="*/ 381663 h 3364433"/>
              <a:gd name="connsiteX4" fmla="*/ 108989 w 1114176"/>
              <a:gd name="connsiteY4" fmla="*/ 476913 h 3364433"/>
              <a:gd name="connsiteX5" fmla="*/ 151852 w 1114176"/>
              <a:gd name="connsiteY5" fmla="*/ 629313 h 3364433"/>
              <a:gd name="connsiteX6" fmla="*/ 156615 w 1114176"/>
              <a:gd name="connsiteY6" fmla="*/ 824575 h 3364433"/>
              <a:gd name="connsiteX7" fmla="*/ 170902 w 1114176"/>
              <a:gd name="connsiteY7" fmla="*/ 957927 h 3364433"/>
              <a:gd name="connsiteX8" fmla="*/ 199477 w 1114176"/>
              <a:gd name="connsiteY8" fmla="*/ 1019838 h 3364433"/>
              <a:gd name="connsiteX9" fmla="*/ 175665 w 1114176"/>
              <a:gd name="connsiteY9" fmla="*/ 1129377 h 3364433"/>
              <a:gd name="connsiteX10" fmla="*/ 32789 w 1114176"/>
              <a:gd name="connsiteY10" fmla="*/ 1524663 h 3364433"/>
              <a:gd name="connsiteX11" fmla="*/ 47077 w 1114176"/>
              <a:gd name="connsiteY11" fmla="*/ 1581814 h 3364433"/>
              <a:gd name="connsiteX12" fmla="*/ 75652 w 1114176"/>
              <a:gd name="connsiteY12" fmla="*/ 1705638 h 3364433"/>
              <a:gd name="connsiteX13" fmla="*/ 94702 w 1114176"/>
              <a:gd name="connsiteY13" fmla="*/ 1967577 h 3364433"/>
              <a:gd name="connsiteX14" fmla="*/ 85177 w 1114176"/>
              <a:gd name="connsiteY14" fmla="*/ 2219988 h 3364433"/>
              <a:gd name="connsiteX15" fmla="*/ 137564 w 1114176"/>
              <a:gd name="connsiteY15" fmla="*/ 2486688 h 3364433"/>
              <a:gd name="connsiteX16" fmla="*/ 56602 w 1114176"/>
              <a:gd name="connsiteY16" fmla="*/ 2820063 h 3364433"/>
              <a:gd name="connsiteX17" fmla="*/ 89940 w 1114176"/>
              <a:gd name="connsiteY17" fmla="*/ 3167726 h 3364433"/>
              <a:gd name="connsiteX18" fmla="*/ 142327 w 1114176"/>
              <a:gd name="connsiteY18" fmla="*/ 3353463 h 3364433"/>
              <a:gd name="connsiteX19" fmla="*/ 137564 w 1114176"/>
              <a:gd name="connsiteY19" fmla="*/ 3343938 h 3364433"/>
              <a:gd name="connsiteX20" fmla="*/ 675727 w 1114176"/>
              <a:gd name="connsiteY20" fmla="*/ 3353463 h 3364433"/>
              <a:gd name="connsiteX21" fmla="*/ 637627 w 1114176"/>
              <a:gd name="connsiteY21" fmla="*/ 3343938 h 3364433"/>
              <a:gd name="connsiteX22" fmla="*/ 675727 w 1114176"/>
              <a:gd name="connsiteY22" fmla="*/ 3334413 h 3364433"/>
              <a:gd name="connsiteX23" fmla="*/ 675727 w 1114176"/>
              <a:gd name="connsiteY23" fmla="*/ 3248688 h 3364433"/>
              <a:gd name="connsiteX24" fmla="*/ 628102 w 1114176"/>
              <a:gd name="connsiteY24" fmla="*/ 3182013 h 3364433"/>
              <a:gd name="connsiteX25" fmla="*/ 590002 w 1114176"/>
              <a:gd name="connsiteY25" fmla="*/ 2986751 h 3364433"/>
              <a:gd name="connsiteX26" fmla="*/ 523327 w 1114176"/>
              <a:gd name="connsiteY26" fmla="*/ 2610513 h 3364433"/>
              <a:gd name="connsiteX27" fmla="*/ 447127 w 1114176"/>
              <a:gd name="connsiteY27" fmla="*/ 2534313 h 3364433"/>
              <a:gd name="connsiteX28" fmla="*/ 437602 w 1114176"/>
              <a:gd name="connsiteY28" fmla="*/ 2429538 h 3364433"/>
              <a:gd name="connsiteX29" fmla="*/ 494752 w 1114176"/>
              <a:gd name="connsiteY29" fmla="*/ 2315238 h 3364433"/>
              <a:gd name="connsiteX30" fmla="*/ 599527 w 1114176"/>
              <a:gd name="connsiteY30" fmla="*/ 2239038 h 3364433"/>
              <a:gd name="connsiteX31" fmla="*/ 799552 w 1114176"/>
              <a:gd name="connsiteY31" fmla="*/ 2039013 h 3364433"/>
              <a:gd name="connsiteX32" fmla="*/ 861465 w 1114176"/>
              <a:gd name="connsiteY32" fmla="*/ 1981864 h 3364433"/>
              <a:gd name="connsiteX33" fmla="*/ 909090 w 1114176"/>
              <a:gd name="connsiteY33" fmla="*/ 1824701 h 3364433"/>
              <a:gd name="connsiteX34" fmla="*/ 928139 w 1114176"/>
              <a:gd name="connsiteY34" fmla="*/ 1715163 h 3364433"/>
              <a:gd name="connsiteX35" fmla="*/ 1090064 w 1114176"/>
              <a:gd name="connsiteY35" fmla="*/ 1467513 h 3364433"/>
              <a:gd name="connsiteX36" fmla="*/ 1090065 w 1114176"/>
              <a:gd name="connsiteY36" fmla="*/ 1381789 h 3364433"/>
              <a:gd name="connsiteX37" fmla="*/ 1113877 w 1114176"/>
              <a:gd name="connsiteY37" fmla="*/ 1238913 h 3364433"/>
              <a:gd name="connsiteX38" fmla="*/ 1071015 w 1114176"/>
              <a:gd name="connsiteY38" fmla="*/ 1067463 h 3364433"/>
              <a:gd name="connsiteX39" fmla="*/ 1056727 w 1114176"/>
              <a:gd name="connsiteY39" fmla="*/ 962688 h 3364433"/>
              <a:gd name="connsiteX40" fmla="*/ 894802 w 1114176"/>
              <a:gd name="connsiteY40" fmla="*/ 1019838 h 3364433"/>
              <a:gd name="connsiteX41" fmla="*/ 890039 w 1114176"/>
              <a:gd name="connsiteY41" fmla="*/ 848388 h 3364433"/>
              <a:gd name="connsiteX42" fmla="*/ 799552 w 1114176"/>
              <a:gd name="connsiteY42" fmla="*/ 667413 h 3364433"/>
              <a:gd name="connsiteX43" fmla="*/ 642390 w 1114176"/>
              <a:gd name="connsiteY43" fmla="*/ 648364 h 3364433"/>
              <a:gd name="connsiteX44" fmla="*/ 609052 w 1114176"/>
              <a:gd name="connsiteY44" fmla="*/ 581688 h 3364433"/>
              <a:gd name="connsiteX45" fmla="*/ 442365 w 1114176"/>
              <a:gd name="connsiteY45" fmla="*/ 543589 h 3364433"/>
              <a:gd name="connsiteX46" fmla="*/ 323302 w 1114176"/>
              <a:gd name="connsiteY46" fmla="*/ 448338 h 3364433"/>
              <a:gd name="connsiteX47" fmla="*/ 161377 w 1114176"/>
              <a:gd name="connsiteY47" fmla="*/ 43526 h 3364433"/>
              <a:gd name="connsiteX48" fmla="*/ 166139 w 1114176"/>
              <a:gd name="connsiteY48" fmla="*/ 10188 h 3364433"/>
              <a:gd name="connsiteX49" fmla="*/ 4215 w 1114176"/>
              <a:gd name="connsiteY49" fmla="*/ 10188 h 3364433"/>
              <a:gd name="connsiteX0" fmla="*/ 4215 w 1114176"/>
              <a:gd name="connsiteY0" fmla="*/ 10188 h 3364433"/>
              <a:gd name="connsiteX1" fmla="*/ 51840 w 1114176"/>
              <a:gd name="connsiteY1" fmla="*/ 129251 h 3364433"/>
              <a:gd name="connsiteX2" fmla="*/ 56603 w 1114176"/>
              <a:gd name="connsiteY2" fmla="*/ 214976 h 3364433"/>
              <a:gd name="connsiteX3" fmla="*/ 113752 w 1114176"/>
              <a:gd name="connsiteY3" fmla="*/ 381663 h 3364433"/>
              <a:gd name="connsiteX4" fmla="*/ 108989 w 1114176"/>
              <a:gd name="connsiteY4" fmla="*/ 476913 h 3364433"/>
              <a:gd name="connsiteX5" fmla="*/ 151852 w 1114176"/>
              <a:gd name="connsiteY5" fmla="*/ 629313 h 3364433"/>
              <a:gd name="connsiteX6" fmla="*/ 156615 w 1114176"/>
              <a:gd name="connsiteY6" fmla="*/ 824575 h 3364433"/>
              <a:gd name="connsiteX7" fmla="*/ 170902 w 1114176"/>
              <a:gd name="connsiteY7" fmla="*/ 957927 h 3364433"/>
              <a:gd name="connsiteX8" fmla="*/ 199477 w 1114176"/>
              <a:gd name="connsiteY8" fmla="*/ 1019838 h 3364433"/>
              <a:gd name="connsiteX9" fmla="*/ 175665 w 1114176"/>
              <a:gd name="connsiteY9" fmla="*/ 1129377 h 3364433"/>
              <a:gd name="connsiteX10" fmla="*/ 32789 w 1114176"/>
              <a:gd name="connsiteY10" fmla="*/ 1524663 h 3364433"/>
              <a:gd name="connsiteX11" fmla="*/ 47077 w 1114176"/>
              <a:gd name="connsiteY11" fmla="*/ 1581814 h 3364433"/>
              <a:gd name="connsiteX12" fmla="*/ 75652 w 1114176"/>
              <a:gd name="connsiteY12" fmla="*/ 1705638 h 3364433"/>
              <a:gd name="connsiteX13" fmla="*/ 94702 w 1114176"/>
              <a:gd name="connsiteY13" fmla="*/ 1967577 h 3364433"/>
              <a:gd name="connsiteX14" fmla="*/ 85177 w 1114176"/>
              <a:gd name="connsiteY14" fmla="*/ 2219988 h 3364433"/>
              <a:gd name="connsiteX15" fmla="*/ 137564 w 1114176"/>
              <a:gd name="connsiteY15" fmla="*/ 2486688 h 3364433"/>
              <a:gd name="connsiteX16" fmla="*/ 56602 w 1114176"/>
              <a:gd name="connsiteY16" fmla="*/ 2820063 h 3364433"/>
              <a:gd name="connsiteX17" fmla="*/ 89940 w 1114176"/>
              <a:gd name="connsiteY17" fmla="*/ 3167726 h 3364433"/>
              <a:gd name="connsiteX18" fmla="*/ 142327 w 1114176"/>
              <a:gd name="connsiteY18" fmla="*/ 3353463 h 3364433"/>
              <a:gd name="connsiteX19" fmla="*/ 137564 w 1114176"/>
              <a:gd name="connsiteY19" fmla="*/ 3343938 h 3364433"/>
              <a:gd name="connsiteX20" fmla="*/ 675727 w 1114176"/>
              <a:gd name="connsiteY20" fmla="*/ 3353463 h 3364433"/>
              <a:gd name="connsiteX21" fmla="*/ 637627 w 1114176"/>
              <a:gd name="connsiteY21" fmla="*/ 3343938 h 3364433"/>
              <a:gd name="connsiteX22" fmla="*/ 675727 w 1114176"/>
              <a:gd name="connsiteY22" fmla="*/ 3334413 h 3364433"/>
              <a:gd name="connsiteX23" fmla="*/ 675727 w 1114176"/>
              <a:gd name="connsiteY23" fmla="*/ 3248688 h 3364433"/>
              <a:gd name="connsiteX24" fmla="*/ 628102 w 1114176"/>
              <a:gd name="connsiteY24" fmla="*/ 3182013 h 3364433"/>
              <a:gd name="connsiteX25" fmla="*/ 590002 w 1114176"/>
              <a:gd name="connsiteY25" fmla="*/ 2986751 h 3364433"/>
              <a:gd name="connsiteX26" fmla="*/ 523327 w 1114176"/>
              <a:gd name="connsiteY26" fmla="*/ 2610513 h 3364433"/>
              <a:gd name="connsiteX27" fmla="*/ 447127 w 1114176"/>
              <a:gd name="connsiteY27" fmla="*/ 2534313 h 3364433"/>
              <a:gd name="connsiteX28" fmla="*/ 437602 w 1114176"/>
              <a:gd name="connsiteY28" fmla="*/ 2429538 h 3364433"/>
              <a:gd name="connsiteX29" fmla="*/ 494752 w 1114176"/>
              <a:gd name="connsiteY29" fmla="*/ 2315238 h 3364433"/>
              <a:gd name="connsiteX30" fmla="*/ 599527 w 1114176"/>
              <a:gd name="connsiteY30" fmla="*/ 2239038 h 3364433"/>
              <a:gd name="connsiteX31" fmla="*/ 780502 w 1114176"/>
              <a:gd name="connsiteY31" fmla="*/ 2043776 h 3364433"/>
              <a:gd name="connsiteX32" fmla="*/ 861465 w 1114176"/>
              <a:gd name="connsiteY32" fmla="*/ 1981864 h 3364433"/>
              <a:gd name="connsiteX33" fmla="*/ 909090 w 1114176"/>
              <a:gd name="connsiteY33" fmla="*/ 1824701 h 3364433"/>
              <a:gd name="connsiteX34" fmla="*/ 928139 w 1114176"/>
              <a:gd name="connsiteY34" fmla="*/ 1715163 h 3364433"/>
              <a:gd name="connsiteX35" fmla="*/ 1090064 w 1114176"/>
              <a:gd name="connsiteY35" fmla="*/ 1467513 h 3364433"/>
              <a:gd name="connsiteX36" fmla="*/ 1090065 w 1114176"/>
              <a:gd name="connsiteY36" fmla="*/ 1381789 h 3364433"/>
              <a:gd name="connsiteX37" fmla="*/ 1113877 w 1114176"/>
              <a:gd name="connsiteY37" fmla="*/ 1238913 h 3364433"/>
              <a:gd name="connsiteX38" fmla="*/ 1071015 w 1114176"/>
              <a:gd name="connsiteY38" fmla="*/ 1067463 h 3364433"/>
              <a:gd name="connsiteX39" fmla="*/ 1056727 w 1114176"/>
              <a:gd name="connsiteY39" fmla="*/ 962688 h 3364433"/>
              <a:gd name="connsiteX40" fmla="*/ 894802 w 1114176"/>
              <a:gd name="connsiteY40" fmla="*/ 1019838 h 3364433"/>
              <a:gd name="connsiteX41" fmla="*/ 890039 w 1114176"/>
              <a:gd name="connsiteY41" fmla="*/ 848388 h 3364433"/>
              <a:gd name="connsiteX42" fmla="*/ 799552 w 1114176"/>
              <a:gd name="connsiteY42" fmla="*/ 667413 h 3364433"/>
              <a:gd name="connsiteX43" fmla="*/ 642390 w 1114176"/>
              <a:gd name="connsiteY43" fmla="*/ 648364 h 3364433"/>
              <a:gd name="connsiteX44" fmla="*/ 609052 w 1114176"/>
              <a:gd name="connsiteY44" fmla="*/ 581688 h 3364433"/>
              <a:gd name="connsiteX45" fmla="*/ 442365 w 1114176"/>
              <a:gd name="connsiteY45" fmla="*/ 543589 h 3364433"/>
              <a:gd name="connsiteX46" fmla="*/ 323302 w 1114176"/>
              <a:gd name="connsiteY46" fmla="*/ 448338 h 3364433"/>
              <a:gd name="connsiteX47" fmla="*/ 161377 w 1114176"/>
              <a:gd name="connsiteY47" fmla="*/ 43526 h 3364433"/>
              <a:gd name="connsiteX48" fmla="*/ 166139 w 1114176"/>
              <a:gd name="connsiteY48" fmla="*/ 10188 h 3364433"/>
              <a:gd name="connsiteX49" fmla="*/ 4215 w 1114176"/>
              <a:gd name="connsiteY49" fmla="*/ 10188 h 33644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</a:cxnLst>
            <a:rect l="l" t="t" r="r" b="b"/>
            <a:pathLst>
              <a:path w="1114176" h="3364433">
                <a:moveTo>
                  <a:pt x="4215" y="10188"/>
                </a:moveTo>
                <a:cubicBezTo>
                  <a:pt x="-14835" y="30032"/>
                  <a:pt x="35965" y="60989"/>
                  <a:pt x="51840" y="129251"/>
                </a:cubicBezTo>
                <a:cubicBezTo>
                  <a:pt x="62953" y="161795"/>
                  <a:pt x="46284" y="172907"/>
                  <a:pt x="56603" y="214976"/>
                </a:cubicBezTo>
                <a:cubicBezTo>
                  <a:pt x="66922" y="257045"/>
                  <a:pt x="107402" y="336419"/>
                  <a:pt x="113752" y="381663"/>
                </a:cubicBezTo>
                <a:cubicBezTo>
                  <a:pt x="120102" y="426907"/>
                  <a:pt x="102639" y="435638"/>
                  <a:pt x="108989" y="476913"/>
                </a:cubicBezTo>
                <a:cubicBezTo>
                  <a:pt x="115339" y="518188"/>
                  <a:pt x="143914" y="571369"/>
                  <a:pt x="151852" y="629313"/>
                </a:cubicBezTo>
                <a:cubicBezTo>
                  <a:pt x="159790" y="687257"/>
                  <a:pt x="153440" y="769806"/>
                  <a:pt x="156615" y="824575"/>
                </a:cubicBezTo>
                <a:cubicBezTo>
                  <a:pt x="159790" y="879344"/>
                  <a:pt x="163758" y="928558"/>
                  <a:pt x="170902" y="957927"/>
                </a:cubicBezTo>
                <a:cubicBezTo>
                  <a:pt x="178046" y="987296"/>
                  <a:pt x="198683" y="991263"/>
                  <a:pt x="199477" y="1019838"/>
                </a:cubicBezTo>
                <a:cubicBezTo>
                  <a:pt x="200271" y="1048413"/>
                  <a:pt x="203446" y="1045240"/>
                  <a:pt x="175665" y="1129377"/>
                </a:cubicBezTo>
                <a:cubicBezTo>
                  <a:pt x="147884" y="1213514"/>
                  <a:pt x="54220" y="1449257"/>
                  <a:pt x="32789" y="1524663"/>
                </a:cubicBezTo>
                <a:cubicBezTo>
                  <a:pt x="11358" y="1600069"/>
                  <a:pt x="39933" y="1551652"/>
                  <a:pt x="47077" y="1581814"/>
                </a:cubicBezTo>
                <a:cubicBezTo>
                  <a:pt x="54221" y="1611976"/>
                  <a:pt x="67715" y="1641344"/>
                  <a:pt x="75652" y="1705638"/>
                </a:cubicBezTo>
                <a:cubicBezTo>
                  <a:pt x="83590" y="1769932"/>
                  <a:pt x="93115" y="1881852"/>
                  <a:pt x="94702" y="1967577"/>
                </a:cubicBezTo>
                <a:cubicBezTo>
                  <a:pt x="96290" y="2053302"/>
                  <a:pt x="78033" y="2133470"/>
                  <a:pt x="85177" y="2219988"/>
                </a:cubicBezTo>
                <a:cubicBezTo>
                  <a:pt x="92321" y="2306506"/>
                  <a:pt x="139152" y="2388263"/>
                  <a:pt x="137564" y="2486688"/>
                </a:cubicBezTo>
                <a:cubicBezTo>
                  <a:pt x="135977" y="2585113"/>
                  <a:pt x="64539" y="2706557"/>
                  <a:pt x="56602" y="2820063"/>
                </a:cubicBezTo>
                <a:cubicBezTo>
                  <a:pt x="48665" y="2933569"/>
                  <a:pt x="75652" y="3078826"/>
                  <a:pt x="89940" y="3167726"/>
                </a:cubicBezTo>
                <a:cubicBezTo>
                  <a:pt x="104228" y="3256626"/>
                  <a:pt x="134390" y="3324094"/>
                  <a:pt x="142327" y="3353463"/>
                </a:cubicBezTo>
                <a:cubicBezTo>
                  <a:pt x="150264" y="3382832"/>
                  <a:pt x="48664" y="3343938"/>
                  <a:pt x="137564" y="3343938"/>
                </a:cubicBezTo>
                <a:cubicBezTo>
                  <a:pt x="226464" y="3343938"/>
                  <a:pt x="592383" y="3353463"/>
                  <a:pt x="675727" y="3353463"/>
                </a:cubicBezTo>
                <a:cubicBezTo>
                  <a:pt x="759071" y="3353463"/>
                  <a:pt x="637627" y="3347113"/>
                  <a:pt x="637627" y="3343938"/>
                </a:cubicBezTo>
                <a:cubicBezTo>
                  <a:pt x="637627" y="3340763"/>
                  <a:pt x="669377" y="3350288"/>
                  <a:pt x="675727" y="3334413"/>
                </a:cubicBezTo>
                <a:cubicBezTo>
                  <a:pt x="682077" y="3318538"/>
                  <a:pt x="683664" y="3274088"/>
                  <a:pt x="675727" y="3248688"/>
                </a:cubicBezTo>
                <a:cubicBezTo>
                  <a:pt x="667790" y="3223288"/>
                  <a:pt x="642389" y="3225669"/>
                  <a:pt x="628102" y="3182013"/>
                </a:cubicBezTo>
                <a:cubicBezTo>
                  <a:pt x="613815" y="3138357"/>
                  <a:pt x="607464" y="3082001"/>
                  <a:pt x="590002" y="2986751"/>
                </a:cubicBezTo>
                <a:cubicBezTo>
                  <a:pt x="572540" y="2891501"/>
                  <a:pt x="547140" y="2685919"/>
                  <a:pt x="523327" y="2610513"/>
                </a:cubicBezTo>
                <a:cubicBezTo>
                  <a:pt x="499515" y="2535107"/>
                  <a:pt x="461414" y="2564475"/>
                  <a:pt x="447127" y="2534313"/>
                </a:cubicBezTo>
                <a:cubicBezTo>
                  <a:pt x="432840" y="2504151"/>
                  <a:pt x="429665" y="2466050"/>
                  <a:pt x="437602" y="2429538"/>
                </a:cubicBezTo>
                <a:cubicBezTo>
                  <a:pt x="445539" y="2393026"/>
                  <a:pt x="467765" y="2346988"/>
                  <a:pt x="494752" y="2315238"/>
                </a:cubicBezTo>
                <a:cubicBezTo>
                  <a:pt x="521739" y="2283488"/>
                  <a:pt x="551902" y="2284282"/>
                  <a:pt x="599527" y="2239038"/>
                </a:cubicBezTo>
                <a:cubicBezTo>
                  <a:pt x="647152" y="2193794"/>
                  <a:pt x="736846" y="2086638"/>
                  <a:pt x="780502" y="2043776"/>
                </a:cubicBezTo>
                <a:cubicBezTo>
                  <a:pt x="824158" y="2000914"/>
                  <a:pt x="843209" y="2017583"/>
                  <a:pt x="861465" y="1981864"/>
                </a:cubicBezTo>
                <a:cubicBezTo>
                  <a:pt x="879721" y="1946145"/>
                  <a:pt x="897978" y="1869151"/>
                  <a:pt x="909090" y="1824701"/>
                </a:cubicBezTo>
                <a:cubicBezTo>
                  <a:pt x="920202" y="1780251"/>
                  <a:pt x="897977" y="1774694"/>
                  <a:pt x="928139" y="1715163"/>
                </a:cubicBezTo>
                <a:cubicBezTo>
                  <a:pt x="958301" y="1655632"/>
                  <a:pt x="1063076" y="1523075"/>
                  <a:pt x="1090064" y="1467513"/>
                </a:cubicBezTo>
                <a:cubicBezTo>
                  <a:pt x="1117052" y="1411951"/>
                  <a:pt x="1086096" y="1419889"/>
                  <a:pt x="1090065" y="1381789"/>
                </a:cubicBezTo>
                <a:cubicBezTo>
                  <a:pt x="1094034" y="1343689"/>
                  <a:pt x="1117052" y="1291301"/>
                  <a:pt x="1113877" y="1238913"/>
                </a:cubicBezTo>
                <a:cubicBezTo>
                  <a:pt x="1110702" y="1186525"/>
                  <a:pt x="1109115" y="1118264"/>
                  <a:pt x="1071015" y="1067463"/>
                </a:cubicBezTo>
                <a:cubicBezTo>
                  <a:pt x="1032915" y="1016662"/>
                  <a:pt x="1086096" y="970626"/>
                  <a:pt x="1056727" y="962688"/>
                </a:cubicBezTo>
                <a:cubicBezTo>
                  <a:pt x="1027358" y="954751"/>
                  <a:pt x="922583" y="1038888"/>
                  <a:pt x="894802" y="1019838"/>
                </a:cubicBezTo>
                <a:cubicBezTo>
                  <a:pt x="867021" y="1000788"/>
                  <a:pt x="905914" y="907125"/>
                  <a:pt x="890039" y="848388"/>
                </a:cubicBezTo>
                <a:cubicBezTo>
                  <a:pt x="874164" y="789651"/>
                  <a:pt x="840827" y="700750"/>
                  <a:pt x="799552" y="667413"/>
                </a:cubicBezTo>
                <a:cubicBezTo>
                  <a:pt x="758277" y="634076"/>
                  <a:pt x="674140" y="662652"/>
                  <a:pt x="642390" y="648364"/>
                </a:cubicBezTo>
                <a:cubicBezTo>
                  <a:pt x="610640" y="634077"/>
                  <a:pt x="642389" y="599150"/>
                  <a:pt x="609052" y="581688"/>
                </a:cubicBezTo>
                <a:cubicBezTo>
                  <a:pt x="575715" y="564226"/>
                  <a:pt x="489990" y="565814"/>
                  <a:pt x="442365" y="543589"/>
                </a:cubicBezTo>
                <a:cubicBezTo>
                  <a:pt x="394740" y="521364"/>
                  <a:pt x="370133" y="531682"/>
                  <a:pt x="323302" y="448338"/>
                </a:cubicBezTo>
                <a:cubicBezTo>
                  <a:pt x="276471" y="364994"/>
                  <a:pt x="183602" y="114964"/>
                  <a:pt x="161377" y="43526"/>
                </a:cubicBezTo>
                <a:cubicBezTo>
                  <a:pt x="139152" y="-27912"/>
                  <a:pt x="192333" y="15744"/>
                  <a:pt x="166139" y="10188"/>
                </a:cubicBezTo>
                <a:cubicBezTo>
                  <a:pt x="139945" y="4632"/>
                  <a:pt x="23265" y="-9656"/>
                  <a:pt x="4215" y="10188"/>
                </a:cubicBezTo>
                <a:close/>
              </a:path>
            </a:pathLst>
          </a:custGeom>
          <a:solidFill>
            <a:srgbClr val="FF00FF">
              <a:alpha val="30000"/>
            </a:srgbClr>
          </a:solidFill>
          <a:ln w="19050"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395847" y="840932"/>
            <a:ext cx="19085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Resorption bay (Red area)</a:t>
            </a:r>
            <a:endParaRPr kumimoji="1" lang="ja-JP" altLang="en-US" b="1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8" name="正方形/長方形 17"/>
          <p:cNvSpPr/>
          <p:nvPr/>
        </p:nvSpPr>
        <p:spPr>
          <a:xfrm rot="393349">
            <a:off x="1222345" y="478874"/>
            <a:ext cx="1050286" cy="78854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フリーフォーム 18"/>
          <p:cNvSpPr/>
          <p:nvPr/>
        </p:nvSpPr>
        <p:spPr>
          <a:xfrm>
            <a:off x="5739912" y="704585"/>
            <a:ext cx="619862" cy="2269256"/>
          </a:xfrm>
          <a:custGeom>
            <a:avLst/>
            <a:gdLst>
              <a:gd name="connsiteX0" fmla="*/ 166169 w 843120"/>
              <a:gd name="connsiteY0" fmla="*/ 621 h 1882873"/>
              <a:gd name="connsiteX1" fmla="*/ 175694 w 843120"/>
              <a:gd name="connsiteY1" fmla="*/ 286371 h 1882873"/>
              <a:gd name="connsiteX2" fmla="*/ 204269 w 843120"/>
              <a:gd name="connsiteY2" fmla="*/ 429246 h 1882873"/>
              <a:gd name="connsiteX3" fmla="*/ 137594 w 843120"/>
              <a:gd name="connsiteY3" fmla="*/ 648321 h 1882873"/>
              <a:gd name="connsiteX4" fmla="*/ 137594 w 843120"/>
              <a:gd name="connsiteY4" fmla="*/ 772146 h 1882873"/>
              <a:gd name="connsiteX5" fmla="*/ 128069 w 843120"/>
              <a:gd name="connsiteY5" fmla="*/ 915021 h 1882873"/>
              <a:gd name="connsiteX6" fmla="*/ 99494 w 843120"/>
              <a:gd name="connsiteY6" fmla="*/ 1257921 h 1882873"/>
              <a:gd name="connsiteX7" fmla="*/ 4244 w 843120"/>
              <a:gd name="connsiteY7" fmla="*/ 1591296 h 1882873"/>
              <a:gd name="connsiteX8" fmla="*/ 32819 w 843120"/>
              <a:gd name="connsiteY8" fmla="*/ 1867521 h 1882873"/>
              <a:gd name="connsiteX9" fmla="*/ 175694 w 843120"/>
              <a:gd name="connsiteY9" fmla="*/ 1848471 h 1882873"/>
              <a:gd name="connsiteX10" fmla="*/ 261419 w 843120"/>
              <a:gd name="connsiteY10" fmla="*/ 1857996 h 1882873"/>
              <a:gd name="connsiteX11" fmla="*/ 404294 w 843120"/>
              <a:gd name="connsiteY11" fmla="*/ 1543671 h 1882873"/>
              <a:gd name="connsiteX12" fmla="*/ 518594 w 843120"/>
              <a:gd name="connsiteY12" fmla="*/ 1334121 h 1882873"/>
              <a:gd name="connsiteX13" fmla="*/ 594794 w 843120"/>
              <a:gd name="connsiteY13" fmla="*/ 991221 h 1882873"/>
              <a:gd name="connsiteX14" fmla="*/ 613844 w 843120"/>
              <a:gd name="connsiteY14" fmla="*/ 714996 h 1882873"/>
              <a:gd name="connsiteX15" fmla="*/ 661469 w 843120"/>
              <a:gd name="connsiteY15" fmla="*/ 438771 h 1882873"/>
              <a:gd name="connsiteX16" fmla="*/ 728144 w 843120"/>
              <a:gd name="connsiteY16" fmla="*/ 343521 h 1882873"/>
              <a:gd name="connsiteX17" fmla="*/ 842444 w 843120"/>
              <a:gd name="connsiteY17" fmla="*/ 219696 h 1882873"/>
              <a:gd name="connsiteX18" fmla="*/ 670994 w 843120"/>
              <a:gd name="connsiteY18" fmla="*/ 210171 h 1882873"/>
              <a:gd name="connsiteX19" fmla="*/ 166169 w 843120"/>
              <a:gd name="connsiteY19" fmla="*/ 621 h 1882873"/>
              <a:gd name="connsiteX0" fmla="*/ 142357 w 843120"/>
              <a:gd name="connsiteY0" fmla="*/ 182 h 2444409"/>
              <a:gd name="connsiteX1" fmla="*/ 175694 w 843120"/>
              <a:gd name="connsiteY1" fmla="*/ 847907 h 2444409"/>
              <a:gd name="connsiteX2" fmla="*/ 204269 w 843120"/>
              <a:gd name="connsiteY2" fmla="*/ 990782 h 2444409"/>
              <a:gd name="connsiteX3" fmla="*/ 137594 w 843120"/>
              <a:gd name="connsiteY3" fmla="*/ 1209857 h 2444409"/>
              <a:gd name="connsiteX4" fmla="*/ 137594 w 843120"/>
              <a:gd name="connsiteY4" fmla="*/ 1333682 h 2444409"/>
              <a:gd name="connsiteX5" fmla="*/ 128069 w 843120"/>
              <a:gd name="connsiteY5" fmla="*/ 1476557 h 2444409"/>
              <a:gd name="connsiteX6" fmla="*/ 99494 w 843120"/>
              <a:gd name="connsiteY6" fmla="*/ 1819457 h 2444409"/>
              <a:gd name="connsiteX7" fmla="*/ 4244 w 843120"/>
              <a:gd name="connsiteY7" fmla="*/ 2152832 h 2444409"/>
              <a:gd name="connsiteX8" fmla="*/ 32819 w 843120"/>
              <a:gd name="connsiteY8" fmla="*/ 2429057 h 2444409"/>
              <a:gd name="connsiteX9" fmla="*/ 175694 w 843120"/>
              <a:gd name="connsiteY9" fmla="*/ 2410007 h 2444409"/>
              <a:gd name="connsiteX10" fmla="*/ 261419 w 843120"/>
              <a:gd name="connsiteY10" fmla="*/ 2419532 h 2444409"/>
              <a:gd name="connsiteX11" fmla="*/ 404294 w 843120"/>
              <a:gd name="connsiteY11" fmla="*/ 2105207 h 2444409"/>
              <a:gd name="connsiteX12" fmla="*/ 518594 w 843120"/>
              <a:gd name="connsiteY12" fmla="*/ 1895657 h 2444409"/>
              <a:gd name="connsiteX13" fmla="*/ 594794 w 843120"/>
              <a:gd name="connsiteY13" fmla="*/ 1552757 h 2444409"/>
              <a:gd name="connsiteX14" fmla="*/ 613844 w 843120"/>
              <a:gd name="connsiteY14" fmla="*/ 1276532 h 2444409"/>
              <a:gd name="connsiteX15" fmla="*/ 661469 w 843120"/>
              <a:gd name="connsiteY15" fmla="*/ 1000307 h 2444409"/>
              <a:gd name="connsiteX16" fmla="*/ 728144 w 843120"/>
              <a:gd name="connsiteY16" fmla="*/ 905057 h 2444409"/>
              <a:gd name="connsiteX17" fmla="*/ 842444 w 843120"/>
              <a:gd name="connsiteY17" fmla="*/ 781232 h 2444409"/>
              <a:gd name="connsiteX18" fmla="*/ 670994 w 843120"/>
              <a:gd name="connsiteY18" fmla="*/ 771707 h 2444409"/>
              <a:gd name="connsiteX19" fmla="*/ 142357 w 843120"/>
              <a:gd name="connsiteY19" fmla="*/ 182 h 2444409"/>
              <a:gd name="connsiteX0" fmla="*/ 142357 w 843120"/>
              <a:gd name="connsiteY0" fmla="*/ 3082 h 2447309"/>
              <a:gd name="connsiteX1" fmla="*/ 189982 w 843120"/>
              <a:gd name="connsiteY1" fmla="*/ 517432 h 2447309"/>
              <a:gd name="connsiteX2" fmla="*/ 175694 w 843120"/>
              <a:gd name="connsiteY2" fmla="*/ 850807 h 2447309"/>
              <a:gd name="connsiteX3" fmla="*/ 204269 w 843120"/>
              <a:gd name="connsiteY3" fmla="*/ 993682 h 2447309"/>
              <a:gd name="connsiteX4" fmla="*/ 137594 w 843120"/>
              <a:gd name="connsiteY4" fmla="*/ 1212757 h 2447309"/>
              <a:gd name="connsiteX5" fmla="*/ 137594 w 843120"/>
              <a:gd name="connsiteY5" fmla="*/ 1336582 h 2447309"/>
              <a:gd name="connsiteX6" fmla="*/ 128069 w 843120"/>
              <a:gd name="connsiteY6" fmla="*/ 1479457 h 2447309"/>
              <a:gd name="connsiteX7" fmla="*/ 99494 w 843120"/>
              <a:gd name="connsiteY7" fmla="*/ 1822357 h 2447309"/>
              <a:gd name="connsiteX8" fmla="*/ 4244 w 843120"/>
              <a:gd name="connsiteY8" fmla="*/ 2155732 h 2447309"/>
              <a:gd name="connsiteX9" fmla="*/ 32819 w 843120"/>
              <a:gd name="connsiteY9" fmla="*/ 2431957 h 2447309"/>
              <a:gd name="connsiteX10" fmla="*/ 175694 w 843120"/>
              <a:gd name="connsiteY10" fmla="*/ 2412907 h 2447309"/>
              <a:gd name="connsiteX11" fmla="*/ 261419 w 843120"/>
              <a:gd name="connsiteY11" fmla="*/ 2422432 h 2447309"/>
              <a:gd name="connsiteX12" fmla="*/ 404294 w 843120"/>
              <a:gd name="connsiteY12" fmla="*/ 2108107 h 2447309"/>
              <a:gd name="connsiteX13" fmla="*/ 518594 w 843120"/>
              <a:gd name="connsiteY13" fmla="*/ 1898557 h 2447309"/>
              <a:gd name="connsiteX14" fmla="*/ 594794 w 843120"/>
              <a:gd name="connsiteY14" fmla="*/ 1555657 h 2447309"/>
              <a:gd name="connsiteX15" fmla="*/ 613844 w 843120"/>
              <a:gd name="connsiteY15" fmla="*/ 1279432 h 2447309"/>
              <a:gd name="connsiteX16" fmla="*/ 661469 w 843120"/>
              <a:gd name="connsiteY16" fmla="*/ 1003207 h 2447309"/>
              <a:gd name="connsiteX17" fmla="*/ 728144 w 843120"/>
              <a:gd name="connsiteY17" fmla="*/ 907957 h 2447309"/>
              <a:gd name="connsiteX18" fmla="*/ 842444 w 843120"/>
              <a:gd name="connsiteY18" fmla="*/ 784132 h 2447309"/>
              <a:gd name="connsiteX19" fmla="*/ 670994 w 843120"/>
              <a:gd name="connsiteY19" fmla="*/ 774607 h 2447309"/>
              <a:gd name="connsiteX20" fmla="*/ 142357 w 843120"/>
              <a:gd name="connsiteY20" fmla="*/ 3082 h 2447309"/>
              <a:gd name="connsiteX0" fmla="*/ 142357 w 843120"/>
              <a:gd name="connsiteY0" fmla="*/ 3082 h 2447309"/>
              <a:gd name="connsiteX1" fmla="*/ 189982 w 843120"/>
              <a:gd name="connsiteY1" fmla="*/ 517432 h 2447309"/>
              <a:gd name="connsiteX2" fmla="*/ 175694 w 843120"/>
              <a:gd name="connsiteY2" fmla="*/ 850807 h 2447309"/>
              <a:gd name="connsiteX3" fmla="*/ 185219 w 843120"/>
              <a:gd name="connsiteY3" fmla="*/ 1007970 h 2447309"/>
              <a:gd name="connsiteX4" fmla="*/ 137594 w 843120"/>
              <a:gd name="connsiteY4" fmla="*/ 1212757 h 2447309"/>
              <a:gd name="connsiteX5" fmla="*/ 137594 w 843120"/>
              <a:gd name="connsiteY5" fmla="*/ 1336582 h 2447309"/>
              <a:gd name="connsiteX6" fmla="*/ 128069 w 843120"/>
              <a:gd name="connsiteY6" fmla="*/ 1479457 h 2447309"/>
              <a:gd name="connsiteX7" fmla="*/ 99494 w 843120"/>
              <a:gd name="connsiteY7" fmla="*/ 1822357 h 2447309"/>
              <a:gd name="connsiteX8" fmla="*/ 4244 w 843120"/>
              <a:gd name="connsiteY8" fmla="*/ 2155732 h 2447309"/>
              <a:gd name="connsiteX9" fmla="*/ 32819 w 843120"/>
              <a:gd name="connsiteY9" fmla="*/ 2431957 h 2447309"/>
              <a:gd name="connsiteX10" fmla="*/ 175694 w 843120"/>
              <a:gd name="connsiteY10" fmla="*/ 2412907 h 2447309"/>
              <a:gd name="connsiteX11" fmla="*/ 261419 w 843120"/>
              <a:gd name="connsiteY11" fmla="*/ 2422432 h 2447309"/>
              <a:gd name="connsiteX12" fmla="*/ 404294 w 843120"/>
              <a:gd name="connsiteY12" fmla="*/ 2108107 h 2447309"/>
              <a:gd name="connsiteX13" fmla="*/ 518594 w 843120"/>
              <a:gd name="connsiteY13" fmla="*/ 1898557 h 2447309"/>
              <a:gd name="connsiteX14" fmla="*/ 594794 w 843120"/>
              <a:gd name="connsiteY14" fmla="*/ 1555657 h 2447309"/>
              <a:gd name="connsiteX15" fmla="*/ 613844 w 843120"/>
              <a:gd name="connsiteY15" fmla="*/ 1279432 h 2447309"/>
              <a:gd name="connsiteX16" fmla="*/ 661469 w 843120"/>
              <a:gd name="connsiteY16" fmla="*/ 1003207 h 2447309"/>
              <a:gd name="connsiteX17" fmla="*/ 728144 w 843120"/>
              <a:gd name="connsiteY17" fmla="*/ 907957 h 2447309"/>
              <a:gd name="connsiteX18" fmla="*/ 842444 w 843120"/>
              <a:gd name="connsiteY18" fmla="*/ 784132 h 2447309"/>
              <a:gd name="connsiteX19" fmla="*/ 670994 w 843120"/>
              <a:gd name="connsiteY19" fmla="*/ 774607 h 2447309"/>
              <a:gd name="connsiteX20" fmla="*/ 142357 w 843120"/>
              <a:gd name="connsiteY20" fmla="*/ 3082 h 2447309"/>
              <a:gd name="connsiteX0" fmla="*/ 142357 w 843120"/>
              <a:gd name="connsiteY0" fmla="*/ 5 h 2444232"/>
              <a:gd name="connsiteX1" fmla="*/ 189982 w 843120"/>
              <a:gd name="connsiteY1" fmla="*/ 514355 h 2444232"/>
              <a:gd name="connsiteX2" fmla="*/ 175694 w 843120"/>
              <a:gd name="connsiteY2" fmla="*/ 847730 h 2444232"/>
              <a:gd name="connsiteX3" fmla="*/ 185219 w 843120"/>
              <a:gd name="connsiteY3" fmla="*/ 1004893 h 2444232"/>
              <a:gd name="connsiteX4" fmla="*/ 137594 w 843120"/>
              <a:gd name="connsiteY4" fmla="*/ 1209680 h 2444232"/>
              <a:gd name="connsiteX5" fmla="*/ 137594 w 843120"/>
              <a:gd name="connsiteY5" fmla="*/ 1333505 h 2444232"/>
              <a:gd name="connsiteX6" fmla="*/ 128069 w 843120"/>
              <a:gd name="connsiteY6" fmla="*/ 1476380 h 2444232"/>
              <a:gd name="connsiteX7" fmla="*/ 99494 w 843120"/>
              <a:gd name="connsiteY7" fmla="*/ 1819280 h 2444232"/>
              <a:gd name="connsiteX8" fmla="*/ 4244 w 843120"/>
              <a:gd name="connsiteY8" fmla="*/ 2152655 h 2444232"/>
              <a:gd name="connsiteX9" fmla="*/ 32819 w 843120"/>
              <a:gd name="connsiteY9" fmla="*/ 2428880 h 2444232"/>
              <a:gd name="connsiteX10" fmla="*/ 175694 w 843120"/>
              <a:gd name="connsiteY10" fmla="*/ 2409830 h 2444232"/>
              <a:gd name="connsiteX11" fmla="*/ 261419 w 843120"/>
              <a:gd name="connsiteY11" fmla="*/ 2419355 h 2444232"/>
              <a:gd name="connsiteX12" fmla="*/ 404294 w 843120"/>
              <a:gd name="connsiteY12" fmla="*/ 2105030 h 2444232"/>
              <a:gd name="connsiteX13" fmla="*/ 518594 w 843120"/>
              <a:gd name="connsiteY13" fmla="*/ 1895480 h 2444232"/>
              <a:gd name="connsiteX14" fmla="*/ 594794 w 843120"/>
              <a:gd name="connsiteY14" fmla="*/ 1552580 h 2444232"/>
              <a:gd name="connsiteX15" fmla="*/ 613844 w 843120"/>
              <a:gd name="connsiteY15" fmla="*/ 1276355 h 2444232"/>
              <a:gd name="connsiteX16" fmla="*/ 661469 w 843120"/>
              <a:gd name="connsiteY16" fmla="*/ 1000130 h 2444232"/>
              <a:gd name="connsiteX17" fmla="*/ 728144 w 843120"/>
              <a:gd name="connsiteY17" fmla="*/ 904880 h 2444232"/>
              <a:gd name="connsiteX18" fmla="*/ 842444 w 843120"/>
              <a:gd name="connsiteY18" fmla="*/ 781055 h 2444232"/>
              <a:gd name="connsiteX19" fmla="*/ 670994 w 843120"/>
              <a:gd name="connsiteY19" fmla="*/ 771530 h 2444232"/>
              <a:gd name="connsiteX20" fmla="*/ 366194 w 843120"/>
              <a:gd name="connsiteY20" fmla="*/ 504830 h 2444232"/>
              <a:gd name="connsiteX21" fmla="*/ 142357 w 843120"/>
              <a:gd name="connsiteY21" fmla="*/ 5 h 2444232"/>
              <a:gd name="connsiteX0" fmla="*/ 142357 w 795934"/>
              <a:gd name="connsiteY0" fmla="*/ 5 h 2444232"/>
              <a:gd name="connsiteX1" fmla="*/ 189982 w 795934"/>
              <a:gd name="connsiteY1" fmla="*/ 514355 h 2444232"/>
              <a:gd name="connsiteX2" fmla="*/ 175694 w 795934"/>
              <a:gd name="connsiteY2" fmla="*/ 847730 h 2444232"/>
              <a:gd name="connsiteX3" fmla="*/ 185219 w 795934"/>
              <a:gd name="connsiteY3" fmla="*/ 1004893 h 2444232"/>
              <a:gd name="connsiteX4" fmla="*/ 137594 w 795934"/>
              <a:gd name="connsiteY4" fmla="*/ 1209680 h 2444232"/>
              <a:gd name="connsiteX5" fmla="*/ 137594 w 795934"/>
              <a:gd name="connsiteY5" fmla="*/ 1333505 h 2444232"/>
              <a:gd name="connsiteX6" fmla="*/ 128069 w 795934"/>
              <a:gd name="connsiteY6" fmla="*/ 1476380 h 2444232"/>
              <a:gd name="connsiteX7" fmla="*/ 99494 w 795934"/>
              <a:gd name="connsiteY7" fmla="*/ 1819280 h 2444232"/>
              <a:gd name="connsiteX8" fmla="*/ 4244 w 795934"/>
              <a:gd name="connsiteY8" fmla="*/ 2152655 h 2444232"/>
              <a:gd name="connsiteX9" fmla="*/ 32819 w 795934"/>
              <a:gd name="connsiteY9" fmla="*/ 2428880 h 2444232"/>
              <a:gd name="connsiteX10" fmla="*/ 175694 w 795934"/>
              <a:gd name="connsiteY10" fmla="*/ 2409830 h 2444232"/>
              <a:gd name="connsiteX11" fmla="*/ 261419 w 795934"/>
              <a:gd name="connsiteY11" fmla="*/ 2419355 h 2444232"/>
              <a:gd name="connsiteX12" fmla="*/ 404294 w 795934"/>
              <a:gd name="connsiteY12" fmla="*/ 2105030 h 2444232"/>
              <a:gd name="connsiteX13" fmla="*/ 518594 w 795934"/>
              <a:gd name="connsiteY13" fmla="*/ 1895480 h 2444232"/>
              <a:gd name="connsiteX14" fmla="*/ 594794 w 795934"/>
              <a:gd name="connsiteY14" fmla="*/ 1552580 h 2444232"/>
              <a:gd name="connsiteX15" fmla="*/ 613844 w 795934"/>
              <a:gd name="connsiteY15" fmla="*/ 1276355 h 2444232"/>
              <a:gd name="connsiteX16" fmla="*/ 661469 w 795934"/>
              <a:gd name="connsiteY16" fmla="*/ 1000130 h 2444232"/>
              <a:gd name="connsiteX17" fmla="*/ 728144 w 795934"/>
              <a:gd name="connsiteY17" fmla="*/ 904880 h 2444232"/>
              <a:gd name="connsiteX18" fmla="*/ 794819 w 795934"/>
              <a:gd name="connsiteY18" fmla="*/ 866780 h 2444232"/>
              <a:gd name="connsiteX19" fmla="*/ 670994 w 795934"/>
              <a:gd name="connsiteY19" fmla="*/ 771530 h 2444232"/>
              <a:gd name="connsiteX20" fmla="*/ 366194 w 795934"/>
              <a:gd name="connsiteY20" fmla="*/ 504830 h 2444232"/>
              <a:gd name="connsiteX21" fmla="*/ 142357 w 795934"/>
              <a:gd name="connsiteY21" fmla="*/ 5 h 2444232"/>
              <a:gd name="connsiteX0" fmla="*/ 142357 w 795832"/>
              <a:gd name="connsiteY0" fmla="*/ 5 h 2444232"/>
              <a:gd name="connsiteX1" fmla="*/ 189982 w 795832"/>
              <a:gd name="connsiteY1" fmla="*/ 514355 h 2444232"/>
              <a:gd name="connsiteX2" fmla="*/ 175694 w 795832"/>
              <a:gd name="connsiteY2" fmla="*/ 847730 h 2444232"/>
              <a:gd name="connsiteX3" fmla="*/ 185219 w 795832"/>
              <a:gd name="connsiteY3" fmla="*/ 1004893 h 2444232"/>
              <a:gd name="connsiteX4" fmla="*/ 137594 w 795832"/>
              <a:gd name="connsiteY4" fmla="*/ 1209680 h 2444232"/>
              <a:gd name="connsiteX5" fmla="*/ 137594 w 795832"/>
              <a:gd name="connsiteY5" fmla="*/ 1333505 h 2444232"/>
              <a:gd name="connsiteX6" fmla="*/ 128069 w 795832"/>
              <a:gd name="connsiteY6" fmla="*/ 1476380 h 2444232"/>
              <a:gd name="connsiteX7" fmla="*/ 99494 w 795832"/>
              <a:gd name="connsiteY7" fmla="*/ 1819280 h 2444232"/>
              <a:gd name="connsiteX8" fmla="*/ 4244 w 795832"/>
              <a:gd name="connsiteY8" fmla="*/ 2152655 h 2444232"/>
              <a:gd name="connsiteX9" fmla="*/ 32819 w 795832"/>
              <a:gd name="connsiteY9" fmla="*/ 2428880 h 2444232"/>
              <a:gd name="connsiteX10" fmla="*/ 175694 w 795832"/>
              <a:gd name="connsiteY10" fmla="*/ 2409830 h 2444232"/>
              <a:gd name="connsiteX11" fmla="*/ 261419 w 795832"/>
              <a:gd name="connsiteY11" fmla="*/ 2419355 h 2444232"/>
              <a:gd name="connsiteX12" fmla="*/ 404294 w 795832"/>
              <a:gd name="connsiteY12" fmla="*/ 2105030 h 2444232"/>
              <a:gd name="connsiteX13" fmla="*/ 518594 w 795832"/>
              <a:gd name="connsiteY13" fmla="*/ 1895480 h 2444232"/>
              <a:gd name="connsiteX14" fmla="*/ 594794 w 795832"/>
              <a:gd name="connsiteY14" fmla="*/ 1552580 h 2444232"/>
              <a:gd name="connsiteX15" fmla="*/ 613844 w 795832"/>
              <a:gd name="connsiteY15" fmla="*/ 1276355 h 2444232"/>
              <a:gd name="connsiteX16" fmla="*/ 661469 w 795832"/>
              <a:gd name="connsiteY16" fmla="*/ 1000130 h 2444232"/>
              <a:gd name="connsiteX17" fmla="*/ 699569 w 795832"/>
              <a:gd name="connsiteY17" fmla="*/ 1057279 h 2444232"/>
              <a:gd name="connsiteX18" fmla="*/ 728144 w 795832"/>
              <a:gd name="connsiteY18" fmla="*/ 904880 h 2444232"/>
              <a:gd name="connsiteX19" fmla="*/ 794819 w 795832"/>
              <a:gd name="connsiteY19" fmla="*/ 866780 h 2444232"/>
              <a:gd name="connsiteX20" fmla="*/ 670994 w 795832"/>
              <a:gd name="connsiteY20" fmla="*/ 771530 h 2444232"/>
              <a:gd name="connsiteX21" fmla="*/ 366194 w 795832"/>
              <a:gd name="connsiteY21" fmla="*/ 504830 h 2444232"/>
              <a:gd name="connsiteX22" fmla="*/ 142357 w 795832"/>
              <a:gd name="connsiteY22" fmla="*/ 5 h 2444232"/>
              <a:gd name="connsiteX0" fmla="*/ 142357 w 795832"/>
              <a:gd name="connsiteY0" fmla="*/ 5 h 2444232"/>
              <a:gd name="connsiteX1" fmla="*/ 189982 w 795832"/>
              <a:gd name="connsiteY1" fmla="*/ 514355 h 2444232"/>
              <a:gd name="connsiteX2" fmla="*/ 175694 w 795832"/>
              <a:gd name="connsiteY2" fmla="*/ 847730 h 2444232"/>
              <a:gd name="connsiteX3" fmla="*/ 185219 w 795832"/>
              <a:gd name="connsiteY3" fmla="*/ 1004893 h 2444232"/>
              <a:gd name="connsiteX4" fmla="*/ 137594 w 795832"/>
              <a:gd name="connsiteY4" fmla="*/ 1209680 h 2444232"/>
              <a:gd name="connsiteX5" fmla="*/ 137594 w 795832"/>
              <a:gd name="connsiteY5" fmla="*/ 1333505 h 2444232"/>
              <a:gd name="connsiteX6" fmla="*/ 128069 w 795832"/>
              <a:gd name="connsiteY6" fmla="*/ 1476380 h 2444232"/>
              <a:gd name="connsiteX7" fmla="*/ 99494 w 795832"/>
              <a:gd name="connsiteY7" fmla="*/ 1819280 h 2444232"/>
              <a:gd name="connsiteX8" fmla="*/ 4244 w 795832"/>
              <a:gd name="connsiteY8" fmla="*/ 2152655 h 2444232"/>
              <a:gd name="connsiteX9" fmla="*/ 32819 w 795832"/>
              <a:gd name="connsiteY9" fmla="*/ 2428880 h 2444232"/>
              <a:gd name="connsiteX10" fmla="*/ 175694 w 795832"/>
              <a:gd name="connsiteY10" fmla="*/ 2409830 h 2444232"/>
              <a:gd name="connsiteX11" fmla="*/ 261419 w 795832"/>
              <a:gd name="connsiteY11" fmla="*/ 2419355 h 2444232"/>
              <a:gd name="connsiteX12" fmla="*/ 404294 w 795832"/>
              <a:gd name="connsiteY12" fmla="*/ 2105030 h 2444232"/>
              <a:gd name="connsiteX13" fmla="*/ 518594 w 795832"/>
              <a:gd name="connsiteY13" fmla="*/ 1895480 h 2444232"/>
              <a:gd name="connsiteX14" fmla="*/ 594794 w 795832"/>
              <a:gd name="connsiteY14" fmla="*/ 1552580 h 2444232"/>
              <a:gd name="connsiteX15" fmla="*/ 613844 w 795832"/>
              <a:gd name="connsiteY15" fmla="*/ 1276355 h 2444232"/>
              <a:gd name="connsiteX16" fmla="*/ 632894 w 795832"/>
              <a:gd name="connsiteY16" fmla="*/ 1157292 h 2444232"/>
              <a:gd name="connsiteX17" fmla="*/ 699569 w 795832"/>
              <a:gd name="connsiteY17" fmla="*/ 1057279 h 2444232"/>
              <a:gd name="connsiteX18" fmla="*/ 728144 w 795832"/>
              <a:gd name="connsiteY18" fmla="*/ 904880 h 2444232"/>
              <a:gd name="connsiteX19" fmla="*/ 794819 w 795832"/>
              <a:gd name="connsiteY19" fmla="*/ 866780 h 2444232"/>
              <a:gd name="connsiteX20" fmla="*/ 670994 w 795832"/>
              <a:gd name="connsiteY20" fmla="*/ 771530 h 2444232"/>
              <a:gd name="connsiteX21" fmla="*/ 366194 w 795832"/>
              <a:gd name="connsiteY21" fmla="*/ 504830 h 2444232"/>
              <a:gd name="connsiteX22" fmla="*/ 142357 w 795832"/>
              <a:gd name="connsiteY22" fmla="*/ 5 h 2444232"/>
              <a:gd name="connsiteX0" fmla="*/ 142357 w 795909"/>
              <a:gd name="connsiteY0" fmla="*/ 5 h 2444232"/>
              <a:gd name="connsiteX1" fmla="*/ 189982 w 795909"/>
              <a:gd name="connsiteY1" fmla="*/ 514355 h 2444232"/>
              <a:gd name="connsiteX2" fmla="*/ 175694 w 795909"/>
              <a:gd name="connsiteY2" fmla="*/ 847730 h 2444232"/>
              <a:gd name="connsiteX3" fmla="*/ 185219 w 795909"/>
              <a:gd name="connsiteY3" fmla="*/ 1004893 h 2444232"/>
              <a:gd name="connsiteX4" fmla="*/ 137594 w 795909"/>
              <a:gd name="connsiteY4" fmla="*/ 1209680 h 2444232"/>
              <a:gd name="connsiteX5" fmla="*/ 137594 w 795909"/>
              <a:gd name="connsiteY5" fmla="*/ 1333505 h 2444232"/>
              <a:gd name="connsiteX6" fmla="*/ 128069 w 795909"/>
              <a:gd name="connsiteY6" fmla="*/ 1476380 h 2444232"/>
              <a:gd name="connsiteX7" fmla="*/ 99494 w 795909"/>
              <a:gd name="connsiteY7" fmla="*/ 1819280 h 2444232"/>
              <a:gd name="connsiteX8" fmla="*/ 4244 w 795909"/>
              <a:gd name="connsiteY8" fmla="*/ 2152655 h 2444232"/>
              <a:gd name="connsiteX9" fmla="*/ 32819 w 795909"/>
              <a:gd name="connsiteY9" fmla="*/ 2428880 h 2444232"/>
              <a:gd name="connsiteX10" fmla="*/ 175694 w 795909"/>
              <a:gd name="connsiteY10" fmla="*/ 2409830 h 2444232"/>
              <a:gd name="connsiteX11" fmla="*/ 261419 w 795909"/>
              <a:gd name="connsiteY11" fmla="*/ 2419355 h 2444232"/>
              <a:gd name="connsiteX12" fmla="*/ 404294 w 795909"/>
              <a:gd name="connsiteY12" fmla="*/ 2105030 h 2444232"/>
              <a:gd name="connsiteX13" fmla="*/ 518594 w 795909"/>
              <a:gd name="connsiteY13" fmla="*/ 1895480 h 2444232"/>
              <a:gd name="connsiteX14" fmla="*/ 594794 w 795909"/>
              <a:gd name="connsiteY14" fmla="*/ 1552580 h 2444232"/>
              <a:gd name="connsiteX15" fmla="*/ 613844 w 795909"/>
              <a:gd name="connsiteY15" fmla="*/ 1276355 h 2444232"/>
              <a:gd name="connsiteX16" fmla="*/ 632894 w 795909"/>
              <a:gd name="connsiteY16" fmla="*/ 1157292 h 2444232"/>
              <a:gd name="connsiteX17" fmla="*/ 699569 w 795909"/>
              <a:gd name="connsiteY17" fmla="*/ 1057279 h 2444232"/>
              <a:gd name="connsiteX18" fmla="*/ 732907 w 795909"/>
              <a:gd name="connsiteY18" fmla="*/ 942980 h 2444232"/>
              <a:gd name="connsiteX19" fmla="*/ 794819 w 795909"/>
              <a:gd name="connsiteY19" fmla="*/ 866780 h 2444232"/>
              <a:gd name="connsiteX20" fmla="*/ 670994 w 795909"/>
              <a:gd name="connsiteY20" fmla="*/ 771530 h 2444232"/>
              <a:gd name="connsiteX21" fmla="*/ 366194 w 795909"/>
              <a:gd name="connsiteY21" fmla="*/ 504830 h 2444232"/>
              <a:gd name="connsiteX22" fmla="*/ 142357 w 795909"/>
              <a:gd name="connsiteY22" fmla="*/ 5 h 2444232"/>
              <a:gd name="connsiteX0" fmla="*/ 142357 w 795909"/>
              <a:gd name="connsiteY0" fmla="*/ 5 h 2444232"/>
              <a:gd name="connsiteX1" fmla="*/ 189982 w 795909"/>
              <a:gd name="connsiteY1" fmla="*/ 514355 h 2444232"/>
              <a:gd name="connsiteX2" fmla="*/ 175694 w 795909"/>
              <a:gd name="connsiteY2" fmla="*/ 847730 h 2444232"/>
              <a:gd name="connsiteX3" fmla="*/ 185219 w 795909"/>
              <a:gd name="connsiteY3" fmla="*/ 1004893 h 2444232"/>
              <a:gd name="connsiteX4" fmla="*/ 137594 w 795909"/>
              <a:gd name="connsiteY4" fmla="*/ 1209680 h 2444232"/>
              <a:gd name="connsiteX5" fmla="*/ 137594 w 795909"/>
              <a:gd name="connsiteY5" fmla="*/ 1333505 h 2444232"/>
              <a:gd name="connsiteX6" fmla="*/ 128069 w 795909"/>
              <a:gd name="connsiteY6" fmla="*/ 1476380 h 2444232"/>
              <a:gd name="connsiteX7" fmla="*/ 99494 w 795909"/>
              <a:gd name="connsiteY7" fmla="*/ 1819280 h 2444232"/>
              <a:gd name="connsiteX8" fmla="*/ 4244 w 795909"/>
              <a:gd name="connsiteY8" fmla="*/ 2152655 h 2444232"/>
              <a:gd name="connsiteX9" fmla="*/ 32819 w 795909"/>
              <a:gd name="connsiteY9" fmla="*/ 2428880 h 2444232"/>
              <a:gd name="connsiteX10" fmla="*/ 175694 w 795909"/>
              <a:gd name="connsiteY10" fmla="*/ 2409830 h 2444232"/>
              <a:gd name="connsiteX11" fmla="*/ 261419 w 795909"/>
              <a:gd name="connsiteY11" fmla="*/ 2419355 h 2444232"/>
              <a:gd name="connsiteX12" fmla="*/ 404294 w 795909"/>
              <a:gd name="connsiteY12" fmla="*/ 2105030 h 2444232"/>
              <a:gd name="connsiteX13" fmla="*/ 518594 w 795909"/>
              <a:gd name="connsiteY13" fmla="*/ 1895480 h 2444232"/>
              <a:gd name="connsiteX14" fmla="*/ 594794 w 795909"/>
              <a:gd name="connsiteY14" fmla="*/ 1552580 h 2444232"/>
              <a:gd name="connsiteX15" fmla="*/ 613844 w 795909"/>
              <a:gd name="connsiteY15" fmla="*/ 1276355 h 2444232"/>
              <a:gd name="connsiteX16" fmla="*/ 632894 w 795909"/>
              <a:gd name="connsiteY16" fmla="*/ 1157292 h 2444232"/>
              <a:gd name="connsiteX17" fmla="*/ 699569 w 795909"/>
              <a:gd name="connsiteY17" fmla="*/ 1057279 h 2444232"/>
              <a:gd name="connsiteX18" fmla="*/ 732907 w 795909"/>
              <a:gd name="connsiteY18" fmla="*/ 942980 h 2444232"/>
              <a:gd name="connsiteX19" fmla="*/ 794819 w 795909"/>
              <a:gd name="connsiteY19" fmla="*/ 866780 h 2444232"/>
              <a:gd name="connsiteX20" fmla="*/ 670994 w 795909"/>
              <a:gd name="connsiteY20" fmla="*/ 771530 h 2444232"/>
              <a:gd name="connsiteX21" fmla="*/ 366194 w 795909"/>
              <a:gd name="connsiteY21" fmla="*/ 504830 h 2444232"/>
              <a:gd name="connsiteX22" fmla="*/ 142357 w 795909"/>
              <a:gd name="connsiteY22" fmla="*/ 5 h 2444232"/>
              <a:gd name="connsiteX0" fmla="*/ 142357 w 795909"/>
              <a:gd name="connsiteY0" fmla="*/ 5 h 2444232"/>
              <a:gd name="connsiteX1" fmla="*/ 189982 w 795909"/>
              <a:gd name="connsiteY1" fmla="*/ 514355 h 2444232"/>
              <a:gd name="connsiteX2" fmla="*/ 175694 w 795909"/>
              <a:gd name="connsiteY2" fmla="*/ 847730 h 2444232"/>
              <a:gd name="connsiteX3" fmla="*/ 185219 w 795909"/>
              <a:gd name="connsiteY3" fmla="*/ 1004893 h 2444232"/>
              <a:gd name="connsiteX4" fmla="*/ 137594 w 795909"/>
              <a:gd name="connsiteY4" fmla="*/ 1209680 h 2444232"/>
              <a:gd name="connsiteX5" fmla="*/ 137594 w 795909"/>
              <a:gd name="connsiteY5" fmla="*/ 1333505 h 2444232"/>
              <a:gd name="connsiteX6" fmla="*/ 128069 w 795909"/>
              <a:gd name="connsiteY6" fmla="*/ 1476380 h 2444232"/>
              <a:gd name="connsiteX7" fmla="*/ 99494 w 795909"/>
              <a:gd name="connsiteY7" fmla="*/ 1819280 h 2444232"/>
              <a:gd name="connsiteX8" fmla="*/ 4244 w 795909"/>
              <a:gd name="connsiteY8" fmla="*/ 2152655 h 2444232"/>
              <a:gd name="connsiteX9" fmla="*/ 32819 w 795909"/>
              <a:gd name="connsiteY9" fmla="*/ 2428880 h 2444232"/>
              <a:gd name="connsiteX10" fmla="*/ 175694 w 795909"/>
              <a:gd name="connsiteY10" fmla="*/ 2409830 h 2444232"/>
              <a:gd name="connsiteX11" fmla="*/ 261419 w 795909"/>
              <a:gd name="connsiteY11" fmla="*/ 2419355 h 2444232"/>
              <a:gd name="connsiteX12" fmla="*/ 404294 w 795909"/>
              <a:gd name="connsiteY12" fmla="*/ 2105030 h 2444232"/>
              <a:gd name="connsiteX13" fmla="*/ 518594 w 795909"/>
              <a:gd name="connsiteY13" fmla="*/ 1895480 h 2444232"/>
              <a:gd name="connsiteX14" fmla="*/ 594794 w 795909"/>
              <a:gd name="connsiteY14" fmla="*/ 1552580 h 2444232"/>
              <a:gd name="connsiteX15" fmla="*/ 613844 w 795909"/>
              <a:gd name="connsiteY15" fmla="*/ 1276355 h 2444232"/>
              <a:gd name="connsiteX16" fmla="*/ 632894 w 795909"/>
              <a:gd name="connsiteY16" fmla="*/ 1157292 h 2444232"/>
              <a:gd name="connsiteX17" fmla="*/ 699569 w 795909"/>
              <a:gd name="connsiteY17" fmla="*/ 1057279 h 2444232"/>
              <a:gd name="connsiteX18" fmla="*/ 732907 w 795909"/>
              <a:gd name="connsiteY18" fmla="*/ 942980 h 2444232"/>
              <a:gd name="connsiteX19" fmla="*/ 794819 w 795909"/>
              <a:gd name="connsiteY19" fmla="*/ 866780 h 2444232"/>
              <a:gd name="connsiteX20" fmla="*/ 670994 w 795909"/>
              <a:gd name="connsiteY20" fmla="*/ 771530 h 2444232"/>
              <a:gd name="connsiteX21" fmla="*/ 366194 w 795909"/>
              <a:gd name="connsiteY21" fmla="*/ 504830 h 2444232"/>
              <a:gd name="connsiteX22" fmla="*/ 142357 w 795909"/>
              <a:gd name="connsiteY22" fmla="*/ 5 h 2444232"/>
              <a:gd name="connsiteX0" fmla="*/ 142357 w 795909"/>
              <a:gd name="connsiteY0" fmla="*/ 5 h 2444232"/>
              <a:gd name="connsiteX1" fmla="*/ 189982 w 795909"/>
              <a:gd name="connsiteY1" fmla="*/ 514355 h 2444232"/>
              <a:gd name="connsiteX2" fmla="*/ 175694 w 795909"/>
              <a:gd name="connsiteY2" fmla="*/ 847730 h 2444232"/>
              <a:gd name="connsiteX3" fmla="*/ 185219 w 795909"/>
              <a:gd name="connsiteY3" fmla="*/ 1004893 h 2444232"/>
              <a:gd name="connsiteX4" fmla="*/ 137594 w 795909"/>
              <a:gd name="connsiteY4" fmla="*/ 1209680 h 2444232"/>
              <a:gd name="connsiteX5" fmla="*/ 137594 w 795909"/>
              <a:gd name="connsiteY5" fmla="*/ 1333505 h 2444232"/>
              <a:gd name="connsiteX6" fmla="*/ 128069 w 795909"/>
              <a:gd name="connsiteY6" fmla="*/ 1476380 h 2444232"/>
              <a:gd name="connsiteX7" fmla="*/ 99494 w 795909"/>
              <a:gd name="connsiteY7" fmla="*/ 1819280 h 2444232"/>
              <a:gd name="connsiteX8" fmla="*/ 4244 w 795909"/>
              <a:gd name="connsiteY8" fmla="*/ 2152655 h 2444232"/>
              <a:gd name="connsiteX9" fmla="*/ 32819 w 795909"/>
              <a:gd name="connsiteY9" fmla="*/ 2428880 h 2444232"/>
              <a:gd name="connsiteX10" fmla="*/ 175694 w 795909"/>
              <a:gd name="connsiteY10" fmla="*/ 2409830 h 2444232"/>
              <a:gd name="connsiteX11" fmla="*/ 261419 w 795909"/>
              <a:gd name="connsiteY11" fmla="*/ 2419355 h 2444232"/>
              <a:gd name="connsiteX12" fmla="*/ 404294 w 795909"/>
              <a:gd name="connsiteY12" fmla="*/ 2105030 h 2444232"/>
              <a:gd name="connsiteX13" fmla="*/ 518594 w 795909"/>
              <a:gd name="connsiteY13" fmla="*/ 1895480 h 2444232"/>
              <a:gd name="connsiteX14" fmla="*/ 594794 w 795909"/>
              <a:gd name="connsiteY14" fmla="*/ 1552580 h 2444232"/>
              <a:gd name="connsiteX15" fmla="*/ 613844 w 795909"/>
              <a:gd name="connsiteY15" fmla="*/ 1276355 h 2444232"/>
              <a:gd name="connsiteX16" fmla="*/ 632894 w 795909"/>
              <a:gd name="connsiteY16" fmla="*/ 1157292 h 2444232"/>
              <a:gd name="connsiteX17" fmla="*/ 699569 w 795909"/>
              <a:gd name="connsiteY17" fmla="*/ 1057279 h 2444232"/>
              <a:gd name="connsiteX18" fmla="*/ 732907 w 795909"/>
              <a:gd name="connsiteY18" fmla="*/ 942980 h 2444232"/>
              <a:gd name="connsiteX19" fmla="*/ 794819 w 795909"/>
              <a:gd name="connsiteY19" fmla="*/ 866780 h 2444232"/>
              <a:gd name="connsiteX20" fmla="*/ 670994 w 795909"/>
              <a:gd name="connsiteY20" fmla="*/ 771530 h 2444232"/>
              <a:gd name="connsiteX21" fmla="*/ 366194 w 795909"/>
              <a:gd name="connsiteY21" fmla="*/ 504830 h 2444232"/>
              <a:gd name="connsiteX22" fmla="*/ 142357 w 795909"/>
              <a:gd name="connsiteY22" fmla="*/ 5 h 2444232"/>
              <a:gd name="connsiteX0" fmla="*/ 142357 w 795909"/>
              <a:gd name="connsiteY0" fmla="*/ 5 h 2444232"/>
              <a:gd name="connsiteX1" fmla="*/ 189982 w 795909"/>
              <a:gd name="connsiteY1" fmla="*/ 514355 h 2444232"/>
              <a:gd name="connsiteX2" fmla="*/ 175694 w 795909"/>
              <a:gd name="connsiteY2" fmla="*/ 847730 h 2444232"/>
              <a:gd name="connsiteX3" fmla="*/ 185219 w 795909"/>
              <a:gd name="connsiteY3" fmla="*/ 1004893 h 2444232"/>
              <a:gd name="connsiteX4" fmla="*/ 137594 w 795909"/>
              <a:gd name="connsiteY4" fmla="*/ 1209680 h 2444232"/>
              <a:gd name="connsiteX5" fmla="*/ 137594 w 795909"/>
              <a:gd name="connsiteY5" fmla="*/ 1333505 h 2444232"/>
              <a:gd name="connsiteX6" fmla="*/ 128069 w 795909"/>
              <a:gd name="connsiteY6" fmla="*/ 1476380 h 2444232"/>
              <a:gd name="connsiteX7" fmla="*/ 99494 w 795909"/>
              <a:gd name="connsiteY7" fmla="*/ 1819280 h 2444232"/>
              <a:gd name="connsiteX8" fmla="*/ 4244 w 795909"/>
              <a:gd name="connsiteY8" fmla="*/ 2152655 h 2444232"/>
              <a:gd name="connsiteX9" fmla="*/ 32819 w 795909"/>
              <a:gd name="connsiteY9" fmla="*/ 2428880 h 2444232"/>
              <a:gd name="connsiteX10" fmla="*/ 175694 w 795909"/>
              <a:gd name="connsiteY10" fmla="*/ 2409830 h 2444232"/>
              <a:gd name="connsiteX11" fmla="*/ 261419 w 795909"/>
              <a:gd name="connsiteY11" fmla="*/ 2419355 h 2444232"/>
              <a:gd name="connsiteX12" fmla="*/ 404294 w 795909"/>
              <a:gd name="connsiteY12" fmla="*/ 2105030 h 2444232"/>
              <a:gd name="connsiteX13" fmla="*/ 518594 w 795909"/>
              <a:gd name="connsiteY13" fmla="*/ 1895480 h 2444232"/>
              <a:gd name="connsiteX14" fmla="*/ 594794 w 795909"/>
              <a:gd name="connsiteY14" fmla="*/ 1552580 h 2444232"/>
              <a:gd name="connsiteX15" fmla="*/ 613844 w 795909"/>
              <a:gd name="connsiteY15" fmla="*/ 1276355 h 2444232"/>
              <a:gd name="connsiteX16" fmla="*/ 632894 w 795909"/>
              <a:gd name="connsiteY16" fmla="*/ 1157292 h 2444232"/>
              <a:gd name="connsiteX17" fmla="*/ 699569 w 795909"/>
              <a:gd name="connsiteY17" fmla="*/ 1057279 h 2444232"/>
              <a:gd name="connsiteX18" fmla="*/ 732907 w 795909"/>
              <a:gd name="connsiteY18" fmla="*/ 942980 h 2444232"/>
              <a:gd name="connsiteX19" fmla="*/ 794819 w 795909"/>
              <a:gd name="connsiteY19" fmla="*/ 866780 h 2444232"/>
              <a:gd name="connsiteX20" fmla="*/ 670994 w 795909"/>
              <a:gd name="connsiteY20" fmla="*/ 771530 h 2444232"/>
              <a:gd name="connsiteX21" fmla="*/ 366194 w 795909"/>
              <a:gd name="connsiteY21" fmla="*/ 504830 h 2444232"/>
              <a:gd name="connsiteX22" fmla="*/ 142357 w 795909"/>
              <a:gd name="connsiteY22" fmla="*/ 5 h 2444232"/>
              <a:gd name="connsiteX0" fmla="*/ 142357 w 742784"/>
              <a:gd name="connsiteY0" fmla="*/ 5 h 2444232"/>
              <a:gd name="connsiteX1" fmla="*/ 189982 w 742784"/>
              <a:gd name="connsiteY1" fmla="*/ 514355 h 2444232"/>
              <a:gd name="connsiteX2" fmla="*/ 175694 w 742784"/>
              <a:gd name="connsiteY2" fmla="*/ 847730 h 2444232"/>
              <a:gd name="connsiteX3" fmla="*/ 185219 w 742784"/>
              <a:gd name="connsiteY3" fmla="*/ 1004893 h 2444232"/>
              <a:gd name="connsiteX4" fmla="*/ 137594 w 742784"/>
              <a:gd name="connsiteY4" fmla="*/ 1209680 h 2444232"/>
              <a:gd name="connsiteX5" fmla="*/ 137594 w 742784"/>
              <a:gd name="connsiteY5" fmla="*/ 1333505 h 2444232"/>
              <a:gd name="connsiteX6" fmla="*/ 128069 w 742784"/>
              <a:gd name="connsiteY6" fmla="*/ 1476380 h 2444232"/>
              <a:gd name="connsiteX7" fmla="*/ 99494 w 742784"/>
              <a:gd name="connsiteY7" fmla="*/ 1819280 h 2444232"/>
              <a:gd name="connsiteX8" fmla="*/ 4244 w 742784"/>
              <a:gd name="connsiteY8" fmla="*/ 2152655 h 2444232"/>
              <a:gd name="connsiteX9" fmla="*/ 32819 w 742784"/>
              <a:gd name="connsiteY9" fmla="*/ 2428880 h 2444232"/>
              <a:gd name="connsiteX10" fmla="*/ 175694 w 742784"/>
              <a:gd name="connsiteY10" fmla="*/ 2409830 h 2444232"/>
              <a:gd name="connsiteX11" fmla="*/ 261419 w 742784"/>
              <a:gd name="connsiteY11" fmla="*/ 2419355 h 2444232"/>
              <a:gd name="connsiteX12" fmla="*/ 404294 w 742784"/>
              <a:gd name="connsiteY12" fmla="*/ 2105030 h 2444232"/>
              <a:gd name="connsiteX13" fmla="*/ 518594 w 742784"/>
              <a:gd name="connsiteY13" fmla="*/ 1895480 h 2444232"/>
              <a:gd name="connsiteX14" fmla="*/ 594794 w 742784"/>
              <a:gd name="connsiteY14" fmla="*/ 1552580 h 2444232"/>
              <a:gd name="connsiteX15" fmla="*/ 613844 w 742784"/>
              <a:gd name="connsiteY15" fmla="*/ 1276355 h 2444232"/>
              <a:gd name="connsiteX16" fmla="*/ 632894 w 742784"/>
              <a:gd name="connsiteY16" fmla="*/ 1157292 h 2444232"/>
              <a:gd name="connsiteX17" fmla="*/ 699569 w 742784"/>
              <a:gd name="connsiteY17" fmla="*/ 1057279 h 2444232"/>
              <a:gd name="connsiteX18" fmla="*/ 732907 w 742784"/>
              <a:gd name="connsiteY18" fmla="*/ 942980 h 2444232"/>
              <a:gd name="connsiteX19" fmla="*/ 509069 w 742784"/>
              <a:gd name="connsiteY19" fmla="*/ 933455 h 2444232"/>
              <a:gd name="connsiteX20" fmla="*/ 670994 w 742784"/>
              <a:gd name="connsiteY20" fmla="*/ 771530 h 2444232"/>
              <a:gd name="connsiteX21" fmla="*/ 366194 w 742784"/>
              <a:gd name="connsiteY21" fmla="*/ 504830 h 2444232"/>
              <a:gd name="connsiteX22" fmla="*/ 142357 w 742784"/>
              <a:gd name="connsiteY22" fmla="*/ 5 h 2444232"/>
              <a:gd name="connsiteX0" fmla="*/ 142357 w 742784"/>
              <a:gd name="connsiteY0" fmla="*/ 5 h 2444232"/>
              <a:gd name="connsiteX1" fmla="*/ 189982 w 742784"/>
              <a:gd name="connsiteY1" fmla="*/ 514355 h 2444232"/>
              <a:gd name="connsiteX2" fmla="*/ 175694 w 742784"/>
              <a:gd name="connsiteY2" fmla="*/ 847730 h 2444232"/>
              <a:gd name="connsiteX3" fmla="*/ 185219 w 742784"/>
              <a:gd name="connsiteY3" fmla="*/ 1004893 h 2444232"/>
              <a:gd name="connsiteX4" fmla="*/ 137594 w 742784"/>
              <a:gd name="connsiteY4" fmla="*/ 1209680 h 2444232"/>
              <a:gd name="connsiteX5" fmla="*/ 137594 w 742784"/>
              <a:gd name="connsiteY5" fmla="*/ 1333505 h 2444232"/>
              <a:gd name="connsiteX6" fmla="*/ 128069 w 742784"/>
              <a:gd name="connsiteY6" fmla="*/ 1476380 h 2444232"/>
              <a:gd name="connsiteX7" fmla="*/ 99494 w 742784"/>
              <a:gd name="connsiteY7" fmla="*/ 1819280 h 2444232"/>
              <a:gd name="connsiteX8" fmla="*/ 4244 w 742784"/>
              <a:gd name="connsiteY8" fmla="*/ 2152655 h 2444232"/>
              <a:gd name="connsiteX9" fmla="*/ 32819 w 742784"/>
              <a:gd name="connsiteY9" fmla="*/ 2428880 h 2444232"/>
              <a:gd name="connsiteX10" fmla="*/ 175694 w 742784"/>
              <a:gd name="connsiteY10" fmla="*/ 2409830 h 2444232"/>
              <a:gd name="connsiteX11" fmla="*/ 261419 w 742784"/>
              <a:gd name="connsiteY11" fmla="*/ 2419355 h 2444232"/>
              <a:gd name="connsiteX12" fmla="*/ 404294 w 742784"/>
              <a:gd name="connsiteY12" fmla="*/ 2105030 h 2444232"/>
              <a:gd name="connsiteX13" fmla="*/ 518594 w 742784"/>
              <a:gd name="connsiteY13" fmla="*/ 1895480 h 2444232"/>
              <a:gd name="connsiteX14" fmla="*/ 594794 w 742784"/>
              <a:gd name="connsiteY14" fmla="*/ 1552580 h 2444232"/>
              <a:gd name="connsiteX15" fmla="*/ 613844 w 742784"/>
              <a:gd name="connsiteY15" fmla="*/ 1276355 h 2444232"/>
              <a:gd name="connsiteX16" fmla="*/ 632894 w 742784"/>
              <a:gd name="connsiteY16" fmla="*/ 1157292 h 2444232"/>
              <a:gd name="connsiteX17" fmla="*/ 699569 w 742784"/>
              <a:gd name="connsiteY17" fmla="*/ 1057279 h 2444232"/>
              <a:gd name="connsiteX18" fmla="*/ 732907 w 742784"/>
              <a:gd name="connsiteY18" fmla="*/ 942980 h 2444232"/>
              <a:gd name="connsiteX19" fmla="*/ 509069 w 742784"/>
              <a:gd name="connsiteY19" fmla="*/ 933455 h 2444232"/>
              <a:gd name="connsiteX20" fmla="*/ 342381 w 742784"/>
              <a:gd name="connsiteY20" fmla="*/ 800105 h 2444232"/>
              <a:gd name="connsiteX21" fmla="*/ 366194 w 742784"/>
              <a:gd name="connsiteY21" fmla="*/ 504830 h 2444232"/>
              <a:gd name="connsiteX22" fmla="*/ 142357 w 742784"/>
              <a:gd name="connsiteY22" fmla="*/ 5 h 2444232"/>
              <a:gd name="connsiteX0" fmla="*/ 142357 w 742784"/>
              <a:gd name="connsiteY0" fmla="*/ 5 h 2444232"/>
              <a:gd name="connsiteX1" fmla="*/ 189982 w 742784"/>
              <a:gd name="connsiteY1" fmla="*/ 514355 h 2444232"/>
              <a:gd name="connsiteX2" fmla="*/ 175694 w 742784"/>
              <a:gd name="connsiteY2" fmla="*/ 847730 h 2444232"/>
              <a:gd name="connsiteX3" fmla="*/ 185219 w 742784"/>
              <a:gd name="connsiteY3" fmla="*/ 1004893 h 2444232"/>
              <a:gd name="connsiteX4" fmla="*/ 137594 w 742784"/>
              <a:gd name="connsiteY4" fmla="*/ 1209680 h 2444232"/>
              <a:gd name="connsiteX5" fmla="*/ 137594 w 742784"/>
              <a:gd name="connsiteY5" fmla="*/ 1333505 h 2444232"/>
              <a:gd name="connsiteX6" fmla="*/ 128069 w 742784"/>
              <a:gd name="connsiteY6" fmla="*/ 1476380 h 2444232"/>
              <a:gd name="connsiteX7" fmla="*/ 99494 w 742784"/>
              <a:gd name="connsiteY7" fmla="*/ 1819280 h 2444232"/>
              <a:gd name="connsiteX8" fmla="*/ 4244 w 742784"/>
              <a:gd name="connsiteY8" fmla="*/ 2152655 h 2444232"/>
              <a:gd name="connsiteX9" fmla="*/ 32819 w 742784"/>
              <a:gd name="connsiteY9" fmla="*/ 2428880 h 2444232"/>
              <a:gd name="connsiteX10" fmla="*/ 175694 w 742784"/>
              <a:gd name="connsiteY10" fmla="*/ 2409830 h 2444232"/>
              <a:gd name="connsiteX11" fmla="*/ 261419 w 742784"/>
              <a:gd name="connsiteY11" fmla="*/ 2419355 h 2444232"/>
              <a:gd name="connsiteX12" fmla="*/ 404294 w 742784"/>
              <a:gd name="connsiteY12" fmla="*/ 2105030 h 2444232"/>
              <a:gd name="connsiteX13" fmla="*/ 518594 w 742784"/>
              <a:gd name="connsiteY13" fmla="*/ 1895480 h 2444232"/>
              <a:gd name="connsiteX14" fmla="*/ 594794 w 742784"/>
              <a:gd name="connsiteY14" fmla="*/ 1552580 h 2444232"/>
              <a:gd name="connsiteX15" fmla="*/ 613844 w 742784"/>
              <a:gd name="connsiteY15" fmla="*/ 1276355 h 2444232"/>
              <a:gd name="connsiteX16" fmla="*/ 632894 w 742784"/>
              <a:gd name="connsiteY16" fmla="*/ 1157292 h 2444232"/>
              <a:gd name="connsiteX17" fmla="*/ 699569 w 742784"/>
              <a:gd name="connsiteY17" fmla="*/ 1057279 h 2444232"/>
              <a:gd name="connsiteX18" fmla="*/ 732907 w 742784"/>
              <a:gd name="connsiteY18" fmla="*/ 942980 h 2444232"/>
              <a:gd name="connsiteX19" fmla="*/ 509069 w 742784"/>
              <a:gd name="connsiteY19" fmla="*/ 933455 h 2444232"/>
              <a:gd name="connsiteX20" fmla="*/ 428106 w 742784"/>
              <a:gd name="connsiteY20" fmla="*/ 809630 h 2444232"/>
              <a:gd name="connsiteX21" fmla="*/ 366194 w 742784"/>
              <a:gd name="connsiteY21" fmla="*/ 504830 h 2444232"/>
              <a:gd name="connsiteX22" fmla="*/ 142357 w 742784"/>
              <a:gd name="connsiteY22" fmla="*/ 5 h 2444232"/>
              <a:gd name="connsiteX0" fmla="*/ 142357 w 700210"/>
              <a:gd name="connsiteY0" fmla="*/ 5 h 2444232"/>
              <a:gd name="connsiteX1" fmla="*/ 189982 w 700210"/>
              <a:gd name="connsiteY1" fmla="*/ 514355 h 2444232"/>
              <a:gd name="connsiteX2" fmla="*/ 175694 w 700210"/>
              <a:gd name="connsiteY2" fmla="*/ 847730 h 2444232"/>
              <a:gd name="connsiteX3" fmla="*/ 185219 w 700210"/>
              <a:gd name="connsiteY3" fmla="*/ 1004893 h 2444232"/>
              <a:gd name="connsiteX4" fmla="*/ 137594 w 700210"/>
              <a:gd name="connsiteY4" fmla="*/ 1209680 h 2444232"/>
              <a:gd name="connsiteX5" fmla="*/ 137594 w 700210"/>
              <a:gd name="connsiteY5" fmla="*/ 1333505 h 2444232"/>
              <a:gd name="connsiteX6" fmla="*/ 128069 w 700210"/>
              <a:gd name="connsiteY6" fmla="*/ 1476380 h 2444232"/>
              <a:gd name="connsiteX7" fmla="*/ 99494 w 700210"/>
              <a:gd name="connsiteY7" fmla="*/ 1819280 h 2444232"/>
              <a:gd name="connsiteX8" fmla="*/ 4244 w 700210"/>
              <a:gd name="connsiteY8" fmla="*/ 2152655 h 2444232"/>
              <a:gd name="connsiteX9" fmla="*/ 32819 w 700210"/>
              <a:gd name="connsiteY9" fmla="*/ 2428880 h 2444232"/>
              <a:gd name="connsiteX10" fmla="*/ 175694 w 700210"/>
              <a:gd name="connsiteY10" fmla="*/ 2409830 h 2444232"/>
              <a:gd name="connsiteX11" fmla="*/ 261419 w 700210"/>
              <a:gd name="connsiteY11" fmla="*/ 2419355 h 2444232"/>
              <a:gd name="connsiteX12" fmla="*/ 404294 w 700210"/>
              <a:gd name="connsiteY12" fmla="*/ 2105030 h 2444232"/>
              <a:gd name="connsiteX13" fmla="*/ 518594 w 700210"/>
              <a:gd name="connsiteY13" fmla="*/ 1895480 h 2444232"/>
              <a:gd name="connsiteX14" fmla="*/ 594794 w 700210"/>
              <a:gd name="connsiteY14" fmla="*/ 1552580 h 2444232"/>
              <a:gd name="connsiteX15" fmla="*/ 613844 w 700210"/>
              <a:gd name="connsiteY15" fmla="*/ 1276355 h 2444232"/>
              <a:gd name="connsiteX16" fmla="*/ 632894 w 700210"/>
              <a:gd name="connsiteY16" fmla="*/ 1157292 h 2444232"/>
              <a:gd name="connsiteX17" fmla="*/ 699569 w 700210"/>
              <a:gd name="connsiteY17" fmla="*/ 1057279 h 2444232"/>
              <a:gd name="connsiteX18" fmla="*/ 542407 w 700210"/>
              <a:gd name="connsiteY18" fmla="*/ 1057280 h 2444232"/>
              <a:gd name="connsiteX19" fmla="*/ 509069 w 700210"/>
              <a:gd name="connsiteY19" fmla="*/ 933455 h 2444232"/>
              <a:gd name="connsiteX20" fmla="*/ 428106 w 700210"/>
              <a:gd name="connsiteY20" fmla="*/ 809630 h 2444232"/>
              <a:gd name="connsiteX21" fmla="*/ 366194 w 700210"/>
              <a:gd name="connsiteY21" fmla="*/ 504830 h 2444232"/>
              <a:gd name="connsiteX22" fmla="*/ 142357 w 700210"/>
              <a:gd name="connsiteY22" fmla="*/ 5 h 2444232"/>
              <a:gd name="connsiteX0" fmla="*/ 142357 w 704056"/>
              <a:gd name="connsiteY0" fmla="*/ 5 h 2444232"/>
              <a:gd name="connsiteX1" fmla="*/ 189982 w 704056"/>
              <a:gd name="connsiteY1" fmla="*/ 514355 h 2444232"/>
              <a:gd name="connsiteX2" fmla="*/ 175694 w 704056"/>
              <a:gd name="connsiteY2" fmla="*/ 847730 h 2444232"/>
              <a:gd name="connsiteX3" fmla="*/ 185219 w 704056"/>
              <a:gd name="connsiteY3" fmla="*/ 1004893 h 2444232"/>
              <a:gd name="connsiteX4" fmla="*/ 137594 w 704056"/>
              <a:gd name="connsiteY4" fmla="*/ 1209680 h 2444232"/>
              <a:gd name="connsiteX5" fmla="*/ 137594 w 704056"/>
              <a:gd name="connsiteY5" fmla="*/ 1333505 h 2444232"/>
              <a:gd name="connsiteX6" fmla="*/ 128069 w 704056"/>
              <a:gd name="connsiteY6" fmla="*/ 1476380 h 2444232"/>
              <a:gd name="connsiteX7" fmla="*/ 99494 w 704056"/>
              <a:gd name="connsiteY7" fmla="*/ 1819280 h 2444232"/>
              <a:gd name="connsiteX8" fmla="*/ 4244 w 704056"/>
              <a:gd name="connsiteY8" fmla="*/ 2152655 h 2444232"/>
              <a:gd name="connsiteX9" fmla="*/ 32819 w 704056"/>
              <a:gd name="connsiteY9" fmla="*/ 2428880 h 2444232"/>
              <a:gd name="connsiteX10" fmla="*/ 175694 w 704056"/>
              <a:gd name="connsiteY10" fmla="*/ 2409830 h 2444232"/>
              <a:gd name="connsiteX11" fmla="*/ 261419 w 704056"/>
              <a:gd name="connsiteY11" fmla="*/ 2419355 h 2444232"/>
              <a:gd name="connsiteX12" fmla="*/ 404294 w 704056"/>
              <a:gd name="connsiteY12" fmla="*/ 2105030 h 2444232"/>
              <a:gd name="connsiteX13" fmla="*/ 518594 w 704056"/>
              <a:gd name="connsiteY13" fmla="*/ 1895480 h 2444232"/>
              <a:gd name="connsiteX14" fmla="*/ 594794 w 704056"/>
              <a:gd name="connsiteY14" fmla="*/ 1552580 h 2444232"/>
              <a:gd name="connsiteX15" fmla="*/ 613844 w 704056"/>
              <a:gd name="connsiteY15" fmla="*/ 1276355 h 2444232"/>
              <a:gd name="connsiteX16" fmla="*/ 699569 w 704056"/>
              <a:gd name="connsiteY16" fmla="*/ 1147767 h 2444232"/>
              <a:gd name="connsiteX17" fmla="*/ 699569 w 704056"/>
              <a:gd name="connsiteY17" fmla="*/ 1057279 h 2444232"/>
              <a:gd name="connsiteX18" fmla="*/ 542407 w 704056"/>
              <a:gd name="connsiteY18" fmla="*/ 1057280 h 2444232"/>
              <a:gd name="connsiteX19" fmla="*/ 509069 w 704056"/>
              <a:gd name="connsiteY19" fmla="*/ 933455 h 2444232"/>
              <a:gd name="connsiteX20" fmla="*/ 428106 w 704056"/>
              <a:gd name="connsiteY20" fmla="*/ 809630 h 2444232"/>
              <a:gd name="connsiteX21" fmla="*/ 366194 w 704056"/>
              <a:gd name="connsiteY21" fmla="*/ 504830 h 2444232"/>
              <a:gd name="connsiteX22" fmla="*/ 142357 w 704056"/>
              <a:gd name="connsiteY22" fmla="*/ 5 h 2444232"/>
              <a:gd name="connsiteX0" fmla="*/ 142357 w 702501"/>
              <a:gd name="connsiteY0" fmla="*/ 5 h 2444232"/>
              <a:gd name="connsiteX1" fmla="*/ 189982 w 702501"/>
              <a:gd name="connsiteY1" fmla="*/ 514355 h 2444232"/>
              <a:gd name="connsiteX2" fmla="*/ 175694 w 702501"/>
              <a:gd name="connsiteY2" fmla="*/ 847730 h 2444232"/>
              <a:gd name="connsiteX3" fmla="*/ 185219 w 702501"/>
              <a:gd name="connsiteY3" fmla="*/ 1004893 h 2444232"/>
              <a:gd name="connsiteX4" fmla="*/ 137594 w 702501"/>
              <a:gd name="connsiteY4" fmla="*/ 1209680 h 2444232"/>
              <a:gd name="connsiteX5" fmla="*/ 137594 w 702501"/>
              <a:gd name="connsiteY5" fmla="*/ 1333505 h 2444232"/>
              <a:gd name="connsiteX6" fmla="*/ 128069 w 702501"/>
              <a:gd name="connsiteY6" fmla="*/ 1476380 h 2444232"/>
              <a:gd name="connsiteX7" fmla="*/ 99494 w 702501"/>
              <a:gd name="connsiteY7" fmla="*/ 1819280 h 2444232"/>
              <a:gd name="connsiteX8" fmla="*/ 4244 w 702501"/>
              <a:gd name="connsiteY8" fmla="*/ 2152655 h 2444232"/>
              <a:gd name="connsiteX9" fmla="*/ 32819 w 702501"/>
              <a:gd name="connsiteY9" fmla="*/ 2428880 h 2444232"/>
              <a:gd name="connsiteX10" fmla="*/ 175694 w 702501"/>
              <a:gd name="connsiteY10" fmla="*/ 2409830 h 2444232"/>
              <a:gd name="connsiteX11" fmla="*/ 261419 w 702501"/>
              <a:gd name="connsiteY11" fmla="*/ 2419355 h 2444232"/>
              <a:gd name="connsiteX12" fmla="*/ 404294 w 702501"/>
              <a:gd name="connsiteY12" fmla="*/ 2105030 h 2444232"/>
              <a:gd name="connsiteX13" fmla="*/ 518594 w 702501"/>
              <a:gd name="connsiteY13" fmla="*/ 1895480 h 2444232"/>
              <a:gd name="connsiteX14" fmla="*/ 594794 w 702501"/>
              <a:gd name="connsiteY14" fmla="*/ 1552580 h 2444232"/>
              <a:gd name="connsiteX15" fmla="*/ 613844 w 702501"/>
              <a:gd name="connsiteY15" fmla="*/ 1276355 h 2444232"/>
              <a:gd name="connsiteX16" fmla="*/ 699569 w 702501"/>
              <a:gd name="connsiteY16" fmla="*/ 1147767 h 2444232"/>
              <a:gd name="connsiteX17" fmla="*/ 690044 w 702501"/>
              <a:gd name="connsiteY17" fmla="*/ 1104904 h 2444232"/>
              <a:gd name="connsiteX18" fmla="*/ 542407 w 702501"/>
              <a:gd name="connsiteY18" fmla="*/ 1057280 h 2444232"/>
              <a:gd name="connsiteX19" fmla="*/ 509069 w 702501"/>
              <a:gd name="connsiteY19" fmla="*/ 933455 h 2444232"/>
              <a:gd name="connsiteX20" fmla="*/ 428106 w 702501"/>
              <a:gd name="connsiteY20" fmla="*/ 809630 h 2444232"/>
              <a:gd name="connsiteX21" fmla="*/ 366194 w 702501"/>
              <a:gd name="connsiteY21" fmla="*/ 504830 h 2444232"/>
              <a:gd name="connsiteX22" fmla="*/ 142357 w 702501"/>
              <a:gd name="connsiteY22" fmla="*/ 5 h 2444232"/>
              <a:gd name="connsiteX0" fmla="*/ 142357 w 702501"/>
              <a:gd name="connsiteY0" fmla="*/ 3799 h 2448026"/>
              <a:gd name="connsiteX1" fmla="*/ 132833 w 702501"/>
              <a:gd name="connsiteY1" fmla="*/ 289548 h 2448026"/>
              <a:gd name="connsiteX2" fmla="*/ 189982 w 702501"/>
              <a:gd name="connsiteY2" fmla="*/ 518149 h 2448026"/>
              <a:gd name="connsiteX3" fmla="*/ 175694 w 702501"/>
              <a:gd name="connsiteY3" fmla="*/ 851524 h 2448026"/>
              <a:gd name="connsiteX4" fmla="*/ 185219 w 702501"/>
              <a:gd name="connsiteY4" fmla="*/ 1008687 h 2448026"/>
              <a:gd name="connsiteX5" fmla="*/ 137594 w 702501"/>
              <a:gd name="connsiteY5" fmla="*/ 1213474 h 2448026"/>
              <a:gd name="connsiteX6" fmla="*/ 137594 w 702501"/>
              <a:gd name="connsiteY6" fmla="*/ 1337299 h 2448026"/>
              <a:gd name="connsiteX7" fmla="*/ 128069 w 702501"/>
              <a:gd name="connsiteY7" fmla="*/ 1480174 h 2448026"/>
              <a:gd name="connsiteX8" fmla="*/ 99494 w 702501"/>
              <a:gd name="connsiteY8" fmla="*/ 1823074 h 2448026"/>
              <a:gd name="connsiteX9" fmla="*/ 4244 w 702501"/>
              <a:gd name="connsiteY9" fmla="*/ 2156449 h 2448026"/>
              <a:gd name="connsiteX10" fmla="*/ 32819 w 702501"/>
              <a:gd name="connsiteY10" fmla="*/ 2432674 h 2448026"/>
              <a:gd name="connsiteX11" fmla="*/ 175694 w 702501"/>
              <a:gd name="connsiteY11" fmla="*/ 2413624 h 2448026"/>
              <a:gd name="connsiteX12" fmla="*/ 261419 w 702501"/>
              <a:gd name="connsiteY12" fmla="*/ 2423149 h 2448026"/>
              <a:gd name="connsiteX13" fmla="*/ 404294 w 702501"/>
              <a:gd name="connsiteY13" fmla="*/ 2108824 h 2448026"/>
              <a:gd name="connsiteX14" fmla="*/ 518594 w 702501"/>
              <a:gd name="connsiteY14" fmla="*/ 1899274 h 2448026"/>
              <a:gd name="connsiteX15" fmla="*/ 594794 w 702501"/>
              <a:gd name="connsiteY15" fmla="*/ 1556374 h 2448026"/>
              <a:gd name="connsiteX16" fmla="*/ 613844 w 702501"/>
              <a:gd name="connsiteY16" fmla="*/ 1280149 h 2448026"/>
              <a:gd name="connsiteX17" fmla="*/ 699569 w 702501"/>
              <a:gd name="connsiteY17" fmla="*/ 1151561 h 2448026"/>
              <a:gd name="connsiteX18" fmla="*/ 690044 w 702501"/>
              <a:gd name="connsiteY18" fmla="*/ 1108698 h 2448026"/>
              <a:gd name="connsiteX19" fmla="*/ 542407 w 702501"/>
              <a:gd name="connsiteY19" fmla="*/ 1061074 h 2448026"/>
              <a:gd name="connsiteX20" fmla="*/ 509069 w 702501"/>
              <a:gd name="connsiteY20" fmla="*/ 937249 h 2448026"/>
              <a:gd name="connsiteX21" fmla="*/ 428106 w 702501"/>
              <a:gd name="connsiteY21" fmla="*/ 813424 h 2448026"/>
              <a:gd name="connsiteX22" fmla="*/ 366194 w 702501"/>
              <a:gd name="connsiteY22" fmla="*/ 508624 h 2448026"/>
              <a:gd name="connsiteX23" fmla="*/ 142357 w 702501"/>
              <a:gd name="connsiteY23" fmla="*/ 3799 h 2448026"/>
              <a:gd name="connsiteX0" fmla="*/ 142357 w 702501"/>
              <a:gd name="connsiteY0" fmla="*/ 266 h 2444493"/>
              <a:gd name="connsiteX1" fmla="*/ 132833 w 702501"/>
              <a:gd name="connsiteY1" fmla="*/ 286015 h 2444493"/>
              <a:gd name="connsiteX2" fmla="*/ 189982 w 702501"/>
              <a:gd name="connsiteY2" fmla="*/ 514616 h 2444493"/>
              <a:gd name="connsiteX3" fmla="*/ 175694 w 702501"/>
              <a:gd name="connsiteY3" fmla="*/ 847991 h 2444493"/>
              <a:gd name="connsiteX4" fmla="*/ 185219 w 702501"/>
              <a:gd name="connsiteY4" fmla="*/ 1005154 h 2444493"/>
              <a:gd name="connsiteX5" fmla="*/ 137594 w 702501"/>
              <a:gd name="connsiteY5" fmla="*/ 1209941 h 2444493"/>
              <a:gd name="connsiteX6" fmla="*/ 137594 w 702501"/>
              <a:gd name="connsiteY6" fmla="*/ 1333766 h 2444493"/>
              <a:gd name="connsiteX7" fmla="*/ 128069 w 702501"/>
              <a:gd name="connsiteY7" fmla="*/ 1476641 h 2444493"/>
              <a:gd name="connsiteX8" fmla="*/ 99494 w 702501"/>
              <a:gd name="connsiteY8" fmla="*/ 1819541 h 2444493"/>
              <a:gd name="connsiteX9" fmla="*/ 4244 w 702501"/>
              <a:gd name="connsiteY9" fmla="*/ 2152916 h 2444493"/>
              <a:gd name="connsiteX10" fmla="*/ 32819 w 702501"/>
              <a:gd name="connsiteY10" fmla="*/ 2429141 h 2444493"/>
              <a:gd name="connsiteX11" fmla="*/ 175694 w 702501"/>
              <a:gd name="connsiteY11" fmla="*/ 2410091 h 2444493"/>
              <a:gd name="connsiteX12" fmla="*/ 261419 w 702501"/>
              <a:gd name="connsiteY12" fmla="*/ 2419616 h 2444493"/>
              <a:gd name="connsiteX13" fmla="*/ 404294 w 702501"/>
              <a:gd name="connsiteY13" fmla="*/ 2105291 h 2444493"/>
              <a:gd name="connsiteX14" fmla="*/ 518594 w 702501"/>
              <a:gd name="connsiteY14" fmla="*/ 1895741 h 2444493"/>
              <a:gd name="connsiteX15" fmla="*/ 594794 w 702501"/>
              <a:gd name="connsiteY15" fmla="*/ 1552841 h 2444493"/>
              <a:gd name="connsiteX16" fmla="*/ 613844 w 702501"/>
              <a:gd name="connsiteY16" fmla="*/ 1276616 h 2444493"/>
              <a:gd name="connsiteX17" fmla="*/ 699569 w 702501"/>
              <a:gd name="connsiteY17" fmla="*/ 1148028 h 2444493"/>
              <a:gd name="connsiteX18" fmla="*/ 690044 w 702501"/>
              <a:gd name="connsiteY18" fmla="*/ 1105165 h 2444493"/>
              <a:gd name="connsiteX19" fmla="*/ 542407 w 702501"/>
              <a:gd name="connsiteY19" fmla="*/ 1057541 h 2444493"/>
              <a:gd name="connsiteX20" fmla="*/ 509069 w 702501"/>
              <a:gd name="connsiteY20" fmla="*/ 933716 h 2444493"/>
              <a:gd name="connsiteX21" fmla="*/ 428106 w 702501"/>
              <a:gd name="connsiteY21" fmla="*/ 809891 h 2444493"/>
              <a:gd name="connsiteX22" fmla="*/ 366194 w 702501"/>
              <a:gd name="connsiteY22" fmla="*/ 505091 h 2444493"/>
              <a:gd name="connsiteX23" fmla="*/ 213795 w 702501"/>
              <a:gd name="connsiteY23" fmla="*/ 338403 h 2444493"/>
              <a:gd name="connsiteX24" fmla="*/ 142357 w 702501"/>
              <a:gd name="connsiteY24" fmla="*/ 266 h 2444493"/>
              <a:gd name="connsiteX0" fmla="*/ 142357 w 702501"/>
              <a:gd name="connsiteY0" fmla="*/ 266 h 2444493"/>
              <a:gd name="connsiteX1" fmla="*/ 132833 w 702501"/>
              <a:gd name="connsiteY1" fmla="*/ 286015 h 2444493"/>
              <a:gd name="connsiteX2" fmla="*/ 189982 w 702501"/>
              <a:gd name="connsiteY2" fmla="*/ 514616 h 2444493"/>
              <a:gd name="connsiteX3" fmla="*/ 175694 w 702501"/>
              <a:gd name="connsiteY3" fmla="*/ 847991 h 2444493"/>
              <a:gd name="connsiteX4" fmla="*/ 185219 w 702501"/>
              <a:gd name="connsiteY4" fmla="*/ 1005154 h 2444493"/>
              <a:gd name="connsiteX5" fmla="*/ 137594 w 702501"/>
              <a:gd name="connsiteY5" fmla="*/ 1209941 h 2444493"/>
              <a:gd name="connsiteX6" fmla="*/ 137594 w 702501"/>
              <a:gd name="connsiteY6" fmla="*/ 1333766 h 2444493"/>
              <a:gd name="connsiteX7" fmla="*/ 128069 w 702501"/>
              <a:gd name="connsiteY7" fmla="*/ 1476641 h 2444493"/>
              <a:gd name="connsiteX8" fmla="*/ 99494 w 702501"/>
              <a:gd name="connsiteY8" fmla="*/ 1819541 h 2444493"/>
              <a:gd name="connsiteX9" fmla="*/ 4244 w 702501"/>
              <a:gd name="connsiteY9" fmla="*/ 2152916 h 2444493"/>
              <a:gd name="connsiteX10" fmla="*/ 32819 w 702501"/>
              <a:gd name="connsiteY10" fmla="*/ 2429141 h 2444493"/>
              <a:gd name="connsiteX11" fmla="*/ 175694 w 702501"/>
              <a:gd name="connsiteY11" fmla="*/ 2410091 h 2444493"/>
              <a:gd name="connsiteX12" fmla="*/ 261419 w 702501"/>
              <a:gd name="connsiteY12" fmla="*/ 2419616 h 2444493"/>
              <a:gd name="connsiteX13" fmla="*/ 404294 w 702501"/>
              <a:gd name="connsiteY13" fmla="*/ 2105291 h 2444493"/>
              <a:gd name="connsiteX14" fmla="*/ 518594 w 702501"/>
              <a:gd name="connsiteY14" fmla="*/ 1895741 h 2444493"/>
              <a:gd name="connsiteX15" fmla="*/ 594794 w 702501"/>
              <a:gd name="connsiteY15" fmla="*/ 1552841 h 2444493"/>
              <a:gd name="connsiteX16" fmla="*/ 613844 w 702501"/>
              <a:gd name="connsiteY16" fmla="*/ 1276616 h 2444493"/>
              <a:gd name="connsiteX17" fmla="*/ 699569 w 702501"/>
              <a:gd name="connsiteY17" fmla="*/ 1148028 h 2444493"/>
              <a:gd name="connsiteX18" fmla="*/ 690044 w 702501"/>
              <a:gd name="connsiteY18" fmla="*/ 1105165 h 2444493"/>
              <a:gd name="connsiteX19" fmla="*/ 542407 w 702501"/>
              <a:gd name="connsiteY19" fmla="*/ 1057541 h 2444493"/>
              <a:gd name="connsiteX20" fmla="*/ 509069 w 702501"/>
              <a:gd name="connsiteY20" fmla="*/ 933716 h 2444493"/>
              <a:gd name="connsiteX21" fmla="*/ 428106 w 702501"/>
              <a:gd name="connsiteY21" fmla="*/ 809891 h 2444493"/>
              <a:gd name="connsiteX22" fmla="*/ 266182 w 702501"/>
              <a:gd name="connsiteY22" fmla="*/ 690828 h 2444493"/>
              <a:gd name="connsiteX23" fmla="*/ 213795 w 702501"/>
              <a:gd name="connsiteY23" fmla="*/ 338403 h 2444493"/>
              <a:gd name="connsiteX24" fmla="*/ 142357 w 702501"/>
              <a:gd name="connsiteY24" fmla="*/ 266 h 2444493"/>
              <a:gd name="connsiteX0" fmla="*/ 142357 w 702501"/>
              <a:gd name="connsiteY0" fmla="*/ 266 h 2444493"/>
              <a:gd name="connsiteX1" fmla="*/ 132833 w 702501"/>
              <a:gd name="connsiteY1" fmla="*/ 286015 h 2444493"/>
              <a:gd name="connsiteX2" fmla="*/ 189982 w 702501"/>
              <a:gd name="connsiteY2" fmla="*/ 514616 h 2444493"/>
              <a:gd name="connsiteX3" fmla="*/ 175694 w 702501"/>
              <a:gd name="connsiteY3" fmla="*/ 847991 h 2444493"/>
              <a:gd name="connsiteX4" fmla="*/ 185219 w 702501"/>
              <a:gd name="connsiteY4" fmla="*/ 1005154 h 2444493"/>
              <a:gd name="connsiteX5" fmla="*/ 137594 w 702501"/>
              <a:gd name="connsiteY5" fmla="*/ 1209941 h 2444493"/>
              <a:gd name="connsiteX6" fmla="*/ 137594 w 702501"/>
              <a:gd name="connsiteY6" fmla="*/ 1333766 h 2444493"/>
              <a:gd name="connsiteX7" fmla="*/ 128069 w 702501"/>
              <a:gd name="connsiteY7" fmla="*/ 1476641 h 2444493"/>
              <a:gd name="connsiteX8" fmla="*/ 99494 w 702501"/>
              <a:gd name="connsiteY8" fmla="*/ 1819541 h 2444493"/>
              <a:gd name="connsiteX9" fmla="*/ 4244 w 702501"/>
              <a:gd name="connsiteY9" fmla="*/ 2152916 h 2444493"/>
              <a:gd name="connsiteX10" fmla="*/ 32819 w 702501"/>
              <a:gd name="connsiteY10" fmla="*/ 2429141 h 2444493"/>
              <a:gd name="connsiteX11" fmla="*/ 175694 w 702501"/>
              <a:gd name="connsiteY11" fmla="*/ 2410091 h 2444493"/>
              <a:gd name="connsiteX12" fmla="*/ 261419 w 702501"/>
              <a:gd name="connsiteY12" fmla="*/ 2419616 h 2444493"/>
              <a:gd name="connsiteX13" fmla="*/ 404294 w 702501"/>
              <a:gd name="connsiteY13" fmla="*/ 2105291 h 2444493"/>
              <a:gd name="connsiteX14" fmla="*/ 518594 w 702501"/>
              <a:gd name="connsiteY14" fmla="*/ 1895741 h 2444493"/>
              <a:gd name="connsiteX15" fmla="*/ 594794 w 702501"/>
              <a:gd name="connsiteY15" fmla="*/ 1552841 h 2444493"/>
              <a:gd name="connsiteX16" fmla="*/ 613844 w 702501"/>
              <a:gd name="connsiteY16" fmla="*/ 1276616 h 2444493"/>
              <a:gd name="connsiteX17" fmla="*/ 699569 w 702501"/>
              <a:gd name="connsiteY17" fmla="*/ 1148028 h 2444493"/>
              <a:gd name="connsiteX18" fmla="*/ 690044 w 702501"/>
              <a:gd name="connsiteY18" fmla="*/ 1105165 h 2444493"/>
              <a:gd name="connsiteX19" fmla="*/ 542407 w 702501"/>
              <a:gd name="connsiteY19" fmla="*/ 1057541 h 2444493"/>
              <a:gd name="connsiteX20" fmla="*/ 509069 w 702501"/>
              <a:gd name="connsiteY20" fmla="*/ 933716 h 2444493"/>
              <a:gd name="connsiteX21" fmla="*/ 418581 w 702501"/>
              <a:gd name="connsiteY21" fmla="*/ 876566 h 2444493"/>
              <a:gd name="connsiteX22" fmla="*/ 266182 w 702501"/>
              <a:gd name="connsiteY22" fmla="*/ 690828 h 2444493"/>
              <a:gd name="connsiteX23" fmla="*/ 213795 w 702501"/>
              <a:gd name="connsiteY23" fmla="*/ 338403 h 2444493"/>
              <a:gd name="connsiteX24" fmla="*/ 142357 w 702501"/>
              <a:gd name="connsiteY24" fmla="*/ 266 h 2444493"/>
              <a:gd name="connsiteX0" fmla="*/ 142357 w 702501"/>
              <a:gd name="connsiteY0" fmla="*/ 266 h 2444493"/>
              <a:gd name="connsiteX1" fmla="*/ 132833 w 702501"/>
              <a:gd name="connsiteY1" fmla="*/ 286015 h 2444493"/>
              <a:gd name="connsiteX2" fmla="*/ 189982 w 702501"/>
              <a:gd name="connsiteY2" fmla="*/ 514616 h 2444493"/>
              <a:gd name="connsiteX3" fmla="*/ 175694 w 702501"/>
              <a:gd name="connsiteY3" fmla="*/ 847991 h 2444493"/>
              <a:gd name="connsiteX4" fmla="*/ 185219 w 702501"/>
              <a:gd name="connsiteY4" fmla="*/ 1005154 h 2444493"/>
              <a:gd name="connsiteX5" fmla="*/ 137594 w 702501"/>
              <a:gd name="connsiteY5" fmla="*/ 1209941 h 2444493"/>
              <a:gd name="connsiteX6" fmla="*/ 137594 w 702501"/>
              <a:gd name="connsiteY6" fmla="*/ 1333766 h 2444493"/>
              <a:gd name="connsiteX7" fmla="*/ 128069 w 702501"/>
              <a:gd name="connsiteY7" fmla="*/ 1476641 h 2444493"/>
              <a:gd name="connsiteX8" fmla="*/ 99494 w 702501"/>
              <a:gd name="connsiteY8" fmla="*/ 1819541 h 2444493"/>
              <a:gd name="connsiteX9" fmla="*/ 4244 w 702501"/>
              <a:gd name="connsiteY9" fmla="*/ 2152916 h 2444493"/>
              <a:gd name="connsiteX10" fmla="*/ 32819 w 702501"/>
              <a:gd name="connsiteY10" fmla="*/ 2429141 h 2444493"/>
              <a:gd name="connsiteX11" fmla="*/ 175694 w 702501"/>
              <a:gd name="connsiteY11" fmla="*/ 2410091 h 2444493"/>
              <a:gd name="connsiteX12" fmla="*/ 261419 w 702501"/>
              <a:gd name="connsiteY12" fmla="*/ 2419616 h 2444493"/>
              <a:gd name="connsiteX13" fmla="*/ 404294 w 702501"/>
              <a:gd name="connsiteY13" fmla="*/ 2105291 h 2444493"/>
              <a:gd name="connsiteX14" fmla="*/ 518594 w 702501"/>
              <a:gd name="connsiteY14" fmla="*/ 1895741 h 2444493"/>
              <a:gd name="connsiteX15" fmla="*/ 594794 w 702501"/>
              <a:gd name="connsiteY15" fmla="*/ 1552841 h 2444493"/>
              <a:gd name="connsiteX16" fmla="*/ 613844 w 702501"/>
              <a:gd name="connsiteY16" fmla="*/ 1276616 h 2444493"/>
              <a:gd name="connsiteX17" fmla="*/ 699569 w 702501"/>
              <a:gd name="connsiteY17" fmla="*/ 1148028 h 2444493"/>
              <a:gd name="connsiteX18" fmla="*/ 690044 w 702501"/>
              <a:gd name="connsiteY18" fmla="*/ 1105165 h 2444493"/>
              <a:gd name="connsiteX19" fmla="*/ 542407 w 702501"/>
              <a:gd name="connsiteY19" fmla="*/ 1057541 h 2444493"/>
              <a:gd name="connsiteX20" fmla="*/ 509069 w 702501"/>
              <a:gd name="connsiteY20" fmla="*/ 933716 h 2444493"/>
              <a:gd name="connsiteX21" fmla="*/ 418581 w 702501"/>
              <a:gd name="connsiteY21" fmla="*/ 876566 h 2444493"/>
              <a:gd name="connsiteX22" fmla="*/ 266182 w 702501"/>
              <a:gd name="connsiteY22" fmla="*/ 690828 h 2444493"/>
              <a:gd name="connsiteX23" fmla="*/ 213795 w 702501"/>
              <a:gd name="connsiteY23" fmla="*/ 338403 h 2444493"/>
              <a:gd name="connsiteX24" fmla="*/ 142357 w 702501"/>
              <a:gd name="connsiteY24" fmla="*/ 266 h 2444493"/>
              <a:gd name="connsiteX0" fmla="*/ 142357 w 702501"/>
              <a:gd name="connsiteY0" fmla="*/ 266 h 2444493"/>
              <a:gd name="connsiteX1" fmla="*/ 132833 w 702501"/>
              <a:gd name="connsiteY1" fmla="*/ 286015 h 2444493"/>
              <a:gd name="connsiteX2" fmla="*/ 189982 w 702501"/>
              <a:gd name="connsiteY2" fmla="*/ 514616 h 2444493"/>
              <a:gd name="connsiteX3" fmla="*/ 175694 w 702501"/>
              <a:gd name="connsiteY3" fmla="*/ 847991 h 2444493"/>
              <a:gd name="connsiteX4" fmla="*/ 185219 w 702501"/>
              <a:gd name="connsiteY4" fmla="*/ 1005154 h 2444493"/>
              <a:gd name="connsiteX5" fmla="*/ 137594 w 702501"/>
              <a:gd name="connsiteY5" fmla="*/ 1209941 h 2444493"/>
              <a:gd name="connsiteX6" fmla="*/ 137594 w 702501"/>
              <a:gd name="connsiteY6" fmla="*/ 1333766 h 2444493"/>
              <a:gd name="connsiteX7" fmla="*/ 128069 w 702501"/>
              <a:gd name="connsiteY7" fmla="*/ 1476641 h 2444493"/>
              <a:gd name="connsiteX8" fmla="*/ 99494 w 702501"/>
              <a:gd name="connsiteY8" fmla="*/ 1819541 h 2444493"/>
              <a:gd name="connsiteX9" fmla="*/ 4244 w 702501"/>
              <a:gd name="connsiteY9" fmla="*/ 2152916 h 2444493"/>
              <a:gd name="connsiteX10" fmla="*/ 32819 w 702501"/>
              <a:gd name="connsiteY10" fmla="*/ 2429141 h 2444493"/>
              <a:gd name="connsiteX11" fmla="*/ 175694 w 702501"/>
              <a:gd name="connsiteY11" fmla="*/ 2410091 h 2444493"/>
              <a:gd name="connsiteX12" fmla="*/ 261419 w 702501"/>
              <a:gd name="connsiteY12" fmla="*/ 2419616 h 2444493"/>
              <a:gd name="connsiteX13" fmla="*/ 404294 w 702501"/>
              <a:gd name="connsiteY13" fmla="*/ 2105291 h 2444493"/>
              <a:gd name="connsiteX14" fmla="*/ 518594 w 702501"/>
              <a:gd name="connsiteY14" fmla="*/ 1895741 h 2444493"/>
              <a:gd name="connsiteX15" fmla="*/ 594794 w 702501"/>
              <a:gd name="connsiteY15" fmla="*/ 1552841 h 2444493"/>
              <a:gd name="connsiteX16" fmla="*/ 613844 w 702501"/>
              <a:gd name="connsiteY16" fmla="*/ 1276616 h 2444493"/>
              <a:gd name="connsiteX17" fmla="*/ 699569 w 702501"/>
              <a:gd name="connsiteY17" fmla="*/ 1148028 h 2444493"/>
              <a:gd name="connsiteX18" fmla="*/ 690044 w 702501"/>
              <a:gd name="connsiteY18" fmla="*/ 1105165 h 2444493"/>
              <a:gd name="connsiteX19" fmla="*/ 542407 w 702501"/>
              <a:gd name="connsiteY19" fmla="*/ 1057541 h 2444493"/>
              <a:gd name="connsiteX20" fmla="*/ 490019 w 702501"/>
              <a:gd name="connsiteY20" fmla="*/ 981341 h 2444493"/>
              <a:gd name="connsiteX21" fmla="*/ 418581 w 702501"/>
              <a:gd name="connsiteY21" fmla="*/ 876566 h 2444493"/>
              <a:gd name="connsiteX22" fmla="*/ 266182 w 702501"/>
              <a:gd name="connsiteY22" fmla="*/ 690828 h 2444493"/>
              <a:gd name="connsiteX23" fmla="*/ 213795 w 702501"/>
              <a:gd name="connsiteY23" fmla="*/ 338403 h 2444493"/>
              <a:gd name="connsiteX24" fmla="*/ 142357 w 702501"/>
              <a:gd name="connsiteY24" fmla="*/ 266 h 2444493"/>
              <a:gd name="connsiteX0" fmla="*/ 142357 w 700352"/>
              <a:gd name="connsiteY0" fmla="*/ 266 h 2444493"/>
              <a:gd name="connsiteX1" fmla="*/ 132833 w 700352"/>
              <a:gd name="connsiteY1" fmla="*/ 286015 h 2444493"/>
              <a:gd name="connsiteX2" fmla="*/ 189982 w 700352"/>
              <a:gd name="connsiteY2" fmla="*/ 514616 h 2444493"/>
              <a:gd name="connsiteX3" fmla="*/ 175694 w 700352"/>
              <a:gd name="connsiteY3" fmla="*/ 847991 h 2444493"/>
              <a:gd name="connsiteX4" fmla="*/ 185219 w 700352"/>
              <a:gd name="connsiteY4" fmla="*/ 1005154 h 2444493"/>
              <a:gd name="connsiteX5" fmla="*/ 137594 w 700352"/>
              <a:gd name="connsiteY5" fmla="*/ 1209941 h 2444493"/>
              <a:gd name="connsiteX6" fmla="*/ 137594 w 700352"/>
              <a:gd name="connsiteY6" fmla="*/ 1333766 h 2444493"/>
              <a:gd name="connsiteX7" fmla="*/ 128069 w 700352"/>
              <a:gd name="connsiteY7" fmla="*/ 1476641 h 2444493"/>
              <a:gd name="connsiteX8" fmla="*/ 99494 w 700352"/>
              <a:gd name="connsiteY8" fmla="*/ 1819541 h 2444493"/>
              <a:gd name="connsiteX9" fmla="*/ 4244 w 700352"/>
              <a:gd name="connsiteY9" fmla="*/ 2152916 h 2444493"/>
              <a:gd name="connsiteX10" fmla="*/ 32819 w 700352"/>
              <a:gd name="connsiteY10" fmla="*/ 2429141 h 2444493"/>
              <a:gd name="connsiteX11" fmla="*/ 175694 w 700352"/>
              <a:gd name="connsiteY11" fmla="*/ 2410091 h 2444493"/>
              <a:gd name="connsiteX12" fmla="*/ 261419 w 700352"/>
              <a:gd name="connsiteY12" fmla="*/ 2419616 h 2444493"/>
              <a:gd name="connsiteX13" fmla="*/ 404294 w 700352"/>
              <a:gd name="connsiteY13" fmla="*/ 2105291 h 2444493"/>
              <a:gd name="connsiteX14" fmla="*/ 518594 w 700352"/>
              <a:gd name="connsiteY14" fmla="*/ 1895741 h 2444493"/>
              <a:gd name="connsiteX15" fmla="*/ 594794 w 700352"/>
              <a:gd name="connsiteY15" fmla="*/ 1552841 h 2444493"/>
              <a:gd name="connsiteX16" fmla="*/ 613844 w 700352"/>
              <a:gd name="connsiteY16" fmla="*/ 1276616 h 2444493"/>
              <a:gd name="connsiteX17" fmla="*/ 656708 w 700352"/>
              <a:gd name="connsiteY17" fmla="*/ 1252803 h 2444493"/>
              <a:gd name="connsiteX18" fmla="*/ 699569 w 700352"/>
              <a:gd name="connsiteY18" fmla="*/ 1148028 h 2444493"/>
              <a:gd name="connsiteX19" fmla="*/ 690044 w 700352"/>
              <a:gd name="connsiteY19" fmla="*/ 1105165 h 2444493"/>
              <a:gd name="connsiteX20" fmla="*/ 542407 w 700352"/>
              <a:gd name="connsiteY20" fmla="*/ 1057541 h 2444493"/>
              <a:gd name="connsiteX21" fmla="*/ 490019 w 700352"/>
              <a:gd name="connsiteY21" fmla="*/ 981341 h 2444493"/>
              <a:gd name="connsiteX22" fmla="*/ 418581 w 700352"/>
              <a:gd name="connsiteY22" fmla="*/ 876566 h 2444493"/>
              <a:gd name="connsiteX23" fmla="*/ 266182 w 700352"/>
              <a:gd name="connsiteY23" fmla="*/ 690828 h 2444493"/>
              <a:gd name="connsiteX24" fmla="*/ 213795 w 700352"/>
              <a:gd name="connsiteY24" fmla="*/ 338403 h 2444493"/>
              <a:gd name="connsiteX25" fmla="*/ 142357 w 700352"/>
              <a:gd name="connsiteY25" fmla="*/ 266 h 2444493"/>
              <a:gd name="connsiteX0" fmla="*/ 142357 w 700352"/>
              <a:gd name="connsiteY0" fmla="*/ 266 h 2444493"/>
              <a:gd name="connsiteX1" fmla="*/ 132833 w 700352"/>
              <a:gd name="connsiteY1" fmla="*/ 286015 h 2444493"/>
              <a:gd name="connsiteX2" fmla="*/ 189982 w 700352"/>
              <a:gd name="connsiteY2" fmla="*/ 514616 h 2444493"/>
              <a:gd name="connsiteX3" fmla="*/ 175694 w 700352"/>
              <a:gd name="connsiteY3" fmla="*/ 847991 h 2444493"/>
              <a:gd name="connsiteX4" fmla="*/ 185219 w 700352"/>
              <a:gd name="connsiteY4" fmla="*/ 1005154 h 2444493"/>
              <a:gd name="connsiteX5" fmla="*/ 137594 w 700352"/>
              <a:gd name="connsiteY5" fmla="*/ 1209941 h 2444493"/>
              <a:gd name="connsiteX6" fmla="*/ 137594 w 700352"/>
              <a:gd name="connsiteY6" fmla="*/ 1333766 h 2444493"/>
              <a:gd name="connsiteX7" fmla="*/ 128069 w 700352"/>
              <a:gd name="connsiteY7" fmla="*/ 1476641 h 2444493"/>
              <a:gd name="connsiteX8" fmla="*/ 99494 w 700352"/>
              <a:gd name="connsiteY8" fmla="*/ 1819541 h 2444493"/>
              <a:gd name="connsiteX9" fmla="*/ 4244 w 700352"/>
              <a:gd name="connsiteY9" fmla="*/ 2152916 h 2444493"/>
              <a:gd name="connsiteX10" fmla="*/ 32819 w 700352"/>
              <a:gd name="connsiteY10" fmla="*/ 2429141 h 2444493"/>
              <a:gd name="connsiteX11" fmla="*/ 175694 w 700352"/>
              <a:gd name="connsiteY11" fmla="*/ 2410091 h 2444493"/>
              <a:gd name="connsiteX12" fmla="*/ 261419 w 700352"/>
              <a:gd name="connsiteY12" fmla="*/ 2419616 h 2444493"/>
              <a:gd name="connsiteX13" fmla="*/ 404294 w 700352"/>
              <a:gd name="connsiteY13" fmla="*/ 2105291 h 2444493"/>
              <a:gd name="connsiteX14" fmla="*/ 470969 w 700352"/>
              <a:gd name="connsiteY14" fmla="*/ 1829066 h 2444493"/>
              <a:gd name="connsiteX15" fmla="*/ 594794 w 700352"/>
              <a:gd name="connsiteY15" fmla="*/ 1552841 h 2444493"/>
              <a:gd name="connsiteX16" fmla="*/ 613844 w 700352"/>
              <a:gd name="connsiteY16" fmla="*/ 1276616 h 2444493"/>
              <a:gd name="connsiteX17" fmla="*/ 656708 w 700352"/>
              <a:gd name="connsiteY17" fmla="*/ 1252803 h 2444493"/>
              <a:gd name="connsiteX18" fmla="*/ 699569 w 700352"/>
              <a:gd name="connsiteY18" fmla="*/ 1148028 h 2444493"/>
              <a:gd name="connsiteX19" fmla="*/ 690044 w 700352"/>
              <a:gd name="connsiteY19" fmla="*/ 1105165 h 2444493"/>
              <a:gd name="connsiteX20" fmla="*/ 542407 w 700352"/>
              <a:gd name="connsiteY20" fmla="*/ 1057541 h 2444493"/>
              <a:gd name="connsiteX21" fmla="*/ 490019 w 700352"/>
              <a:gd name="connsiteY21" fmla="*/ 981341 h 2444493"/>
              <a:gd name="connsiteX22" fmla="*/ 418581 w 700352"/>
              <a:gd name="connsiteY22" fmla="*/ 876566 h 2444493"/>
              <a:gd name="connsiteX23" fmla="*/ 266182 w 700352"/>
              <a:gd name="connsiteY23" fmla="*/ 690828 h 2444493"/>
              <a:gd name="connsiteX24" fmla="*/ 213795 w 700352"/>
              <a:gd name="connsiteY24" fmla="*/ 338403 h 2444493"/>
              <a:gd name="connsiteX25" fmla="*/ 142357 w 700352"/>
              <a:gd name="connsiteY25" fmla="*/ 266 h 2444493"/>
              <a:gd name="connsiteX0" fmla="*/ 142357 w 700352"/>
              <a:gd name="connsiteY0" fmla="*/ 266 h 2444493"/>
              <a:gd name="connsiteX1" fmla="*/ 132833 w 700352"/>
              <a:gd name="connsiteY1" fmla="*/ 286015 h 2444493"/>
              <a:gd name="connsiteX2" fmla="*/ 189982 w 700352"/>
              <a:gd name="connsiteY2" fmla="*/ 514616 h 2444493"/>
              <a:gd name="connsiteX3" fmla="*/ 175694 w 700352"/>
              <a:gd name="connsiteY3" fmla="*/ 847991 h 2444493"/>
              <a:gd name="connsiteX4" fmla="*/ 185219 w 700352"/>
              <a:gd name="connsiteY4" fmla="*/ 1005154 h 2444493"/>
              <a:gd name="connsiteX5" fmla="*/ 137594 w 700352"/>
              <a:gd name="connsiteY5" fmla="*/ 1209941 h 2444493"/>
              <a:gd name="connsiteX6" fmla="*/ 137594 w 700352"/>
              <a:gd name="connsiteY6" fmla="*/ 1333766 h 2444493"/>
              <a:gd name="connsiteX7" fmla="*/ 89969 w 700352"/>
              <a:gd name="connsiteY7" fmla="*/ 1552841 h 2444493"/>
              <a:gd name="connsiteX8" fmla="*/ 99494 w 700352"/>
              <a:gd name="connsiteY8" fmla="*/ 1819541 h 2444493"/>
              <a:gd name="connsiteX9" fmla="*/ 4244 w 700352"/>
              <a:gd name="connsiteY9" fmla="*/ 2152916 h 2444493"/>
              <a:gd name="connsiteX10" fmla="*/ 32819 w 700352"/>
              <a:gd name="connsiteY10" fmla="*/ 2429141 h 2444493"/>
              <a:gd name="connsiteX11" fmla="*/ 175694 w 700352"/>
              <a:gd name="connsiteY11" fmla="*/ 2410091 h 2444493"/>
              <a:gd name="connsiteX12" fmla="*/ 261419 w 700352"/>
              <a:gd name="connsiteY12" fmla="*/ 2419616 h 2444493"/>
              <a:gd name="connsiteX13" fmla="*/ 404294 w 700352"/>
              <a:gd name="connsiteY13" fmla="*/ 2105291 h 2444493"/>
              <a:gd name="connsiteX14" fmla="*/ 470969 w 700352"/>
              <a:gd name="connsiteY14" fmla="*/ 1829066 h 2444493"/>
              <a:gd name="connsiteX15" fmla="*/ 594794 w 700352"/>
              <a:gd name="connsiteY15" fmla="*/ 1552841 h 2444493"/>
              <a:gd name="connsiteX16" fmla="*/ 613844 w 700352"/>
              <a:gd name="connsiteY16" fmla="*/ 1276616 h 2444493"/>
              <a:gd name="connsiteX17" fmla="*/ 656708 w 700352"/>
              <a:gd name="connsiteY17" fmla="*/ 1252803 h 2444493"/>
              <a:gd name="connsiteX18" fmla="*/ 699569 w 700352"/>
              <a:gd name="connsiteY18" fmla="*/ 1148028 h 2444493"/>
              <a:gd name="connsiteX19" fmla="*/ 690044 w 700352"/>
              <a:gd name="connsiteY19" fmla="*/ 1105165 h 2444493"/>
              <a:gd name="connsiteX20" fmla="*/ 542407 w 700352"/>
              <a:gd name="connsiteY20" fmla="*/ 1057541 h 2444493"/>
              <a:gd name="connsiteX21" fmla="*/ 490019 w 700352"/>
              <a:gd name="connsiteY21" fmla="*/ 981341 h 2444493"/>
              <a:gd name="connsiteX22" fmla="*/ 418581 w 700352"/>
              <a:gd name="connsiteY22" fmla="*/ 876566 h 2444493"/>
              <a:gd name="connsiteX23" fmla="*/ 266182 w 700352"/>
              <a:gd name="connsiteY23" fmla="*/ 690828 h 2444493"/>
              <a:gd name="connsiteX24" fmla="*/ 213795 w 700352"/>
              <a:gd name="connsiteY24" fmla="*/ 338403 h 2444493"/>
              <a:gd name="connsiteX25" fmla="*/ 142357 w 700352"/>
              <a:gd name="connsiteY25" fmla="*/ 266 h 2444493"/>
              <a:gd name="connsiteX0" fmla="*/ 114949 w 672944"/>
              <a:gd name="connsiteY0" fmla="*/ 266 h 2452035"/>
              <a:gd name="connsiteX1" fmla="*/ 105425 w 672944"/>
              <a:gd name="connsiteY1" fmla="*/ 286015 h 2452035"/>
              <a:gd name="connsiteX2" fmla="*/ 162574 w 672944"/>
              <a:gd name="connsiteY2" fmla="*/ 514616 h 2452035"/>
              <a:gd name="connsiteX3" fmla="*/ 148286 w 672944"/>
              <a:gd name="connsiteY3" fmla="*/ 847991 h 2452035"/>
              <a:gd name="connsiteX4" fmla="*/ 157811 w 672944"/>
              <a:gd name="connsiteY4" fmla="*/ 1005154 h 2452035"/>
              <a:gd name="connsiteX5" fmla="*/ 110186 w 672944"/>
              <a:gd name="connsiteY5" fmla="*/ 1209941 h 2452035"/>
              <a:gd name="connsiteX6" fmla="*/ 110186 w 672944"/>
              <a:gd name="connsiteY6" fmla="*/ 1333766 h 2452035"/>
              <a:gd name="connsiteX7" fmla="*/ 62561 w 672944"/>
              <a:gd name="connsiteY7" fmla="*/ 1552841 h 2452035"/>
              <a:gd name="connsiteX8" fmla="*/ 72086 w 672944"/>
              <a:gd name="connsiteY8" fmla="*/ 1819541 h 2452035"/>
              <a:gd name="connsiteX9" fmla="*/ 33986 w 672944"/>
              <a:gd name="connsiteY9" fmla="*/ 2048141 h 2452035"/>
              <a:gd name="connsiteX10" fmla="*/ 5411 w 672944"/>
              <a:gd name="connsiteY10" fmla="*/ 2429141 h 2452035"/>
              <a:gd name="connsiteX11" fmla="*/ 148286 w 672944"/>
              <a:gd name="connsiteY11" fmla="*/ 2410091 h 2452035"/>
              <a:gd name="connsiteX12" fmla="*/ 234011 w 672944"/>
              <a:gd name="connsiteY12" fmla="*/ 2419616 h 2452035"/>
              <a:gd name="connsiteX13" fmla="*/ 376886 w 672944"/>
              <a:gd name="connsiteY13" fmla="*/ 2105291 h 2452035"/>
              <a:gd name="connsiteX14" fmla="*/ 443561 w 672944"/>
              <a:gd name="connsiteY14" fmla="*/ 1829066 h 2452035"/>
              <a:gd name="connsiteX15" fmla="*/ 567386 w 672944"/>
              <a:gd name="connsiteY15" fmla="*/ 1552841 h 2452035"/>
              <a:gd name="connsiteX16" fmla="*/ 586436 w 672944"/>
              <a:gd name="connsiteY16" fmla="*/ 1276616 h 2452035"/>
              <a:gd name="connsiteX17" fmla="*/ 629300 w 672944"/>
              <a:gd name="connsiteY17" fmla="*/ 1252803 h 2452035"/>
              <a:gd name="connsiteX18" fmla="*/ 672161 w 672944"/>
              <a:gd name="connsiteY18" fmla="*/ 1148028 h 2452035"/>
              <a:gd name="connsiteX19" fmla="*/ 662636 w 672944"/>
              <a:gd name="connsiteY19" fmla="*/ 1105165 h 2452035"/>
              <a:gd name="connsiteX20" fmla="*/ 514999 w 672944"/>
              <a:gd name="connsiteY20" fmla="*/ 1057541 h 2452035"/>
              <a:gd name="connsiteX21" fmla="*/ 462611 w 672944"/>
              <a:gd name="connsiteY21" fmla="*/ 981341 h 2452035"/>
              <a:gd name="connsiteX22" fmla="*/ 391173 w 672944"/>
              <a:gd name="connsiteY22" fmla="*/ 876566 h 2452035"/>
              <a:gd name="connsiteX23" fmla="*/ 238774 w 672944"/>
              <a:gd name="connsiteY23" fmla="*/ 690828 h 2452035"/>
              <a:gd name="connsiteX24" fmla="*/ 186387 w 672944"/>
              <a:gd name="connsiteY24" fmla="*/ 338403 h 2452035"/>
              <a:gd name="connsiteX25" fmla="*/ 114949 w 672944"/>
              <a:gd name="connsiteY25" fmla="*/ 266 h 2452035"/>
              <a:gd name="connsiteX0" fmla="*/ 114949 w 672944"/>
              <a:gd name="connsiteY0" fmla="*/ 266 h 2452035"/>
              <a:gd name="connsiteX1" fmla="*/ 105425 w 672944"/>
              <a:gd name="connsiteY1" fmla="*/ 286015 h 2452035"/>
              <a:gd name="connsiteX2" fmla="*/ 162574 w 672944"/>
              <a:gd name="connsiteY2" fmla="*/ 514616 h 2452035"/>
              <a:gd name="connsiteX3" fmla="*/ 148286 w 672944"/>
              <a:gd name="connsiteY3" fmla="*/ 847991 h 2452035"/>
              <a:gd name="connsiteX4" fmla="*/ 157811 w 672944"/>
              <a:gd name="connsiteY4" fmla="*/ 1005154 h 2452035"/>
              <a:gd name="connsiteX5" fmla="*/ 110186 w 672944"/>
              <a:gd name="connsiteY5" fmla="*/ 1209941 h 2452035"/>
              <a:gd name="connsiteX6" fmla="*/ 110186 w 672944"/>
              <a:gd name="connsiteY6" fmla="*/ 1333766 h 2452035"/>
              <a:gd name="connsiteX7" fmla="*/ 62561 w 672944"/>
              <a:gd name="connsiteY7" fmla="*/ 1552841 h 2452035"/>
              <a:gd name="connsiteX8" fmla="*/ 72086 w 672944"/>
              <a:gd name="connsiteY8" fmla="*/ 1819541 h 2452035"/>
              <a:gd name="connsiteX9" fmla="*/ 33986 w 672944"/>
              <a:gd name="connsiteY9" fmla="*/ 2048141 h 2452035"/>
              <a:gd name="connsiteX10" fmla="*/ 5411 w 672944"/>
              <a:gd name="connsiteY10" fmla="*/ 2429141 h 2452035"/>
              <a:gd name="connsiteX11" fmla="*/ 148286 w 672944"/>
              <a:gd name="connsiteY11" fmla="*/ 2410091 h 2452035"/>
              <a:gd name="connsiteX12" fmla="*/ 234011 w 672944"/>
              <a:gd name="connsiteY12" fmla="*/ 2419616 h 2452035"/>
              <a:gd name="connsiteX13" fmla="*/ 357836 w 672944"/>
              <a:gd name="connsiteY13" fmla="*/ 2019566 h 2452035"/>
              <a:gd name="connsiteX14" fmla="*/ 443561 w 672944"/>
              <a:gd name="connsiteY14" fmla="*/ 1829066 h 2452035"/>
              <a:gd name="connsiteX15" fmla="*/ 567386 w 672944"/>
              <a:gd name="connsiteY15" fmla="*/ 1552841 h 2452035"/>
              <a:gd name="connsiteX16" fmla="*/ 586436 w 672944"/>
              <a:gd name="connsiteY16" fmla="*/ 1276616 h 2452035"/>
              <a:gd name="connsiteX17" fmla="*/ 629300 w 672944"/>
              <a:gd name="connsiteY17" fmla="*/ 1252803 h 2452035"/>
              <a:gd name="connsiteX18" fmla="*/ 672161 w 672944"/>
              <a:gd name="connsiteY18" fmla="*/ 1148028 h 2452035"/>
              <a:gd name="connsiteX19" fmla="*/ 662636 w 672944"/>
              <a:gd name="connsiteY19" fmla="*/ 1105165 h 2452035"/>
              <a:gd name="connsiteX20" fmla="*/ 514999 w 672944"/>
              <a:gd name="connsiteY20" fmla="*/ 1057541 h 2452035"/>
              <a:gd name="connsiteX21" fmla="*/ 462611 w 672944"/>
              <a:gd name="connsiteY21" fmla="*/ 981341 h 2452035"/>
              <a:gd name="connsiteX22" fmla="*/ 391173 w 672944"/>
              <a:gd name="connsiteY22" fmla="*/ 876566 h 2452035"/>
              <a:gd name="connsiteX23" fmla="*/ 238774 w 672944"/>
              <a:gd name="connsiteY23" fmla="*/ 690828 h 2452035"/>
              <a:gd name="connsiteX24" fmla="*/ 186387 w 672944"/>
              <a:gd name="connsiteY24" fmla="*/ 338403 h 2452035"/>
              <a:gd name="connsiteX25" fmla="*/ 114949 w 672944"/>
              <a:gd name="connsiteY25" fmla="*/ 266 h 2452035"/>
              <a:gd name="connsiteX0" fmla="*/ 114949 w 672944"/>
              <a:gd name="connsiteY0" fmla="*/ 266 h 2452035"/>
              <a:gd name="connsiteX1" fmla="*/ 105425 w 672944"/>
              <a:gd name="connsiteY1" fmla="*/ 286015 h 2452035"/>
              <a:gd name="connsiteX2" fmla="*/ 162574 w 672944"/>
              <a:gd name="connsiteY2" fmla="*/ 514616 h 2452035"/>
              <a:gd name="connsiteX3" fmla="*/ 148286 w 672944"/>
              <a:gd name="connsiteY3" fmla="*/ 847991 h 2452035"/>
              <a:gd name="connsiteX4" fmla="*/ 157811 w 672944"/>
              <a:gd name="connsiteY4" fmla="*/ 1005154 h 2452035"/>
              <a:gd name="connsiteX5" fmla="*/ 110186 w 672944"/>
              <a:gd name="connsiteY5" fmla="*/ 1209941 h 2452035"/>
              <a:gd name="connsiteX6" fmla="*/ 110186 w 672944"/>
              <a:gd name="connsiteY6" fmla="*/ 1333766 h 2452035"/>
              <a:gd name="connsiteX7" fmla="*/ 62561 w 672944"/>
              <a:gd name="connsiteY7" fmla="*/ 1552841 h 2452035"/>
              <a:gd name="connsiteX8" fmla="*/ 72086 w 672944"/>
              <a:gd name="connsiteY8" fmla="*/ 1819541 h 2452035"/>
              <a:gd name="connsiteX9" fmla="*/ 33986 w 672944"/>
              <a:gd name="connsiteY9" fmla="*/ 2048141 h 2452035"/>
              <a:gd name="connsiteX10" fmla="*/ 5411 w 672944"/>
              <a:gd name="connsiteY10" fmla="*/ 2429141 h 2452035"/>
              <a:gd name="connsiteX11" fmla="*/ 148286 w 672944"/>
              <a:gd name="connsiteY11" fmla="*/ 2410091 h 2452035"/>
              <a:gd name="connsiteX12" fmla="*/ 234011 w 672944"/>
              <a:gd name="connsiteY12" fmla="*/ 2419616 h 2452035"/>
              <a:gd name="connsiteX13" fmla="*/ 357836 w 672944"/>
              <a:gd name="connsiteY13" fmla="*/ 2019566 h 2452035"/>
              <a:gd name="connsiteX14" fmla="*/ 443561 w 672944"/>
              <a:gd name="connsiteY14" fmla="*/ 1829066 h 2452035"/>
              <a:gd name="connsiteX15" fmla="*/ 567386 w 672944"/>
              <a:gd name="connsiteY15" fmla="*/ 1552841 h 2452035"/>
              <a:gd name="connsiteX16" fmla="*/ 586436 w 672944"/>
              <a:gd name="connsiteY16" fmla="*/ 1276616 h 2452035"/>
              <a:gd name="connsiteX17" fmla="*/ 629300 w 672944"/>
              <a:gd name="connsiteY17" fmla="*/ 1252803 h 2452035"/>
              <a:gd name="connsiteX18" fmla="*/ 672161 w 672944"/>
              <a:gd name="connsiteY18" fmla="*/ 1148028 h 2452035"/>
              <a:gd name="connsiteX19" fmla="*/ 662636 w 672944"/>
              <a:gd name="connsiteY19" fmla="*/ 1105165 h 2452035"/>
              <a:gd name="connsiteX20" fmla="*/ 514999 w 672944"/>
              <a:gd name="connsiteY20" fmla="*/ 1057541 h 2452035"/>
              <a:gd name="connsiteX21" fmla="*/ 462611 w 672944"/>
              <a:gd name="connsiteY21" fmla="*/ 981341 h 2452035"/>
              <a:gd name="connsiteX22" fmla="*/ 391173 w 672944"/>
              <a:gd name="connsiteY22" fmla="*/ 876566 h 2452035"/>
              <a:gd name="connsiteX23" fmla="*/ 238774 w 672944"/>
              <a:gd name="connsiteY23" fmla="*/ 690828 h 2452035"/>
              <a:gd name="connsiteX24" fmla="*/ 186387 w 672944"/>
              <a:gd name="connsiteY24" fmla="*/ 338403 h 2452035"/>
              <a:gd name="connsiteX25" fmla="*/ 114949 w 672944"/>
              <a:gd name="connsiteY25" fmla="*/ 266 h 2452035"/>
              <a:gd name="connsiteX0" fmla="*/ 114949 w 672944"/>
              <a:gd name="connsiteY0" fmla="*/ 266 h 2452035"/>
              <a:gd name="connsiteX1" fmla="*/ 105425 w 672944"/>
              <a:gd name="connsiteY1" fmla="*/ 286015 h 2452035"/>
              <a:gd name="connsiteX2" fmla="*/ 162574 w 672944"/>
              <a:gd name="connsiteY2" fmla="*/ 514616 h 2452035"/>
              <a:gd name="connsiteX3" fmla="*/ 148286 w 672944"/>
              <a:gd name="connsiteY3" fmla="*/ 847991 h 2452035"/>
              <a:gd name="connsiteX4" fmla="*/ 157811 w 672944"/>
              <a:gd name="connsiteY4" fmla="*/ 1005154 h 2452035"/>
              <a:gd name="connsiteX5" fmla="*/ 110186 w 672944"/>
              <a:gd name="connsiteY5" fmla="*/ 1209941 h 2452035"/>
              <a:gd name="connsiteX6" fmla="*/ 110186 w 672944"/>
              <a:gd name="connsiteY6" fmla="*/ 1333766 h 2452035"/>
              <a:gd name="connsiteX7" fmla="*/ 62561 w 672944"/>
              <a:gd name="connsiteY7" fmla="*/ 1552841 h 2452035"/>
              <a:gd name="connsiteX8" fmla="*/ 72086 w 672944"/>
              <a:gd name="connsiteY8" fmla="*/ 1819541 h 2452035"/>
              <a:gd name="connsiteX9" fmla="*/ 33986 w 672944"/>
              <a:gd name="connsiteY9" fmla="*/ 2048141 h 2452035"/>
              <a:gd name="connsiteX10" fmla="*/ 5411 w 672944"/>
              <a:gd name="connsiteY10" fmla="*/ 2429141 h 2452035"/>
              <a:gd name="connsiteX11" fmla="*/ 148286 w 672944"/>
              <a:gd name="connsiteY11" fmla="*/ 2410091 h 2452035"/>
              <a:gd name="connsiteX12" fmla="*/ 234011 w 672944"/>
              <a:gd name="connsiteY12" fmla="*/ 2419616 h 2452035"/>
              <a:gd name="connsiteX13" fmla="*/ 357837 w 672944"/>
              <a:gd name="connsiteY13" fmla="*/ 2091003 h 2452035"/>
              <a:gd name="connsiteX14" fmla="*/ 357836 w 672944"/>
              <a:gd name="connsiteY14" fmla="*/ 2019566 h 2452035"/>
              <a:gd name="connsiteX15" fmla="*/ 443561 w 672944"/>
              <a:gd name="connsiteY15" fmla="*/ 1829066 h 2452035"/>
              <a:gd name="connsiteX16" fmla="*/ 567386 w 672944"/>
              <a:gd name="connsiteY16" fmla="*/ 1552841 h 2452035"/>
              <a:gd name="connsiteX17" fmla="*/ 586436 w 672944"/>
              <a:gd name="connsiteY17" fmla="*/ 1276616 h 2452035"/>
              <a:gd name="connsiteX18" fmla="*/ 629300 w 672944"/>
              <a:gd name="connsiteY18" fmla="*/ 1252803 h 2452035"/>
              <a:gd name="connsiteX19" fmla="*/ 672161 w 672944"/>
              <a:gd name="connsiteY19" fmla="*/ 1148028 h 2452035"/>
              <a:gd name="connsiteX20" fmla="*/ 662636 w 672944"/>
              <a:gd name="connsiteY20" fmla="*/ 1105165 h 2452035"/>
              <a:gd name="connsiteX21" fmla="*/ 514999 w 672944"/>
              <a:gd name="connsiteY21" fmla="*/ 1057541 h 2452035"/>
              <a:gd name="connsiteX22" fmla="*/ 462611 w 672944"/>
              <a:gd name="connsiteY22" fmla="*/ 981341 h 2452035"/>
              <a:gd name="connsiteX23" fmla="*/ 391173 w 672944"/>
              <a:gd name="connsiteY23" fmla="*/ 876566 h 2452035"/>
              <a:gd name="connsiteX24" fmla="*/ 238774 w 672944"/>
              <a:gd name="connsiteY24" fmla="*/ 690828 h 2452035"/>
              <a:gd name="connsiteX25" fmla="*/ 186387 w 672944"/>
              <a:gd name="connsiteY25" fmla="*/ 338403 h 2452035"/>
              <a:gd name="connsiteX26" fmla="*/ 114949 w 672944"/>
              <a:gd name="connsiteY26" fmla="*/ 266 h 2452035"/>
              <a:gd name="connsiteX0" fmla="*/ 114949 w 672944"/>
              <a:gd name="connsiteY0" fmla="*/ 266 h 2452035"/>
              <a:gd name="connsiteX1" fmla="*/ 105425 w 672944"/>
              <a:gd name="connsiteY1" fmla="*/ 286015 h 2452035"/>
              <a:gd name="connsiteX2" fmla="*/ 162574 w 672944"/>
              <a:gd name="connsiteY2" fmla="*/ 514616 h 2452035"/>
              <a:gd name="connsiteX3" fmla="*/ 148286 w 672944"/>
              <a:gd name="connsiteY3" fmla="*/ 847991 h 2452035"/>
              <a:gd name="connsiteX4" fmla="*/ 157811 w 672944"/>
              <a:gd name="connsiteY4" fmla="*/ 1005154 h 2452035"/>
              <a:gd name="connsiteX5" fmla="*/ 110186 w 672944"/>
              <a:gd name="connsiteY5" fmla="*/ 1209941 h 2452035"/>
              <a:gd name="connsiteX6" fmla="*/ 110186 w 672944"/>
              <a:gd name="connsiteY6" fmla="*/ 1333766 h 2452035"/>
              <a:gd name="connsiteX7" fmla="*/ 62561 w 672944"/>
              <a:gd name="connsiteY7" fmla="*/ 1552841 h 2452035"/>
              <a:gd name="connsiteX8" fmla="*/ 72086 w 672944"/>
              <a:gd name="connsiteY8" fmla="*/ 1819541 h 2452035"/>
              <a:gd name="connsiteX9" fmla="*/ 33986 w 672944"/>
              <a:gd name="connsiteY9" fmla="*/ 2048141 h 2452035"/>
              <a:gd name="connsiteX10" fmla="*/ 5411 w 672944"/>
              <a:gd name="connsiteY10" fmla="*/ 2429141 h 2452035"/>
              <a:gd name="connsiteX11" fmla="*/ 148286 w 672944"/>
              <a:gd name="connsiteY11" fmla="*/ 2410091 h 2452035"/>
              <a:gd name="connsiteX12" fmla="*/ 234011 w 672944"/>
              <a:gd name="connsiteY12" fmla="*/ 2419616 h 2452035"/>
              <a:gd name="connsiteX13" fmla="*/ 357837 w 672944"/>
              <a:gd name="connsiteY13" fmla="*/ 2091003 h 2452035"/>
              <a:gd name="connsiteX14" fmla="*/ 357836 w 672944"/>
              <a:gd name="connsiteY14" fmla="*/ 2019566 h 2452035"/>
              <a:gd name="connsiteX15" fmla="*/ 467375 w 672944"/>
              <a:gd name="connsiteY15" fmla="*/ 1900503 h 2452035"/>
              <a:gd name="connsiteX16" fmla="*/ 443561 w 672944"/>
              <a:gd name="connsiteY16" fmla="*/ 1829066 h 2452035"/>
              <a:gd name="connsiteX17" fmla="*/ 567386 w 672944"/>
              <a:gd name="connsiteY17" fmla="*/ 1552841 h 2452035"/>
              <a:gd name="connsiteX18" fmla="*/ 586436 w 672944"/>
              <a:gd name="connsiteY18" fmla="*/ 1276616 h 2452035"/>
              <a:gd name="connsiteX19" fmla="*/ 629300 w 672944"/>
              <a:gd name="connsiteY19" fmla="*/ 1252803 h 2452035"/>
              <a:gd name="connsiteX20" fmla="*/ 672161 w 672944"/>
              <a:gd name="connsiteY20" fmla="*/ 1148028 h 2452035"/>
              <a:gd name="connsiteX21" fmla="*/ 662636 w 672944"/>
              <a:gd name="connsiteY21" fmla="*/ 1105165 h 2452035"/>
              <a:gd name="connsiteX22" fmla="*/ 514999 w 672944"/>
              <a:gd name="connsiteY22" fmla="*/ 1057541 h 2452035"/>
              <a:gd name="connsiteX23" fmla="*/ 462611 w 672944"/>
              <a:gd name="connsiteY23" fmla="*/ 981341 h 2452035"/>
              <a:gd name="connsiteX24" fmla="*/ 391173 w 672944"/>
              <a:gd name="connsiteY24" fmla="*/ 876566 h 2452035"/>
              <a:gd name="connsiteX25" fmla="*/ 238774 w 672944"/>
              <a:gd name="connsiteY25" fmla="*/ 690828 h 2452035"/>
              <a:gd name="connsiteX26" fmla="*/ 186387 w 672944"/>
              <a:gd name="connsiteY26" fmla="*/ 338403 h 2452035"/>
              <a:gd name="connsiteX27" fmla="*/ 114949 w 672944"/>
              <a:gd name="connsiteY27" fmla="*/ 266 h 2452035"/>
              <a:gd name="connsiteX0" fmla="*/ 114949 w 672944"/>
              <a:gd name="connsiteY0" fmla="*/ 266 h 2452035"/>
              <a:gd name="connsiteX1" fmla="*/ 105425 w 672944"/>
              <a:gd name="connsiteY1" fmla="*/ 286015 h 2452035"/>
              <a:gd name="connsiteX2" fmla="*/ 162574 w 672944"/>
              <a:gd name="connsiteY2" fmla="*/ 514616 h 2452035"/>
              <a:gd name="connsiteX3" fmla="*/ 148286 w 672944"/>
              <a:gd name="connsiteY3" fmla="*/ 847991 h 2452035"/>
              <a:gd name="connsiteX4" fmla="*/ 157811 w 672944"/>
              <a:gd name="connsiteY4" fmla="*/ 1005154 h 2452035"/>
              <a:gd name="connsiteX5" fmla="*/ 110186 w 672944"/>
              <a:gd name="connsiteY5" fmla="*/ 1209941 h 2452035"/>
              <a:gd name="connsiteX6" fmla="*/ 110186 w 672944"/>
              <a:gd name="connsiteY6" fmla="*/ 1333766 h 2452035"/>
              <a:gd name="connsiteX7" fmla="*/ 62561 w 672944"/>
              <a:gd name="connsiteY7" fmla="*/ 1552841 h 2452035"/>
              <a:gd name="connsiteX8" fmla="*/ 72086 w 672944"/>
              <a:gd name="connsiteY8" fmla="*/ 1819541 h 2452035"/>
              <a:gd name="connsiteX9" fmla="*/ 33986 w 672944"/>
              <a:gd name="connsiteY9" fmla="*/ 2048141 h 2452035"/>
              <a:gd name="connsiteX10" fmla="*/ 5411 w 672944"/>
              <a:gd name="connsiteY10" fmla="*/ 2429141 h 2452035"/>
              <a:gd name="connsiteX11" fmla="*/ 148286 w 672944"/>
              <a:gd name="connsiteY11" fmla="*/ 2410091 h 2452035"/>
              <a:gd name="connsiteX12" fmla="*/ 234011 w 672944"/>
              <a:gd name="connsiteY12" fmla="*/ 2419616 h 2452035"/>
              <a:gd name="connsiteX13" fmla="*/ 357837 w 672944"/>
              <a:gd name="connsiteY13" fmla="*/ 2091003 h 2452035"/>
              <a:gd name="connsiteX14" fmla="*/ 357836 w 672944"/>
              <a:gd name="connsiteY14" fmla="*/ 2019566 h 2452035"/>
              <a:gd name="connsiteX15" fmla="*/ 467375 w 672944"/>
              <a:gd name="connsiteY15" fmla="*/ 1900503 h 2452035"/>
              <a:gd name="connsiteX16" fmla="*/ 443561 w 672944"/>
              <a:gd name="connsiteY16" fmla="*/ 1829066 h 2452035"/>
              <a:gd name="connsiteX17" fmla="*/ 548336 w 672944"/>
              <a:gd name="connsiteY17" fmla="*/ 1576653 h 2452035"/>
              <a:gd name="connsiteX18" fmla="*/ 586436 w 672944"/>
              <a:gd name="connsiteY18" fmla="*/ 1276616 h 2452035"/>
              <a:gd name="connsiteX19" fmla="*/ 629300 w 672944"/>
              <a:gd name="connsiteY19" fmla="*/ 1252803 h 2452035"/>
              <a:gd name="connsiteX20" fmla="*/ 672161 w 672944"/>
              <a:gd name="connsiteY20" fmla="*/ 1148028 h 2452035"/>
              <a:gd name="connsiteX21" fmla="*/ 662636 w 672944"/>
              <a:gd name="connsiteY21" fmla="*/ 1105165 h 2452035"/>
              <a:gd name="connsiteX22" fmla="*/ 514999 w 672944"/>
              <a:gd name="connsiteY22" fmla="*/ 1057541 h 2452035"/>
              <a:gd name="connsiteX23" fmla="*/ 462611 w 672944"/>
              <a:gd name="connsiteY23" fmla="*/ 981341 h 2452035"/>
              <a:gd name="connsiteX24" fmla="*/ 391173 w 672944"/>
              <a:gd name="connsiteY24" fmla="*/ 876566 h 2452035"/>
              <a:gd name="connsiteX25" fmla="*/ 238774 w 672944"/>
              <a:gd name="connsiteY25" fmla="*/ 690828 h 2452035"/>
              <a:gd name="connsiteX26" fmla="*/ 186387 w 672944"/>
              <a:gd name="connsiteY26" fmla="*/ 338403 h 2452035"/>
              <a:gd name="connsiteX27" fmla="*/ 114949 w 672944"/>
              <a:gd name="connsiteY27" fmla="*/ 266 h 2452035"/>
              <a:gd name="connsiteX0" fmla="*/ 114949 w 672944"/>
              <a:gd name="connsiteY0" fmla="*/ 266 h 2452035"/>
              <a:gd name="connsiteX1" fmla="*/ 105425 w 672944"/>
              <a:gd name="connsiteY1" fmla="*/ 286015 h 2452035"/>
              <a:gd name="connsiteX2" fmla="*/ 162574 w 672944"/>
              <a:gd name="connsiteY2" fmla="*/ 514616 h 2452035"/>
              <a:gd name="connsiteX3" fmla="*/ 148286 w 672944"/>
              <a:gd name="connsiteY3" fmla="*/ 847991 h 2452035"/>
              <a:gd name="connsiteX4" fmla="*/ 157811 w 672944"/>
              <a:gd name="connsiteY4" fmla="*/ 1005154 h 2452035"/>
              <a:gd name="connsiteX5" fmla="*/ 110186 w 672944"/>
              <a:gd name="connsiteY5" fmla="*/ 1209941 h 2452035"/>
              <a:gd name="connsiteX6" fmla="*/ 110186 w 672944"/>
              <a:gd name="connsiteY6" fmla="*/ 1333766 h 2452035"/>
              <a:gd name="connsiteX7" fmla="*/ 62561 w 672944"/>
              <a:gd name="connsiteY7" fmla="*/ 1552841 h 2452035"/>
              <a:gd name="connsiteX8" fmla="*/ 72086 w 672944"/>
              <a:gd name="connsiteY8" fmla="*/ 1819541 h 2452035"/>
              <a:gd name="connsiteX9" fmla="*/ 33986 w 672944"/>
              <a:gd name="connsiteY9" fmla="*/ 2048141 h 2452035"/>
              <a:gd name="connsiteX10" fmla="*/ 5411 w 672944"/>
              <a:gd name="connsiteY10" fmla="*/ 2429141 h 2452035"/>
              <a:gd name="connsiteX11" fmla="*/ 148286 w 672944"/>
              <a:gd name="connsiteY11" fmla="*/ 2410091 h 2452035"/>
              <a:gd name="connsiteX12" fmla="*/ 234011 w 672944"/>
              <a:gd name="connsiteY12" fmla="*/ 2419616 h 2452035"/>
              <a:gd name="connsiteX13" fmla="*/ 357837 w 672944"/>
              <a:gd name="connsiteY13" fmla="*/ 2091003 h 2452035"/>
              <a:gd name="connsiteX14" fmla="*/ 357836 w 672944"/>
              <a:gd name="connsiteY14" fmla="*/ 2019566 h 2452035"/>
              <a:gd name="connsiteX15" fmla="*/ 467375 w 672944"/>
              <a:gd name="connsiteY15" fmla="*/ 1900503 h 2452035"/>
              <a:gd name="connsiteX16" fmla="*/ 443561 w 672944"/>
              <a:gd name="connsiteY16" fmla="*/ 1829066 h 2452035"/>
              <a:gd name="connsiteX17" fmla="*/ 548336 w 672944"/>
              <a:gd name="connsiteY17" fmla="*/ 1576653 h 2452035"/>
              <a:gd name="connsiteX18" fmla="*/ 576912 w 672944"/>
              <a:gd name="connsiteY18" fmla="*/ 1390915 h 2452035"/>
              <a:gd name="connsiteX19" fmla="*/ 586436 w 672944"/>
              <a:gd name="connsiteY19" fmla="*/ 1276616 h 2452035"/>
              <a:gd name="connsiteX20" fmla="*/ 629300 w 672944"/>
              <a:gd name="connsiteY20" fmla="*/ 1252803 h 2452035"/>
              <a:gd name="connsiteX21" fmla="*/ 672161 w 672944"/>
              <a:gd name="connsiteY21" fmla="*/ 1148028 h 2452035"/>
              <a:gd name="connsiteX22" fmla="*/ 662636 w 672944"/>
              <a:gd name="connsiteY22" fmla="*/ 1105165 h 2452035"/>
              <a:gd name="connsiteX23" fmla="*/ 514999 w 672944"/>
              <a:gd name="connsiteY23" fmla="*/ 1057541 h 2452035"/>
              <a:gd name="connsiteX24" fmla="*/ 462611 w 672944"/>
              <a:gd name="connsiteY24" fmla="*/ 981341 h 2452035"/>
              <a:gd name="connsiteX25" fmla="*/ 391173 w 672944"/>
              <a:gd name="connsiteY25" fmla="*/ 876566 h 2452035"/>
              <a:gd name="connsiteX26" fmla="*/ 238774 w 672944"/>
              <a:gd name="connsiteY26" fmla="*/ 690828 h 2452035"/>
              <a:gd name="connsiteX27" fmla="*/ 186387 w 672944"/>
              <a:gd name="connsiteY27" fmla="*/ 338403 h 2452035"/>
              <a:gd name="connsiteX28" fmla="*/ 114949 w 672944"/>
              <a:gd name="connsiteY28" fmla="*/ 266 h 2452035"/>
              <a:gd name="connsiteX0" fmla="*/ 114949 w 672944"/>
              <a:gd name="connsiteY0" fmla="*/ 266 h 2452035"/>
              <a:gd name="connsiteX1" fmla="*/ 105425 w 672944"/>
              <a:gd name="connsiteY1" fmla="*/ 286015 h 2452035"/>
              <a:gd name="connsiteX2" fmla="*/ 162574 w 672944"/>
              <a:gd name="connsiteY2" fmla="*/ 514616 h 2452035"/>
              <a:gd name="connsiteX3" fmla="*/ 148286 w 672944"/>
              <a:gd name="connsiteY3" fmla="*/ 847991 h 2452035"/>
              <a:gd name="connsiteX4" fmla="*/ 157811 w 672944"/>
              <a:gd name="connsiteY4" fmla="*/ 1005154 h 2452035"/>
              <a:gd name="connsiteX5" fmla="*/ 110186 w 672944"/>
              <a:gd name="connsiteY5" fmla="*/ 1209941 h 2452035"/>
              <a:gd name="connsiteX6" fmla="*/ 110186 w 672944"/>
              <a:gd name="connsiteY6" fmla="*/ 1333766 h 2452035"/>
              <a:gd name="connsiteX7" fmla="*/ 62561 w 672944"/>
              <a:gd name="connsiteY7" fmla="*/ 1552841 h 2452035"/>
              <a:gd name="connsiteX8" fmla="*/ 72086 w 672944"/>
              <a:gd name="connsiteY8" fmla="*/ 1819541 h 2452035"/>
              <a:gd name="connsiteX9" fmla="*/ 33986 w 672944"/>
              <a:gd name="connsiteY9" fmla="*/ 2048141 h 2452035"/>
              <a:gd name="connsiteX10" fmla="*/ 5411 w 672944"/>
              <a:gd name="connsiteY10" fmla="*/ 2429141 h 2452035"/>
              <a:gd name="connsiteX11" fmla="*/ 148286 w 672944"/>
              <a:gd name="connsiteY11" fmla="*/ 2410091 h 2452035"/>
              <a:gd name="connsiteX12" fmla="*/ 234011 w 672944"/>
              <a:gd name="connsiteY12" fmla="*/ 2419616 h 2452035"/>
              <a:gd name="connsiteX13" fmla="*/ 357837 w 672944"/>
              <a:gd name="connsiteY13" fmla="*/ 2091003 h 2452035"/>
              <a:gd name="connsiteX14" fmla="*/ 357836 w 672944"/>
              <a:gd name="connsiteY14" fmla="*/ 2019566 h 2452035"/>
              <a:gd name="connsiteX15" fmla="*/ 467375 w 672944"/>
              <a:gd name="connsiteY15" fmla="*/ 1900503 h 2452035"/>
              <a:gd name="connsiteX16" fmla="*/ 443561 w 672944"/>
              <a:gd name="connsiteY16" fmla="*/ 1829066 h 2452035"/>
              <a:gd name="connsiteX17" fmla="*/ 548336 w 672944"/>
              <a:gd name="connsiteY17" fmla="*/ 1576653 h 2452035"/>
              <a:gd name="connsiteX18" fmla="*/ 576912 w 672944"/>
              <a:gd name="connsiteY18" fmla="*/ 1390915 h 2452035"/>
              <a:gd name="connsiteX19" fmla="*/ 586436 w 672944"/>
              <a:gd name="connsiteY19" fmla="*/ 1276616 h 2452035"/>
              <a:gd name="connsiteX20" fmla="*/ 629300 w 672944"/>
              <a:gd name="connsiteY20" fmla="*/ 1252803 h 2452035"/>
              <a:gd name="connsiteX21" fmla="*/ 672161 w 672944"/>
              <a:gd name="connsiteY21" fmla="*/ 1148028 h 2452035"/>
              <a:gd name="connsiteX22" fmla="*/ 662636 w 672944"/>
              <a:gd name="connsiteY22" fmla="*/ 1105165 h 2452035"/>
              <a:gd name="connsiteX23" fmla="*/ 514999 w 672944"/>
              <a:gd name="connsiteY23" fmla="*/ 1057541 h 2452035"/>
              <a:gd name="connsiteX24" fmla="*/ 462611 w 672944"/>
              <a:gd name="connsiteY24" fmla="*/ 981341 h 2452035"/>
              <a:gd name="connsiteX25" fmla="*/ 391173 w 672944"/>
              <a:gd name="connsiteY25" fmla="*/ 876566 h 2452035"/>
              <a:gd name="connsiteX26" fmla="*/ 238774 w 672944"/>
              <a:gd name="connsiteY26" fmla="*/ 690828 h 2452035"/>
              <a:gd name="connsiteX27" fmla="*/ 186387 w 672944"/>
              <a:gd name="connsiteY27" fmla="*/ 338403 h 2452035"/>
              <a:gd name="connsiteX28" fmla="*/ 114949 w 672944"/>
              <a:gd name="connsiteY28" fmla="*/ 266 h 2452035"/>
              <a:gd name="connsiteX0" fmla="*/ 114949 w 672944"/>
              <a:gd name="connsiteY0" fmla="*/ 266 h 2452035"/>
              <a:gd name="connsiteX1" fmla="*/ 105425 w 672944"/>
              <a:gd name="connsiteY1" fmla="*/ 286015 h 2452035"/>
              <a:gd name="connsiteX2" fmla="*/ 162574 w 672944"/>
              <a:gd name="connsiteY2" fmla="*/ 514616 h 2452035"/>
              <a:gd name="connsiteX3" fmla="*/ 148286 w 672944"/>
              <a:gd name="connsiteY3" fmla="*/ 847991 h 2452035"/>
              <a:gd name="connsiteX4" fmla="*/ 157811 w 672944"/>
              <a:gd name="connsiteY4" fmla="*/ 1005154 h 2452035"/>
              <a:gd name="connsiteX5" fmla="*/ 110186 w 672944"/>
              <a:gd name="connsiteY5" fmla="*/ 1209941 h 2452035"/>
              <a:gd name="connsiteX6" fmla="*/ 110186 w 672944"/>
              <a:gd name="connsiteY6" fmla="*/ 1333766 h 2452035"/>
              <a:gd name="connsiteX7" fmla="*/ 62561 w 672944"/>
              <a:gd name="connsiteY7" fmla="*/ 1552841 h 2452035"/>
              <a:gd name="connsiteX8" fmla="*/ 72086 w 672944"/>
              <a:gd name="connsiteY8" fmla="*/ 1819541 h 2452035"/>
              <a:gd name="connsiteX9" fmla="*/ 33986 w 672944"/>
              <a:gd name="connsiteY9" fmla="*/ 2048141 h 2452035"/>
              <a:gd name="connsiteX10" fmla="*/ 5411 w 672944"/>
              <a:gd name="connsiteY10" fmla="*/ 2429141 h 2452035"/>
              <a:gd name="connsiteX11" fmla="*/ 148286 w 672944"/>
              <a:gd name="connsiteY11" fmla="*/ 2410091 h 2452035"/>
              <a:gd name="connsiteX12" fmla="*/ 234011 w 672944"/>
              <a:gd name="connsiteY12" fmla="*/ 2419616 h 2452035"/>
              <a:gd name="connsiteX13" fmla="*/ 357837 w 672944"/>
              <a:gd name="connsiteY13" fmla="*/ 2091003 h 2452035"/>
              <a:gd name="connsiteX14" fmla="*/ 357836 w 672944"/>
              <a:gd name="connsiteY14" fmla="*/ 2019566 h 2452035"/>
              <a:gd name="connsiteX15" fmla="*/ 467375 w 672944"/>
              <a:gd name="connsiteY15" fmla="*/ 1900503 h 2452035"/>
              <a:gd name="connsiteX16" fmla="*/ 443561 w 672944"/>
              <a:gd name="connsiteY16" fmla="*/ 1829066 h 2452035"/>
              <a:gd name="connsiteX17" fmla="*/ 495950 w 672944"/>
              <a:gd name="connsiteY17" fmla="*/ 1752865 h 2452035"/>
              <a:gd name="connsiteX18" fmla="*/ 548336 w 672944"/>
              <a:gd name="connsiteY18" fmla="*/ 1576653 h 2452035"/>
              <a:gd name="connsiteX19" fmla="*/ 576912 w 672944"/>
              <a:gd name="connsiteY19" fmla="*/ 1390915 h 2452035"/>
              <a:gd name="connsiteX20" fmla="*/ 586436 w 672944"/>
              <a:gd name="connsiteY20" fmla="*/ 1276616 h 2452035"/>
              <a:gd name="connsiteX21" fmla="*/ 629300 w 672944"/>
              <a:gd name="connsiteY21" fmla="*/ 1252803 h 2452035"/>
              <a:gd name="connsiteX22" fmla="*/ 672161 w 672944"/>
              <a:gd name="connsiteY22" fmla="*/ 1148028 h 2452035"/>
              <a:gd name="connsiteX23" fmla="*/ 662636 w 672944"/>
              <a:gd name="connsiteY23" fmla="*/ 1105165 h 2452035"/>
              <a:gd name="connsiteX24" fmla="*/ 514999 w 672944"/>
              <a:gd name="connsiteY24" fmla="*/ 1057541 h 2452035"/>
              <a:gd name="connsiteX25" fmla="*/ 462611 w 672944"/>
              <a:gd name="connsiteY25" fmla="*/ 981341 h 2452035"/>
              <a:gd name="connsiteX26" fmla="*/ 391173 w 672944"/>
              <a:gd name="connsiteY26" fmla="*/ 876566 h 2452035"/>
              <a:gd name="connsiteX27" fmla="*/ 238774 w 672944"/>
              <a:gd name="connsiteY27" fmla="*/ 690828 h 2452035"/>
              <a:gd name="connsiteX28" fmla="*/ 186387 w 672944"/>
              <a:gd name="connsiteY28" fmla="*/ 338403 h 2452035"/>
              <a:gd name="connsiteX29" fmla="*/ 114949 w 672944"/>
              <a:gd name="connsiteY29" fmla="*/ 266 h 2452035"/>
              <a:gd name="connsiteX0" fmla="*/ 114949 w 672944"/>
              <a:gd name="connsiteY0" fmla="*/ 266 h 2452035"/>
              <a:gd name="connsiteX1" fmla="*/ 105425 w 672944"/>
              <a:gd name="connsiteY1" fmla="*/ 286015 h 2452035"/>
              <a:gd name="connsiteX2" fmla="*/ 162574 w 672944"/>
              <a:gd name="connsiteY2" fmla="*/ 514616 h 2452035"/>
              <a:gd name="connsiteX3" fmla="*/ 148286 w 672944"/>
              <a:gd name="connsiteY3" fmla="*/ 847991 h 2452035"/>
              <a:gd name="connsiteX4" fmla="*/ 157811 w 672944"/>
              <a:gd name="connsiteY4" fmla="*/ 1005154 h 2452035"/>
              <a:gd name="connsiteX5" fmla="*/ 110186 w 672944"/>
              <a:gd name="connsiteY5" fmla="*/ 1209941 h 2452035"/>
              <a:gd name="connsiteX6" fmla="*/ 110186 w 672944"/>
              <a:gd name="connsiteY6" fmla="*/ 1333766 h 2452035"/>
              <a:gd name="connsiteX7" fmla="*/ 62561 w 672944"/>
              <a:gd name="connsiteY7" fmla="*/ 1552841 h 2452035"/>
              <a:gd name="connsiteX8" fmla="*/ 72086 w 672944"/>
              <a:gd name="connsiteY8" fmla="*/ 1819541 h 2452035"/>
              <a:gd name="connsiteX9" fmla="*/ 33986 w 672944"/>
              <a:gd name="connsiteY9" fmla="*/ 2048141 h 2452035"/>
              <a:gd name="connsiteX10" fmla="*/ 5411 w 672944"/>
              <a:gd name="connsiteY10" fmla="*/ 2429141 h 2452035"/>
              <a:gd name="connsiteX11" fmla="*/ 148286 w 672944"/>
              <a:gd name="connsiteY11" fmla="*/ 2410091 h 2452035"/>
              <a:gd name="connsiteX12" fmla="*/ 234011 w 672944"/>
              <a:gd name="connsiteY12" fmla="*/ 2419616 h 2452035"/>
              <a:gd name="connsiteX13" fmla="*/ 357837 w 672944"/>
              <a:gd name="connsiteY13" fmla="*/ 2091003 h 2452035"/>
              <a:gd name="connsiteX14" fmla="*/ 357836 w 672944"/>
              <a:gd name="connsiteY14" fmla="*/ 2019566 h 2452035"/>
              <a:gd name="connsiteX15" fmla="*/ 467375 w 672944"/>
              <a:gd name="connsiteY15" fmla="*/ 1900503 h 2452035"/>
              <a:gd name="connsiteX16" fmla="*/ 443561 w 672944"/>
              <a:gd name="connsiteY16" fmla="*/ 1829066 h 2452035"/>
              <a:gd name="connsiteX17" fmla="*/ 495950 w 672944"/>
              <a:gd name="connsiteY17" fmla="*/ 1752865 h 2452035"/>
              <a:gd name="connsiteX18" fmla="*/ 548336 w 672944"/>
              <a:gd name="connsiteY18" fmla="*/ 1576653 h 2452035"/>
              <a:gd name="connsiteX19" fmla="*/ 586437 w 672944"/>
              <a:gd name="connsiteY19" fmla="*/ 1395677 h 2452035"/>
              <a:gd name="connsiteX20" fmla="*/ 586436 w 672944"/>
              <a:gd name="connsiteY20" fmla="*/ 1276616 h 2452035"/>
              <a:gd name="connsiteX21" fmla="*/ 629300 w 672944"/>
              <a:gd name="connsiteY21" fmla="*/ 1252803 h 2452035"/>
              <a:gd name="connsiteX22" fmla="*/ 672161 w 672944"/>
              <a:gd name="connsiteY22" fmla="*/ 1148028 h 2452035"/>
              <a:gd name="connsiteX23" fmla="*/ 662636 w 672944"/>
              <a:gd name="connsiteY23" fmla="*/ 1105165 h 2452035"/>
              <a:gd name="connsiteX24" fmla="*/ 514999 w 672944"/>
              <a:gd name="connsiteY24" fmla="*/ 1057541 h 2452035"/>
              <a:gd name="connsiteX25" fmla="*/ 462611 w 672944"/>
              <a:gd name="connsiteY25" fmla="*/ 981341 h 2452035"/>
              <a:gd name="connsiteX26" fmla="*/ 391173 w 672944"/>
              <a:gd name="connsiteY26" fmla="*/ 876566 h 2452035"/>
              <a:gd name="connsiteX27" fmla="*/ 238774 w 672944"/>
              <a:gd name="connsiteY27" fmla="*/ 690828 h 2452035"/>
              <a:gd name="connsiteX28" fmla="*/ 186387 w 672944"/>
              <a:gd name="connsiteY28" fmla="*/ 338403 h 2452035"/>
              <a:gd name="connsiteX29" fmla="*/ 114949 w 672944"/>
              <a:gd name="connsiteY29" fmla="*/ 266 h 2452035"/>
              <a:gd name="connsiteX0" fmla="*/ 114949 w 672944"/>
              <a:gd name="connsiteY0" fmla="*/ 266 h 2452035"/>
              <a:gd name="connsiteX1" fmla="*/ 105425 w 672944"/>
              <a:gd name="connsiteY1" fmla="*/ 286015 h 2452035"/>
              <a:gd name="connsiteX2" fmla="*/ 162574 w 672944"/>
              <a:gd name="connsiteY2" fmla="*/ 514616 h 2452035"/>
              <a:gd name="connsiteX3" fmla="*/ 148286 w 672944"/>
              <a:gd name="connsiteY3" fmla="*/ 847991 h 2452035"/>
              <a:gd name="connsiteX4" fmla="*/ 157811 w 672944"/>
              <a:gd name="connsiteY4" fmla="*/ 1005154 h 2452035"/>
              <a:gd name="connsiteX5" fmla="*/ 110186 w 672944"/>
              <a:gd name="connsiteY5" fmla="*/ 1209941 h 2452035"/>
              <a:gd name="connsiteX6" fmla="*/ 110186 w 672944"/>
              <a:gd name="connsiteY6" fmla="*/ 1333766 h 2452035"/>
              <a:gd name="connsiteX7" fmla="*/ 62561 w 672944"/>
              <a:gd name="connsiteY7" fmla="*/ 1552841 h 2452035"/>
              <a:gd name="connsiteX8" fmla="*/ 72086 w 672944"/>
              <a:gd name="connsiteY8" fmla="*/ 1819541 h 2452035"/>
              <a:gd name="connsiteX9" fmla="*/ 33986 w 672944"/>
              <a:gd name="connsiteY9" fmla="*/ 2048141 h 2452035"/>
              <a:gd name="connsiteX10" fmla="*/ 5411 w 672944"/>
              <a:gd name="connsiteY10" fmla="*/ 2429141 h 2452035"/>
              <a:gd name="connsiteX11" fmla="*/ 148286 w 672944"/>
              <a:gd name="connsiteY11" fmla="*/ 2410091 h 2452035"/>
              <a:gd name="connsiteX12" fmla="*/ 234011 w 672944"/>
              <a:gd name="connsiteY12" fmla="*/ 2419616 h 2452035"/>
              <a:gd name="connsiteX13" fmla="*/ 295925 w 672944"/>
              <a:gd name="connsiteY13" fmla="*/ 2224353 h 2452035"/>
              <a:gd name="connsiteX14" fmla="*/ 357837 w 672944"/>
              <a:gd name="connsiteY14" fmla="*/ 2091003 h 2452035"/>
              <a:gd name="connsiteX15" fmla="*/ 357836 w 672944"/>
              <a:gd name="connsiteY15" fmla="*/ 2019566 h 2452035"/>
              <a:gd name="connsiteX16" fmla="*/ 467375 w 672944"/>
              <a:gd name="connsiteY16" fmla="*/ 1900503 h 2452035"/>
              <a:gd name="connsiteX17" fmla="*/ 443561 w 672944"/>
              <a:gd name="connsiteY17" fmla="*/ 1829066 h 2452035"/>
              <a:gd name="connsiteX18" fmla="*/ 495950 w 672944"/>
              <a:gd name="connsiteY18" fmla="*/ 1752865 h 2452035"/>
              <a:gd name="connsiteX19" fmla="*/ 548336 w 672944"/>
              <a:gd name="connsiteY19" fmla="*/ 1576653 h 2452035"/>
              <a:gd name="connsiteX20" fmla="*/ 586437 w 672944"/>
              <a:gd name="connsiteY20" fmla="*/ 1395677 h 2452035"/>
              <a:gd name="connsiteX21" fmla="*/ 586436 w 672944"/>
              <a:gd name="connsiteY21" fmla="*/ 1276616 h 2452035"/>
              <a:gd name="connsiteX22" fmla="*/ 629300 w 672944"/>
              <a:gd name="connsiteY22" fmla="*/ 1252803 h 2452035"/>
              <a:gd name="connsiteX23" fmla="*/ 672161 w 672944"/>
              <a:gd name="connsiteY23" fmla="*/ 1148028 h 2452035"/>
              <a:gd name="connsiteX24" fmla="*/ 662636 w 672944"/>
              <a:gd name="connsiteY24" fmla="*/ 1105165 h 2452035"/>
              <a:gd name="connsiteX25" fmla="*/ 514999 w 672944"/>
              <a:gd name="connsiteY25" fmla="*/ 1057541 h 2452035"/>
              <a:gd name="connsiteX26" fmla="*/ 462611 w 672944"/>
              <a:gd name="connsiteY26" fmla="*/ 981341 h 2452035"/>
              <a:gd name="connsiteX27" fmla="*/ 391173 w 672944"/>
              <a:gd name="connsiteY27" fmla="*/ 876566 h 2452035"/>
              <a:gd name="connsiteX28" fmla="*/ 238774 w 672944"/>
              <a:gd name="connsiteY28" fmla="*/ 690828 h 2452035"/>
              <a:gd name="connsiteX29" fmla="*/ 186387 w 672944"/>
              <a:gd name="connsiteY29" fmla="*/ 338403 h 2452035"/>
              <a:gd name="connsiteX30" fmla="*/ 114949 w 672944"/>
              <a:gd name="connsiteY30" fmla="*/ 266 h 2452035"/>
              <a:gd name="connsiteX0" fmla="*/ 102306 w 660301"/>
              <a:gd name="connsiteY0" fmla="*/ 266 h 2432111"/>
              <a:gd name="connsiteX1" fmla="*/ 92782 w 660301"/>
              <a:gd name="connsiteY1" fmla="*/ 286015 h 2432111"/>
              <a:gd name="connsiteX2" fmla="*/ 149931 w 660301"/>
              <a:gd name="connsiteY2" fmla="*/ 514616 h 2432111"/>
              <a:gd name="connsiteX3" fmla="*/ 135643 w 660301"/>
              <a:gd name="connsiteY3" fmla="*/ 847991 h 2432111"/>
              <a:gd name="connsiteX4" fmla="*/ 145168 w 660301"/>
              <a:gd name="connsiteY4" fmla="*/ 1005154 h 2432111"/>
              <a:gd name="connsiteX5" fmla="*/ 97543 w 660301"/>
              <a:gd name="connsiteY5" fmla="*/ 1209941 h 2432111"/>
              <a:gd name="connsiteX6" fmla="*/ 97543 w 660301"/>
              <a:gd name="connsiteY6" fmla="*/ 1333766 h 2432111"/>
              <a:gd name="connsiteX7" fmla="*/ 49918 w 660301"/>
              <a:gd name="connsiteY7" fmla="*/ 1552841 h 2432111"/>
              <a:gd name="connsiteX8" fmla="*/ 59443 w 660301"/>
              <a:gd name="connsiteY8" fmla="*/ 1819541 h 2432111"/>
              <a:gd name="connsiteX9" fmla="*/ 21343 w 660301"/>
              <a:gd name="connsiteY9" fmla="*/ 2048141 h 2432111"/>
              <a:gd name="connsiteX10" fmla="*/ 7056 w 660301"/>
              <a:gd name="connsiteY10" fmla="*/ 2391041 h 2432111"/>
              <a:gd name="connsiteX11" fmla="*/ 135643 w 660301"/>
              <a:gd name="connsiteY11" fmla="*/ 2410091 h 2432111"/>
              <a:gd name="connsiteX12" fmla="*/ 221368 w 660301"/>
              <a:gd name="connsiteY12" fmla="*/ 2419616 h 2432111"/>
              <a:gd name="connsiteX13" fmla="*/ 283282 w 660301"/>
              <a:gd name="connsiteY13" fmla="*/ 2224353 h 2432111"/>
              <a:gd name="connsiteX14" fmla="*/ 345194 w 660301"/>
              <a:gd name="connsiteY14" fmla="*/ 2091003 h 2432111"/>
              <a:gd name="connsiteX15" fmla="*/ 345193 w 660301"/>
              <a:gd name="connsiteY15" fmla="*/ 2019566 h 2432111"/>
              <a:gd name="connsiteX16" fmla="*/ 454732 w 660301"/>
              <a:gd name="connsiteY16" fmla="*/ 1900503 h 2432111"/>
              <a:gd name="connsiteX17" fmla="*/ 430918 w 660301"/>
              <a:gd name="connsiteY17" fmla="*/ 1829066 h 2432111"/>
              <a:gd name="connsiteX18" fmla="*/ 483307 w 660301"/>
              <a:gd name="connsiteY18" fmla="*/ 1752865 h 2432111"/>
              <a:gd name="connsiteX19" fmla="*/ 535693 w 660301"/>
              <a:gd name="connsiteY19" fmla="*/ 1576653 h 2432111"/>
              <a:gd name="connsiteX20" fmla="*/ 573794 w 660301"/>
              <a:gd name="connsiteY20" fmla="*/ 1395677 h 2432111"/>
              <a:gd name="connsiteX21" fmla="*/ 573793 w 660301"/>
              <a:gd name="connsiteY21" fmla="*/ 1276616 h 2432111"/>
              <a:gd name="connsiteX22" fmla="*/ 616657 w 660301"/>
              <a:gd name="connsiteY22" fmla="*/ 1252803 h 2432111"/>
              <a:gd name="connsiteX23" fmla="*/ 659518 w 660301"/>
              <a:gd name="connsiteY23" fmla="*/ 1148028 h 2432111"/>
              <a:gd name="connsiteX24" fmla="*/ 649993 w 660301"/>
              <a:gd name="connsiteY24" fmla="*/ 1105165 h 2432111"/>
              <a:gd name="connsiteX25" fmla="*/ 502356 w 660301"/>
              <a:gd name="connsiteY25" fmla="*/ 1057541 h 2432111"/>
              <a:gd name="connsiteX26" fmla="*/ 449968 w 660301"/>
              <a:gd name="connsiteY26" fmla="*/ 981341 h 2432111"/>
              <a:gd name="connsiteX27" fmla="*/ 378530 w 660301"/>
              <a:gd name="connsiteY27" fmla="*/ 876566 h 2432111"/>
              <a:gd name="connsiteX28" fmla="*/ 226131 w 660301"/>
              <a:gd name="connsiteY28" fmla="*/ 690828 h 2432111"/>
              <a:gd name="connsiteX29" fmla="*/ 173744 w 660301"/>
              <a:gd name="connsiteY29" fmla="*/ 338403 h 2432111"/>
              <a:gd name="connsiteX30" fmla="*/ 102306 w 660301"/>
              <a:gd name="connsiteY30" fmla="*/ 266 h 2432111"/>
              <a:gd name="connsiteX0" fmla="*/ 103676 w 661671"/>
              <a:gd name="connsiteY0" fmla="*/ 266 h 2426976"/>
              <a:gd name="connsiteX1" fmla="*/ 94152 w 661671"/>
              <a:gd name="connsiteY1" fmla="*/ 286015 h 2426976"/>
              <a:gd name="connsiteX2" fmla="*/ 151301 w 661671"/>
              <a:gd name="connsiteY2" fmla="*/ 514616 h 2426976"/>
              <a:gd name="connsiteX3" fmla="*/ 137013 w 661671"/>
              <a:gd name="connsiteY3" fmla="*/ 847991 h 2426976"/>
              <a:gd name="connsiteX4" fmla="*/ 146538 w 661671"/>
              <a:gd name="connsiteY4" fmla="*/ 1005154 h 2426976"/>
              <a:gd name="connsiteX5" fmla="*/ 98913 w 661671"/>
              <a:gd name="connsiteY5" fmla="*/ 1209941 h 2426976"/>
              <a:gd name="connsiteX6" fmla="*/ 98913 w 661671"/>
              <a:gd name="connsiteY6" fmla="*/ 1333766 h 2426976"/>
              <a:gd name="connsiteX7" fmla="*/ 51288 w 661671"/>
              <a:gd name="connsiteY7" fmla="*/ 1552841 h 2426976"/>
              <a:gd name="connsiteX8" fmla="*/ 60813 w 661671"/>
              <a:gd name="connsiteY8" fmla="*/ 1819541 h 2426976"/>
              <a:gd name="connsiteX9" fmla="*/ 22713 w 661671"/>
              <a:gd name="connsiteY9" fmla="*/ 2048141 h 2426976"/>
              <a:gd name="connsiteX10" fmla="*/ 8426 w 661671"/>
              <a:gd name="connsiteY10" fmla="*/ 2391041 h 2426976"/>
              <a:gd name="connsiteX11" fmla="*/ 156063 w 661671"/>
              <a:gd name="connsiteY11" fmla="*/ 2386279 h 2426976"/>
              <a:gd name="connsiteX12" fmla="*/ 222738 w 661671"/>
              <a:gd name="connsiteY12" fmla="*/ 2419616 h 2426976"/>
              <a:gd name="connsiteX13" fmla="*/ 284652 w 661671"/>
              <a:gd name="connsiteY13" fmla="*/ 2224353 h 2426976"/>
              <a:gd name="connsiteX14" fmla="*/ 346564 w 661671"/>
              <a:gd name="connsiteY14" fmla="*/ 2091003 h 2426976"/>
              <a:gd name="connsiteX15" fmla="*/ 346563 w 661671"/>
              <a:gd name="connsiteY15" fmla="*/ 2019566 h 2426976"/>
              <a:gd name="connsiteX16" fmla="*/ 456102 w 661671"/>
              <a:gd name="connsiteY16" fmla="*/ 1900503 h 2426976"/>
              <a:gd name="connsiteX17" fmla="*/ 432288 w 661671"/>
              <a:gd name="connsiteY17" fmla="*/ 1829066 h 2426976"/>
              <a:gd name="connsiteX18" fmla="*/ 484677 w 661671"/>
              <a:gd name="connsiteY18" fmla="*/ 1752865 h 2426976"/>
              <a:gd name="connsiteX19" fmla="*/ 537063 w 661671"/>
              <a:gd name="connsiteY19" fmla="*/ 1576653 h 2426976"/>
              <a:gd name="connsiteX20" fmla="*/ 575164 w 661671"/>
              <a:gd name="connsiteY20" fmla="*/ 1395677 h 2426976"/>
              <a:gd name="connsiteX21" fmla="*/ 575163 w 661671"/>
              <a:gd name="connsiteY21" fmla="*/ 1276616 h 2426976"/>
              <a:gd name="connsiteX22" fmla="*/ 618027 w 661671"/>
              <a:gd name="connsiteY22" fmla="*/ 1252803 h 2426976"/>
              <a:gd name="connsiteX23" fmla="*/ 660888 w 661671"/>
              <a:gd name="connsiteY23" fmla="*/ 1148028 h 2426976"/>
              <a:gd name="connsiteX24" fmla="*/ 651363 w 661671"/>
              <a:gd name="connsiteY24" fmla="*/ 1105165 h 2426976"/>
              <a:gd name="connsiteX25" fmla="*/ 503726 w 661671"/>
              <a:gd name="connsiteY25" fmla="*/ 1057541 h 2426976"/>
              <a:gd name="connsiteX26" fmla="*/ 451338 w 661671"/>
              <a:gd name="connsiteY26" fmla="*/ 981341 h 2426976"/>
              <a:gd name="connsiteX27" fmla="*/ 379900 w 661671"/>
              <a:gd name="connsiteY27" fmla="*/ 876566 h 2426976"/>
              <a:gd name="connsiteX28" fmla="*/ 227501 w 661671"/>
              <a:gd name="connsiteY28" fmla="*/ 690828 h 2426976"/>
              <a:gd name="connsiteX29" fmla="*/ 175114 w 661671"/>
              <a:gd name="connsiteY29" fmla="*/ 338403 h 2426976"/>
              <a:gd name="connsiteX30" fmla="*/ 103676 w 661671"/>
              <a:gd name="connsiteY30" fmla="*/ 266 h 2426976"/>
              <a:gd name="connsiteX0" fmla="*/ 103676 w 661671"/>
              <a:gd name="connsiteY0" fmla="*/ 266 h 2415238"/>
              <a:gd name="connsiteX1" fmla="*/ 94152 w 661671"/>
              <a:gd name="connsiteY1" fmla="*/ 286015 h 2415238"/>
              <a:gd name="connsiteX2" fmla="*/ 151301 w 661671"/>
              <a:gd name="connsiteY2" fmla="*/ 514616 h 2415238"/>
              <a:gd name="connsiteX3" fmla="*/ 137013 w 661671"/>
              <a:gd name="connsiteY3" fmla="*/ 847991 h 2415238"/>
              <a:gd name="connsiteX4" fmla="*/ 146538 w 661671"/>
              <a:gd name="connsiteY4" fmla="*/ 1005154 h 2415238"/>
              <a:gd name="connsiteX5" fmla="*/ 98913 w 661671"/>
              <a:gd name="connsiteY5" fmla="*/ 1209941 h 2415238"/>
              <a:gd name="connsiteX6" fmla="*/ 98913 w 661671"/>
              <a:gd name="connsiteY6" fmla="*/ 1333766 h 2415238"/>
              <a:gd name="connsiteX7" fmla="*/ 51288 w 661671"/>
              <a:gd name="connsiteY7" fmla="*/ 1552841 h 2415238"/>
              <a:gd name="connsiteX8" fmla="*/ 60813 w 661671"/>
              <a:gd name="connsiteY8" fmla="*/ 1819541 h 2415238"/>
              <a:gd name="connsiteX9" fmla="*/ 22713 w 661671"/>
              <a:gd name="connsiteY9" fmla="*/ 2048141 h 2415238"/>
              <a:gd name="connsiteX10" fmla="*/ 8426 w 661671"/>
              <a:gd name="connsiteY10" fmla="*/ 2391041 h 2415238"/>
              <a:gd name="connsiteX11" fmla="*/ 156063 w 661671"/>
              <a:gd name="connsiteY11" fmla="*/ 2386279 h 2415238"/>
              <a:gd name="connsiteX12" fmla="*/ 222738 w 661671"/>
              <a:gd name="connsiteY12" fmla="*/ 2381516 h 2415238"/>
              <a:gd name="connsiteX13" fmla="*/ 284652 w 661671"/>
              <a:gd name="connsiteY13" fmla="*/ 2224353 h 2415238"/>
              <a:gd name="connsiteX14" fmla="*/ 346564 w 661671"/>
              <a:gd name="connsiteY14" fmla="*/ 2091003 h 2415238"/>
              <a:gd name="connsiteX15" fmla="*/ 346563 w 661671"/>
              <a:gd name="connsiteY15" fmla="*/ 2019566 h 2415238"/>
              <a:gd name="connsiteX16" fmla="*/ 456102 w 661671"/>
              <a:gd name="connsiteY16" fmla="*/ 1900503 h 2415238"/>
              <a:gd name="connsiteX17" fmla="*/ 432288 w 661671"/>
              <a:gd name="connsiteY17" fmla="*/ 1829066 h 2415238"/>
              <a:gd name="connsiteX18" fmla="*/ 484677 w 661671"/>
              <a:gd name="connsiteY18" fmla="*/ 1752865 h 2415238"/>
              <a:gd name="connsiteX19" fmla="*/ 537063 w 661671"/>
              <a:gd name="connsiteY19" fmla="*/ 1576653 h 2415238"/>
              <a:gd name="connsiteX20" fmla="*/ 575164 w 661671"/>
              <a:gd name="connsiteY20" fmla="*/ 1395677 h 2415238"/>
              <a:gd name="connsiteX21" fmla="*/ 575163 w 661671"/>
              <a:gd name="connsiteY21" fmla="*/ 1276616 h 2415238"/>
              <a:gd name="connsiteX22" fmla="*/ 618027 w 661671"/>
              <a:gd name="connsiteY22" fmla="*/ 1252803 h 2415238"/>
              <a:gd name="connsiteX23" fmla="*/ 660888 w 661671"/>
              <a:gd name="connsiteY23" fmla="*/ 1148028 h 2415238"/>
              <a:gd name="connsiteX24" fmla="*/ 651363 w 661671"/>
              <a:gd name="connsiteY24" fmla="*/ 1105165 h 2415238"/>
              <a:gd name="connsiteX25" fmla="*/ 503726 w 661671"/>
              <a:gd name="connsiteY25" fmla="*/ 1057541 h 2415238"/>
              <a:gd name="connsiteX26" fmla="*/ 451338 w 661671"/>
              <a:gd name="connsiteY26" fmla="*/ 981341 h 2415238"/>
              <a:gd name="connsiteX27" fmla="*/ 379900 w 661671"/>
              <a:gd name="connsiteY27" fmla="*/ 876566 h 2415238"/>
              <a:gd name="connsiteX28" fmla="*/ 227501 w 661671"/>
              <a:gd name="connsiteY28" fmla="*/ 690828 h 2415238"/>
              <a:gd name="connsiteX29" fmla="*/ 175114 w 661671"/>
              <a:gd name="connsiteY29" fmla="*/ 338403 h 2415238"/>
              <a:gd name="connsiteX30" fmla="*/ 103676 w 661671"/>
              <a:gd name="connsiteY30" fmla="*/ 266 h 2415238"/>
              <a:gd name="connsiteX0" fmla="*/ 103676 w 661671"/>
              <a:gd name="connsiteY0" fmla="*/ 266 h 2415238"/>
              <a:gd name="connsiteX1" fmla="*/ 94152 w 661671"/>
              <a:gd name="connsiteY1" fmla="*/ 286015 h 2415238"/>
              <a:gd name="connsiteX2" fmla="*/ 151301 w 661671"/>
              <a:gd name="connsiteY2" fmla="*/ 514616 h 2415238"/>
              <a:gd name="connsiteX3" fmla="*/ 137013 w 661671"/>
              <a:gd name="connsiteY3" fmla="*/ 847991 h 2415238"/>
              <a:gd name="connsiteX4" fmla="*/ 127488 w 661671"/>
              <a:gd name="connsiteY4" fmla="*/ 1028966 h 2415238"/>
              <a:gd name="connsiteX5" fmla="*/ 98913 w 661671"/>
              <a:gd name="connsiteY5" fmla="*/ 1209941 h 2415238"/>
              <a:gd name="connsiteX6" fmla="*/ 98913 w 661671"/>
              <a:gd name="connsiteY6" fmla="*/ 1333766 h 2415238"/>
              <a:gd name="connsiteX7" fmla="*/ 51288 w 661671"/>
              <a:gd name="connsiteY7" fmla="*/ 1552841 h 2415238"/>
              <a:gd name="connsiteX8" fmla="*/ 60813 w 661671"/>
              <a:gd name="connsiteY8" fmla="*/ 1819541 h 2415238"/>
              <a:gd name="connsiteX9" fmla="*/ 22713 w 661671"/>
              <a:gd name="connsiteY9" fmla="*/ 2048141 h 2415238"/>
              <a:gd name="connsiteX10" fmla="*/ 8426 w 661671"/>
              <a:gd name="connsiteY10" fmla="*/ 2391041 h 2415238"/>
              <a:gd name="connsiteX11" fmla="*/ 156063 w 661671"/>
              <a:gd name="connsiteY11" fmla="*/ 2386279 h 2415238"/>
              <a:gd name="connsiteX12" fmla="*/ 222738 w 661671"/>
              <a:gd name="connsiteY12" fmla="*/ 2381516 h 2415238"/>
              <a:gd name="connsiteX13" fmla="*/ 284652 w 661671"/>
              <a:gd name="connsiteY13" fmla="*/ 2224353 h 2415238"/>
              <a:gd name="connsiteX14" fmla="*/ 346564 w 661671"/>
              <a:gd name="connsiteY14" fmla="*/ 2091003 h 2415238"/>
              <a:gd name="connsiteX15" fmla="*/ 346563 w 661671"/>
              <a:gd name="connsiteY15" fmla="*/ 2019566 h 2415238"/>
              <a:gd name="connsiteX16" fmla="*/ 456102 w 661671"/>
              <a:gd name="connsiteY16" fmla="*/ 1900503 h 2415238"/>
              <a:gd name="connsiteX17" fmla="*/ 432288 w 661671"/>
              <a:gd name="connsiteY17" fmla="*/ 1829066 h 2415238"/>
              <a:gd name="connsiteX18" fmla="*/ 484677 w 661671"/>
              <a:gd name="connsiteY18" fmla="*/ 1752865 h 2415238"/>
              <a:gd name="connsiteX19" fmla="*/ 537063 w 661671"/>
              <a:gd name="connsiteY19" fmla="*/ 1576653 h 2415238"/>
              <a:gd name="connsiteX20" fmla="*/ 575164 w 661671"/>
              <a:gd name="connsiteY20" fmla="*/ 1395677 h 2415238"/>
              <a:gd name="connsiteX21" fmla="*/ 575163 w 661671"/>
              <a:gd name="connsiteY21" fmla="*/ 1276616 h 2415238"/>
              <a:gd name="connsiteX22" fmla="*/ 618027 w 661671"/>
              <a:gd name="connsiteY22" fmla="*/ 1252803 h 2415238"/>
              <a:gd name="connsiteX23" fmla="*/ 660888 w 661671"/>
              <a:gd name="connsiteY23" fmla="*/ 1148028 h 2415238"/>
              <a:gd name="connsiteX24" fmla="*/ 651363 w 661671"/>
              <a:gd name="connsiteY24" fmla="*/ 1105165 h 2415238"/>
              <a:gd name="connsiteX25" fmla="*/ 503726 w 661671"/>
              <a:gd name="connsiteY25" fmla="*/ 1057541 h 2415238"/>
              <a:gd name="connsiteX26" fmla="*/ 451338 w 661671"/>
              <a:gd name="connsiteY26" fmla="*/ 981341 h 2415238"/>
              <a:gd name="connsiteX27" fmla="*/ 379900 w 661671"/>
              <a:gd name="connsiteY27" fmla="*/ 876566 h 2415238"/>
              <a:gd name="connsiteX28" fmla="*/ 227501 w 661671"/>
              <a:gd name="connsiteY28" fmla="*/ 690828 h 2415238"/>
              <a:gd name="connsiteX29" fmla="*/ 175114 w 661671"/>
              <a:gd name="connsiteY29" fmla="*/ 338403 h 2415238"/>
              <a:gd name="connsiteX30" fmla="*/ 103676 w 661671"/>
              <a:gd name="connsiteY30" fmla="*/ 266 h 24152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</a:cxnLst>
            <a:rect l="l" t="t" r="r" b="b"/>
            <a:pathLst>
              <a:path w="661671" h="2415238">
                <a:moveTo>
                  <a:pt x="103676" y="266"/>
                </a:moveTo>
                <a:cubicBezTo>
                  <a:pt x="90182" y="-8465"/>
                  <a:pt x="86215" y="200290"/>
                  <a:pt x="94152" y="286015"/>
                </a:cubicBezTo>
                <a:cubicBezTo>
                  <a:pt x="102089" y="371740"/>
                  <a:pt x="148920" y="410635"/>
                  <a:pt x="151301" y="514616"/>
                </a:cubicBezTo>
                <a:cubicBezTo>
                  <a:pt x="153682" y="618597"/>
                  <a:pt x="140982" y="762266"/>
                  <a:pt x="137013" y="847991"/>
                </a:cubicBezTo>
                <a:cubicBezTo>
                  <a:pt x="133044" y="933716"/>
                  <a:pt x="133838" y="968641"/>
                  <a:pt x="127488" y="1028966"/>
                </a:cubicBezTo>
                <a:cubicBezTo>
                  <a:pt x="121138" y="1089291"/>
                  <a:pt x="103675" y="1159141"/>
                  <a:pt x="98913" y="1209941"/>
                </a:cubicBezTo>
                <a:cubicBezTo>
                  <a:pt x="94151" y="1260741"/>
                  <a:pt x="106850" y="1276616"/>
                  <a:pt x="98913" y="1333766"/>
                </a:cubicBezTo>
                <a:cubicBezTo>
                  <a:pt x="90976" y="1390916"/>
                  <a:pt x="57638" y="1471879"/>
                  <a:pt x="51288" y="1552841"/>
                </a:cubicBezTo>
                <a:cubicBezTo>
                  <a:pt x="44938" y="1633803"/>
                  <a:pt x="65575" y="1736991"/>
                  <a:pt x="60813" y="1819541"/>
                </a:cubicBezTo>
                <a:cubicBezTo>
                  <a:pt x="56051" y="1902091"/>
                  <a:pt x="31444" y="1952891"/>
                  <a:pt x="22713" y="2048141"/>
                </a:cubicBezTo>
                <a:cubicBezTo>
                  <a:pt x="13982" y="2143391"/>
                  <a:pt x="-13799" y="2334685"/>
                  <a:pt x="8426" y="2391041"/>
                </a:cubicBezTo>
                <a:cubicBezTo>
                  <a:pt x="30651" y="2447397"/>
                  <a:pt x="120344" y="2387866"/>
                  <a:pt x="156063" y="2386279"/>
                </a:cubicBezTo>
                <a:cubicBezTo>
                  <a:pt x="191782" y="2384692"/>
                  <a:pt x="201307" y="2408504"/>
                  <a:pt x="222738" y="2381516"/>
                </a:cubicBezTo>
                <a:cubicBezTo>
                  <a:pt x="244170" y="2354528"/>
                  <a:pt x="264014" y="2279122"/>
                  <a:pt x="284652" y="2224353"/>
                </a:cubicBezTo>
                <a:cubicBezTo>
                  <a:pt x="305290" y="2169584"/>
                  <a:pt x="341008" y="2121959"/>
                  <a:pt x="346564" y="2091003"/>
                </a:cubicBezTo>
                <a:cubicBezTo>
                  <a:pt x="352120" y="2060047"/>
                  <a:pt x="328307" y="2051316"/>
                  <a:pt x="346563" y="2019566"/>
                </a:cubicBezTo>
                <a:cubicBezTo>
                  <a:pt x="364819" y="1987816"/>
                  <a:pt x="441815" y="1932253"/>
                  <a:pt x="456102" y="1900503"/>
                </a:cubicBezTo>
                <a:cubicBezTo>
                  <a:pt x="470390" y="1868753"/>
                  <a:pt x="427526" y="1853672"/>
                  <a:pt x="432288" y="1829066"/>
                </a:cubicBezTo>
                <a:cubicBezTo>
                  <a:pt x="437050" y="1804460"/>
                  <a:pt x="467215" y="1794934"/>
                  <a:pt x="484677" y="1752865"/>
                </a:cubicBezTo>
                <a:cubicBezTo>
                  <a:pt x="502140" y="1710796"/>
                  <a:pt x="521982" y="1636184"/>
                  <a:pt x="537063" y="1576653"/>
                </a:cubicBezTo>
                <a:cubicBezTo>
                  <a:pt x="552144" y="1517122"/>
                  <a:pt x="573577" y="1459971"/>
                  <a:pt x="575164" y="1395677"/>
                </a:cubicBezTo>
                <a:cubicBezTo>
                  <a:pt x="581514" y="1345671"/>
                  <a:pt x="568019" y="1300428"/>
                  <a:pt x="575163" y="1276616"/>
                </a:cubicBezTo>
                <a:cubicBezTo>
                  <a:pt x="582307" y="1252804"/>
                  <a:pt x="603740" y="1274234"/>
                  <a:pt x="618027" y="1252803"/>
                </a:cubicBezTo>
                <a:cubicBezTo>
                  <a:pt x="632314" y="1231372"/>
                  <a:pt x="655332" y="1172634"/>
                  <a:pt x="660888" y="1148028"/>
                </a:cubicBezTo>
                <a:cubicBezTo>
                  <a:pt x="666444" y="1123422"/>
                  <a:pt x="640251" y="1121040"/>
                  <a:pt x="651363" y="1105165"/>
                </a:cubicBezTo>
                <a:cubicBezTo>
                  <a:pt x="662476" y="1089290"/>
                  <a:pt x="537063" y="1078178"/>
                  <a:pt x="503726" y="1057541"/>
                </a:cubicBezTo>
                <a:cubicBezTo>
                  <a:pt x="470389" y="1036904"/>
                  <a:pt x="460863" y="1003566"/>
                  <a:pt x="451338" y="981341"/>
                </a:cubicBezTo>
                <a:cubicBezTo>
                  <a:pt x="441813" y="959116"/>
                  <a:pt x="417206" y="924985"/>
                  <a:pt x="379900" y="876566"/>
                </a:cubicBezTo>
                <a:cubicBezTo>
                  <a:pt x="342594" y="828147"/>
                  <a:pt x="258457" y="786078"/>
                  <a:pt x="227501" y="690828"/>
                </a:cubicBezTo>
                <a:cubicBezTo>
                  <a:pt x="196545" y="595578"/>
                  <a:pt x="212420" y="422541"/>
                  <a:pt x="175114" y="338403"/>
                </a:cubicBezTo>
                <a:cubicBezTo>
                  <a:pt x="137808" y="254266"/>
                  <a:pt x="117170" y="8997"/>
                  <a:pt x="103676" y="266"/>
                </a:cubicBezTo>
                <a:close/>
              </a:path>
            </a:pathLst>
          </a:custGeom>
          <a:solidFill>
            <a:srgbClr val="FF00FF">
              <a:alpha val="30000"/>
            </a:srgbClr>
          </a:solidFill>
          <a:ln w="19050"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22"/>
          <p:cNvSpPr/>
          <p:nvPr/>
        </p:nvSpPr>
        <p:spPr>
          <a:xfrm>
            <a:off x="5596020" y="1298248"/>
            <a:ext cx="1050286" cy="78854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線矢印コネクタ 23"/>
          <p:cNvCxnSpPr>
            <a:cxnSpLocks/>
          </p:cNvCxnSpPr>
          <p:nvPr/>
        </p:nvCxnSpPr>
        <p:spPr>
          <a:xfrm>
            <a:off x="5710679" y="2137525"/>
            <a:ext cx="0" cy="122605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フリーフォーム 28"/>
          <p:cNvSpPr/>
          <p:nvPr/>
        </p:nvSpPr>
        <p:spPr>
          <a:xfrm>
            <a:off x="5971623" y="4213711"/>
            <a:ext cx="232749" cy="720539"/>
          </a:xfrm>
          <a:custGeom>
            <a:avLst/>
            <a:gdLst>
              <a:gd name="connsiteX0" fmla="*/ 7697 w 237720"/>
              <a:gd name="connsiteY0" fmla="*/ 2238 h 766891"/>
              <a:gd name="connsiteX1" fmla="*/ 100566 w 237720"/>
              <a:gd name="connsiteY1" fmla="*/ 40338 h 766891"/>
              <a:gd name="connsiteX2" fmla="*/ 150572 w 237720"/>
              <a:gd name="connsiteY2" fmla="*/ 35576 h 766891"/>
              <a:gd name="connsiteX3" fmla="*/ 224391 w 237720"/>
              <a:gd name="connsiteY3" fmla="*/ 135588 h 766891"/>
              <a:gd name="connsiteX4" fmla="*/ 233916 w 237720"/>
              <a:gd name="connsiteY4" fmla="*/ 180832 h 766891"/>
              <a:gd name="connsiteX5" fmla="*/ 181528 w 237720"/>
              <a:gd name="connsiteY5" fmla="*/ 330851 h 766891"/>
              <a:gd name="connsiteX6" fmla="*/ 81516 w 237720"/>
              <a:gd name="connsiteY6" fmla="*/ 526113 h 766891"/>
              <a:gd name="connsiteX7" fmla="*/ 33891 w 237720"/>
              <a:gd name="connsiteY7" fmla="*/ 695182 h 766891"/>
              <a:gd name="connsiteX8" fmla="*/ 7697 w 237720"/>
              <a:gd name="connsiteY8" fmla="*/ 764238 h 766891"/>
              <a:gd name="connsiteX9" fmla="*/ 553 w 237720"/>
              <a:gd name="connsiteY9" fmla="*/ 611838 h 766891"/>
              <a:gd name="connsiteX10" fmla="*/ 19603 w 237720"/>
              <a:gd name="connsiteY10" fmla="*/ 447532 h 766891"/>
              <a:gd name="connsiteX11" fmla="*/ 33891 w 237720"/>
              <a:gd name="connsiteY11" fmla="*/ 226076 h 766891"/>
              <a:gd name="connsiteX12" fmla="*/ 41034 w 237720"/>
              <a:gd name="connsiteY12" fmla="*/ 116538 h 766891"/>
              <a:gd name="connsiteX13" fmla="*/ 7697 w 237720"/>
              <a:gd name="connsiteY13" fmla="*/ 2238 h 766891"/>
              <a:gd name="connsiteX0" fmla="*/ 7697 w 247587"/>
              <a:gd name="connsiteY0" fmla="*/ 2238 h 766891"/>
              <a:gd name="connsiteX1" fmla="*/ 100566 w 247587"/>
              <a:gd name="connsiteY1" fmla="*/ 40338 h 766891"/>
              <a:gd name="connsiteX2" fmla="*/ 150572 w 247587"/>
              <a:gd name="connsiteY2" fmla="*/ 35576 h 766891"/>
              <a:gd name="connsiteX3" fmla="*/ 241060 w 247587"/>
              <a:gd name="connsiteY3" fmla="*/ 114157 h 766891"/>
              <a:gd name="connsiteX4" fmla="*/ 233916 w 247587"/>
              <a:gd name="connsiteY4" fmla="*/ 180832 h 766891"/>
              <a:gd name="connsiteX5" fmla="*/ 181528 w 247587"/>
              <a:gd name="connsiteY5" fmla="*/ 330851 h 766891"/>
              <a:gd name="connsiteX6" fmla="*/ 81516 w 247587"/>
              <a:gd name="connsiteY6" fmla="*/ 526113 h 766891"/>
              <a:gd name="connsiteX7" fmla="*/ 33891 w 247587"/>
              <a:gd name="connsiteY7" fmla="*/ 695182 h 766891"/>
              <a:gd name="connsiteX8" fmla="*/ 7697 w 247587"/>
              <a:gd name="connsiteY8" fmla="*/ 764238 h 766891"/>
              <a:gd name="connsiteX9" fmla="*/ 553 w 247587"/>
              <a:gd name="connsiteY9" fmla="*/ 611838 h 766891"/>
              <a:gd name="connsiteX10" fmla="*/ 19603 w 247587"/>
              <a:gd name="connsiteY10" fmla="*/ 447532 h 766891"/>
              <a:gd name="connsiteX11" fmla="*/ 33891 w 247587"/>
              <a:gd name="connsiteY11" fmla="*/ 226076 h 766891"/>
              <a:gd name="connsiteX12" fmla="*/ 41034 w 247587"/>
              <a:gd name="connsiteY12" fmla="*/ 116538 h 766891"/>
              <a:gd name="connsiteX13" fmla="*/ 7697 w 247587"/>
              <a:gd name="connsiteY13" fmla="*/ 2238 h 766891"/>
              <a:gd name="connsiteX0" fmla="*/ 7697 w 248448"/>
              <a:gd name="connsiteY0" fmla="*/ 2238 h 766891"/>
              <a:gd name="connsiteX1" fmla="*/ 100566 w 248448"/>
              <a:gd name="connsiteY1" fmla="*/ 40338 h 766891"/>
              <a:gd name="connsiteX2" fmla="*/ 150572 w 248448"/>
              <a:gd name="connsiteY2" fmla="*/ 35576 h 766891"/>
              <a:gd name="connsiteX3" fmla="*/ 241060 w 248448"/>
              <a:gd name="connsiteY3" fmla="*/ 114157 h 766891"/>
              <a:gd name="connsiteX4" fmla="*/ 236297 w 248448"/>
              <a:gd name="connsiteY4" fmla="*/ 216550 h 766891"/>
              <a:gd name="connsiteX5" fmla="*/ 181528 w 248448"/>
              <a:gd name="connsiteY5" fmla="*/ 330851 h 766891"/>
              <a:gd name="connsiteX6" fmla="*/ 81516 w 248448"/>
              <a:gd name="connsiteY6" fmla="*/ 526113 h 766891"/>
              <a:gd name="connsiteX7" fmla="*/ 33891 w 248448"/>
              <a:gd name="connsiteY7" fmla="*/ 695182 h 766891"/>
              <a:gd name="connsiteX8" fmla="*/ 7697 w 248448"/>
              <a:gd name="connsiteY8" fmla="*/ 764238 h 766891"/>
              <a:gd name="connsiteX9" fmla="*/ 553 w 248448"/>
              <a:gd name="connsiteY9" fmla="*/ 611838 h 766891"/>
              <a:gd name="connsiteX10" fmla="*/ 19603 w 248448"/>
              <a:gd name="connsiteY10" fmla="*/ 447532 h 766891"/>
              <a:gd name="connsiteX11" fmla="*/ 33891 w 248448"/>
              <a:gd name="connsiteY11" fmla="*/ 226076 h 766891"/>
              <a:gd name="connsiteX12" fmla="*/ 41034 w 248448"/>
              <a:gd name="connsiteY12" fmla="*/ 116538 h 766891"/>
              <a:gd name="connsiteX13" fmla="*/ 7697 w 248448"/>
              <a:gd name="connsiteY13" fmla="*/ 2238 h 766891"/>
              <a:gd name="connsiteX0" fmla="*/ 7697 w 248448"/>
              <a:gd name="connsiteY0" fmla="*/ 2238 h 766891"/>
              <a:gd name="connsiteX1" fmla="*/ 100566 w 248448"/>
              <a:gd name="connsiteY1" fmla="*/ 40338 h 766891"/>
              <a:gd name="connsiteX2" fmla="*/ 150572 w 248448"/>
              <a:gd name="connsiteY2" fmla="*/ 35576 h 766891"/>
              <a:gd name="connsiteX3" fmla="*/ 241060 w 248448"/>
              <a:gd name="connsiteY3" fmla="*/ 114157 h 766891"/>
              <a:gd name="connsiteX4" fmla="*/ 236297 w 248448"/>
              <a:gd name="connsiteY4" fmla="*/ 216550 h 766891"/>
              <a:gd name="connsiteX5" fmla="*/ 181528 w 248448"/>
              <a:gd name="connsiteY5" fmla="*/ 330851 h 766891"/>
              <a:gd name="connsiteX6" fmla="*/ 81516 w 248448"/>
              <a:gd name="connsiteY6" fmla="*/ 526113 h 766891"/>
              <a:gd name="connsiteX7" fmla="*/ 33891 w 248448"/>
              <a:gd name="connsiteY7" fmla="*/ 695182 h 766891"/>
              <a:gd name="connsiteX8" fmla="*/ 7697 w 248448"/>
              <a:gd name="connsiteY8" fmla="*/ 764238 h 766891"/>
              <a:gd name="connsiteX9" fmla="*/ 553 w 248448"/>
              <a:gd name="connsiteY9" fmla="*/ 611838 h 766891"/>
              <a:gd name="connsiteX10" fmla="*/ 19603 w 248448"/>
              <a:gd name="connsiteY10" fmla="*/ 447532 h 766891"/>
              <a:gd name="connsiteX11" fmla="*/ 33891 w 248448"/>
              <a:gd name="connsiteY11" fmla="*/ 226076 h 766891"/>
              <a:gd name="connsiteX12" fmla="*/ 41034 w 248448"/>
              <a:gd name="connsiteY12" fmla="*/ 116538 h 766891"/>
              <a:gd name="connsiteX13" fmla="*/ 7697 w 248448"/>
              <a:gd name="connsiteY13" fmla="*/ 2238 h 76689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248448" h="766891">
                <a:moveTo>
                  <a:pt x="7697" y="2238"/>
                </a:moveTo>
                <a:cubicBezTo>
                  <a:pt x="17619" y="-10462"/>
                  <a:pt x="76754" y="34782"/>
                  <a:pt x="100566" y="40338"/>
                </a:cubicBezTo>
                <a:cubicBezTo>
                  <a:pt x="124378" y="45894"/>
                  <a:pt x="127156" y="23273"/>
                  <a:pt x="150572" y="35576"/>
                </a:cubicBezTo>
                <a:cubicBezTo>
                  <a:pt x="173988" y="47879"/>
                  <a:pt x="226773" y="83995"/>
                  <a:pt x="241060" y="114157"/>
                </a:cubicBezTo>
                <a:cubicBezTo>
                  <a:pt x="255347" y="144319"/>
                  <a:pt x="246219" y="180434"/>
                  <a:pt x="236297" y="216550"/>
                </a:cubicBezTo>
                <a:cubicBezTo>
                  <a:pt x="226375" y="252666"/>
                  <a:pt x="207325" y="279257"/>
                  <a:pt x="181528" y="330851"/>
                </a:cubicBezTo>
                <a:cubicBezTo>
                  <a:pt x="155731" y="382445"/>
                  <a:pt x="106122" y="465391"/>
                  <a:pt x="81516" y="526113"/>
                </a:cubicBezTo>
                <a:cubicBezTo>
                  <a:pt x="56910" y="586835"/>
                  <a:pt x="46194" y="655495"/>
                  <a:pt x="33891" y="695182"/>
                </a:cubicBezTo>
                <a:cubicBezTo>
                  <a:pt x="21588" y="734869"/>
                  <a:pt x="13253" y="778129"/>
                  <a:pt x="7697" y="764238"/>
                </a:cubicBezTo>
                <a:cubicBezTo>
                  <a:pt x="2141" y="750347"/>
                  <a:pt x="-1431" y="664622"/>
                  <a:pt x="553" y="611838"/>
                </a:cubicBezTo>
                <a:cubicBezTo>
                  <a:pt x="2537" y="559054"/>
                  <a:pt x="14047" y="511826"/>
                  <a:pt x="19603" y="447532"/>
                </a:cubicBezTo>
                <a:cubicBezTo>
                  <a:pt x="25159" y="383238"/>
                  <a:pt x="30319" y="281242"/>
                  <a:pt x="33891" y="226076"/>
                </a:cubicBezTo>
                <a:cubicBezTo>
                  <a:pt x="37463" y="170910"/>
                  <a:pt x="48972" y="149479"/>
                  <a:pt x="41034" y="116538"/>
                </a:cubicBezTo>
                <a:cubicBezTo>
                  <a:pt x="33097" y="83597"/>
                  <a:pt x="-2225" y="14938"/>
                  <a:pt x="7697" y="2238"/>
                </a:cubicBezTo>
                <a:close/>
              </a:path>
            </a:pathLst>
          </a:custGeom>
          <a:solidFill>
            <a:srgbClr val="FF00FF">
              <a:alpha val="30000"/>
            </a:srgbClr>
          </a:solidFill>
          <a:ln w="19050">
            <a:noFill/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317815" y="3385793"/>
            <a:ext cx="19119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Osteoclast</a:t>
            </a:r>
            <a:endParaRPr kumimoji="1" lang="ja-JP" altLang="en-US" sz="2000" b="1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73875B6D-45CE-2C44-91E5-56D55E53B7B0}"/>
              </a:ext>
            </a:extLst>
          </p:cNvPr>
          <p:cNvSpPr txBox="1"/>
          <p:nvPr/>
        </p:nvSpPr>
        <p:spPr>
          <a:xfrm>
            <a:off x="1577561" y="12607"/>
            <a:ext cx="185868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biopsy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23BFF0D-9BAF-8649-A93F-D8DF18C173EF}"/>
              </a:ext>
            </a:extLst>
          </p:cNvPr>
          <p:cNvSpPr txBox="1"/>
          <p:nvPr/>
        </p:nvSpPr>
        <p:spPr>
          <a:xfrm>
            <a:off x="5983518" y="64117"/>
            <a:ext cx="18182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iopsy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156EAB48-CA36-1644-844C-FE6B8F80AF46}"/>
              </a:ext>
            </a:extLst>
          </p:cNvPr>
          <p:cNvSpPr txBox="1"/>
          <p:nvPr/>
        </p:nvSpPr>
        <p:spPr>
          <a:xfrm>
            <a:off x="94630" y="6209614"/>
            <a:ext cx="271985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t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ea typeface="游ゴシック"/>
                <a:cs typeface="Times New Roman" panose="02020603050405020304" pitchFamily="18" charset="0"/>
              </a:rPr>
              <a:t>Extended image of the upper sectio</a:t>
            </a:r>
            <a:r>
              <a:rPr lang="en-US" altLang="ja-JP" sz="1200" dirty="0">
                <a:latin typeface="Times New Roman" panose="02020603050405020304" pitchFamily="18" charset="0"/>
                <a:ea typeface="游ゴシック"/>
                <a:cs typeface="Times New Roman" panose="02020603050405020304" pitchFamily="18" charset="0"/>
              </a:rPr>
              <a:t>n</a:t>
            </a:r>
            <a:endParaRPr kumimoji="1" lang="ja-JP" altLang="en-US" sz="1200">
              <a:latin typeface="Times New Roman" panose="02020603050405020304" pitchFamily="18" charset="0"/>
              <a:ea typeface="游ゴシック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3173DC5-B476-3642-8BD0-0B5E519D1A5C}"/>
              </a:ext>
            </a:extLst>
          </p:cNvPr>
          <p:cNvSpPr txBox="1"/>
          <p:nvPr/>
        </p:nvSpPr>
        <p:spPr>
          <a:xfrm>
            <a:off x="4572944" y="6208456"/>
            <a:ext cx="260633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t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ea typeface="游ゴシック"/>
                <a:cs typeface="Times New Roman" panose="02020603050405020304" pitchFamily="18" charset="0"/>
              </a:rPr>
              <a:t>Extended image of the upper sectio</a:t>
            </a:r>
            <a:r>
              <a:rPr lang="en-US" altLang="ja-JP" sz="1200" dirty="0">
                <a:latin typeface="Times New Roman" panose="02020603050405020304" pitchFamily="18" charset="0"/>
                <a:ea typeface="游ゴシック"/>
                <a:cs typeface="Times New Roman" panose="02020603050405020304" pitchFamily="18" charset="0"/>
              </a:rPr>
              <a:t>n</a:t>
            </a:r>
            <a:endParaRPr kumimoji="1" lang="ja-JP" altLang="en-US" sz="1200">
              <a:latin typeface="Times New Roman" panose="02020603050405020304" pitchFamily="18" charset="0"/>
              <a:ea typeface="游ゴシック"/>
              <a:cs typeface="Times New Roman" panose="02020603050405020304" pitchFamily="18" charset="0"/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31929B2F-E148-B343-BCF0-06D305DFA7C7}"/>
              </a:ext>
            </a:extLst>
          </p:cNvPr>
          <p:cNvCxnSpPr>
            <a:cxnSpLocks/>
          </p:cNvCxnSpPr>
          <p:nvPr/>
        </p:nvCxnSpPr>
        <p:spPr>
          <a:xfrm flipH="1">
            <a:off x="2314214" y="1409444"/>
            <a:ext cx="260996" cy="15438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8BD3F2DD-D467-C043-8162-802A9D85408B}"/>
              </a:ext>
            </a:extLst>
          </p:cNvPr>
          <p:cNvCxnSpPr>
            <a:cxnSpLocks/>
          </p:cNvCxnSpPr>
          <p:nvPr/>
        </p:nvCxnSpPr>
        <p:spPr>
          <a:xfrm flipH="1">
            <a:off x="3000147" y="3805023"/>
            <a:ext cx="134939" cy="28369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310098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19</TotalTime>
  <Words>128</Words>
  <Application>Microsoft Macintosh PowerPoint</Application>
  <PresentationFormat>画面に合わせる (4:3)</PresentationFormat>
  <Paragraphs>19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HATANO MASAKI</cp:lastModifiedBy>
  <cp:revision>352</cp:revision>
  <dcterms:created xsi:type="dcterms:W3CDTF">2018-05-15T04:33:47Z</dcterms:created>
  <dcterms:modified xsi:type="dcterms:W3CDTF">2020-09-25T15:46:47Z</dcterms:modified>
</cp:coreProperties>
</file>